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300788" cy="2057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11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9F47270-9AE0-43AF-9443-DEE4DF9C1CAF}" v="83" dt="2024-12-29T20:10:32.5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6" autoAdjust="0"/>
    <p:restoredTop sz="94660"/>
  </p:normalViewPr>
  <p:slideViewPr>
    <p:cSldViewPr snapToGrid="0">
      <p:cViewPr>
        <p:scale>
          <a:sx n="200" d="100"/>
          <a:sy n="200" d="100"/>
        </p:scale>
        <p:origin x="726" y="1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nkins, Tommy L." userId="7720e6fb-7c72-4761-b67b-4ef39ba8a345" providerId="ADAL" clId="{C9F47270-9AE0-43AF-9443-DEE4DF9C1CAF}"/>
    <pc:docChg chg="undo custSel modSld modMainMaster">
      <pc:chgData name="Jenkins, Tommy L." userId="7720e6fb-7c72-4761-b67b-4ef39ba8a345" providerId="ADAL" clId="{C9F47270-9AE0-43AF-9443-DEE4DF9C1CAF}" dt="2024-12-29T20:13:24.149" v="278" actId="27918"/>
      <pc:docMkLst>
        <pc:docMk/>
      </pc:docMkLst>
      <pc:sldChg chg="addSp delSp modSp mod">
        <pc:chgData name="Jenkins, Tommy L." userId="7720e6fb-7c72-4761-b67b-4ef39ba8a345" providerId="ADAL" clId="{C9F47270-9AE0-43AF-9443-DEE4DF9C1CAF}" dt="2024-12-29T20:13:24.149" v="278" actId="27918"/>
        <pc:sldMkLst>
          <pc:docMk/>
          <pc:sldMk cId="2873051424" sldId="261"/>
        </pc:sldMkLst>
        <pc:spChg chg="mod">
          <ac:chgData name="Jenkins, Tommy L." userId="7720e6fb-7c72-4761-b67b-4ef39ba8a345" providerId="ADAL" clId="{C9F47270-9AE0-43AF-9443-DEE4DF9C1CAF}" dt="2024-12-29T20:08:38.134" v="252" actId="164"/>
          <ac:spMkLst>
            <pc:docMk/>
            <pc:sldMk cId="2873051424" sldId="261"/>
            <ac:spMk id="3" creationId="{F8CCF206-6A6D-0DAC-391B-DF2BBC76A045}"/>
          </ac:spMkLst>
        </pc:spChg>
        <pc:spChg chg="add mod">
          <ac:chgData name="Jenkins, Tommy L." userId="7720e6fb-7c72-4761-b67b-4ef39ba8a345" providerId="ADAL" clId="{C9F47270-9AE0-43AF-9443-DEE4DF9C1CAF}" dt="2024-12-29T20:08:38.134" v="252" actId="164"/>
          <ac:spMkLst>
            <pc:docMk/>
            <pc:sldMk cId="2873051424" sldId="261"/>
            <ac:spMk id="5" creationId="{5E3992FA-C147-4190-AE50-1F4CD3D98355}"/>
          </ac:spMkLst>
        </pc:spChg>
        <pc:spChg chg="add del mod">
          <ac:chgData name="Jenkins, Tommy L." userId="7720e6fb-7c72-4761-b67b-4ef39ba8a345" providerId="ADAL" clId="{C9F47270-9AE0-43AF-9443-DEE4DF9C1CAF}" dt="2024-12-29T20:08:38.134" v="252" actId="164"/>
          <ac:spMkLst>
            <pc:docMk/>
            <pc:sldMk cId="2873051424" sldId="261"/>
            <ac:spMk id="40" creationId="{2377DDAE-3168-2510-58CD-69D12706E4B8}"/>
          </ac:spMkLst>
        </pc:spChg>
        <pc:spChg chg="mod">
          <ac:chgData name="Jenkins, Tommy L." userId="7720e6fb-7c72-4761-b67b-4ef39ba8a345" providerId="ADAL" clId="{C9F47270-9AE0-43AF-9443-DEE4DF9C1CAF}" dt="2024-12-29T20:08:38.134" v="252" actId="164"/>
          <ac:spMkLst>
            <pc:docMk/>
            <pc:sldMk cId="2873051424" sldId="261"/>
            <ac:spMk id="41" creationId="{2446263F-D352-C6F7-12C6-A8764D0122B4}"/>
          </ac:spMkLst>
        </pc:spChg>
        <pc:spChg chg="mod">
          <ac:chgData name="Jenkins, Tommy L." userId="7720e6fb-7c72-4761-b67b-4ef39ba8a345" providerId="ADAL" clId="{C9F47270-9AE0-43AF-9443-DEE4DF9C1CAF}" dt="2024-12-29T20:04:31.512" v="49" actId="164"/>
          <ac:spMkLst>
            <pc:docMk/>
            <pc:sldMk cId="2873051424" sldId="261"/>
            <ac:spMk id="42" creationId="{7E5E1260-267E-47EC-B21C-A6789612227A}"/>
          </ac:spMkLst>
        </pc:spChg>
        <pc:spChg chg="del">
          <ac:chgData name="Jenkins, Tommy L." userId="7720e6fb-7c72-4761-b67b-4ef39ba8a345" providerId="ADAL" clId="{C9F47270-9AE0-43AF-9443-DEE4DF9C1CAF}" dt="2024-12-29T19:49:22.905" v="6" actId="478"/>
          <ac:spMkLst>
            <pc:docMk/>
            <pc:sldMk cId="2873051424" sldId="261"/>
            <ac:spMk id="43" creationId="{50D217A8-95D7-0D4E-0C08-B53C160F8292}"/>
          </ac:spMkLst>
        </pc:spChg>
        <pc:spChg chg="del">
          <ac:chgData name="Jenkins, Tommy L." userId="7720e6fb-7c72-4761-b67b-4ef39ba8a345" providerId="ADAL" clId="{C9F47270-9AE0-43AF-9443-DEE4DF9C1CAF}" dt="2024-12-29T19:49:22.905" v="6" actId="478"/>
          <ac:spMkLst>
            <pc:docMk/>
            <pc:sldMk cId="2873051424" sldId="261"/>
            <ac:spMk id="57" creationId="{9E05C334-7AD7-9C36-BDC1-35B4510F694E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70" creationId="{35BDF44B-3658-918C-9489-5912D75185B9}"/>
          </ac:spMkLst>
        </pc:spChg>
        <pc:spChg chg="add mod">
          <ac:chgData name="Jenkins, Tommy L." userId="7720e6fb-7c72-4761-b67b-4ef39ba8a345" providerId="ADAL" clId="{C9F47270-9AE0-43AF-9443-DEE4DF9C1CAF}" dt="2024-12-29T20:08:38.134" v="252" actId="164"/>
          <ac:spMkLst>
            <pc:docMk/>
            <pc:sldMk cId="2873051424" sldId="261"/>
            <ac:spMk id="102" creationId="{D2632C33-FDDA-484D-928F-98ED29EC3E00}"/>
          </ac:spMkLst>
        </pc:spChg>
        <pc:spChg chg="add mod">
          <ac:chgData name="Jenkins, Tommy L." userId="7720e6fb-7c72-4761-b67b-4ef39ba8a345" providerId="ADAL" clId="{C9F47270-9AE0-43AF-9443-DEE4DF9C1CAF}" dt="2024-12-29T20:08:38.134" v="252" actId="164"/>
          <ac:spMkLst>
            <pc:docMk/>
            <pc:sldMk cId="2873051424" sldId="261"/>
            <ac:spMk id="103" creationId="{1CEB434A-AFB2-4852-9071-14B7F86397B8}"/>
          </ac:spMkLst>
        </pc:spChg>
        <pc:spChg chg="add mod">
          <ac:chgData name="Jenkins, Tommy L." userId="7720e6fb-7c72-4761-b67b-4ef39ba8a345" providerId="ADAL" clId="{C9F47270-9AE0-43AF-9443-DEE4DF9C1CAF}" dt="2024-12-29T20:08:38.134" v="252" actId="164"/>
          <ac:spMkLst>
            <pc:docMk/>
            <pc:sldMk cId="2873051424" sldId="261"/>
            <ac:spMk id="104" creationId="{0BFBF0AF-451B-4CAD-AC9C-B8976196DD10}"/>
          </ac:spMkLst>
        </pc:spChg>
        <pc:spChg chg="add mod">
          <ac:chgData name="Jenkins, Tommy L." userId="7720e6fb-7c72-4761-b67b-4ef39ba8a345" providerId="ADAL" clId="{C9F47270-9AE0-43AF-9443-DEE4DF9C1CAF}" dt="2024-12-29T20:08:38.134" v="252" actId="164"/>
          <ac:spMkLst>
            <pc:docMk/>
            <pc:sldMk cId="2873051424" sldId="261"/>
            <ac:spMk id="108" creationId="{DDD2E38F-BDF8-4358-B0CC-22981CC6598A}"/>
          </ac:spMkLst>
        </pc:spChg>
        <pc:spChg chg="add mod">
          <ac:chgData name="Jenkins, Tommy L." userId="7720e6fb-7c72-4761-b67b-4ef39ba8a345" providerId="ADAL" clId="{C9F47270-9AE0-43AF-9443-DEE4DF9C1CAF}" dt="2024-12-29T20:08:38.134" v="252" actId="164"/>
          <ac:spMkLst>
            <pc:docMk/>
            <pc:sldMk cId="2873051424" sldId="261"/>
            <ac:spMk id="109" creationId="{0C086398-51A3-4A3D-8B16-20519FCA2706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18" creationId="{B3B53D47-9D64-4F41-9825-15E5A68B2090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19" creationId="{C1DA65D8-4C63-4265-8979-29E6704B4E88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42" creationId="{00D99197-B309-4E03-95F2-02665BCA2459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147" creationId="{9E025E92-67D1-4F74-B715-F8F0752077B6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148" creationId="{49E5F428-D157-4A61-BAF6-C63EEA0DE917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151" creationId="{E3D266B1-26EC-4EDC-AB50-029B1DC17496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54" creationId="{B1DA0755-2D8B-4762-B703-873934067FD3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56" creationId="{D6E29882-7BD0-4EF7-89A4-4956FF14019A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157" creationId="{2CD75655-D99F-4BE9-8C0F-2C6162A43BF3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58" creationId="{5A5812AD-718D-4591-B0F6-27574B3DEA1A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59" creationId="{9DEB4B02-CBB5-41EC-8387-BB24D84C2778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160" creationId="{20CCCD7F-CFEB-4BD0-B32C-9E6A8D7C6413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161" creationId="{795CF644-D35F-4681-9D20-19B15F83743F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63" creationId="{1CB78446-DF05-43C3-9EAF-31FFB7A5EA09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64" creationId="{8A988E74-1D35-44D0-97BF-E09D3EE477F7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165" creationId="{0F5E4B12-CC9C-4583-82CC-951DFC235708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70" creationId="{322CA788-66A3-4D36-94B2-1F98C5EDBA0A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72" creationId="{A497ADDD-2D55-4FA7-8D96-19861DAE013F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75" creationId="{6EE824EB-FE3E-47B4-A37C-84FBFAE7555B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81" creationId="{72E68161-FA8A-4910-984C-AF7886475649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82" creationId="{1936E29A-D0A6-4818-A7EE-A7B14911A420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83" creationId="{5FA7641C-7D32-4012-85AA-2E119A1DCD10}"/>
          </ac:spMkLst>
        </pc:spChg>
        <pc:spChg chg="mod">
          <ac:chgData name="Jenkins, Tommy L." userId="7720e6fb-7c72-4761-b67b-4ef39ba8a345" providerId="ADAL" clId="{C9F47270-9AE0-43AF-9443-DEE4DF9C1CAF}" dt="2024-12-29T20:08:52.871" v="257"/>
          <ac:spMkLst>
            <pc:docMk/>
            <pc:sldMk cId="2873051424" sldId="261"/>
            <ac:spMk id="184" creationId="{74CBAA30-554B-439A-892B-95891DD385BA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185" creationId="{4EEABEEC-58CD-447E-AD8B-A42A5555AE76}"/>
          </ac:spMkLst>
        </pc:spChg>
        <pc:spChg chg="del">
          <ac:chgData name="Jenkins, Tommy L." userId="7720e6fb-7c72-4761-b67b-4ef39ba8a345" providerId="ADAL" clId="{C9F47270-9AE0-43AF-9443-DEE4DF9C1CAF}" dt="2024-12-29T19:49:13.223" v="2" actId="478"/>
          <ac:spMkLst>
            <pc:docMk/>
            <pc:sldMk cId="2873051424" sldId="261"/>
            <ac:spMk id="186" creationId="{58373527-3237-4BD1-9074-98740DCC8D62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188" creationId="{30510A66-61AF-4344-8E12-D2A12CF7AC7E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189" creationId="{0A8A9EDB-238E-4358-911C-B764D64ECA2B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190" creationId="{9EFC3561-8FD4-493E-AD69-A16BDF03F537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196" creationId="{60EC5E02-0607-475D-8A3F-AB7FF64E5DDB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197" creationId="{AA551317-38FB-4FDC-BF03-CAF6B3089F8B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198" creationId="{2C7B1419-54AA-42D3-B73C-CC64A2C10331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199" creationId="{0F78E579-DBB5-4A8E-8D22-A58961CE0525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202" creationId="{E9BB50E2-77A6-4CEF-B01E-68107483348F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203" creationId="{8246248B-07C8-42B9-A6AF-F26A70BF444B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212" creationId="{42F67D48-FB68-48C7-A0A4-63AC6EF3B766}"/>
          </ac:spMkLst>
        </pc:spChg>
        <pc:spChg chg="add del">
          <ac:chgData name="Jenkins, Tommy L." userId="7720e6fb-7c72-4761-b67b-4ef39ba8a345" providerId="ADAL" clId="{C9F47270-9AE0-43AF-9443-DEE4DF9C1CAF}" dt="2024-12-29T19:49:20.913" v="5" actId="478"/>
          <ac:spMkLst>
            <pc:docMk/>
            <pc:sldMk cId="2873051424" sldId="261"/>
            <ac:spMk id="216" creationId="{EE920946-4245-49EE-A41C-78ACAC93AEEB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222" creationId="{0E9DBAB7-1F4F-4661-9F2D-173F139FB34B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223" creationId="{43487C8C-7B72-45AF-B259-457DB6D0FEF8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224" creationId="{53B0FBE3-C901-4333-804A-11BDCD963FA4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225" creationId="{30B509D1-B4DF-41B0-A776-99778F30B980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226" creationId="{C4AC588B-9BCF-4B4F-9D97-13C6831D74F6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227" creationId="{B96128B6-C8A8-4265-A8E1-6FA1366240BC}"/>
          </ac:spMkLst>
        </pc:spChg>
        <pc:spChg chg="mod">
          <ac:chgData name="Jenkins, Tommy L." userId="7720e6fb-7c72-4761-b67b-4ef39ba8a345" providerId="ADAL" clId="{C9F47270-9AE0-43AF-9443-DEE4DF9C1CAF}" dt="2024-12-29T20:10:21.708" v="269"/>
          <ac:spMkLst>
            <pc:docMk/>
            <pc:sldMk cId="2873051424" sldId="261"/>
            <ac:spMk id="228" creationId="{F42D35E1-669A-43DF-A6BC-248D33FDD84E}"/>
          </ac:spMkLst>
        </pc:spChg>
        <pc:grpChg chg="add mod">
          <ac:chgData name="Jenkins, Tommy L." userId="7720e6fb-7c72-4761-b67b-4ef39ba8a345" providerId="ADAL" clId="{C9F47270-9AE0-43AF-9443-DEE4DF9C1CAF}" dt="2024-12-29T20:08:38.134" v="252" actId="164"/>
          <ac:grpSpMkLst>
            <pc:docMk/>
            <pc:sldMk cId="2873051424" sldId="261"/>
            <ac:grpSpMk id="4" creationId="{5485FC17-7BD5-4AFF-B561-132DF3B310B7}"/>
          </ac:grpSpMkLst>
        </pc:grpChg>
        <pc:grpChg chg="add del mod">
          <ac:chgData name="Jenkins, Tommy L." userId="7720e6fb-7c72-4761-b67b-4ef39ba8a345" providerId="ADAL" clId="{C9F47270-9AE0-43AF-9443-DEE4DF9C1CAF}" dt="2024-12-29T20:10:08.600" v="265" actId="21"/>
          <ac:grpSpMkLst>
            <pc:docMk/>
            <pc:sldMk cId="2873051424" sldId="261"/>
            <ac:grpSpMk id="10" creationId="{6587D7D4-9595-455B-AAE0-235AE53CAA7D}"/>
          </ac:grpSpMkLst>
        </pc:grpChg>
        <pc:grpChg chg="mod">
          <ac:chgData name="Jenkins, Tommy L." userId="7720e6fb-7c72-4761-b67b-4ef39ba8a345" providerId="ADAL" clId="{C9F47270-9AE0-43AF-9443-DEE4DF9C1CAF}" dt="2024-12-29T20:04:31.512" v="49" actId="164"/>
          <ac:grpSpMkLst>
            <pc:docMk/>
            <pc:sldMk cId="2873051424" sldId="261"/>
            <ac:grpSpMk id="90" creationId="{51236B9A-8B0C-5965-71DC-4CEAE012BA12}"/>
          </ac:grpSpMkLst>
        </pc:grpChg>
        <pc:grpChg chg="mod">
          <ac:chgData name="Jenkins, Tommy L." userId="7720e6fb-7c72-4761-b67b-4ef39ba8a345" providerId="ADAL" clId="{C9F47270-9AE0-43AF-9443-DEE4DF9C1CAF}" dt="2024-12-29T20:04:31.512" v="49" actId="164"/>
          <ac:grpSpMkLst>
            <pc:docMk/>
            <pc:sldMk cId="2873051424" sldId="261"/>
            <ac:grpSpMk id="91" creationId="{2E55411F-1E3C-554A-F275-1555B07533A7}"/>
          </ac:grpSpMkLst>
        </pc:grpChg>
        <pc:grpChg chg="mod">
          <ac:chgData name="Jenkins, Tommy L." userId="7720e6fb-7c72-4761-b67b-4ef39ba8a345" providerId="ADAL" clId="{C9F47270-9AE0-43AF-9443-DEE4DF9C1CAF}" dt="2024-12-29T20:04:31.512" v="49" actId="164"/>
          <ac:grpSpMkLst>
            <pc:docMk/>
            <pc:sldMk cId="2873051424" sldId="261"/>
            <ac:grpSpMk id="92" creationId="{F9FFE7EE-476C-DAE8-90BC-1F9AB27AC558}"/>
          </ac:grpSpMkLst>
        </pc:grpChg>
        <pc:grpChg chg="add del mod">
          <ac:chgData name="Jenkins, Tommy L." userId="7720e6fb-7c72-4761-b67b-4ef39ba8a345" providerId="ADAL" clId="{C9F47270-9AE0-43AF-9443-DEE4DF9C1CAF}" dt="2024-12-29T20:09:22.212" v="262"/>
          <ac:grpSpMkLst>
            <pc:docMk/>
            <pc:sldMk cId="2873051424" sldId="261"/>
            <ac:grpSpMk id="112" creationId="{AF1E68FB-9121-4F51-A485-D23713FB5C04}"/>
          </ac:grpSpMkLst>
        </pc:grpChg>
        <pc:grpChg chg="del">
          <ac:chgData name="Jenkins, Tommy L." userId="7720e6fb-7c72-4761-b67b-4ef39ba8a345" providerId="ADAL" clId="{C9F47270-9AE0-43AF-9443-DEE4DF9C1CAF}" dt="2024-12-29T19:49:12.431" v="1" actId="478"/>
          <ac:grpSpMkLst>
            <pc:docMk/>
            <pc:sldMk cId="2873051424" sldId="261"/>
            <ac:grpSpMk id="123" creationId="{8EEA0B13-752F-4B74-BC82-D3685EA8065E}"/>
          </ac:grpSpMkLst>
        </pc:grpChg>
        <pc:grpChg chg="del">
          <ac:chgData name="Jenkins, Tommy L." userId="7720e6fb-7c72-4761-b67b-4ef39ba8a345" providerId="ADAL" clId="{C9F47270-9AE0-43AF-9443-DEE4DF9C1CAF}" dt="2024-12-29T19:49:22.905" v="6" actId="478"/>
          <ac:grpSpMkLst>
            <pc:docMk/>
            <pc:sldMk cId="2873051424" sldId="261"/>
            <ac:grpSpMk id="124" creationId="{843079B2-2368-4F60-ADA0-12DA3C337058}"/>
          </ac:grpSpMkLst>
        </pc:grpChg>
        <pc:grpChg chg="mod">
          <ac:chgData name="Jenkins, Tommy L." userId="7720e6fb-7c72-4761-b67b-4ef39ba8a345" providerId="ADAL" clId="{C9F47270-9AE0-43AF-9443-DEE4DF9C1CAF}" dt="2024-12-29T20:08:52.871" v="257"/>
          <ac:grpSpMkLst>
            <pc:docMk/>
            <pc:sldMk cId="2873051424" sldId="261"/>
            <ac:grpSpMk id="144" creationId="{8D1BA928-71A0-4454-AECA-06FC5C05657D}"/>
          </ac:grpSpMkLst>
        </pc:grpChg>
        <pc:grpChg chg="mod">
          <ac:chgData name="Jenkins, Tommy L." userId="7720e6fb-7c72-4761-b67b-4ef39ba8a345" providerId="ADAL" clId="{C9F47270-9AE0-43AF-9443-DEE4DF9C1CAF}" dt="2024-12-29T20:08:52.871" v="257"/>
          <ac:grpSpMkLst>
            <pc:docMk/>
            <pc:sldMk cId="2873051424" sldId="261"/>
            <ac:grpSpMk id="167" creationId="{CE16D6E1-0D95-4534-BB35-C827C5267DDB}"/>
          </ac:grpSpMkLst>
        </pc:grpChg>
        <pc:grpChg chg="mod">
          <ac:chgData name="Jenkins, Tommy L." userId="7720e6fb-7c72-4761-b67b-4ef39ba8a345" providerId="ADAL" clId="{C9F47270-9AE0-43AF-9443-DEE4DF9C1CAF}" dt="2024-12-29T20:08:52.871" v="257"/>
          <ac:grpSpMkLst>
            <pc:docMk/>
            <pc:sldMk cId="2873051424" sldId="261"/>
            <ac:grpSpMk id="168" creationId="{B6F96277-0F05-4B87-8E5D-BADE2D454458}"/>
          </ac:grpSpMkLst>
        </pc:grpChg>
        <pc:grpChg chg="mod">
          <ac:chgData name="Jenkins, Tommy L." userId="7720e6fb-7c72-4761-b67b-4ef39ba8a345" providerId="ADAL" clId="{C9F47270-9AE0-43AF-9443-DEE4DF9C1CAF}" dt="2024-12-29T20:08:52.871" v="257"/>
          <ac:grpSpMkLst>
            <pc:docMk/>
            <pc:sldMk cId="2873051424" sldId="261"/>
            <ac:grpSpMk id="169" creationId="{905A3430-E0B6-4CEE-8E02-1E246CAE4D69}"/>
          </ac:grpSpMkLst>
        </pc:grpChg>
        <pc:grpChg chg="add mod">
          <ac:chgData name="Jenkins, Tommy L." userId="7720e6fb-7c72-4761-b67b-4ef39ba8a345" providerId="ADAL" clId="{C9F47270-9AE0-43AF-9443-DEE4DF9C1CAF}" dt="2024-12-29T20:10:25.946" v="271" actId="12789"/>
          <ac:grpSpMkLst>
            <pc:docMk/>
            <pc:sldMk cId="2873051424" sldId="261"/>
            <ac:grpSpMk id="187" creationId="{4FE6EACE-47ED-42D4-AD36-5FA1211F823E}"/>
          </ac:grpSpMkLst>
        </pc:grpChg>
        <pc:grpChg chg="mod">
          <ac:chgData name="Jenkins, Tommy L." userId="7720e6fb-7c72-4761-b67b-4ef39ba8a345" providerId="ADAL" clId="{C9F47270-9AE0-43AF-9443-DEE4DF9C1CAF}" dt="2024-12-29T20:10:21.708" v="269"/>
          <ac:grpSpMkLst>
            <pc:docMk/>
            <pc:sldMk cId="2873051424" sldId="261"/>
            <ac:grpSpMk id="191" creationId="{66AA7E3E-22F3-4B9D-9572-43937574994E}"/>
          </ac:grpSpMkLst>
        </pc:grpChg>
        <pc:grpChg chg="mod">
          <ac:chgData name="Jenkins, Tommy L." userId="7720e6fb-7c72-4761-b67b-4ef39ba8a345" providerId="ADAL" clId="{C9F47270-9AE0-43AF-9443-DEE4DF9C1CAF}" dt="2024-12-29T20:10:21.708" v="269"/>
          <ac:grpSpMkLst>
            <pc:docMk/>
            <pc:sldMk cId="2873051424" sldId="261"/>
            <ac:grpSpMk id="204" creationId="{B552DE7D-A8AE-4217-88CE-3673BE7FE311}"/>
          </ac:grpSpMkLst>
        </pc:grpChg>
        <pc:grpChg chg="mod">
          <ac:chgData name="Jenkins, Tommy L." userId="7720e6fb-7c72-4761-b67b-4ef39ba8a345" providerId="ADAL" clId="{C9F47270-9AE0-43AF-9443-DEE4DF9C1CAF}" dt="2024-12-29T20:10:21.708" v="269"/>
          <ac:grpSpMkLst>
            <pc:docMk/>
            <pc:sldMk cId="2873051424" sldId="261"/>
            <ac:grpSpMk id="205" creationId="{5F820643-300C-4F47-8213-5C0C6FF7E6A3}"/>
          </ac:grpSpMkLst>
        </pc:grpChg>
        <pc:grpChg chg="mod">
          <ac:chgData name="Jenkins, Tommy L." userId="7720e6fb-7c72-4761-b67b-4ef39ba8a345" providerId="ADAL" clId="{C9F47270-9AE0-43AF-9443-DEE4DF9C1CAF}" dt="2024-12-29T20:10:21.708" v="269"/>
          <ac:grpSpMkLst>
            <pc:docMk/>
            <pc:sldMk cId="2873051424" sldId="261"/>
            <ac:grpSpMk id="221" creationId="{7AE9A579-B43F-4CE3-8093-E7B43BADC267}"/>
          </ac:grpSpMkLst>
        </pc:grpChg>
        <pc:graphicFrameChg chg="del">
          <ac:chgData name="Jenkins, Tommy L." userId="7720e6fb-7c72-4761-b67b-4ef39ba8a345" providerId="ADAL" clId="{C9F47270-9AE0-43AF-9443-DEE4DF9C1CAF}" dt="2024-12-29T19:49:09.023" v="0" actId="478"/>
          <ac:graphicFrameMkLst>
            <pc:docMk/>
            <pc:sldMk cId="2873051424" sldId="261"/>
            <ac:graphicFrameMk id="2" creationId="{862211CF-BF66-A054-EA39-2A88B5A9D72E}"/>
          </ac:graphicFrameMkLst>
        </pc:graphicFrameChg>
        <pc:graphicFrameChg chg="add mod">
          <ac:chgData name="Jenkins, Tommy L." userId="7720e6fb-7c72-4761-b67b-4ef39ba8a345" providerId="ADAL" clId="{C9F47270-9AE0-43AF-9443-DEE4DF9C1CAF}" dt="2024-12-29T20:08:38.134" v="252" actId="164"/>
          <ac:graphicFrameMkLst>
            <pc:docMk/>
            <pc:sldMk cId="2873051424" sldId="261"/>
            <ac:graphicFrameMk id="99" creationId="{02EDD74B-FE6C-491C-A5BF-E93B2E4F0887}"/>
          </ac:graphicFrameMkLst>
        </pc:graphicFrameChg>
        <pc:graphicFrameChg chg="add mod">
          <ac:chgData name="Jenkins, Tommy L." userId="7720e6fb-7c72-4761-b67b-4ef39ba8a345" providerId="ADAL" clId="{C9F47270-9AE0-43AF-9443-DEE4DF9C1CAF}" dt="2024-12-29T20:08:38.134" v="252" actId="164"/>
          <ac:graphicFrameMkLst>
            <pc:docMk/>
            <pc:sldMk cId="2873051424" sldId="261"/>
            <ac:graphicFrameMk id="100" creationId="{2303FE2D-1FDA-478A-8642-57C6E7ACD216}"/>
          </ac:graphicFrameMkLst>
        </pc:graphicFrameChg>
        <pc:graphicFrameChg chg="add mod">
          <ac:chgData name="Jenkins, Tommy L." userId="7720e6fb-7c72-4761-b67b-4ef39ba8a345" providerId="ADAL" clId="{C9F47270-9AE0-43AF-9443-DEE4DF9C1CAF}" dt="2024-12-29T20:08:38.134" v="252" actId="164"/>
          <ac:graphicFrameMkLst>
            <pc:docMk/>
            <pc:sldMk cId="2873051424" sldId="261"/>
            <ac:graphicFrameMk id="101" creationId="{C77C9557-7BA7-4F41-9E96-20EFFA6536FE}"/>
          </ac:graphicFrameMkLst>
        </pc:graphicFrameChg>
        <pc:graphicFrameChg chg="mod">
          <ac:chgData name="Jenkins, Tommy L." userId="7720e6fb-7c72-4761-b67b-4ef39ba8a345" providerId="ADAL" clId="{C9F47270-9AE0-43AF-9443-DEE4DF9C1CAF}" dt="2024-12-29T20:08:52.871" v="257"/>
          <ac:graphicFrameMkLst>
            <pc:docMk/>
            <pc:sldMk cId="2873051424" sldId="261"/>
            <ac:graphicFrameMk id="145" creationId="{A1A72039-B57C-48D3-ACF0-4700645E85D1}"/>
          </ac:graphicFrameMkLst>
        </pc:graphicFrameChg>
        <pc:graphicFrameChg chg="mod">
          <ac:chgData name="Jenkins, Tommy L." userId="7720e6fb-7c72-4761-b67b-4ef39ba8a345" providerId="ADAL" clId="{C9F47270-9AE0-43AF-9443-DEE4DF9C1CAF}" dt="2024-12-29T20:08:52.871" v="257"/>
          <ac:graphicFrameMkLst>
            <pc:docMk/>
            <pc:sldMk cId="2873051424" sldId="261"/>
            <ac:graphicFrameMk id="146" creationId="{84A3F1B1-A34E-4DCD-850B-DC3D496D69DA}"/>
          </ac:graphicFrameMkLst>
        </pc:graphicFrameChg>
        <pc:graphicFrameChg chg="mod">
          <ac:chgData name="Jenkins, Tommy L." userId="7720e6fb-7c72-4761-b67b-4ef39ba8a345" providerId="ADAL" clId="{C9F47270-9AE0-43AF-9443-DEE4DF9C1CAF}" dt="2024-12-29T20:08:52.871" v="257"/>
          <ac:graphicFrameMkLst>
            <pc:docMk/>
            <pc:sldMk cId="2873051424" sldId="261"/>
            <ac:graphicFrameMk id="150" creationId="{FA10FE5E-AE4F-4682-8B88-DAFA942D8B93}"/>
          </ac:graphicFrameMkLst>
        </pc:graphicFrameChg>
        <pc:graphicFrameChg chg="mod">
          <ac:chgData name="Jenkins, Tommy L." userId="7720e6fb-7c72-4761-b67b-4ef39ba8a345" providerId="ADAL" clId="{C9F47270-9AE0-43AF-9443-DEE4DF9C1CAF}" dt="2024-12-29T20:10:21.708" v="269"/>
          <ac:graphicFrameMkLst>
            <pc:docMk/>
            <pc:sldMk cId="2873051424" sldId="261"/>
            <ac:graphicFrameMk id="192" creationId="{B24268B3-E5AB-4A71-A20A-0A09CF83001E}"/>
          </ac:graphicFrameMkLst>
        </pc:graphicFrameChg>
        <pc:graphicFrameChg chg="mod">
          <ac:chgData name="Jenkins, Tommy L." userId="7720e6fb-7c72-4761-b67b-4ef39ba8a345" providerId="ADAL" clId="{C9F47270-9AE0-43AF-9443-DEE4DF9C1CAF}" dt="2024-12-29T20:10:21.708" v="269"/>
          <ac:graphicFrameMkLst>
            <pc:docMk/>
            <pc:sldMk cId="2873051424" sldId="261"/>
            <ac:graphicFrameMk id="194" creationId="{F247EFA3-0E44-410D-9DE7-07F594918041}"/>
          </ac:graphicFrameMkLst>
        </pc:graphicFrameChg>
        <pc:graphicFrameChg chg="mod">
          <ac:chgData name="Jenkins, Tommy L." userId="7720e6fb-7c72-4761-b67b-4ef39ba8a345" providerId="ADAL" clId="{C9F47270-9AE0-43AF-9443-DEE4DF9C1CAF}" dt="2024-12-29T20:10:21.708" v="269"/>
          <ac:graphicFrameMkLst>
            <pc:docMk/>
            <pc:sldMk cId="2873051424" sldId="261"/>
            <ac:graphicFrameMk id="195" creationId="{4563B8EE-2B99-4BD2-B899-7F1C5C814561}"/>
          </ac:graphicFrameMkLst>
        </pc:graphicFrameChg>
        <pc:cxnChg chg="add del mod">
          <ac:chgData name="Jenkins, Tommy L." userId="7720e6fb-7c72-4761-b67b-4ef39ba8a345" providerId="ADAL" clId="{C9F47270-9AE0-43AF-9443-DEE4DF9C1CAF}" dt="2024-12-29T20:07:07.293" v="180" actId="478"/>
          <ac:cxnSpMkLst>
            <pc:docMk/>
            <pc:sldMk cId="2873051424" sldId="261"/>
            <ac:cxnSpMk id="7" creationId="{D8EB8FF5-BB2F-4386-ACE7-6FD46A4F6328}"/>
          </ac:cxnSpMkLst>
        </pc:cxnChg>
        <pc:cxnChg chg="add del mod">
          <ac:chgData name="Jenkins, Tommy L." userId="7720e6fb-7c72-4761-b67b-4ef39ba8a345" providerId="ADAL" clId="{C9F47270-9AE0-43AF-9443-DEE4DF9C1CAF}" dt="2024-12-29T20:08:00.983" v="242" actId="478"/>
          <ac:cxnSpMkLst>
            <pc:docMk/>
            <pc:sldMk cId="2873051424" sldId="261"/>
            <ac:cxnSpMk id="9" creationId="{506A75E8-E68D-4DE7-B792-626A5687E512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43" creationId="{54EA5ECF-788A-46D5-A712-A901BC633B86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49" creationId="{0ECECF7D-00F6-4218-825E-CEC57CBBE781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52" creationId="{B768FBAC-9791-449A-B3A4-AC87BFEE77C4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53" creationId="{E69AA3C0-3526-48C9-9AA9-BF624E9455FC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55" creationId="{A0260734-F847-4812-8599-CA387F88A1BB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62" creationId="{17F1B9FE-4FD9-4835-93B8-ECC1A10241A8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66" creationId="{6AD00A49-8FC1-4DFC-ADA1-613907598664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71" creationId="{6EBEBE45-893D-4252-8426-E3C3C434C64D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73" creationId="{E83187A5-47C8-40FE-B98A-D369E4BAF20C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74" creationId="{DB0BE5FB-1135-4777-A3B8-254A57D30BDA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76" creationId="{1C3DFA96-B45F-4C59-B98D-DFC9F689A554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77" creationId="{18185986-57C5-4841-A4D6-026704A11325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78" creationId="{CDCAF5A9-E618-4B50-9BAE-B00C12B4FF23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79" creationId="{1024FFC2-EE9D-419D-BB98-518EDC7C92D4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80" creationId="{B93B02E1-E768-4363-AEBC-0141DBC0AA0D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193" creationId="{86770317-1CB5-4999-8004-F99186D6AC06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00" creationId="{BA732214-0867-4787-A5EA-CF4E21780ED6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01" creationId="{9B7F5B8E-2356-4398-BC57-3F254F5F69A3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06" creationId="{1E3C53EE-2E9F-4EDC-ABE1-B1A92363A935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07" creationId="{9EE03F2A-231D-41A7-BD9D-EFFAE75A68E0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08" creationId="{88AFC272-D5C9-48A9-BF33-65D29EA3310F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09" creationId="{975B35CF-3748-4AA8-B3B2-E88F7A1D9CAD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10" creationId="{2A04B2CE-EA52-4E2B-9595-EA38E96C432B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11" creationId="{C8834D01-E48E-479A-9AB8-5B6A170BE67F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13" creationId="{60B2D811-4543-4B7F-B9D8-E2F0D6801C65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14" creationId="{13E97D18-8B27-4FED-A395-69E967F769DF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15" creationId="{3530104D-88C3-4CA9-8BFA-935F4E4C2A81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17" creationId="{BF731AEE-4D31-4344-8E54-88C87DE7B6A2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18" creationId="{D5D426F2-7005-4C88-AC8B-C0FEE0146A4B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19" creationId="{21D531ED-82CC-4409-A784-CA361B9C9E4C}"/>
          </ac:cxnSpMkLst>
        </pc:cxnChg>
        <pc:cxnChg chg="add del">
          <ac:chgData name="Jenkins, Tommy L." userId="7720e6fb-7c72-4761-b67b-4ef39ba8a345" providerId="ADAL" clId="{C9F47270-9AE0-43AF-9443-DEE4DF9C1CAF}" dt="2024-12-29T19:49:20.913" v="5" actId="478"/>
          <ac:cxnSpMkLst>
            <pc:docMk/>
            <pc:sldMk cId="2873051424" sldId="261"/>
            <ac:cxnSpMk id="220" creationId="{1AC9AC85-53BE-493C-BDBE-0BAD547AD9E4}"/>
          </ac:cxnSpMkLst>
        </pc:cxnChg>
      </pc:sldChg>
      <pc:sldMasterChg chg="modSp modSldLayout">
        <pc:chgData name="Jenkins, Tommy L." userId="7720e6fb-7c72-4761-b67b-4ef39ba8a345" providerId="ADAL" clId="{C9F47270-9AE0-43AF-9443-DEE4DF9C1CAF}" dt="2024-12-29T20:09:23.160" v="263"/>
        <pc:sldMasterMkLst>
          <pc:docMk/>
          <pc:sldMasterMk cId="2914257068" sldId="2147483660"/>
        </pc:sldMasterMkLst>
        <pc:spChg chg="mod">
          <ac:chgData name="Jenkins, Tommy L." userId="7720e6fb-7c72-4761-b67b-4ef39ba8a345" providerId="ADAL" clId="{C9F47270-9AE0-43AF-9443-DEE4DF9C1CAF}" dt="2024-12-29T20:09:23.160" v="263"/>
          <ac:spMkLst>
            <pc:docMk/>
            <pc:sldMasterMk cId="2914257068" sldId="2147483660"/>
            <ac:spMk id="2" creationId="{00000000-0000-0000-0000-000000000000}"/>
          </ac:spMkLst>
        </pc:spChg>
        <pc:spChg chg="mod">
          <ac:chgData name="Jenkins, Tommy L." userId="7720e6fb-7c72-4761-b67b-4ef39ba8a345" providerId="ADAL" clId="{C9F47270-9AE0-43AF-9443-DEE4DF9C1CAF}" dt="2024-12-29T20:09:23.160" v="263"/>
          <ac:spMkLst>
            <pc:docMk/>
            <pc:sldMasterMk cId="2914257068" sldId="2147483660"/>
            <ac:spMk id="3" creationId="{00000000-0000-0000-0000-000000000000}"/>
          </ac:spMkLst>
        </pc:spChg>
        <pc:spChg chg="mod">
          <ac:chgData name="Jenkins, Tommy L." userId="7720e6fb-7c72-4761-b67b-4ef39ba8a345" providerId="ADAL" clId="{C9F47270-9AE0-43AF-9443-DEE4DF9C1CAF}" dt="2024-12-29T20:09:23.160" v="263"/>
          <ac:spMkLst>
            <pc:docMk/>
            <pc:sldMasterMk cId="2914257068" sldId="2147483660"/>
            <ac:spMk id="4" creationId="{00000000-0000-0000-0000-000000000000}"/>
          </ac:spMkLst>
        </pc:spChg>
        <pc:spChg chg="mod">
          <ac:chgData name="Jenkins, Tommy L." userId="7720e6fb-7c72-4761-b67b-4ef39ba8a345" providerId="ADAL" clId="{C9F47270-9AE0-43AF-9443-DEE4DF9C1CAF}" dt="2024-12-29T20:09:23.160" v="263"/>
          <ac:spMkLst>
            <pc:docMk/>
            <pc:sldMasterMk cId="2914257068" sldId="2147483660"/>
            <ac:spMk id="5" creationId="{00000000-0000-0000-0000-000000000000}"/>
          </ac:spMkLst>
        </pc:spChg>
        <pc:spChg chg="mod">
          <ac:chgData name="Jenkins, Tommy L." userId="7720e6fb-7c72-4761-b67b-4ef39ba8a345" providerId="ADAL" clId="{C9F47270-9AE0-43AF-9443-DEE4DF9C1CAF}" dt="2024-12-29T20:09:23.160" v="263"/>
          <ac:spMkLst>
            <pc:docMk/>
            <pc:sldMasterMk cId="2914257068" sldId="2147483660"/>
            <ac:spMk id="6" creationId="{00000000-0000-0000-0000-000000000000}"/>
          </ac:spMkLst>
        </pc:spChg>
        <pc:sldLayoutChg chg="modSp">
          <pc:chgData name="Jenkins, Tommy L." userId="7720e6fb-7c72-4761-b67b-4ef39ba8a345" providerId="ADAL" clId="{C9F47270-9AE0-43AF-9443-DEE4DF9C1CAF}" dt="2024-12-29T20:09:23.160" v="263"/>
          <pc:sldLayoutMkLst>
            <pc:docMk/>
            <pc:sldMasterMk cId="2914257068" sldId="2147483660"/>
            <pc:sldLayoutMk cId="3004506183" sldId="2147483661"/>
          </pc:sldLayoutMkLst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3004506183" sldId="2147483661"/>
              <ac:spMk id="2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3004506183" sldId="2147483661"/>
              <ac:spMk id="3" creationId="{00000000-0000-0000-0000-000000000000}"/>
            </ac:spMkLst>
          </pc:spChg>
        </pc:sldLayoutChg>
        <pc:sldLayoutChg chg="modSp">
          <pc:chgData name="Jenkins, Tommy L." userId="7720e6fb-7c72-4761-b67b-4ef39ba8a345" providerId="ADAL" clId="{C9F47270-9AE0-43AF-9443-DEE4DF9C1CAF}" dt="2024-12-29T20:09:23.160" v="263"/>
          <pc:sldLayoutMkLst>
            <pc:docMk/>
            <pc:sldMasterMk cId="2914257068" sldId="2147483660"/>
            <pc:sldLayoutMk cId="2103381982" sldId="2147483663"/>
          </pc:sldLayoutMkLst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2103381982" sldId="2147483663"/>
              <ac:spMk id="2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2103381982" sldId="2147483663"/>
              <ac:spMk id="3" creationId="{00000000-0000-0000-0000-000000000000}"/>
            </ac:spMkLst>
          </pc:spChg>
        </pc:sldLayoutChg>
        <pc:sldLayoutChg chg="modSp">
          <pc:chgData name="Jenkins, Tommy L." userId="7720e6fb-7c72-4761-b67b-4ef39ba8a345" providerId="ADAL" clId="{C9F47270-9AE0-43AF-9443-DEE4DF9C1CAF}" dt="2024-12-29T20:09:23.160" v="263"/>
          <pc:sldLayoutMkLst>
            <pc:docMk/>
            <pc:sldMasterMk cId="2914257068" sldId="2147483660"/>
            <pc:sldLayoutMk cId="1814214734" sldId="2147483664"/>
          </pc:sldLayoutMkLst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1814214734" sldId="2147483664"/>
              <ac:spMk id="3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1814214734" sldId="2147483664"/>
              <ac:spMk id="4" creationId="{00000000-0000-0000-0000-000000000000}"/>
            </ac:spMkLst>
          </pc:spChg>
        </pc:sldLayoutChg>
        <pc:sldLayoutChg chg="modSp">
          <pc:chgData name="Jenkins, Tommy L." userId="7720e6fb-7c72-4761-b67b-4ef39ba8a345" providerId="ADAL" clId="{C9F47270-9AE0-43AF-9443-DEE4DF9C1CAF}" dt="2024-12-29T20:09:23.160" v="263"/>
          <pc:sldLayoutMkLst>
            <pc:docMk/>
            <pc:sldMasterMk cId="2914257068" sldId="2147483660"/>
            <pc:sldLayoutMk cId="191272470" sldId="2147483665"/>
          </pc:sldLayoutMkLst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191272470" sldId="2147483665"/>
              <ac:spMk id="2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191272470" sldId="2147483665"/>
              <ac:spMk id="3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191272470" sldId="2147483665"/>
              <ac:spMk id="4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191272470" sldId="2147483665"/>
              <ac:spMk id="5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191272470" sldId="2147483665"/>
              <ac:spMk id="6" creationId="{00000000-0000-0000-0000-000000000000}"/>
            </ac:spMkLst>
          </pc:spChg>
        </pc:sldLayoutChg>
        <pc:sldLayoutChg chg="modSp">
          <pc:chgData name="Jenkins, Tommy L." userId="7720e6fb-7c72-4761-b67b-4ef39ba8a345" providerId="ADAL" clId="{C9F47270-9AE0-43AF-9443-DEE4DF9C1CAF}" dt="2024-12-29T20:09:23.160" v="263"/>
          <pc:sldLayoutMkLst>
            <pc:docMk/>
            <pc:sldMasterMk cId="2914257068" sldId="2147483660"/>
            <pc:sldLayoutMk cId="363976100" sldId="2147483668"/>
          </pc:sldLayoutMkLst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363976100" sldId="2147483668"/>
              <ac:spMk id="2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363976100" sldId="2147483668"/>
              <ac:spMk id="3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363976100" sldId="2147483668"/>
              <ac:spMk id="4" creationId="{00000000-0000-0000-0000-000000000000}"/>
            </ac:spMkLst>
          </pc:spChg>
        </pc:sldLayoutChg>
        <pc:sldLayoutChg chg="modSp">
          <pc:chgData name="Jenkins, Tommy L." userId="7720e6fb-7c72-4761-b67b-4ef39ba8a345" providerId="ADAL" clId="{C9F47270-9AE0-43AF-9443-DEE4DF9C1CAF}" dt="2024-12-29T20:09:23.160" v="263"/>
          <pc:sldLayoutMkLst>
            <pc:docMk/>
            <pc:sldMasterMk cId="2914257068" sldId="2147483660"/>
            <pc:sldLayoutMk cId="3984684516" sldId="2147483669"/>
          </pc:sldLayoutMkLst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3984684516" sldId="2147483669"/>
              <ac:spMk id="2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3984684516" sldId="2147483669"/>
              <ac:spMk id="3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3984684516" sldId="2147483669"/>
              <ac:spMk id="4" creationId="{00000000-0000-0000-0000-000000000000}"/>
            </ac:spMkLst>
          </pc:spChg>
        </pc:sldLayoutChg>
        <pc:sldLayoutChg chg="modSp">
          <pc:chgData name="Jenkins, Tommy L." userId="7720e6fb-7c72-4761-b67b-4ef39ba8a345" providerId="ADAL" clId="{C9F47270-9AE0-43AF-9443-DEE4DF9C1CAF}" dt="2024-12-29T20:09:23.160" v="263"/>
          <pc:sldLayoutMkLst>
            <pc:docMk/>
            <pc:sldMasterMk cId="2914257068" sldId="2147483660"/>
            <pc:sldLayoutMk cId="3399254985" sldId="2147483671"/>
          </pc:sldLayoutMkLst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3399254985" sldId="2147483671"/>
              <ac:spMk id="2" creationId="{00000000-0000-0000-0000-000000000000}"/>
            </ac:spMkLst>
          </pc:spChg>
          <pc:spChg chg="mod">
            <ac:chgData name="Jenkins, Tommy L." userId="7720e6fb-7c72-4761-b67b-4ef39ba8a345" providerId="ADAL" clId="{C9F47270-9AE0-43AF-9443-DEE4DF9C1CAF}" dt="2024-12-29T20:09:23.160" v="263"/>
            <ac:spMkLst>
              <pc:docMk/>
              <pc:sldMasterMk cId="2914257068" sldId="2147483660"/>
              <pc:sldLayoutMk cId="3399254985" sldId="2147483671"/>
              <ac:spMk id="3" creationId="{00000000-0000-0000-0000-000000000000}"/>
            </ac:spMkLst>
          </pc:spChg>
        </pc:sldLayoutChg>
      </pc:sldMaster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444499125109362"/>
          <c:y val="5.7703022049981116E-2"/>
          <c:w val="0.76045111548556432"/>
          <c:h val="0.7453702564755631"/>
        </c:manualLayout>
      </c:layout>
      <c:scatterChart>
        <c:scatterStyle val="lineMarker"/>
        <c:varyColors val="0"/>
        <c:ser>
          <c:idx val="0"/>
          <c:order val="0"/>
          <c:tx>
            <c:v>PLA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d28 S'!$A$7:$A$277</c:f>
              <c:numCache>
                <c:formatCode>General</c:formatCode>
                <c:ptCount val="271"/>
                <c:pt idx="0">
                  <c:v>1</c:v>
                </c:pt>
                <c:pt idx="1">
                  <c:v>1.0019155073930994</c:v>
                </c:pt>
                <c:pt idx="2">
                  <c:v>1.0019155073930994</c:v>
                </c:pt>
                <c:pt idx="3">
                  <c:v>1.0019155073930994</c:v>
                </c:pt>
                <c:pt idx="4">
                  <c:v>1.0001964333109483</c:v>
                </c:pt>
                <c:pt idx="5">
                  <c:v>1.0000542338013212</c:v>
                </c:pt>
                <c:pt idx="6">
                  <c:v>1.0019155073930994</c:v>
                </c:pt>
                <c:pt idx="7">
                  <c:v>1.0019155073930994</c:v>
                </c:pt>
                <c:pt idx="8">
                  <c:v>1.0019155073930994</c:v>
                </c:pt>
                <c:pt idx="9">
                  <c:v>1.0019155073930994</c:v>
                </c:pt>
                <c:pt idx="10">
                  <c:v>1.0019155073930994</c:v>
                </c:pt>
                <c:pt idx="11">
                  <c:v>1.0001241929170614</c:v>
                </c:pt>
                <c:pt idx="12">
                  <c:v>0.99832441238452196</c:v>
                </c:pt>
                <c:pt idx="13">
                  <c:v>0.99832441238452196</c:v>
                </c:pt>
                <c:pt idx="14">
                  <c:v>1.0001503866553054</c:v>
                </c:pt>
                <c:pt idx="15">
                  <c:v>1.0019155073930994</c:v>
                </c:pt>
                <c:pt idx="16">
                  <c:v>1.0037621844237157</c:v>
                </c:pt>
                <c:pt idx="17">
                  <c:v>1.0036503262886085</c:v>
                </c:pt>
                <c:pt idx="18">
                  <c:v>1.0000486530402726</c:v>
                </c:pt>
                <c:pt idx="19">
                  <c:v>1.0001996858716522</c:v>
                </c:pt>
                <c:pt idx="20">
                  <c:v>1.0000253990987535</c:v>
                </c:pt>
                <c:pt idx="21">
                  <c:v>1.0002246468812168</c:v>
                </c:pt>
                <c:pt idx="22">
                  <c:v>1.0000066940766601</c:v>
                </c:pt>
                <c:pt idx="23">
                  <c:v>1.000235259737192</c:v>
                </c:pt>
                <c:pt idx="24">
                  <c:v>0.99999241850294052</c:v>
                </c:pt>
                <c:pt idx="25">
                  <c:v>1.002214823469086</c:v>
                </c:pt>
                <c:pt idx="26">
                  <c:v>1.0055066024016768</c:v>
                </c:pt>
                <c:pt idx="27">
                  <c:v>1.0055066024016768</c:v>
                </c:pt>
                <c:pt idx="28">
                  <c:v>1.0035499936200434</c:v>
                </c:pt>
                <c:pt idx="29">
                  <c:v>1.0019155073930994</c:v>
                </c:pt>
                <c:pt idx="30">
                  <c:v>1.0059118556274207</c:v>
                </c:pt>
                <c:pt idx="31">
                  <c:v>1.0070896311486908</c:v>
                </c:pt>
                <c:pt idx="32">
                  <c:v>1.0014694171972836</c:v>
                </c:pt>
                <c:pt idx="33">
                  <c:v>1.0003468475551962</c:v>
                </c:pt>
                <c:pt idx="34">
                  <c:v>1.005982924136968</c:v>
                </c:pt>
                <c:pt idx="35">
                  <c:v>1.0049994800637823</c:v>
                </c:pt>
                <c:pt idx="36">
                  <c:v>1.0019155073930994</c:v>
                </c:pt>
                <c:pt idx="37">
                  <c:v>1.0019155073930994</c:v>
                </c:pt>
                <c:pt idx="38">
                  <c:v>1.0039862968745519</c:v>
                </c:pt>
                <c:pt idx="39">
                  <c:v>1.0055066024016768</c:v>
                </c:pt>
                <c:pt idx="40">
                  <c:v>1.0055066024016768</c:v>
                </c:pt>
                <c:pt idx="41">
                  <c:v>1.0033935667627372</c:v>
                </c:pt>
                <c:pt idx="42">
                  <c:v>1.0019155073930994</c:v>
                </c:pt>
                <c:pt idx="43">
                  <c:v>1.0061511085485602</c:v>
                </c:pt>
                <c:pt idx="44">
                  <c:v>1.0090976974102543</c:v>
                </c:pt>
                <c:pt idx="45">
                  <c:v>1.0090976974102543</c:v>
                </c:pt>
                <c:pt idx="46">
                  <c:v>1.0069314533805076</c:v>
                </c:pt>
                <c:pt idx="47">
                  <c:v>1.0055066024016768</c:v>
                </c:pt>
                <c:pt idx="48">
                  <c:v>1.0076879089099584</c:v>
                </c:pt>
                <c:pt idx="49">
                  <c:v>1.0090976974102543</c:v>
                </c:pt>
                <c:pt idx="50">
                  <c:v>1.0090976974102543</c:v>
                </c:pt>
                <c:pt idx="51">
                  <c:v>1.0090976974102543</c:v>
                </c:pt>
                <c:pt idx="52">
                  <c:v>1.0090976974102543</c:v>
                </c:pt>
                <c:pt idx="53">
                  <c:v>1.0068624896132172</c:v>
                </c:pt>
                <c:pt idx="54">
                  <c:v>1.0100014615052386</c:v>
                </c:pt>
                <c:pt idx="55">
                  <c:v>1.0104269891194437</c:v>
                </c:pt>
                <c:pt idx="56">
                  <c:v>1.0113692923573807</c:v>
                </c:pt>
                <c:pt idx="57">
                  <c:v>1.0126887924188317</c:v>
                </c:pt>
                <c:pt idx="58">
                  <c:v>1.0103990636287772</c:v>
                </c:pt>
                <c:pt idx="59">
                  <c:v>1.0090976974102543</c:v>
                </c:pt>
                <c:pt idx="60">
                  <c:v>1.0114113312475892</c:v>
                </c:pt>
                <c:pt idx="61">
                  <c:v>1.0103709273167922</c:v>
                </c:pt>
                <c:pt idx="62">
                  <c:v>1.0137624061433517</c:v>
                </c:pt>
                <c:pt idx="63">
                  <c:v>1.0139333742827994</c:v>
                </c:pt>
                <c:pt idx="64">
                  <c:v>1.0126887924188317</c:v>
                </c:pt>
                <c:pt idx="65">
                  <c:v>1.0079534090681439</c:v>
                </c:pt>
                <c:pt idx="66">
                  <c:v>1.0102627870192689</c:v>
                </c:pt>
                <c:pt idx="67">
                  <c:v>1.0126887924188317</c:v>
                </c:pt>
                <c:pt idx="68">
                  <c:v>1.0126887924188317</c:v>
                </c:pt>
                <c:pt idx="69">
                  <c:v>1.0102771813121521</c:v>
                </c:pt>
                <c:pt idx="70">
                  <c:v>1.0163609860758098</c:v>
                </c:pt>
                <c:pt idx="71">
                  <c:v>1.0150024244688083</c:v>
                </c:pt>
                <c:pt idx="72">
                  <c:v>1.0175765138601127</c:v>
                </c:pt>
                <c:pt idx="73">
                  <c:v>1.0174182900641167</c:v>
                </c:pt>
                <c:pt idx="74">
                  <c:v>1.0187441162933339</c:v>
                </c:pt>
                <c:pt idx="75">
                  <c:v>1.0173987552602695</c:v>
                </c:pt>
                <c:pt idx="76">
                  <c:v>1.0187656018828131</c:v>
                </c:pt>
                <c:pt idx="77">
                  <c:v>1.0173785434974447</c:v>
                </c:pt>
                <c:pt idx="78">
                  <c:v>1.016279887427409</c:v>
                </c:pt>
                <c:pt idx="79">
                  <c:v>1.0187954811259783</c:v>
                </c:pt>
                <c:pt idx="80">
                  <c:v>1.0198709824359864</c:v>
                </c:pt>
                <c:pt idx="81">
                  <c:v>1.0147938251050141</c:v>
                </c:pt>
                <c:pt idx="82">
                  <c:v>1.0126887924188317</c:v>
                </c:pt>
                <c:pt idx="83">
                  <c:v>1.0177842706724582</c:v>
                </c:pt>
                <c:pt idx="84">
                  <c:v>1.0198709824359864</c:v>
                </c:pt>
                <c:pt idx="85">
                  <c:v>1.0172880413085037</c:v>
                </c:pt>
                <c:pt idx="86">
                  <c:v>1.0188749907728187</c:v>
                </c:pt>
                <c:pt idx="87">
                  <c:v>1.0224728632535187</c:v>
                </c:pt>
                <c:pt idx="88">
                  <c:v>1.023462077444564</c:v>
                </c:pt>
                <c:pt idx="89">
                  <c:v>1.023462077444564</c:v>
                </c:pt>
                <c:pt idx="90">
                  <c:v>1.0208273388049569</c:v>
                </c:pt>
                <c:pt idx="91">
                  <c:v>1.0172241849340067</c:v>
                </c:pt>
                <c:pt idx="92">
                  <c:v>1.0189361769774936</c:v>
                </c:pt>
                <c:pt idx="93">
                  <c:v>1.0252070666678814</c:v>
                </c:pt>
                <c:pt idx="94">
                  <c:v>1.0190325286031561</c:v>
                </c:pt>
                <c:pt idx="95">
                  <c:v>1.021635596418867</c:v>
                </c:pt>
                <c:pt idx="96">
                  <c:v>1.0261572342874061</c:v>
                </c:pt>
                <c:pt idx="97">
                  <c:v>1.0243432541951061</c:v>
                </c:pt>
                <c:pt idx="98">
                  <c:v>1.0207416886355172</c:v>
                </c:pt>
                <c:pt idx="99">
                  <c:v>1.0225987204869449</c:v>
                </c:pt>
                <c:pt idx="100">
                  <c:v>1.0316715595893784</c:v>
                </c:pt>
                <c:pt idx="101">
                  <c:v>1.0287399007712377</c:v>
                </c:pt>
                <c:pt idx="102">
                  <c:v>1.0242918490332382</c:v>
                </c:pt>
                <c:pt idx="103">
                  <c:v>1.020690919648841</c:v>
                </c:pt>
                <c:pt idx="104">
                  <c:v>1.0254373586059173</c:v>
                </c:pt>
                <c:pt idx="105">
                  <c:v>1.0298491381326562</c:v>
                </c:pt>
                <c:pt idx="106">
                  <c:v>1.0278408048498668</c:v>
                </c:pt>
                <c:pt idx="107">
                  <c:v>1.0270531724531413</c:v>
                </c:pt>
                <c:pt idx="108">
                  <c:v>1.0298791242324241</c:v>
                </c:pt>
                <c:pt idx="109">
                  <c:v>1.0334775499748314</c:v>
                </c:pt>
                <c:pt idx="110">
                  <c:v>1.0285414206001249</c:v>
                </c:pt>
                <c:pt idx="111">
                  <c:v>1.0299101428912054</c:v>
                </c:pt>
                <c:pt idx="112">
                  <c:v>1.0277840494186559</c:v>
                </c:pt>
                <c:pt idx="113">
                  <c:v>1.0328101889440138</c:v>
                </c:pt>
                <c:pt idx="114">
                  <c:v>1.031360530576829</c:v>
                </c:pt>
                <c:pt idx="115">
                  <c:v>1.0306442674617187</c:v>
                </c:pt>
                <c:pt idx="116">
                  <c:v>1.0306442674617187</c:v>
                </c:pt>
                <c:pt idx="117">
                  <c:v>1.033556431996012</c:v>
                </c:pt>
                <c:pt idx="118">
                  <c:v>1.0313052925895976</c:v>
                </c:pt>
                <c:pt idx="119">
                  <c:v>1.0306442674617187</c:v>
                </c:pt>
                <c:pt idx="120">
                  <c:v>1.0276991219858591</c:v>
                </c:pt>
                <c:pt idx="121">
                  <c:v>1.0329803611090989</c:v>
                </c:pt>
                <c:pt idx="122">
                  <c:v>1.034235362470296</c:v>
                </c:pt>
                <c:pt idx="123">
                  <c:v>1.034235362470296</c:v>
                </c:pt>
                <c:pt idx="124">
                  <c:v>1.0312804865499827</c:v>
                </c:pt>
                <c:pt idx="125">
                  <c:v>1.0336206056055706</c:v>
                </c:pt>
                <c:pt idx="126">
                  <c:v>1.034235362470296</c:v>
                </c:pt>
                <c:pt idx="127">
                  <c:v>1.034235362470296</c:v>
                </c:pt>
                <c:pt idx="128">
                  <c:v>1.034235362470296</c:v>
                </c:pt>
                <c:pt idx="129">
                  <c:v>1.0401823004575557</c:v>
                </c:pt>
                <c:pt idx="130">
                  <c:v>1.0383935258876202</c:v>
                </c:pt>
                <c:pt idx="131">
                  <c:v>1.0347829548800838</c:v>
                </c:pt>
                <c:pt idx="132">
                  <c:v>1.0372906904512973</c:v>
                </c:pt>
                <c:pt idx="133">
                  <c:v>1.0439574281787714</c:v>
                </c:pt>
                <c:pt idx="134">
                  <c:v>1.0419341236146353</c:v>
                </c:pt>
                <c:pt idx="135">
                  <c:v>1.0351986853121684</c:v>
                </c:pt>
                <c:pt idx="136">
                  <c:v>1.0373577309043038</c:v>
                </c:pt>
                <c:pt idx="137">
                  <c:v>1.0409616577321592</c:v>
                </c:pt>
                <c:pt idx="138">
                  <c:v>1.0414175524874509</c:v>
                </c:pt>
                <c:pt idx="139">
                  <c:v>1.0319633708184142</c:v>
                </c:pt>
                <c:pt idx="140">
                  <c:v>1.0401388648550074</c:v>
                </c:pt>
                <c:pt idx="141">
                  <c:v>1.0445924851634023</c:v>
                </c:pt>
                <c:pt idx="142">
                  <c:v>1.0386325418551958</c:v>
                </c:pt>
                <c:pt idx="143">
                  <c:v>1.034629773356458</c:v>
                </c:pt>
                <c:pt idx="144">
                  <c:v>1.040647310313723</c:v>
                </c:pt>
                <c:pt idx="145">
                  <c:v>1.0414175524874509</c:v>
                </c:pt>
                <c:pt idx="146">
                  <c:v>1.0414175524874509</c:v>
                </c:pt>
                <c:pt idx="147">
                  <c:v>1.0446602410178811</c:v>
                </c:pt>
                <c:pt idx="148">
                  <c:v>1.0417586909003953</c:v>
                </c:pt>
                <c:pt idx="149">
                  <c:v>1.0446737651959066</c:v>
                </c:pt>
                <c:pt idx="150">
                  <c:v>1.0482812176901755</c:v>
                </c:pt>
                <c:pt idx="151">
                  <c:v>1.0485997425046056</c:v>
                </c:pt>
                <c:pt idx="152">
                  <c:v>1.0485997425046056</c:v>
                </c:pt>
                <c:pt idx="153">
                  <c:v>1.0485997425046056</c:v>
                </c:pt>
                <c:pt idx="154">
                  <c:v>1.0452919830843661</c:v>
                </c:pt>
                <c:pt idx="155">
                  <c:v>1.0516574068952786</c:v>
                </c:pt>
                <c:pt idx="156">
                  <c:v>1.045513901265718</c:v>
                </c:pt>
                <c:pt idx="157">
                  <c:v>1.0516973819413986</c:v>
                </c:pt>
                <c:pt idx="158">
                  <c:v>1.0555504256074058</c:v>
                </c:pt>
                <c:pt idx="159">
                  <c:v>1.0490517895281197</c:v>
                </c:pt>
                <c:pt idx="160">
                  <c:v>1.0519756582572426</c:v>
                </c:pt>
                <c:pt idx="161">
                  <c:v>1.0547683962229544</c:v>
                </c:pt>
                <c:pt idx="162">
                  <c:v>1.0575611341886662</c:v>
                </c:pt>
                <c:pt idx="163">
                  <c:v>1.0645776127806263</c:v>
                </c:pt>
                <c:pt idx="164">
                  <c:v>1.0580878088346424</c:v>
                </c:pt>
                <c:pt idx="165">
                  <c:v>1.0646188416962996</c:v>
                </c:pt>
                <c:pt idx="166">
                  <c:v>1.0718243009184312</c:v>
                </c:pt>
                <c:pt idx="167">
                  <c:v>1.0721182403864311</c:v>
                </c:pt>
                <c:pt idx="168">
                  <c:v>1.0686613296170302</c:v>
                </c:pt>
                <c:pt idx="169">
                  <c:v>1.078952042145185</c:v>
                </c:pt>
                <c:pt idx="170">
                  <c:v>1.0758134500874676</c:v>
                </c:pt>
                <c:pt idx="171">
                  <c:v>1.0792068823201428</c:v>
                </c:pt>
                <c:pt idx="172">
                  <c:v>1.0757930562261586</c:v>
                </c:pt>
                <c:pt idx="173">
                  <c:v>1.0721910953853879</c:v>
                </c:pt>
                <c:pt idx="174">
                  <c:v>1.0897638954347197</c:v>
                </c:pt>
                <c:pt idx="175">
                  <c:v>1.0900737154293183</c:v>
                </c:pt>
                <c:pt idx="176">
                  <c:v>1.0936214267662336</c:v>
                </c:pt>
                <c:pt idx="177">
                  <c:v>1.0936648104378954</c:v>
                </c:pt>
                <c:pt idx="178">
                  <c:v>1.1008040895051823</c:v>
                </c:pt>
                <c:pt idx="179">
                  <c:v>1.1008470004550504</c:v>
                </c:pt>
                <c:pt idx="180">
                  <c:v>1.0936672905845113</c:v>
                </c:pt>
                <c:pt idx="181">
                  <c:v>1.0972660468105826</c:v>
                </c:pt>
                <c:pt idx="182">
                  <c:v>1.1008470004550504</c:v>
                </c:pt>
                <c:pt idx="183">
                  <c:v>1.1008470004550504</c:v>
                </c:pt>
                <c:pt idx="184">
                  <c:v>1.1008907671497539</c:v>
                </c:pt>
                <c:pt idx="185">
                  <c:v>1.1044380954636279</c:v>
                </c:pt>
                <c:pt idx="186">
                  <c:v>1.1045030450696822</c:v>
                </c:pt>
                <c:pt idx="187">
                  <c:v>1.1080291904722053</c:v>
                </c:pt>
                <c:pt idx="188">
                  <c:v>1.1081165936022375</c:v>
                </c:pt>
                <c:pt idx="189">
                  <c:v>1.1116202854807826</c:v>
                </c:pt>
                <c:pt idx="190">
                  <c:v>1.1116202854807826</c:v>
                </c:pt>
                <c:pt idx="191">
                  <c:v>1.1116202854807826</c:v>
                </c:pt>
                <c:pt idx="192">
                  <c:v>1.1116202854807826</c:v>
                </c:pt>
                <c:pt idx="193">
                  <c:v>1.1117607312825744</c:v>
                </c:pt>
                <c:pt idx="194">
                  <c:v>1.11521138048936</c:v>
                </c:pt>
                <c:pt idx="195">
                  <c:v>1.11521138048936</c:v>
                </c:pt>
                <c:pt idx="196">
                  <c:v>1.11521138048936</c:v>
                </c:pt>
                <c:pt idx="197">
                  <c:v>1.1153915975521957</c:v>
                </c:pt>
                <c:pt idx="198">
                  <c:v>1.1188024754979375</c:v>
                </c:pt>
                <c:pt idx="199">
                  <c:v>1.119005528515151</c:v>
                </c:pt>
                <c:pt idx="200">
                  <c:v>1.1221806343211078</c:v>
                </c:pt>
                <c:pt idx="201">
                  <c:v>1.1185790834551104</c:v>
                </c:pt>
                <c:pt idx="202">
                  <c:v>1.1154372309990528</c:v>
                </c:pt>
                <c:pt idx="203">
                  <c:v>1.1188024754979375</c:v>
                </c:pt>
                <c:pt idx="204">
                  <c:v>1.1188024754979375</c:v>
                </c:pt>
                <c:pt idx="205">
                  <c:v>1.1188024754979375</c:v>
                </c:pt>
                <c:pt idx="206">
                  <c:v>1.1190788509383067</c:v>
                </c:pt>
                <c:pt idx="207">
                  <c:v>1.1223935705065149</c:v>
                </c:pt>
                <c:pt idx="208">
                  <c:v>1.1223935705065149</c:v>
                </c:pt>
                <c:pt idx="209">
                  <c:v>1.1223935705065149</c:v>
                </c:pt>
                <c:pt idx="210">
                  <c:v>1.1223935705065149</c:v>
                </c:pt>
                <c:pt idx="211">
                  <c:v>1.1223935705065149</c:v>
                </c:pt>
                <c:pt idx="212">
                  <c:v>1.1223935705065149</c:v>
                </c:pt>
                <c:pt idx="213">
                  <c:v>1.1223935705065149</c:v>
                </c:pt>
                <c:pt idx="214">
                  <c:v>1.1227555319113487</c:v>
                </c:pt>
                <c:pt idx="215">
                  <c:v>1.1263552925820584</c:v>
                </c:pt>
                <c:pt idx="216">
                  <c:v>1.1291971094702833</c:v>
                </c:pt>
                <c:pt idx="217">
                  <c:v>1.1255873494489876</c:v>
                </c:pt>
                <c:pt idx="218">
                  <c:v>1.1235975368898308</c:v>
                </c:pt>
                <c:pt idx="219">
                  <c:v>1.1327606279931177</c:v>
                </c:pt>
                <c:pt idx="220">
                  <c:v>1.1295757605236696</c:v>
                </c:pt>
                <c:pt idx="221">
                  <c:v>1.1291422172963976</c:v>
                </c:pt>
                <c:pt idx="222">
                  <c:v>1.1264324714464107</c:v>
                </c:pt>
                <c:pt idx="223">
                  <c:v>1.1304814708986852</c:v>
                </c:pt>
              </c:numCache>
            </c:numRef>
          </c:xVal>
          <c:yVal>
            <c:numRef>
              <c:f>'d28 S'!$B$7:$B$277</c:f>
              <c:numCache>
                <c:formatCode>General</c:formatCode>
                <c:ptCount val="271"/>
                <c:pt idx="0">
                  <c:v>0</c:v>
                </c:pt>
                <c:pt idx="1">
                  <c:v>2.7915346436202422E-3</c:v>
                </c:pt>
                <c:pt idx="2">
                  <c:v>3.5376859490166964E-3</c:v>
                </c:pt>
                <c:pt idx="3">
                  <c:v>5.2323561359309692E-3</c:v>
                </c:pt>
                <c:pt idx="4">
                  <c:v>3.098408959693091E-3</c:v>
                </c:pt>
                <c:pt idx="5">
                  <c:v>2.1002932705662426E-3</c:v>
                </c:pt>
                <c:pt idx="6">
                  <c:v>-9.0468039905483122E-4</c:v>
                </c:pt>
                <c:pt idx="7">
                  <c:v>2.9013541555314238E-3</c:v>
                </c:pt>
                <c:pt idx="8">
                  <c:v>4.3502599565368779E-3</c:v>
                </c:pt>
                <c:pt idx="9">
                  <c:v>3.037742466073151E-3</c:v>
                </c:pt>
                <c:pt idx="10">
                  <c:v>5.5193036766440599E-3</c:v>
                </c:pt>
                <c:pt idx="11">
                  <c:v>1.4174655503170059E-3</c:v>
                </c:pt>
                <c:pt idx="12">
                  <c:v>6.4089283996233331E-3</c:v>
                </c:pt>
                <c:pt idx="13">
                  <c:v>2.3026619050087269E-3</c:v>
                </c:pt>
                <c:pt idx="14">
                  <c:v>5.0844543500605755E-3</c:v>
                </c:pt>
                <c:pt idx="15">
                  <c:v>1.059224455137597E-2</c:v>
                </c:pt>
                <c:pt idx="16">
                  <c:v>5.5684570477089997E-3</c:v>
                </c:pt>
                <c:pt idx="17">
                  <c:v>3.7838934186958783E-3</c:v>
                </c:pt>
                <c:pt idx="18">
                  <c:v>5.9045565483922414E-3</c:v>
                </c:pt>
                <c:pt idx="19">
                  <c:v>6.8362488298479391E-3</c:v>
                </c:pt>
                <c:pt idx="20">
                  <c:v>3.4043971082252118E-3</c:v>
                </c:pt>
                <c:pt idx="21">
                  <c:v>7.007620650146029E-3</c:v>
                </c:pt>
                <c:pt idx="22">
                  <c:v>5.5272742456784849E-3</c:v>
                </c:pt>
                <c:pt idx="23">
                  <c:v>7.3087376993939699E-3</c:v>
                </c:pt>
                <c:pt idx="24">
                  <c:v>9.2345603854593027E-3</c:v>
                </c:pt>
                <c:pt idx="25">
                  <c:v>8.6141697300428782E-3</c:v>
                </c:pt>
                <c:pt idx="26">
                  <c:v>9.7902989099648789E-3</c:v>
                </c:pt>
                <c:pt idx="27">
                  <c:v>1.0582503058354968E-2</c:v>
                </c:pt>
                <c:pt idx="28">
                  <c:v>8.7536578631084855E-3</c:v>
                </c:pt>
                <c:pt idx="29">
                  <c:v>9.4980371861972737E-3</c:v>
                </c:pt>
                <c:pt idx="30">
                  <c:v>9.0326348347871521E-3</c:v>
                </c:pt>
                <c:pt idx="31">
                  <c:v>8.4162291111142418E-3</c:v>
                </c:pt>
                <c:pt idx="32">
                  <c:v>1.2963101140816089E-2</c:v>
                </c:pt>
                <c:pt idx="33">
                  <c:v>1.460861830943912E-2</c:v>
                </c:pt>
                <c:pt idx="34">
                  <c:v>1.3501570687036635E-2</c:v>
                </c:pt>
                <c:pt idx="35">
                  <c:v>1.2916161071960667E-2</c:v>
                </c:pt>
                <c:pt idx="36">
                  <c:v>1.5208639811272878E-2</c:v>
                </c:pt>
                <c:pt idx="37">
                  <c:v>1.5037711074745122E-2</c:v>
                </c:pt>
                <c:pt idx="38">
                  <c:v>1.9318890884857273E-2</c:v>
                </c:pt>
                <c:pt idx="39">
                  <c:v>1.5778990222536243E-2</c:v>
                </c:pt>
                <c:pt idx="40">
                  <c:v>2.0107994857949726E-2</c:v>
                </c:pt>
                <c:pt idx="41">
                  <c:v>1.8237525187997213E-2</c:v>
                </c:pt>
                <c:pt idx="42">
                  <c:v>2.0714215299283908E-2</c:v>
                </c:pt>
                <c:pt idx="43">
                  <c:v>2.1801779935644423E-2</c:v>
                </c:pt>
                <c:pt idx="44">
                  <c:v>2.055480109640594E-2</c:v>
                </c:pt>
                <c:pt idx="45">
                  <c:v>2.467833762762673E-2</c:v>
                </c:pt>
                <c:pt idx="46">
                  <c:v>2.5634385405503422E-2</c:v>
                </c:pt>
                <c:pt idx="47">
                  <c:v>2.9132658770928788E-2</c:v>
                </c:pt>
                <c:pt idx="48">
                  <c:v>3.1177157352706823E-2</c:v>
                </c:pt>
                <c:pt idx="49">
                  <c:v>3.5942337038277726E-2</c:v>
                </c:pt>
                <c:pt idx="50">
                  <c:v>3.8550545419142872E-2</c:v>
                </c:pt>
                <c:pt idx="51">
                  <c:v>4.342997580710227E-2</c:v>
                </c:pt>
                <c:pt idx="52">
                  <c:v>4.6429633177026509E-2</c:v>
                </c:pt>
                <c:pt idx="53">
                  <c:v>5.1522946027530755E-2</c:v>
                </c:pt>
                <c:pt idx="54">
                  <c:v>6.3476860734888035E-2</c:v>
                </c:pt>
                <c:pt idx="55">
                  <c:v>6.9965052093858934E-2</c:v>
                </c:pt>
                <c:pt idx="56">
                  <c:v>7.5322284828871364E-2</c:v>
                </c:pt>
                <c:pt idx="57">
                  <c:v>8.6322813083163794E-2</c:v>
                </c:pt>
                <c:pt idx="58">
                  <c:v>9.5295665828003182E-2</c:v>
                </c:pt>
                <c:pt idx="59">
                  <c:v>0.11376434563179348</c:v>
                </c:pt>
                <c:pt idx="60">
                  <c:v>0.12735579635552832</c:v>
                </c:pt>
                <c:pt idx="61">
                  <c:v>0.14014399546960529</c:v>
                </c:pt>
                <c:pt idx="62">
                  <c:v>0.15860734697939316</c:v>
                </c:pt>
                <c:pt idx="63">
                  <c:v>0.1798117783795477</c:v>
                </c:pt>
                <c:pt idx="64">
                  <c:v>0.20162638975307348</c:v>
                </c:pt>
                <c:pt idx="65">
                  <c:v>0.22109362797698742</c:v>
                </c:pt>
                <c:pt idx="66">
                  <c:v>0.2454814779797965</c:v>
                </c:pt>
                <c:pt idx="67">
                  <c:v>0.26755027832802042</c:v>
                </c:pt>
                <c:pt idx="68">
                  <c:v>0.289495082953098</c:v>
                </c:pt>
                <c:pt idx="69">
                  <c:v>0.31347642476303433</c:v>
                </c:pt>
                <c:pt idx="70">
                  <c:v>0.33465691270645254</c:v>
                </c:pt>
                <c:pt idx="71">
                  <c:v>0.35884639664524953</c:v>
                </c:pt>
                <c:pt idx="72">
                  <c:v>0.38226002679121618</c:v>
                </c:pt>
                <c:pt idx="73">
                  <c:v>0.40262395367873133</c:v>
                </c:pt>
                <c:pt idx="74">
                  <c:v>0.436075028582392</c:v>
                </c:pt>
                <c:pt idx="75">
                  <c:v>0.456764432954404</c:v>
                </c:pt>
                <c:pt idx="76">
                  <c:v>0.48218802654777076</c:v>
                </c:pt>
                <c:pt idx="77">
                  <c:v>0.50894938317607374</c:v>
                </c:pt>
                <c:pt idx="78">
                  <c:v>0.52504236633522527</c:v>
                </c:pt>
                <c:pt idx="79">
                  <c:v>0.56265190377774954</c:v>
                </c:pt>
                <c:pt idx="80">
                  <c:v>0.58062464584398887</c:v>
                </c:pt>
                <c:pt idx="81">
                  <c:v>0.60896155191585566</c:v>
                </c:pt>
                <c:pt idx="82">
                  <c:v>0.63453655033795553</c:v>
                </c:pt>
                <c:pt idx="83">
                  <c:v>0.66159552379483133</c:v>
                </c:pt>
                <c:pt idx="84">
                  <c:v>0.68736893343597982</c:v>
                </c:pt>
                <c:pt idx="85">
                  <c:v>0.71203974745885557</c:v>
                </c:pt>
                <c:pt idx="86">
                  <c:v>0.73598609411750404</c:v>
                </c:pt>
                <c:pt idx="87">
                  <c:v>0.76512942394015859</c:v>
                </c:pt>
                <c:pt idx="88">
                  <c:v>0.78946988373486759</c:v>
                </c:pt>
                <c:pt idx="89">
                  <c:v>0.80801117283320401</c:v>
                </c:pt>
                <c:pt idx="90">
                  <c:v>0.83499744668546461</c:v>
                </c:pt>
                <c:pt idx="91">
                  <c:v>0.86164541902359193</c:v>
                </c:pt>
                <c:pt idx="92">
                  <c:v>0.88770538251000397</c:v>
                </c:pt>
                <c:pt idx="93">
                  <c:v>0.90926934957899497</c:v>
                </c:pt>
                <c:pt idx="94">
                  <c:v>0.93416295853923126</c:v>
                </c:pt>
                <c:pt idx="95">
                  <c:v>0.96342486548096473</c:v>
                </c:pt>
                <c:pt idx="96">
                  <c:v>0.98684605909511303</c:v>
                </c:pt>
                <c:pt idx="97">
                  <c:v>1.0106636235970223</c:v>
                </c:pt>
                <c:pt idx="98">
                  <c:v>1.0353069833592707</c:v>
                </c:pt>
                <c:pt idx="99">
                  <c:v>1.052878884189395</c:v>
                </c:pt>
                <c:pt idx="100">
                  <c:v>1.0862675096811434</c:v>
                </c:pt>
                <c:pt idx="101">
                  <c:v>1.1057015138000921</c:v>
                </c:pt>
                <c:pt idx="102">
                  <c:v>1.1282086792176194</c:v>
                </c:pt>
                <c:pt idx="103">
                  <c:v>1.1544249694314648</c:v>
                </c:pt>
                <c:pt idx="104">
                  <c:v>1.1736872038013768</c:v>
                </c:pt>
                <c:pt idx="105">
                  <c:v>1.201857623263177</c:v>
                </c:pt>
                <c:pt idx="106">
                  <c:v>1.218216659882192</c:v>
                </c:pt>
                <c:pt idx="107">
                  <c:v>1.2448164066440919</c:v>
                </c:pt>
                <c:pt idx="108">
                  <c:v>1.2627133334083769</c:v>
                </c:pt>
                <c:pt idx="109">
                  <c:v>1.2836211075244315</c:v>
                </c:pt>
                <c:pt idx="110">
                  <c:v>1.3011563424670101</c:v>
                </c:pt>
                <c:pt idx="111">
                  <c:v>1.325630551472192</c:v>
                </c:pt>
                <c:pt idx="112">
                  <c:v>1.3427406969254434</c:v>
                </c:pt>
                <c:pt idx="113">
                  <c:v>1.369561342113286</c:v>
                </c:pt>
                <c:pt idx="114">
                  <c:v>1.3874999921289133</c:v>
                </c:pt>
                <c:pt idx="115">
                  <c:v>1.4061352036978041</c:v>
                </c:pt>
                <c:pt idx="116">
                  <c:v>1.4248442889021888</c:v>
                </c:pt>
                <c:pt idx="117">
                  <c:v>1.4377201565146223</c:v>
                </c:pt>
                <c:pt idx="118">
                  <c:v>1.4715152676217254</c:v>
                </c:pt>
                <c:pt idx="119">
                  <c:v>1.4839823918671102</c:v>
                </c:pt>
                <c:pt idx="120">
                  <c:v>1.4941075051231587</c:v>
                </c:pt>
                <c:pt idx="121">
                  <c:v>1.5146870021426102</c:v>
                </c:pt>
                <c:pt idx="122">
                  <c:v>1.5292110284931497</c:v>
                </c:pt>
                <c:pt idx="123">
                  <c:v>1.5521841035506707</c:v>
                </c:pt>
                <c:pt idx="124">
                  <c:v>1.5683931351470008</c:v>
                </c:pt>
                <c:pt idx="125">
                  <c:v>1.5826939150098374</c:v>
                </c:pt>
                <c:pt idx="126">
                  <c:v>1.601716466459701</c:v>
                </c:pt>
                <c:pt idx="127">
                  <c:v>1.612759220315086</c:v>
                </c:pt>
                <c:pt idx="128">
                  <c:v>1.6260499723791861</c:v>
                </c:pt>
                <c:pt idx="129">
                  <c:v>1.6416315296241495</c:v>
                </c:pt>
                <c:pt idx="130">
                  <c:v>1.6530189066984224</c:v>
                </c:pt>
                <c:pt idx="131">
                  <c:v>1.6721922759615799</c:v>
                </c:pt>
                <c:pt idx="132">
                  <c:v>1.6865671100800466</c:v>
                </c:pt>
                <c:pt idx="133">
                  <c:v>1.697665314317089</c:v>
                </c:pt>
                <c:pt idx="134">
                  <c:v>1.7140470187631285</c:v>
                </c:pt>
                <c:pt idx="135">
                  <c:v>1.7263264786875374</c:v>
                </c:pt>
                <c:pt idx="136">
                  <c:v>1.740464339187989</c:v>
                </c:pt>
                <c:pt idx="137">
                  <c:v>1.7483926600437951</c:v>
                </c:pt>
                <c:pt idx="138">
                  <c:v>1.7627243259498344</c:v>
                </c:pt>
                <c:pt idx="139">
                  <c:v>1.7819078099405892</c:v>
                </c:pt>
                <c:pt idx="140">
                  <c:v>1.7841083050536162</c:v>
                </c:pt>
                <c:pt idx="141">
                  <c:v>1.8043995323365163</c:v>
                </c:pt>
                <c:pt idx="142">
                  <c:v>1.8072531498601707</c:v>
                </c:pt>
                <c:pt idx="143">
                  <c:v>1.8252709114952281</c:v>
                </c:pt>
                <c:pt idx="144">
                  <c:v>1.8271202810644889</c:v>
                </c:pt>
                <c:pt idx="145">
                  <c:v>1.8322722898147101</c:v>
                </c:pt>
                <c:pt idx="146">
                  <c:v>1.8373975667848497</c:v>
                </c:pt>
                <c:pt idx="147">
                  <c:v>1.843414204124586</c:v>
                </c:pt>
                <c:pt idx="148">
                  <c:v>1.8582786994308922</c:v>
                </c:pt>
                <c:pt idx="149">
                  <c:v>1.8613772378585343</c:v>
                </c:pt>
                <c:pt idx="150">
                  <c:v>1.8736998659953708</c:v>
                </c:pt>
                <c:pt idx="151">
                  <c:v>1.8880597086425768</c:v>
                </c:pt>
                <c:pt idx="152">
                  <c:v>1.9009184173421194</c:v>
                </c:pt>
                <c:pt idx="153">
                  <c:v>1.9065584616989586</c:v>
                </c:pt>
                <c:pt idx="154">
                  <c:v>1.9172547861341043</c:v>
                </c:pt>
                <c:pt idx="155">
                  <c:v>1.930421994025395</c:v>
                </c:pt>
                <c:pt idx="156">
                  <c:v>1.9364133445461376</c:v>
                </c:pt>
                <c:pt idx="157">
                  <c:v>1.9496470206473586</c:v>
                </c:pt>
                <c:pt idx="158">
                  <c:v>1.9642839345827012</c:v>
                </c:pt>
                <c:pt idx="159">
                  <c:v>1.9740291133833434</c:v>
                </c:pt>
                <c:pt idx="160">
                  <c:v>1.9738055056553676</c:v>
                </c:pt>
                <c:pt idx="161">
                  <c:v>1.9838729107780677</c:v>
                </c:pt>
                <c:pt idx="162">
                  <c:v>1.9953155576138557</c:v>
                </c:pt>
                <c:pt idx="163">
                  <c:v>2.0052316030628523</c:v>
                </c:pt>
                <c:pt idx="164">
                  <c:v>2.0157196724815583</c:v>
                </c:pt>
                <c:pt idx="165">
                  <c:v>2.0199667743520067</c:v>
                </c:pt>
                <c:pt idx="166">
                  <c:v>2.0346755751013523</c:v>
                </c:pt>
                <c:pt idx="167">
                  <c:v>2.0372611523436555</c:v>
                </c:pt>
                <c:pt idx="168">
                  <c:v>2.0581910524263312</c:v>
                </c:pt>
                <c:pt idx="169">
                  <c:v>2.0580732880978645</c:v>
                </c:pt>
                <c:pt idx="170">
                  <c:v>2.0695908922899613</c:v>
                </c:pt>
                <c:pt idx="171">
                  <c:v>2.0815378305445797</c:v>
                </c:pt>
                <c:pt idx="172">
                  <c:v>2.0876655492677614</c:v>
                </c:pt>
                <c:pt idx="173">
                  <c:v>2.0966264754392645</c:v>
                </c:pt>
                <c:pt idx="174">
                  <c:v>2.1032610142631736</c:v>
                </c:pt>
                <c:pt idx="175">
                  <c:v>2.1094100461623646</c:v>
                </c:pt>
                <c:pt idx="176">
                  <c:v>2.1211355441306341</c:v>
                </c:pt>
                <c:pt idx="177">
                  <c:v>2.1291115487022614</c:v>
                </c:pt>
                <c:pt idx="178">
                  <c:v>2.1389732274904163</c:v>
                </c:pt>
                <c:pt idx="179">
                  <c:v>2.1431020231719948</c:v>
                </c:pt>
                <c:pt idx="180">
                  <c:v>2.1499016487999163</c:v>
                </c:pt>
                <c:pt idx="181">
                  <c:v>2.15949185552414</c:v>
                </c:pt>
                <c:pt idx="182">
                  <c:v>2.1699250164215975</c:v>
                </c:pt>
                <c:pt idx="183">
                  <c:v>2.1743052353320462</c:v>
                </c:pt>
                <c:pt idx="184">
                  <c:v>2.185192655870746</c:v>
                </c:pt>
                <c:pt idx="185">
                  <c:v>2.1857598030967917</c:v>
                </c:pt>
                <c:pt idx="186">
                  <c:v>2.1952759555653856</c:v>
                </c:pt>
                <c:pt idx="187">
                  <c:v>2.2046965599822039</c:v>
                </c:pt>
                <c:pt idx="188">
                  <c:v>2.2107104880199069</c:v>
                </c:pt>
                <c:pt idx="189">
                  <c:v>2.2182725112405461</c:v>
                </c:pt>
                <c:pt idx="190">
                  <c:v>2.2245963834310793</c:v>
                </c:pt>
                <c:pt idx="191">
                  <c:v>2.2275991931868102</c:v>
                </c:pt>
                <c:pt idx="192">
                  <c:v>2.2345368125983947</c:v>
                </c:pt>
                <c:pt idx="193">
                  <c:v>2.2465021741068494</c:v>
                </c:pt>
                <c:pt idx="194">
                  <c:v>2.2493973342617126</c:v>
                </c:pt>
                <c:pt idx="195">
                  <c:v>2.2594502897735582</c:v>
                </c:pt>
                <c:pt idx="196">
                  <c:v>2.2637264714858523</c:v>
                </c:pt>
                <c:pt idx="197">
                  <c:v>2.2740021316249948</c:v>
                </c:pt>
                <c:pt idx="198">
                  <c:v>2.277365820411819</c:v>
                </c:pt>
                <c:pt idx="199">
                  <c:v>2.2827130795287127</c:v>
                </c:pt>
                <c:pt idx="200">
                  <c:v>2.2918044134381828</c:v>
                </c:pt>
                <c:pt idx="201">
                  <c:v>2.2908691623756159</c:v>
                </c:pt>
                <c:pt idx="202">
                  <c:v>2.3015075077472069</c:v>
                </c:pt>
                <c:pt idx="203">
                  <c:v>2.3046347647764249</c:v>
                </c:pt>
                <c:pt idx="204">
                  <c:v>2.311206086552843</c:v>
                </c:pt>
                <c:pt idx="205">
                  <c:v>2.3112167431408492</c:v>
                </c:pt>
                <c:pt idx="206">
                  <c:v>2.3215433381582522</c:v>
                </c:pt>
                <c:pt idx="207">
                  <c:v>2.3187527570619495</c:v>
                </c:pt>
                <c:pt idx="208">
                  <c:v>2.3250598315798645</c:v>
                </c:pt>
                <c:pt idx="209">
                  <c:v>2.330593129436513</c:v>
                </c:pt>
                <c:pt idx="210">
                  <c:v>2.3322427331357072</c:v>
                </c:pt>
                <c:pt idx="211">
                  <c:v>2.3404826237255647</c:v>
                </c:pt>
                <c:pt idx="212">
                  <c:v>2.346036873517952</c:v>
                </c:pt>
                <c:pt idx="213">
                  <c:v>2.3507945885119796</c:v>
                </c:pt>
                <c:pt idx="214">
                  <c:v>2.3547349973920402</c:v>
                </c:pt>
                <c:pt idx="215">
                  <c:v>2.3609976393565764</c:v>
                </c:pt>
                <c:pt idx="216">
                  <c:v>2.3555076903324919</c:v>
                </c:pt>
                <c:pt idx="217">
                  <c:v>2.3474305384848826</c:v>
                </c:pt>
                <c:pt idx="218">
                  <c:v>2.3371026791265281</c:v>
                </c:pt>
                <c:pt idx="219">
                  <c:v>2.3308297418142585</c:v>
                </c:pt>
                <c:pt idx="220">
                  <c:v>2.3247993773442097</c:v>
                </c:pt>
                <c:pt idx="221">
                  <c:v>2.3222434218041581</c:v>
                </c:pt>
                <c:pt idx="222">
                  <c:v>2.317443802938655</c:v>
                </c:pt>
                <c:pt idx="223">
                  <c:v>2.26254955068174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F1A-4FCD-8C7C-DF2E7516E699}"/>
            </c:ext>
          </c:extLst>
        </c:ser>
        <c:ser>
          <c:idx val="1"/>
          <c:order val="1"/>
          <c:tx>
            <c:v>TD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d28 S'!$C$7:$C$233</c:f>
              <c:numCache>
                <c:formatCode>General</c:formatCode>
                <c:ptCount val="227"/>
                <c:pt idx="0">
                  <c:v>1</c:v>
                </c:pt>
                <c:pt idx="1">
                  <c:v>0.99707162618773737</c:v>
                </c:pt>
                <c:pt idx="2">
                  <c:v>0.99962524964836852</c:v>
                </c:pt>
                <c:pt idx="3">
                  <c:v>1</c:v>
                </c:pt>
                <c:pt idx="4">
                  <c:v>0.99704735208073925</c:v>
                </c:pt>
                <c:pt idx="5">
                  <c:v>0.99965946705445063</c:v>
                </c:pt>
                <c:pt idx="6">
                  <c:v>1</c:v>
                </c:pt>
                <c:pt idx="7">
                  <c:v>1.0029840184476675</c:v>
                </c:pt>
                <c:pt idx="8">
                  <c:v>1.0003041933254706</c:v>
                </c:pt>
                <c:pt idx="9">
                  <c:v>1</c:v>
                </c:pt>
                <c:pt idx="10">
                  <c:v>1.0060175266476219</c:v>
                </c:pt>
                <c:pt idx="11">
                  <c:v>1.0035781294061878</c:v>
                </c:pt>
                <c:pt idx="12">
                  <c:v>1.0002634444199958</c:v>
                </c:pt>
                <c:pt idx="13">
                  <c:v>1.0030429690602516</c:v>
                </c:pt>
                <c:pt idx="14">
                  <c:v>1.0063553962952827</c:v>
                </c:pt>
                <c:pt idx="15">
                  <c:v>1.0066006600660067</c:v>
                </c:pt>
                <c:pt idx="16">
                  <c:v>1.0035294668073236</c:v>
                </c:pt>
                <c:pt idx="17">
                  <c:v>1.0033003300330035</c:v>
                </c:pt>
                <c:pt idx="18">
                  <c:v>1.0063917260176041</c:v>
                </c:pt>
                <c:pt idx="19">
                  <c:v>1.0066006600660067</c:v>
                </c:pt>
                <c:pt idx="20">
                  <c:v>1.0034863017340026</c:v>
                </c:pt>
                <c:pt idx="21">
                  <c:v>1.0064229618247722</c:v>
                </c:pt>
                <c:pt idx="22">
                  <c:v>1.003466564574649</c:v>
                </c:pt>
                <c:pt idx="23">
                  <c:v>1.0064410560907449</c:v>
                </c:pt>
                <c:pt idx="24">
                  <c:v>1.0066006600660067</c:v>
                </c:pt>
                <c:pt idx="25">
                  <c:v>1.0097632675123027</c:v>
                </c:pt>
                <c:pt idx="26">
                  <c:v>1.0067284153769824</c:v>
                </c:pt>
                <c:pt idx="27">
                  <c:v>1.0066006600660067</c:v>
                </c:pt>
                <c:pt idx="28">
                  <c:v>1.0097926332019251</c:v>
                </c:pt>
                <c:pt idx="29">
                  <c:v>1.0066979387080155</c:v>
                </c:pt>
                <c:pt idx="30">
                  <c:v>1.0098119848915279</c:v>
                </c:pt>
                <c:pt idx="31">
                  <c:v>1.0099009900990099</c:v>
                </c:pt>
                <c:pt idx="32">
                  <c:v>1.0131318090486727</c:v>
                </c:pt>
                <c:pt idx="33">
                  <c:v>1.0132013201320131</c:v>
                </c:pt>
                <c:pt idx="34">
                  <c:v>1.0099541922870425</c:v>
                </c:pt>
                <c:pt idx="35">
                  <c:v>1.0099009900990099</c:v>
                </c:pt>
                <c:pt idx="36">
                  <c:v>1.0099009900990099</c:v>
                </c:pt>
                <c:pt idx="37">
                  <c:v>1.0131793162064007</c:v>
                </c:pt>
                <c:pt idx="38">
                  <c:v>1.0099099790752366</c:v>
                </c:pt>
                <c:pt idx="39">
                  <c:v>1.0131982184344828</c:v>
                </c:pt>
                <c:pt idx="40">
                  <c:v>1.0132013201320131</c:v>
                </c:pt>
                <c:pt idx="41">
                  <c:v>1.0131949703929031</c:v>
                </c:pt>
                <c:pt idx="42">
                  <c:v>1.0099275813271991</c:v>
                </c:pt>
                <c:pt idx="43">
                  <c:v>1.0132013201320131</c:v>
                </c:pt>
                <c:pt idx="44">
                  <c:v>1.0132013201320131</c:v>
                </c:pt>
                <c:pt idx="45">
                  <c:v>1.0132569718438009</c:v>
                </c:pt>
                <c:pt idx="46">
                  <c:v>1.0165016501650164</c:v>
                </c:pt>
                <c:pt idx="47">
                  <c:v>1.0165016501650164</c:v>
                </c:pt>
                <c:pt idx="48">
                  <c:v>1.0164184471775175</c:v>
                </c:pt>
                <c:pt idx="49">
                  <c:v>1.0133900199785968</c:v>
                </c:pt>
                <c:pt idx="50">
                  <c:v>1.0196972106071305</c:v>
                </c:pt>
                <c:pt idx="51">
                  <c:v>1.0166190448636394</c:v>
                </c:pt>
                <c:pt idx="52">
                  <c:v>1.0196776337546714</c:v>
                </c:pt>
                <c:pt idx="53">
                  <c:v>1.0166314726857186</c:v>
                </c:pt>
                <c:pt idx="54">
                  <c:v>1.0195108389855909</c:v>
                </c:pt>
                <c:pt idx="55">
                  <c:v>1.013354088086394</c:v>
                </c:pt>
                <c:pt idx="56">
                  <c:v>1.0165016501650164</c:v>
                </c:pt>
                <c:pt idx="57">
                  <c:v>1.0168492415804973</c:v>
                </c:pt>
                <c:pt idx="58">
                  <c:v>1.0229262010363189</c:v>
                </c:pt>
                <c:pt idx="59">
                  <c:v>1.01980198019802</c:v>
                </c:pt>
                <c:pt idx="60">
                  <c:v>1.0200060908691193</c:v>
                </c:pt>
                <c:pt idx="61">
                  <c:v>1.0231023102310233</c:v>
                </c:pt>
                <c:pt idx="62">
                  <c:v>1.0228781219187171</c:v>
                </c:pt>
                <c:pt idx="63">
                  <c:v>1.01980198019802</c:v>
                </c:pt>
                <c:pt idx="64">
                  <c:v>1.0200455826777883</c:v>
                </c:pt>
                <c:pt idx="65">
                  <c:v>1.0231023102310233</c:v>
                </c:pt>
                <c:pt idx="66">
                  <c:v>1.0228373322070765</c:v>
                </c:pt>
                <c:pt idx="67">
                  <c:v>1.0200734077108164</c:v>
                </c:pt>
                <c:pt idx="68">
                  <c:v>1.0231023102310233</c:v>
                </c:pt>
                <c:pt idx="69">
                  <c:v>1.0231023102310233</c:v>
                </c:pt>
                <c:pt idx="70">
                  <c:v>1.0231023102310233</c:v>
                </c:pt>
                <c:pt idx="71">
                  <c:v>1.0231023102310233</c:v>
                </c:pt>
                <c:pt idx="72">
                  <c:v>1.0234222325785365</c:v>
                </c:pt>
                <c:pt idx="73">
                  <c:v>1.0260686652778017</c:v>
                </c:pt>
                <c:pt idx="74">
                  <c:v>1.0234405503103461</c:v>
                </c:pt>
                <c:pt idx="75">
                  <c:v>1.0267460372070258</c:v>
                </c:pt>
                <c:pt idx="76">
                  <c:v>1.0293500640880164</c:v>
                </c:pt>
                <c:pt idx="77">
                  <c:v>1.0260358512325514</c:v>
                </c:pt>
                <c:pt idx="78">
                  <c:v>1.0231023102310233</c:v>
                </c:pt>
                <c:pt idx="79">
                  <c:v>1.0234899316012556</c:v>
                </c:pt>
                <c:pt idx="80">
                  <c:v>1.0264026402640265</c:v>
                </c:pt>
                <c:pt idx="81">
                  <c:v>1.0264026402640265</c:v>
                </c:pt>
                <c:pt idx="82">
                  <c:v>1.0268223858991423</c:v>
                </c:pt>
                <c:pt idx="83">
                  <c:v>1.0297029702970297</c:v>
                </c:pt>
                <c:pt idx="84">
                  <c:v>1.0292678246067044</c:v>
                </c:pt>
                <c:pt idx="85">
                  <c:v>1.0264026402640265</c:v>
                </c:pt>
                <c:pt idx="86">
                  <c:v>1.0264026402640265</c:v>
                </c:pt>
                <c:pt idx="87">
                  <c:v>1.026871565394589</c:v>
                </c:pt>
                <c:pt idx="88">
                  <c:v>1.0292243018354705</c:v>
                </c:pt>
                <c:pt idx="89">
                  <c:v>1.0268892314943412</c:v>
                </c:pt>
                <c:pt idx="90">
                  <c:v>1.0297029702970297</c:v>
                </c:pt>
                <c:pt idx="91">
                  <c:v>1.0302043986554406</c:v>
                </c:pt>
                <c:pt idx="92">
                  <c:v>1.0324894016010144</c:v>
                </c:pt>
                <c:pt idx="93">
                  <c:v>1.0291784070324328</c:v>
                </c:pt>
                <c:pt idx="94">
                  <c:v>1.0269383033344655</c:v>
                </c:pt>
                <c:pt idx="95">
                  <c:v>1.0291608993971031</c:v>
                </c:pt>
                <c:pt idx="96">
                  <c:v>1.0269437147796412</c:v>
                </c:pt>
                <c:pt idx="97">
                  <c:v>1.0302691049291572</c:v>
                </c:pt>
                <c:pt idx="98">
                  <c:v>1.0335765650913131</c:v>
                </c:pt>
                <c:pt idx="99">
                  <c:v>1.0351328289900343</c:v>
                </c:pt>
                <c:pt idx="100">
                  <c:v>1.0302932463095247</c:v>
                </c:pt>
                <c:pt idx="101">
                  <c:v>1.0335934669782367</c:v>
                </c:pt>
                <c:pt idx="102">
                  <c:v>1.0350723066748913</c:v>
                </c:pt>
                <c:pt idx="103">
                  <c:v>1.0303271115942283</c:v>
                </c:pt>
                <c:pt idx="104">
                  <c:v>1.0330033003300332</c:v>
                </c:pt>
                <c:pt idx="105">
                  <c:v>1.0336456032578969</c:v>
                </c:pt>
                <c:pt idx="106">
                  <c:v>1.0363036303630364</c:v>
                </c:pt>
                <c:pt idx="107">
                  <c:v>1.0363036303630364</c:v>
                </c:pt>
                <c:pt idx="108">
                  <c:v>1.0363036303630364</c:v>
                </c:pt>
                <c:pt idx="109">
                  <c:v>1.0363036303630364</c:v>
                </c:pt>
                <c:pt idx="110">
                  <c:v>1.0363036303630364</c:v>
                </c:pt>
                <c:pt idx="111">
                  <c:v>1.0369952122142256</c:v>
                </c:pt>
                <c:pt idx="112">
                  <c:v>1.0396039603960396</c:v>
                </c:pt>
                <c:pt idx="113">
                  <c:v>1.0388828920926585</c:v>
                </c:pt>
                <c:pt idx="114">
                  <c:v>1.037035486768523</c:v>
                </c:pt>
                <c:pt idx="115">
                  <c:v>1.0396039603960396</c:v>
                </c:pt>
                <c:pt idx="116">
                  <c:v>1.0396039603960396</c:v>
                </c:pt>
                <c:pt idx="117">
                  <c:v>1.0396039603960396</c:v>
                </c:pt>
                <c:pt idx="118">
                  <c:v>1.0403729537655804</c:v>
                </c:pt>
                <c:pt idx="119">
                  <c:v>1.0429042904290429</c:v>
                </c:pt>
                <c:pt idx="120">
                  <c:v>1.0429042904290429</c:v>
                </c:pt>
                <c:pt idx="121">
                  <c:v>1.0421051495196165</c:v>
                </c:pt>
                <c:pt idx="122">
                  <c:v>1.0396039603960396</c:v>
                </c:pt>
                <c:pt idx="123">
                  <c:v>1.0404219324455666</c:v>
                </c:pt>
                <c:pt idx="124">
                  <c:v>1.0429042904290429</c:v>
                </c:pt>
                <c:pt idx="125">
                  <c:v>1.0420675397224486</c:v>
                </c:pt>
                <c:pt idx="126">
                  <c:v>1.040447299776561</c:v>
                </c:pt>
                <c:pt idx="127">
                  <c:v>1.0429042904290429</c:v>
                </c:pt>
                <c:pt idx="128">
                  <c:v>1.0429042904290429</c:v>
                </c:pt>
                <c:pt idx="129">
                  <c:v>1.0420258610003925</c:v>
                </c:pt>
                <c:pt idx="130">
                  <c:v>1.041366226113579</c:v>
                </c:pt>
                <c:pt idx="131">
                  <c:v>1.0462046204620463</c:v>
                </c:pt>
                <c:pt idx="132">
                  <c:v>1.0462046204620463</c:v>
                </c:pt>
                <c:pt idx="133">
                  <c:v>1.0452937983336967</c:v>
                </c:pt>
                <c:pt idx="134">
                  <c:v>1.0438321725070787</c:v>
                </c:pt>
                <c:pt idx="135">
                  <c:v>1.0462046204620463</c:v>
                </c:pt>
                <c:pt idx="136">
                  <c:v>1.0462046204620463</c:v>
                </c:pt>
                <c:pt idx="137">
                  <c:v>1.0462046204620463</c:v>
                </c:pt>
                <c:pt idx="138">
                  <c:v>1.0471701802016624</c:v>
                </c:pt>
                <c:pt idx="139">
                  <c:v>1.0485270670916251</c:v>
                </c:pt>
                <c:pt idx="140">
                  <c:v>1.0471900518457917</c:v>
                </c:pt>
                <c:pt idx="141">
                  <c:v>1.0485095273389795</c:v>
                </c:pt>
                <c:pt idx="142">
                  <c:v>1.047204814923443</c:v>
                </c:pt>
                <c:pt idx="143">
                  <c:v>1.0485006843981322</c:v>
                </c:pt>
                <c:pt idx="144">
                  <c:v>1.0472287981588591</c:v>
                </c:pt>
                <c:pt idx="145">
                  <c:v>1.0505373738098156</c:v>
                </c:pt>
                <c:pt idx="146">
                  <c:v>1.052805280528053</c:v>
                </c:pt>
                <c:pt idx="147">
                  <c:v>1.052805280528053</c:v>
                </c:pt>
                <c:pt idx="148">
                  <c:v>1.052805280528053</c:v>
                </c:pt>
                <c:pt idx="149">
                  <c:v>1.0517327094098652</c:v>
                </c:pt>
                <c:pt idx="150">
                  <c:v>1.0505868290199294</c:v>
                </c:pt>
                <c:pt idx="151">
                  <c:v>1.052805280528053</c:v>
                </c:pt>
                <c:pt idx="152">
                  <c:v>1.0539082454958297</c:v>
                </c:pt>
                <c:pt idx="153">
                  <c:v>1.0561056105610562</c:v>
                </c:pt>
                <c:pt idx="154">
                  <c:v>1.0561056105610562</c:v>
                </c:pt>
                <c:pt idx="155">
                  <c:v>1.0572353842822186</c:v>
                </c:pt>
                <c:pt idx="156">
                  <c:v>1.0616809690881974</c:v>
                </c:pt>
                <c:pt idx="157">
                  <c:v>1.0616809690881974</c:v>
                </c:pt>
                <c:pt idx="158">
                  <c:v>1.0607087949288951</c:v>
                </c:pt>
                <c:pt idx="159">
                  <c:v>1.0607087949288951</c:v>
                </c:pt>
                <c:pt idx="160">
                  <c:v>1.0640158512276263</c:v>
                </c:pt>
                <c:pt idx="161">
                  <c:v>1.0637679444776496</c:v>
                </c:pt>
                <c:pt idx="162">
                  <c:v>1.061944387071095</c:v>
                </c:pt>
                <c:pt idx="163">
                  <c:v>1.0661430267706467</c:v>
                </c:pt>
                <c:pt idx="164">
                  <c:v>1.0661430267706467</c:v>
                </c:pt>
                <c:pt idx="165">
                  <c:v>1.0661430267706467</c:v>
                </c:pt>
                <c:pt idx="166">
                  <c:v>1.067377320095005</c:v>
                </c:pt>
                <c:pt idx="167">
                  <c:v>1.0681994533457291</c:v>
                </c:pt>
                <c:pt idx="168">
                  <c:v>1.0661430267706467</c:v>
                </c:pt>
                <c:pt idx="169">
                  <c:v>1.0661430267706467</c:v>
                </c:pt>
                <c:pt idx="170">
                  <c:v>1.0674249899469541</c:v>
                </c:pt>
                <c:pt idx="171">
                  <c:v>1.0707255133488163</c:v>
                </c:pt>
                <c:pt idx="172">
                  <c:v>1.0727436868366531</c:v>
                </c:pt>
                <c:pt idx="173">
                  <c:v>1.0727436868366531</c:v>
                </c:pt>
                <c:pt idx="174">
                  <c:v>1.0740625505425732</c:v>
                </c:pt>
                <c:pt idx="175">
                  <c:v>1.0760440168696563</c:v>
                </c:pt>
                <c:pt idx="176">
                  <c:v>1.0747241459585151</c:v>
                </c:pt>
                <c:pt idx="177">
                  <c:v>1.0753841957878361</c:v>
                </c:pt>
                <c:pt idx="178">
                  <c:v>1.0779880637487731</c:v>
                </c:pt>
                <c:pt idx="179">
                  <c:v>1.0774113591823993</c:v>
                </c:pt>
                <c:pt idx="180">
                  <c:v>1.0779673005285162</c:v>
                </c:pt>
                <c:pt idx="181">
                  <c:v>1.0760440168696563</c:v>
                </c:pt>
                <c:pt idx="182">
                  <c:v>1.0773998397057378</c:v>
                </c:pt>
                <c:pt idx="183">
                  <c:v>1.0793443469026598</c:v>
                </c:pt>
                <c:pt idx="184">
                  <c:v>1.0793443469026598</c:v>
                </c:pt>
                <c:pt idx="185">
                  <c:v>1.080763321209113</c:v>
                </c:pt>
                <c:pt idx="186">
                  <c:v>1.0812192145781068</c:v>
                </c:pt>
                <c:pt idx="187">
                  <c:v>1.0807879983775541</c:v>
                </c:pt>
                <c:pt idx="188">
                  <c:v>1.082644676935663</c:v>
                </c:pt>
                <c:pt idx="189">
                  <c:v>1.082644676935663</c:v>
                </c:pt>
                <c:pt idx="190">
                  <c:v>1.0841193823353208</c:v>
                </c:pt>
                <c:pt idx="191">
                  <c:v>1.084463942376918</c:v>
                </c:pt>
                <c:pt idx="192">
                  <c:v>1.0841351565745763</c:v>
                </c:pt>
                <c:pt idx="193">
                  <c:v>1.0844451068598882</c:v>
                </c:pt>
                <c:pt idx="194">
                  <c:v>1.0841540320401402</c:v>
                </c:pt>
                <c:pt idx="195">
                  <c:v>1.0859450069686662</c:v>
                </c:pt>
                <c:pt idx="196">
                  <c:v>1.0874753127235124</c:v>
                </c:pt>
                <c:pt idx="197">
                  <c:v>1.0877056537820311</c:v>
                </c:pt>
                <c:pt idx="198">
                  <c:v>1.0859450069686662</c:v>
                </c:pt>
                <c:pt idx="199">
                  <c:v>1.0859450069686662</c:v>
                </c:pt>
                <c:pt idx="200">
                  <c:v>1.0875174486178789</c:v>
                </c:pt>
                <c:pt idx="201">
                  <c:v>1.0892453370016695</c:v>
                </c:pt>
                <c:pt idx="202">
                  <c:v>1.0892453370016695</c:v>
                </c:pt>
                <c:pt idx="203">
                  <c:v>1.0892453370016695</c:v>
                </c:pt>
                <c:pt idx="204">
                  <c:v>1.0892453370016695</c:v>
                </c:pt>
                <c:pt idx="205">
                  <c:v>1.0892453370016695</c:v>
                </c:pt>
                <c:pt idx="206">
                  <c:v>1.0892453370016695</c:v>
                </c:pt>
                <c:pt idx="207">
                  <c:v>1.090880407149643</c:v>
                </c:pt>
                <c:pt idx="208">
                  <c:v>1.0908948401651619</c:v>
                </c:pt>
                <c:pt idx="209">
                  <c:v>1.0892453370016695</c:v>
                </c:pt>
                <c:pt idx="210">
                  <c:v>1.0909157602792854</c:v>
                </c:pt>
                <c:pt idx="211">
                  <c:v>1.0908728443599798</c:v>
                </c:pt>
                <c:pt idx="212">
                  <c:v>1.0892453370016695</c:v>
                </c:pt>
                <c:pt idx="213">
                  <c:v>1.0892453370016695</c:v>
                </c:pt>
                <c:pt idx="214">
                  <c:v>1.0892453370016695</c:v>
                </c:pt>
                <c:pt idx="215">
                  <c:v>1.0909592220689728</c:v>
                </c:pt>
                <c:pt idx="216">
                  <c:v>1.0908231967116815</c:v>
                </c:pt>
                <c:pt idx="217">
                  <c:v>1.0892453370016695</c:v>
                </c:pt>
                <c:pt idx="218">
                  <c:v>1.0909922910210017</c:v>
                </c:pt>
                <c:pt idx="219">
                  <c:v>1.0907888844949247</c:v>
                </c:pt>
                <c:pt idx="220">
                  <c:v>1.0892453370016695</c:v>
                </c:pt>
                <c:pt idx="221">
                  <c:v>1.0910227018939957</c:v>
                </c:pt>
              </c:numCache>
            </c:numRef>
          </c:xVal>
          <c:yVal>
            <c:numRef>
              <c:f>'d28 S'!$D$7:$D$233</c:f>
              <c:numCache>
                <c:formatCode>General</c:formatCode>
                <c:ptCount val="227"/>
                <c:pt idx="0">
                  <c:v>0</c:v>
                </c:pt>
                <c:pt idx="1">
                  <c:v>2.982544455033413E-3</c:v>
                </c:pt>
                <c:pt idx="2">
                  <c:v>1.9914524267421675E-3</c:v>
                </c:pt>
                <c:pt idx="3">
                  <c:v>4.4194426206403221E-3</c:v>
                </c:pt>
                <c:pt idx="4">
                  <c:v>3.0616341142995882E-3</c:v>
                </c:pt>
                <c:pt idx="5">
                  <c:v>5.0147775320403178E-3</c:v>
                </c:pt>
                <c:pt idx="6">
                  <c:v>5.2699650860298947E-3</c:v>
                </c:pt>
                <c:pt idx="7">
                  <c:v>6.0747641416357082E-3</c:v>
                </c:pt>
                <c:pt idx="8">
                  <c:v>6.3694967252318404E-3</c:v>
                </c:pt>
                <c:pt idx="9">
                  <c:v>8.8951131033594942E-3</c:v>
                </c:pt>
                <c:pt idx="10">
                  <c:v>7.2246531603452225E-3</c:v>
                </c:pt>
                <c:pt idx="11">
                  <c:v>1.1546160222423002E-2</c:v>
                </c:pt>
                <c:pt idx="12">
                  <c:v>1.1669429527087634E-2</c:v>
                </c:pt>
                <c:pt idx="13">
                  <c:v>1.0964110194376597E-2</c:v>
                </c:pt>
                <c:pt idx="14">
                  <c:v>1.479594143261112E-2</c:v>
                </c:pt>
                <c:pt idx="15">
                  <c:v>1.3677873914513975E-2</c:v>
                </c:pt>
                <c:pt idx="16">
                  <c:v>1.7681478052134228E-2</c:v>
                </c:pt>
                <c:pt idx="17">
                  <c:v>1.6834662664075222E-2</c:v>
                </c:pt>
                <c:pt idx="18">
                  <c:v>2.2408320129421757E-2</c:v>
                </c:pt>
                <c:pt idx="19">
                  <c:v>2.1995261831339007E-2</c:v>
                </c:pt>
                <c:pt idx="20">
                  <c:v>2.518171015299903E-2</c:v>
                </c:pt>
                <c:pt idx="21">
                  <c:v>2.8079911184361397E-2</c:v>
                </c:pt>
                <c:pt idx="22">
                  <c:v>2.9400337574093743E-2</c:v>
                </c:pt>
                <c:pt idx="23">
                  <c:v>3.3863032547792479E-2</c:v>
                </c:pt>
                <c:pt idx="24">
                  <c:v>3.7838212641676625E-2</c:v>
                </c:pt>
                <c:pt idx="25">
                  <c:v>4.1524844192929261E-2</c:v>
                </c:pt>
                <c:pt idx="26">
                  <c:v>4.382740044631616E-2</c:v>
                </c:pt>
                <c:pt idx="27">
                  <c:v>5.3058027921847023E-2</c:v>
                </c:pt>
                <c:pt idx="28">
                  <c:v>5.6001645203750616E-2</c:v>
                </c:pt>
                <c:pt idx="29">
                  <c:v>6.4679263966910233E-2</c:v>
                </c:pt>
                <c:pt idx="30">
                  <c:v>6.7444311466706014E-2</c:v>
                </c:pt>
                <c:pt idx="31">
                  <c:v>7.7312282556333281E-2</c:v>
                </c:pt>
                <c:pt idx="32">
                  <c:v>8.415292365669437E-2</c:v>
                </c:pt>
                <c:pt idx="33">
                  <c:v>9.1802677332598823E-2</c:v>
                </c:pt>
                <c:pt idx="34">
                  <c:v>0.10231604512158719</c:v>
                </c:pt>
                <c:pt idx="35">
                  <c:v>0.11283898210235674</c:v>
                </c:pt>
                <c:pt idx="36">
                  <c:v>0.12040378655805145</c:v>
                </c:pt>
                <c:pt idx="37">
                  <c:v>0.13312145508431977</c:v>
                </c:pt>
                <c:pt idx="38">
                  <c:v>0.14220224791866035</c:v>
                </c:pt>
                <c:pt idx="39">
                  <c:v>0.15429216171230878</c:v>
                </c:pt>
                <c:pt idx="40">
                  <c:v>0.16668357986791449</c:v>
                </c:pt>
                <c:pt idx="41">
                  <c:v>0.17935615111670072</c:v>
                </c:pt>
                <c:pt idx="42">
                  <c:v>0.19464578211748573</c:v>
                </c:pt>
                <c:pt idx="43">
                  <c:v>0.20582614226333687</c:v>
                </c:pt>
                <c:pt idx="44">
                  <c:v>0.22425621661335846</c:v>
                </c:pt>
                <c:pt idx="45">
                  <c:v>0.23716572577618086</c:v>
                </c:pt>
                <c:pt idx="46">
                  <c:v>0.25120444682448317</c:v>
                </c:pt>
                <c:pt idx="47">
                  <c:v>0.26071467978316604</c:v>
                </c:pt>
                <c:pt idx="48">
                  <c:v>0.27665832369385529</c:v>
                </c:pt>
                <c:pt idx="49">
                  <c:v>0.28929661912154453</c:v>
                </c:pt>
                <c:pt idx="50">
                  <c:v>0.31110341316108781</c:v>
                </c:pt>
                <c:pt idx="51">
                  <c:v>0.32184201530939011</c:v>
                </c:pt>
                <c:pt idx="52">
                  <c:v>0.33331713806562058</c:v>
                </c:pt>
                <c:pt idx="53">
                  <c:v>0.3511061001939208</c:v>
                </c:pt>
                <c:pt idx="54">
                  <c:v>0.36714060023332462</c:v>
                </c:pt>
                <c:pt idx="55">
                  <c:v>0.3842971923644895</c:v>
                </c:pt>
                <c:pt idx="56">
                  <c:v>0.39581367923202865</c:v>
                </c:pt>
                <c:pt idx="57">
                  <c:v>0.40939298456428441</c:v>
                </c:pt>
                <c:pt idx="58">
                  <c:v>0.42271897015624427</c:v>
                </c:pt>
                <c:pt idx="59">
                  <c:v>0.4433854630740709</c:v>
                </c:pt>
                <c:pt idx="60">
                  <c:v>0.45582695606206036</c:v>
                </c:pt>
                <c:pt idx="61">
                  <c:v>0.47205794350604346</c:v>
                </c:pt>
                <c:pt idx="62">
                  <c:v>0.48843413063700963</c:v>
                </c:pt>
                <c:pt idx="63">
                  <c:v>0.50334625505304764</c:v>
                </c:pt>
                <c:pt idx="64">
                  <c:v>0.51720764283208986</c:v>
                </c:pt>
                <c:pt idx="65">
                  <c:v>0.53443152646496739</c:v>
                </c:pt>
                <c:pt idx="66">
                  <c:v>0.5488113675416143</c:v>
                </c:pt>
                <c:pt idx="67">
                  <c:v>0.56221088233067129</c:v>
                </c:pt>
                <c:pt idx="68">
                  <c:v>0.58321994443839442</c:v>
                </c:pt>
                <c:pt idx="69">
                  <c:v>0.59451930910096951</c:v>
                </c:pt>
                <c:pt idx="70">
                  <c:v>0.61246616683159938</c:v>
                </c:pt>
                <c:pt idx="71">
                  <c:v>0.62440593488687646</c:v>
                </c:pt>
                <c:pt idx="72">
                  <c:v>0.64200644300616605</c:v>
                </c:pt>
                <c:pt idx="73">
                  <c:v>0.65535158273344518</c:v>
                </c:pt>
                <c:pt idx="74">
                  <c:v>0.66963407795789553</c:v>
                </c:pt>
                <c:pt idx="75">
                  <c:v>0.68579216627502437</c:v>
                </c:pt>
                <c:pt idx="76">
                  <c:v>0.70173332140826328</c:v>
                </c:pt>
                <c:pt idx="77">
                  <c:v>0.71608720359099054</c:v>
                </c:pt>
                <c:pt idx="78">
                  <c:v>0.73533156496840912</c:v>
                </c:pt>
                <c:pt idx="79">
                  <c:v>0.74627437288173903</c:v>
                </c:pt>
                <c:pt idx="80">
                  <c:v>0.76265430893063757</c:v>
                </c:pt>
                <c:pt idx="81">
                  <c:v>0.77799828348968825</c:v>
                </c:pt>
                <c:pt idx="82">
                  <c:v>0.79435654512230558</c:v>
                </c:pt>
                <c:pt idx="83">
                  <c:v>0.8074446791983817</c:v>
                </c:pt>
                <c:pt idx="84">
                  <c:v>0.8223722403353162</c:v>
                </c:pt>
                <c:pt idx="85">
                  <c:v>0.83917596162814712</c:v>
                </c:pt>
                <c:pt idx="86">
                  <c:v>0.8525245667417517</c:v>
                </c:pt>
                <c:pt idx="87">
                  <c:v>0.86629141248116825</c:v>
                </c:pt>
                <c:pt idx="88">
                  <c:v>0.88351532761755724</c:v>
                </c:pt>
                <c:pt idx="89">
                  <c:v>0.90035584501244725</c:v>
                </c:pt>
                <c:pt idx="90">
                  <c:v>0.91044257648966498</c:v>
                </c:pt>
                <c:pt idx="91">
                  <c:v>0.92473181346569255</c:v>
                </c:pt>
                <c:pt idx="92">
                  <c:v>0.93722459417127812</c:v>
                </c:pt>
                <c:pt idx="93">
                  <c:v>0.9522333713622485</c:v>
                </c:pt>
                <c:pt idx="94">
                  <c:v>0.96391084117629711</c:v>
                </c:pt>
                <c:pt idx="95">
                  <c:v>0.9779619116013204</c:v>
                </c:pt>
                <c:pt idx="96">
                  <c:v>0.9939436432580625</c:v>
                </c:pt>
                <c:pt idx="97">
                  <c:v>1.0028372107203627</c:v>
                </c:pt>
                <c:pt idx="98">
                  <c:v>1.0155165552242358</c:v>
                </c:pt>
                <c:pt idx="99">
                  <c:v>1.0267253787932127</c:v>
                </c:pt>
                <c:pt idx="100">
                  <c:v>1.0375612637866882</c:v>
                </c:pt>
                <c:pt idx="101">
                  <c:v>1.0514779402293564</c:v>
                </c:pt>
                <c:pt idx="102">
                  <c:v>1.0624821799911597</c:v>
                </c:pt>
                <c:pt idx="103">
                  <c:v>1.0692490083628172</c:v>
                </c:pt>
                <c:pt idx="104">
                  <c:v>1.0820747181836186</c:v>
                </c:pt>
                <c:pt idx="105">
                  <c:v>1.0934169906295887</c:v>
                </c:pt>
                <c:pt idx="106">
                  <c:v>1.1012908524142506</c:v>
                </c:pt>
                <c:pt idx="107">
                  <c:v>1.1202389547644662</c:v>
                </c:pt>
                <c:pt idx="108">
                  <c:v>1.1240546601424768</c:v>
                </c:pt>
                <c:pt idx="109">
                  <c:v>1.1363467004693586</c:v>
                </c:pt>
                <c:pt idx="110">
                  <c:v>1.1502320624210625</c:v>
                </c:pt>
                <c:pt idx="111">
                  <c:v>1.1572340330065678</c:v>
                </c:pt>
                <c:pt idx="112">
                  <c:v>1.1673543472276184</c:v>
                </c:pt>
                <c:pt idx="113">
                  <c:v>1.173389033979517</c:v>
                </c:pt>
                <c:pt idx="114">
                  <c:v>1.1886406402412739</c:v>
                </c:pt>
                <c:pt idx="115">
                  <c:v>1.1995501804458912</c:v>
                </c:pt>
                <c:pt idx="116">
                  <c:v>1.2090294612039969</c:v>
                </c:pt>
                <c:pt idx="117">
                  <c:v>1.217053279705961</c:v>
                </c:pt>
                <c:pt idx="118">
                  <c:v>1.2315853457527728</c:v>
                </c:pt>
                <c:pt idx="119">
                  <c:v>1.2371350044333416</c:v>
                </c:pt>
                <c:pt idx="120">
                  <c:v>1.2547023708579652</c:v>
                </c:pt>
                <c:pt idx="121">
                  <c:v>1.2580319140382106</c:v>
                </c:pt>
                <c:pt idx="122">
                  <c:v>1.2700230328181068</c:v>
                </c:pt>
                <c:pt idx="123">
                  <c:v>1.2784022109358553</c:v>
                </c:pt>
                <c:pt idx="124">
                  <c:v>1.292351966066164</c:v>
                </c:pt>
                <c:pt idx="125">
                  <c:v>1.2983662385422634</c:v>
                </c:pt>
                <c:pt idx="126">
                  <c:v>1.3088856392538066</c:v>
                </c:pt>
                <c:pt idx="127">
                  <c:v>1.316592910466815</c:v>
                </c:pt>
                <c:pt idx="128">
                  <c:v>1.3271656151207265</c:v>
                </c:pt>
                <c:pt idx="129">
                  <c:v>1.3349982703116439</c:v>
                </c:pt>
                <c:pt idx="130">
                  <c:v>1.3502622259501174</c:v>
                </c:pt>
                <c:pt idx="131">
                  <c:v>1.3511244140675656</c:v>
                </c:pt>
                <c:pt idx="132">
                  <c:v>1.3578375604547095</c:v>
                </c:pt>
                <c:pt idx="133">
                  <c:v>1.3706360512411111</c:v>
                </c:pt>
                <c:pt idx="134">
                  <c:v>1.3758881907539948</c:v>
                </c:pt>
                <c:pt idx="135">
                  <c:v>1.3823132690270667</c:v>
                </c:pt>
                <c:pt idx="136">
                  <c:v>1.3836327621252549</c:v>
                </c:pt>
                <c:pt idx="137">
                  <c:v>1.39443682857157</c:v>
                </c:pt>
                <c:pt idx="138">
                  <c:v>1.4010201804891196</c:v>
                </c:pt>
                <c:pt idx="139">
                  <c:v>1.4146915705870624</c:v>
                </c:pt>
                <c:pt idx="140">
                  <c:v>1.4229894696437539</c:v>
                </c:pt>
                <c:pt idx="141">
                  <c:v>1.4326930554075676</c:v>
                </c:pt>
                <c:pt idx="142">
                  <c:v>1.4358838571207981</c:v>
                </c:pt>
                <c:pt idx="143">
                  <c:v>1.4416802513076439</c:v>
                </c:pt>
                <c:pt idx="144">
                  <c:v>1.4521077877780857</c:v>
                </c:pt>
                <c:pt idx="145">
                  <c:v>1.4562729301116184</c:v>
                </c:pt>
                <c:pt idx="146">
                  <c:v>1.4682336795059125</c:v>
                </c:pt>
                <c:pt idx="147">
                  <c:v>1.4748138810722569</c:v>
                </c:pt>
                <c:pt idx="148">
                  <c:v>1.4848703061708934</c:v>
                </c:pt>
                <c:pt idx="149">
                  <c:v>1.487996462677422</c:v>
                </c:pt>
                <c:pt idx="150">
                  <c:v>1.5010608431054218</c:v>
                </c:pt>
                <c:pt idx="151">
                  <c:v>1.510962270924834</c:v>
                </c:pt>
                <c:pt idx="152">
                  <c:v>1.5180645486926672</c:v>
                </c:pt>
                <c:pt idx="153">
                  <c:v>1.5217176959485634</c:v>
                </c:pt>
                <c:pt idx="154">
                  <c:v>1.5337137292763394</c:v>
                </c:pt>
                <c:pt idx="155">
                  <c:v>1.5438341695114368</c:v>
                </c:pt>
                <c:pt idx="156">
                  <c:v>1.5508966268400561</c:v>
                </c:pt>
                <c:pt idx="157">
                  <c:v>1.5552397010095782</c:v>
                </c:pt>
                <c:pt idx="158">
                  <c:v>1.5618134758594684</c:v>
                </c:pt>
                <c:pt idx="159">
                  <c:v>1.5806011623263858</c:v>
                </c:pt>
                <c:pt idx="160">
                  <c:v>1.587093028044978</c:v>
                </c:pt>
                <c:pt idx="161">
                  <c:v>1.5898895318015425</c:v>
                </c:pt>
                <c:pt idx="162">
                  <c:v>1.6004613543571173</c:v>
                </c:pt>
                <c:pt idx="163">
                  <c:v>1.6083861258172336</c:v>
                </c:pt>
                <c:pt idx="164">
                  <c:v>1.610962104989534</c:v>
                </c:pt>
                <c:pt idx="165">
                  <c:v>1.624397092733147</c:v>
                </c:pt>
                <c:pt idx="166">
                  <c:v>1.6268815857064896</c:v>
                </c:pt>
                <c:pt idx="167">
                  <c:v>1.6337307012515891</c:v>
                </c:pt>
                <c:pt idx="168">
                  <c:v>1.6457040520506989</c:v>
                </c:pt>
                <c:pt idx="169">
                  <c:v>1.6480341778150582</c:v>
                </c:pt>
                <c:pt idx="170">
                  <c:v>1.6610079541424367</c:v>
                </c:pt>
                <c:pt idx="171">
                  <c:v>1.6619538155878573</c:v>
                </c:pt>
                <c:pt idx="172">
                  <c:v>1.674993119220276</c:v>
                </c:pt>
                <c:pt idx="173">
                  <c:v>1.680131090005534</c:v>
                </c:pt>
                <c:pt idx="174">
                  <c:v>1.6858420466677326</c:v>
                </c:pt>
                <c:pt idx="175">
                  <c:v>1.6937417413322675</c:v>
                </c:pt>
                <c:pt idx="176">
                  <c:v>1.6974848626185424</c:v>
                </c:pt>
                <c:pt idx="177">
                  <c:v>1.7032408062959314</c:v>
                </c:pt>
                <c:pt idx="178">
                  <c:v>1.711179691329441</c:v>
                </c:pt>
                <c:pt idx="179">
                  <c:v>1.7230411416537919</c:v>
                </c:pt>
                <c:pt idx="180">
                  <c:v>1.7307283766331429</c:v>
                </c:pt>
                <c:pt idx="181">
                  <c:v>1.73354516865146</c:v>
                </c:pt>
                <c:pt idx="182">
                  <c:v>1.7385175569774494</c:v>
                </c:pt>
                <c:pt idx="183">
                  <c:v>1.7487003741663818</c:v>
                </c:pt>
                <c:pt idx="184">
                  <c:v>1.7610265643003118</c:v>
                </c:pt>
                <c:pt idx="185">
                  <c:v>1.7674287080166207</c:v>
                </c:pt>
                <c:pt idx="186">
                  <c:v>1.7726225030252083</c:v>
                </c:pt>
                <c:pt idx="187">
                  <c:v>1.7826364613896186</c:v>
                </c:pt>
                <c:pt idx="188">
                  <c:v>1.7849824649240458</c:v>
                </c:pt>
                <c:pt idx="189">
                  <c:v>1.7873060379578998</c:v>
                </c:pt>
                <c:pt idx="190">
                  <c:v>1.7984597933878361</c:v>
                </c:pt>
                <c:pt idx="191">
                  <c:v>1.8012884307266799</c:v>
                </c:pt>
                <c:pt idx="192">
                  <c:v>1.8158556546929272</c:v>
                </c:pt>
                <c:pt idx="193">
                  <c:v>1.8181608296757517</c:v>
                </c:pt>
                <c:pt idx="194">
                  <c:v>1.8283605327471364</c:v>
                </c:pt>
                <c:pt idx="195">
                  <c:v>1.835679554677792</c:v>
                </c:pt>
                <c:pt idx="196">
                  <c:v>1.8408296228116714</c:v>
                </c:pt>
                <c:pt idx="197">
                  <c:v>1.8447911264433925</c:v>
                </c:pt>
                <c:pt idx="198">
                  <c:v>1.852562664820957</c:v>
                </c:pt>
                <c:pt idx="199">
                  <c:v>1.8622993922794346</c:v>
                </c:pt>
                <c:pt idx="200">
                  <c:v>1.8617136789836293</c:v>
                </c:pt>
                <c:pt idx="201">
                  <c:v>1.8677797432335193</c:v>
                </c:pt>
                <c:pt idx="202">
                  <c:v>1.8675933684563035</c:v>
                </c:pt>
                <c:pt idx="203">
                  <c:v>1.8709511387833333</c:v>
                </c:pt>
                <c:pt idx="204">
                  <c:v>1.8737455003010794</c:v>
                </c:pt>
                <c:pt idx="205">
                  <c:v>1.8785693180642973</c:v>
                </c:pt>
                <c:pt idx="206">
                  <c:v>1.8767343014951239</c:v>
                </c:pt>
                <c:pt idx="207">
                  <c:v>1.8775333565744494</c:v>
                </c:pt>
                <c:pt idx="208">
                  <c:v>1.881174784523866</c:v>
                </c:pt>
                <c:pt idx="209">
                  <c:v>1.8822467860314853</c:v>
                </c:pt>
                <c:pt idx="210">
                  <c:v>1.8792099734850964</c:v>
                </c:pt>
                <c:pt idx="211">
                  <c:v>1.8807535195608978</c:v>
                </c:pt>
                <c:pt idx="212">
                  <c:v>1.8774374598838068</c:v>
                </c:pt>
                <c:pt idx="213">
                  <c:v>1.8632104738475657</c:v>
                </c:pt>
                <c:pt idx="214">
                  <c:v>1.8560328396789378</c:v>
                </c:pt>
                <c:pt idx="215">
                  <c:v>1.851449834761735</c:v>
                </c:pt>
                <c:pt idx="216">
                  <c:v>1.8480751785522527</c:v>
                </c:pt>
                <c:pt idx="217">
                  <c:v>1.8472702008126649</c:v>
                </c:pt>
                <c:pt idx="218">
                  <c:v>1.8199785823203289</c:v>
                </c:pt>
                <c:pt idx="219">
                  <c:v>1.7425658842883458</c:v>
                </c:pt>
                <c:pt idx="220">
                  <c:v>1.6837470631172233</c:v>
                </c:pt>
                <c:pt idx="221">
                  <c:v>1.57666952402407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F1A-4FCD-8C7C-DF2E7516E699}"/>
            </c:ext>
          </c:extLst>
        </c:ser>
        <c:ser>
          <c:idx val="2"/>
          <c:order val="2"/>
          <c:tx>
            <c:v>EDC-TD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d28 S'!$E$7:$E$229</c:f>
              <c:numCache>
                <c:formatCode>General</c:formatCode>
                <c:ptCount val="223"/>
                <c:pt idx="0">
                  <c:v>1</c:v>
                </c:pt>
                <c:pt idx="1">
                  <c:v>1.001171805107681</c:v>
                </c:pt>
                <c:pt idx="2">
                  <c:v>0.99782397629134367</c:v>
                </c:pt>
                <c:pt idx="3">
                  <c:v>1.0002326018141059</c:v>
                </c:pt>
                <c:pt idx="4">
                  <c:v>1.0021366648300352</c:v>
                </c:pt>
                <c:pt idx="5">
                  <c:v>1.0021366648300352</c:v>
                </c:pt>
                <c:pt idx="6">
                  <c:v>0.99994395040152839</c:v>
                </c:pt>
                <c:pt idx="7">
                  <c:v>1.003428015862887</c:v>
                </c:pt>
                <c:pt idx="8">
                  <c:v>1.0052488904972092</c:v>
                </c:pt>
                <c:pt idx="9">
                  <c:v>1.0008096501813404</c:v>
                </c:pt>
                <c:pt idx="10">
                  <c:v>1.003486939408653</c:v>
                </c:pt>
                <c:pt idx="11">
                  <c:v>1.0052488904972092</c:v>
                </c:pt>
                <c:pt idx="12">
                  <c:v>1.0030008617467969</c:v>
                </c:pt>
                <c:pt idx="13">
                  <c:v>1.0021366648300352</c:v>
                </c:pt>
                <c:pt idx="14">
                  <c:v>1.0044034837301248</c:v>
                </c:pt>
                <c:pt idx="15">
                  <c:v>1.0029727143462197</c:v>
                </c:pt>
                <c:pt idx="16">
                  <c:v>1.0021366648300352</c:v>
                </c:pt>
                <c:pt idx="17">
                  <c:v>1.0044312190407994</c:v>
                </c:pt>
                <c:pt idx="18">
                  <c:v>1.0075521050192235</c:v>
                </c:pt>
                <c:pt idx="19">
                  <c:v>1.0060503153856697</c:v>
                </c:pt>
                <c:pt idx="20">
                  <c:v>1.0052488904972092</c:v>
                </c:pt>
                <c:pt idx="21">
                  <c:v>1.0052488904972092</c:v>
                </c:pt>
                <c:pt idx="22">
                  <c:v>1.0075888219885463</c:v>
                </c:pt>
                <c:pt idx="23">
                  <c:v>1.0060096547680271</c:v>
                </c:pt>
                <c:pt idx="24">
                  <c:v>1.0076062853485801</c:v>
                </c:pt>
                <c:pt idx="25">
                  <c:v>1.0107238556471669</c:v>
                </c:pt>
                <c:pt idx="26">
                  <c:v>1.0090994858305449</c:v>
                </c:pt>
                <c:pt idx="27">
                  <c:v>1.0083611161643833</c:v>
                </c:pt>
                <c:pt idx="28">
                  <c:v>1.0059659866007495</c:v>
                </c:pt>
                <c:pt idx="29">
                  <c:v>1.0076496845998171</c:v>
                </c:pt>
                <c:pt idx="30">
                  <c:v>1.0083611161643833</c:v>
                </c:pt>
                <c:pt idx="31">
                  <c:v>1.0083611161643833</c:v>
                </c:pt>
                <c:pt idx="32">
                  <c:v>1.0107947231728869</c:v>
                </c:pt>
                <c:pt idx="33">
                  <c:v>1.0114733418315573</c:v>
                </c:pt>
                <c:pt idx="34">
                  <c:v>1.0090364384061203</c:v>
                </c:pt>
                <c:pt idx="35">
                  <c:v>1.0059030173839292</c:v>
                </c:pt>
                <c:pt idx="36">
                  <c:v>1.0077193925111325</c:v>
                </c:pt>
                <c:pt idx="37">
                  <c:v>1.0108390892089265</c:v>
                </c:pt>
                <c:pt idx="38">
                  <c:v>1.0114733418315573</c:v>
                </c:pt>
                <c:pt idx="39">
                  <c:v>1.0114733418315573</c:v>
                </c:pt>
                <c:pt idx="40">
                  <c:v>1.0114733418315573</c:v>
                </c:pt>
                <c:pt idx="41">
                  <c:v>1.0139894462828023</c:v>
                </c:pt>
                <c:pt idx="42">
                  <c:v>1.0070421192555252</c:v>
                </c:pt>
                <c:pt idx="43">
                  <c:v>1.012846224082163</c:v>
                </c:pt>
                <c:pt idx="44">
                  <c:v>1.0145855674987312</c:v>
                </c:pt>
                <c:pt idx="45">
                  <c:v>1.0145855674987312</c:v>
                </c:pt>
                <c:pt idx="46">
                  <c:v>1.0120235279307421</c:v>
                </c:pt>
                <c:pt idx="47">
                  <c:v>1.0140423283099429</c:v>
                </c:pt>
                <c:pt idx="48">
                  <c:v>1.0171641418249315</c:v>
                </c:pt>
                <c:pt idx="49">
                  <c:v>1.0176977931659053</c:v>
                </c:pt>
                <c:pt idx="50">
                  <c:v>1.0176977931659053</c:v>
                </c:pt>
                <c:pt idx="51">
                  <c:v>1.0176977931659053</c:v>
                </c:pt>
                <c:pt idx="52">
                  <c:v>1.0150813353705226</c:v>
                </c:pt>
                <c:pt idx="53">
                  <c:v>1.0172119977487362</c:v>
                </c:pt>
                <c:pt idx="54">
                  <c:v>1.0176977931659053</c:v>
                </c:pt>
                <c:pt idx="55">
                  <c:v>1.0176977931659053</c:v>
                </c:pt>
                <c:pt idx="56">
                  <c:v>1.0176977931659053</c:v>
                </c:pt>
                <c:pt idx="57">
                  <c:v>1.0150351410762475</c:v>
                </c:pt>
                <c:pt idx="58">
                  <c:v>1.0172591590838778</c:v>
                </c:pt>
                <c:pt idx="59">
                  <c:v>1.0203445101668158</c:v>
                </c:pt>
                <c:pt idx="60">
                  <c:v>1.0208100188330793</c:v>
                </c:pt>
                <c:pt idx="61">
                  <c:v>1.0181117419112589</c:v>
                </c:pt>
                <c:pt idx="62">
                  <c:v>1.020407683074076</c:v>
                </c:pt>
                <c:pt idx="63">
                  <c:v>1.0235229141117415</c:v>
                </c:pt>
                <c:pt idx="64">
                  <c:v>1.0157635577502053</c:v>
                </c:pt>
                <c:pt idx="65">
                  <c:v>1.0200518218504708</c:v>
                </c:pt>
                <c:pt idx="66">
                  <c:v>1.0235538798817325</c:v>
                </c:pt>
                <c:pt idx="67">
                  <c:v>1.0239222445002534</c:v>
                </c:pt>
                <c:pt idx="68">
                  <c:v>1.0211619301678034</c:v>
                </c:pt>
                <c:pt idx="69">
                  <c:v>1.0180410239694144</c:v>
                </c:pt>
                <c:pt idx="70">
                  <c:v>1.0204802696031263</c:v>
                </c:pt>
                <c:pt idx="71">
                  <c:v>1.023602972821958</c:v>
                </c:pt>
                <c:pt idx="72">
                  <c:v>1.0239222445002534</c:v>
                </c:pt>
                <c:pt idx="73">
                  <c:v>1.0239222445002534</c:v>
                </c:pt>
                <c:pt idx="74">
                  <c:v>1.0239222445002534</c:v>
                </c:pt>
                <c:pt idx="75">
                  <c:v>1.0210939700197983</c:v>
                </c:pt>
                <c:pt idx="76">
                  <c:v>1.0236398803806364</c:v>
                </c:pt>
                <c:pt idx="77">
                  <c:v>1.0239222445002534</c:v>
                </c:pt>
                <c:pt idx="78">
                  <c:v>1.0239222445002534</c:v>
                </c:pt>
                <c:pt idx="79">
                  <c:v>1.0239222445002534</c:v>
                </c:pt>
                <c:pt idx="80">
                  <c:v>1.0239222445002534</c:v>
                </c:pt>
                <c:pt idx="81">
                  <c:v>1.0268093767978392</c:v>
                </c:pt>
                <c:pt idx="82">
                  <c:v>1.0270344701674274</c:v>
                </c:pt>
                <c:pt idx="83">
                  <c:v>1.0241319019549029</c:v>
                </c:pt>
                <c:pt idx="84">
                  <c:v>1.0268348268831251</c:v>
                </c:pt>
                <c:pt idx="85">
                  <c:v>1.0270344701674274</c:v>
                </c:pt>
                <c:pt idx="86">
                  <c:v>1.0270344701674274</c:v>
                </c:pt>
                <c:pt idx="87">
                  <c:v>1.0270344701674274</c:v>
                </c:pt>
                <c:pt idx="88">
                  <c:v>1.0299825456092795</c:v>
                </c:pt>
                <c:pt idx="89">
                  <c:v>1.0271873037226777</c:v>
                </c:pt>
                <c:pt idx="90">
                  <c:v>1.0300023519702157</c:v>
                </c:pt>
                <c:pt idx="91">
                  <c:v>1.0301466958346015</c:v>
                </c:pt>
                <c:pt idx="92">
                  <c:v>1.0301466958346015</c:v>
                </c:pt>
                <c:pt idx="93">
                  <c:v>1.0301466958346015</c:v>
                </c:pt>
                <c:pt idx="94">
                  <c:v>1.0331518196800906</c:v>
                </c:pt>
                <c:pt idx="95">
                  <c:v>1.0302455675057294</c:v>
                </c:pt>
                <c:pt idx="96">
                  <c:v>1.0301466958346015</c:v>
                </c:pt>
                <c:pt idx="97">
                  <c:v>1.0271142531680075</c:v>
                </c:pt>
                <c:pt idx="98">
                  <c:v>1.0300779289360984</c:v>
                </c:pt>
                <c:pt idx="99">
                  <c:v>1.0331968803923286</c:v>
                </c:pt>
                <c:pt idx="100">
                  <c:v>1.0332589215017753</c:v>
                </c:pt>
                <c:pt idx="101">
                  <c:v>1.0332589215017753</c:v>
                </c:pt>
                <c:pt idx="102">
                  <c:v>1.0332589215017753</c:v>
                </c:pt>
                <c:pt idx="103">
                  <c:v>1.0363450961728515</c:v>
                </c:pt>
                <c:pt idx="104">
                  <c:v>1.0301768299685929</c:v>
                </c:pt>
                <c:pt idx="105">
                  <c:v>1.0363580382920543</c:v>
                </c:pt>
                <c:pt idx="106">
                  <c:v>1.0394818928905076</c:v>
                </c:pt>
                <c:pt idx="107">
                  <c:v>1.0363580629223237</c:v>
                </c:pt>
                <c:pt idx="108">
                  <c:v>1.0332775831285397</c:v>
                </c:pt>
                <c:pt idx="109">
                  <c:v>1.0363711471689494</c:v>
                </c:pt>
                <c:pt idx="110">
                  <c:v>1.0364053035878447</c:v>
                </c:pt>
                <c:pt idx="111">
                  <c:v>1.0393838749503663</c:v>
                </c:pt>
                <c:pt idx="112">
                  <c:v>1.0333754496781768</c:v>
                </c:pt>
                <c:pt idx="113">
                  <c:v>1.0394833728361235</c:v>
                </c:pt>
                <c:pt idx="114">
                  <c:v>1.0394066847050691</c:v>
                </c:pt>
                <c:pt idx="115">
                  <c:v>1.0363711471689494</c:v>
                </c:pt>
                <c:pt idx="116">
                  <c:v>1.0366546198171931</c:v>
                </c:pt>
                <c:pt idx="117">
                  <c:v>1.0454982871338818</c:v>
                </c:pt>
                <c:pt idx="118">
                  <c:v>1.0395956324354441</c:v>
                </c:pt>
                <c:pt idx="119">
                  <c:v>1.0427174204056826</c:v>
                </c:pt>
                <c:pt idx="120">
                  <c:v>1.0455807430210986</c:v>
                </c:pt>
                <c:pt idx="121">
                  <c:v>1.0427358524108954</c:v>
                </c:pt>
                <c:pt idx="122">
                  <c:v>1.0455613854416199</c:v>
                </c:pt>
                <c:pt idx="123">
                  <c:v>1.0440027188550172</c:v>
                </c:pt>
                <c:pt idx="124">
                  <c:v>1.044186421485285</c:v>
                </c:pt>
                <c:pt idx="125">
                  <c:v>1.0440027188550172</c:v>
                </c:pt>
                <c:pt idx="126">
                  <c:v>1.044186421485285</c:v>
                </c:pt>
                <c:pt idx="127">
                  <c:v>1.047114944522191</c:v>
                </c:pt>
                <c:pt idx="128">
                  <c:v>1.0473190976558104</c:v>
                </c:pt>
                <c:pt idx="129">
                  <c:v>1.0502271701893651</c:v>
                </c:pt>
                <c:pt idx="130">
                  <c:v>1.0502271701893651</c:v>
                </c:pt>
                <c:pt idx="131">
                  <c:v>1.0504585340397368</c:v>
                </c:pt>
                <c:pt idx="132">
                  <c:v>1.0531021100267384</c:v>
                </c:pt>
                <c:pt idx="133">
                  <c:v>1.0502271701893651</c:v>
                </c:pt>
                <c:pt idx="134">
                  <c:v>1.0504820705356723</c:v>
                </c:pt>
                <c:pt idx="135">
                  <c:v>1.0533393958565391</c:v>
                </c:pt>
                <c:pt idx="136">
                  <c:v>1.0533393958565391</c:v>
                </c:pt>
                <c:pt idx="137">
                  <c:v>1.0536317581154249</c:v>
                </c:pt>
                <c:pt idx="138">
                  <c:v>1.0567487972026643</c:v>
                </c:pt>
                <c:pt idx="139">
                  <c:v>1.0589526848888939</c:v>
                </c:pt>
                <c:pt idx="140">
                  <c:v>1.0533393958565391</c:v>
                </c:pt>
                <c:pt idx="141">
                  <c:v>1.0533393958565391</c:v>
                </c:pt>
                <c:pt idx="142">
                  <c:v>1.0540121204814958</c:v>
                </c:pt>
                <c:pt idx="143">
                  <c:v>1.059563847190887</c:v>
                </c:pt>
                <c:pt idx="144">
                  <c:v>1.0592161226892731</c:v>
                </c:pt>
                <c:pt idx="145">
                  <c:v>1.0568060465066333</c:v>
                </c:pt>
                <c:pt idx="146">
                  <c:v>1.0599329918980449</c:v>
                </c:pt>
                <c:pt idx="147">
                  <c:v>1.0622928207311533</c:v>
                </c:pt>
                <c:pt idx="148">
                  <c:v>1.059563847190887</c:v>
                </c:pt>
                <c:pt idx="149">
                  <c:v>1.0599564748947725</c:v>
                </c:pt>
                <c:pt idx="150">
                  <c:v>1.0626760728580611</c:v>
                </c:pt>
                <c:pt idx="151">
                  <c:v>1.0618420292664201</c:v>
                </c:pt>
                <c:pt idx="152">
                  <c:v>1.0568795287082806</c:v>
                </c:pt>
                <c:pt idx="153">
                  <c:v>1.059563847190887</c:v>
                </c:pt>
                <c:pt idx="154">
                  <c:v>1.0600083372184634</c:v>
                </c:pt>
                <c:pt idx="155">
                  <c:v>1.0622256331407762</c:v>
                </c:pt>
                <c:pt idx="156">
                  <c:v>1.0600276163571243</c:v>
                </c:pt>
                <c:pt idx="157">
                  <c:v>1.0626760728580611</c:v>
                </c:pt>
                <c:pt idx="158">
                  <c:v>1.062193497894903</c:v>
                </c:pt>
                <c:pt idx="159">
                  <c:v>1.0605428349020407</c:v>
                </c:pt>
                <c:pt idx="160">
                  <c:v>1.0657882985252352</c:v>
                </c:pt>
                <c:pt idx="161">
                  <c:v>1.0662849487667478</c:v>
                </c:pt>
                <c:pt idx="162">
                  <c:v>1.0678642385772323</c:v>
                </c:pt>
                <c:pt idx="163">
                  <c:v>1.0637325120129022</c:v>
                </c:pt>
                <c:pt idx="164">
                  <c:v>1.0694297750261594</c:v>
                </c:pt>
                <c:pt idx="165">
                  <c:v>1.0714948328328375</c:v>
                </c:pt>
                <c:pt idx="166">
                  <c:v>1.068900524192409</c:v>
                </c:pt>
                <c:pt idx="167">
                  <c:v>1.0683385552711464</c:v>
                </c:pt>
                <c:pt idx="168">
                  <c:v>1.0669345966101529</c:v>
                </c:pt>
                <c:pt idx="169">
                  <c:v>1.0714342153166296</c:v>
                </c:pt>
                <c:pt idx="170">
                  <c:v>1.0683193533464344</c:v>
                </c:pt>
                <c:pt idx="171">
                  <c:v>1.0669920299584839</c:v>
                </c:pt>
                <c:pt idx="172">
                  <c:v>1.0720127498595831</c:v>
                </c:pt>
                <c:pt idx="173">
                  <c:v>1.0720127498595831</c:v>
                </c:pt>
                <c:pt idx="174">
                  <c:v>1.0720127498595831</c:v>
                </c:pt>
                <c:pt idx="175">
                  <c:v>1.0726445370845918</c:v>
                </c:pt>
                <c:pt idx="176">
                  <c:v>1.0751249755267571</c:v>
                </c:pt>
                <c:pt idx="177">
                  <c:v>1.0751249755267571</c:v>
                </c:pt>
                <c:pt idx="178">
                  <c:v>1.0751249755267571</c:v>
                </c:pt>
                <c:pt idx="179">
                  <c:v>1.0751249755267571</c:v>
                </c:pt>
                <c:pt idx="180">
                  <c:v>1.0751249755267571</c:v>
                </c:pt>
                <c:pt idx="181">
                  <c:v>1.0751249755267571</c:v>
                </c:pt>
                <c:pt idx="182">
                  <c:v>1.0751249755267571</c:v>
                </c:pt>
                <c:pt idx="183">
                  <c:v>1.0765284264554562</c:v>
                </c:pt>
                <c:pt idx="184">
                  <c:v>1.0806294383823842</c:v>
                </c:pt>
                <c:pt idx="185">
                  <c:v>1.0782372011939312</c:v>
                </c:pt>
                <c:pt idx="186">
                  <c:v>1.0796789029215426</c:v>
                </c:pt>
                <c:pt idx="187">
                  <c:v>1.0829648308974009</c:v>
                </c:pt>
                <c:pt idx="188">
                  <c:v>1.0782372011939312</c:v>
                </c:pt>
                <c:pt idx="189">
                  <c:v>1.0797722118636679</c:v>
                </c:pt>
                <c:pt idx="190">
                  <c:v>1.0844616525282793</c:v>
                </c:pt>
                <c:pt idx="191">
                  <c:v>1.0836749650533151</c:v>
                </c:pt>
                <c:pt idx="192">
                  <c:v>1.0821441607200759</c:v>
                </c:pt>
                <c:pt idx="193">
                  <c:v>1.083657186358117</c:v>
                </c:pt>
                <c:pt idx="194">
                  <c:v>1.0813494268611052</c:v>
                </c:pt>
                <c:pt idx="195">
                  <c:v>1.0805283463388251</c:v>
                </c:pt>
                <c:pt idx="196">
                  <c:v>1.0790687748089736</c:v>
                </c:pt>
                <c:pt idx="197">
                  <c:v>1.0813494268611052</c:v>
                </c:pt>
                <c:pt idx="198">
                  <c:v>1.0822008203128552</c:v>
                </c:pt>
                <c:pt idx="199">
                  <c:v>1.0844616525282793</c:v>
                </c:pt>
                <c:pt idx="200">
                  <c:v>1.0853191253532097</c:v>
                </c:pt>
                <c:pt idx="201">
                  <c:v>1.0875738781954534</c:v>
                </c:pt>
                <c:pt idx="202">
                  <c:v>1.0866886770319799</c:v>
                </c:pt>
                <c:pt idx="203">
                  <c:v>1.0853583398627866</c:v>
                </c:pt>
              </c:numCache>
            </c:numRef>
          </c:xVal>
          <c:yVal>
            <c:numRef>
              <c:f>'d28 S'!$F$7:$F$229</c:f>
              <c:numCache>
                <c:formatCode>General</c:formatCode>
                <c:ptCount val="223"/>
                <c:pt idx="0">
                  <c:v>0</c:v>
                </c:pt>
                <c:pt idx="1">
                  <c:v>3.6911995686331033E-3</c:v>
                </c:pt>
                <c:pt idx="2">
                  <c:v>4.4394153939300261E-3</c:v>
                </c:pt>
                <c:pt idx="3">
                  <c:v>9.694139967345675E-3</c:v>
                </c:pt>
                <c:pt idx="4">
                  <c:v>8.0786260766147373E-3</c:v>
                </c:pt>
                <c:pt idx="5">
                  <c:v>8.730592736146011E-3</c:v>
                </c:pt>
                <c:pt idx="6">
                  <c:v>1.2460080702462262E-2</c:v>
                </c:pt>
                <c:pt idx="7">
                  <c:v>1.3415900866675651E-2</c:v>
                </c:pt>
                <c:pt idx="8">
                  <c:v>1.440825305438082E-2</c:v>
                </c:pt>
                <c:pt idx="9">
                  <c:v>1.6180085297562E-2</c:v>
                </c:pt>
                <c:pt idx="10">
                  <c:v>2.1632929719299476E-2</c:v>
                </c:pt>
                <c:pt idx="11">
                  <c:v>2.2170732686040896E-2</c:v>
                </c:pt>
                <c:pt idx="12">
                  <c:v>2.4492309421475438E-2</c:v>
                </c:pt>
                <c:pt idx="13">
                  <c:v>2.7534702964588181E-2</c:v>
                </c:pt>
                <c:pt idx="14">
                  <c:v>3.3326528654680006E-2</c:v>
                </c:pt>
                <c:pt idx="15">
                  <c:v>3.7896264355087944E-2</c:v>
                </c:pt>
                <c:pt idx="16">
                  <c:v>4.2213087768826638E-2</c:v>
                </c:pt>
                <c:pt idx="17">
                  <c:v>4.6907880389950918E-2</c:v>
                </c:pt>
                <c:pt idx="18">
                  <c:v>5.3014096850417261E-2</c:v>
                </c:pt>
                <c:pt idx="19">
                  <c:v>5.6042090713722556E-2</c:v>
                </c:pt>
                <c:pt idx="20">
                  <c:v>6.4087692408065819E-2</c:v>
                </c:pt>
                <c:pt idx="21">
                  <c:v>7.4477356905005732E-2</c:v>
                </c:pt>
                <c:pt idx="22">
                  <c:v>8.2226489072267026E-2</c:v>
                </c:pt>
                <c:pt idx="23">
                  <c:v>9.4485649312376158E-2</c:v>
                </c:pt>
                <c:pt idx="24">
                  <c:v>0.10346213030760958</c:v>
                </c:pt>
                <c:pt idx="25">
                  <c:v>0.11266623907711343</c:v>
                </c:pt>
                <c:pt idx="26">
                  <c:v>0.12028083095244178</c:v>
                </c:pt>
                <c:pt idx="27">
                  <c:v>0.13599055924155093</c:v>
                </c:pt>
                <c:pt idx="28">
                  <c:v>0.14926279247727231</c:v>
                </c:pt>
                <c:pt idx="29">
                  <c:v>0.15735933482993941</c:v>
                </c:pt>
                <c:pt idx="30">
                  <c:v>0.1759856967720014</c:v>
                </c:pt>
                <c:pt idx="31">
                  <c:v>0.18799262978483555</c:v>
                </c:pt>
                <c:pt idx="32">
                  <c:v>0.20076428609172592</c:v>
                </c:pt>
                <c:pt idx="33">
                  <c:v>0.21817665114772714</c:v>
                </c:pt>
                <c:pt idx="34">
                  <c:v>0.22924463190485359</c:v>
                </c:pt>
                <c:pt idx="35">
                  <c:v>0.24944190219964926</c:v>
                </c:pt>
                <c:pt idx="36">
                  <c:v>0.26333940212890161</c:v>
                </c:pt>
                <c:pt idx="37">
                  <c:v>0.27492023715380065</c:v>
                </c:pt>
                <c:pt idx="38">
                  <c:v>0.29461376939602424</c:v>
                </c:pt>
                <c:pt idx="39">
                  <c:v>0.31270795212689201</c:v>
                </c:pt>
                <c:pt idx="40">
                  <c:v>0.32914378964331031</c:v>
                </c:pt>
                <c:pt idx="41">
                  <c:v>0.34305671012519251</c:v>
                </c:pt>
                <c:pt idx="42">
                  <c:v>0.36389437215033432</c:v>
                </c:pt>
                <c:pt idx="43">
                  <c:v>0.37884009354736559</c:v>
                </c:pt>
                <c:pt idx="44">
                  <c:v>0.39225952052500018</c:v>
                </c:pt>
                <c:pt idx="45">
                  <c:v>0.4162066537061877</c:v>
                </c:pt>
                <c:pt idx="46">
                  <c:v>0.43186437121151461</c:v>
                </c:pt>
                <c:pt idx="47">
                  <c:v>0.44943620734836803</c:v>
                </c:pt>
                <c:pt idx="48">
                  <c:v>0.46701402544175979</c:v>
                </c:pt>
                <c:pt idx="49">
                  <c:v>0.48887281102976704</c:v>
                </c:pt>
                <c:pt idx="50">
                  <c:v>0.50523625612606027</c:v>
                </c:pt>
                <c:pt idx="51">
                  <c:v>0.52297773625188959</c:v>
                </c:pt>
                <c:pt idx="52">
                  <c:v>0.53893233073792568</c:v>
                </c:pt>
                <c:pt idx="53">
                  <c:v>0.55887492012866125</c:v>
                </c:pt>
                <c:pt idx="54">
                  <c:v>0.57948494542450502</c:v>
                </c:pt>
                <c:pt idx="55">
                  <c:v>0.59921920511931992</c:v>
                </c:pt>
                <c:pt idx="56">
                  <c:v>0.61492825282654828</c:v>
                </c:pt>
                <c:pt idx="57">
                  <c:v>0.63015286951457949</c:v>
                </c:pt>
                <c:pt idx="58">
                  <c:v>0.649661999887029</c:v>
                </c:pt>
                <c:pt idx="59">
                  <c:v>0.67005810755150508</c:v>
                </c:pt>
                <c:pt idx="60">
                  <c:v>0.68827305774623093</c:v>
                </c:pt>
                <c:pt idx="61">
                  <c:v>0.70459018745448343</c:v>
                </c:pt>
                <c:pt idx="62">
                  <c:v>0.72312450965210595</c:v>
                </c:pt>
                <c:pt idx="63">
                  <c:v>0.74328384646203394</c:v>
                </c:pt>
                <c:pt idx="64">
                  <c:v>0.76026343308163002</c:v>
                </c:pt>
                <c:pt idx="65">
                  <c:v>0.77817849740732947</c:v>
                </c:pt>
                <c:pt idx="66">
                  <c:v>0.79481485583808187</c:v>
                </c:pt>
                <c:pt idx="67">
                  <c:v>0.81121910002716124</c:v>
                </c:pt>
                <c:pt idx="68">
                  <c:v>0.82677211538304107</c:v>
                </c:pt>
                <c:pt idx="69">
                  <c:v>0.84451187614412038</c:v>
                </c:pt>
                <c:pt idx="70">
                  <c:v>0.86766125989994969</c:v>
                </c:pt>
                <c:pt idx="71">
                  <c:v>0.88076274767865159</c:v>
                </c:pt>
                <c:pt idx="72">
                  <c:v>0.89695651296586565</c:v>
                </c:pt>
                <c:pt idx="73">
                  <c:v>0.91581335933509633</c:v>
                </c:pt>
                <c:pt idx="74">
                  <c:v>0.93314627541146422</c:v>
                </c:pt>
                <c:pt idx="75">
                  <c:v>0.95014104975304592</c:v>
                </c:pt>
                <c:pt idx="76">
                  <c:v>0.96716132800513488</c:v>
                </c:pt>
                <c:pt idx="77">
                  <c:v>0.97275714387461321</c:v>
                </c:pt>
                <c:pt idx="78">
                  <c:v>0.99204110910460119</c:v>
                </c:pt>
                <c:pt idx="79">
                  <c:v>1.0114971540902984</c:v>
                </c:pt>
                <c:pt idx="80">
                  <c:v>1.0262584736175582</c:v>
                </c:pt>
                <c:pt idx="81">
                  <c:v>1.0445191302586374</c:v>
                </c:pt>
                <c:pt idx="82">
                  <c:v>1.059902931466731</c:v>
                </c:pt>
                <c:pt idx="83">
                  <c:v>1.0754876117901471</c:v>
                </c:pt>
                <c:pt idx="84">
                  <c:v>1.0889603390751301</c:v>
                </c:pt>
                <c:pt idx="85">
                  <c:v>1.1067998946320867</c:v>
                </c:pt>
                <c:pt idx="86">
                  <c:v>1.1212833218311204</c:v>
                </c:pt>
                <c:pt idx="87">
                  <c:v>1.1253588610578369</c:v>
                </c:pt>
                <c:pt idx="88">
                  <c:v>1.1354253118462601</c:v>
                </c:pt>
                <c:pt idx="89">
                  <c:v>1.1521133945000028</c:v>
                </c:pt>
                <c:pt idx="90">
                  <c:v>1.1624127475722792</c:v>
                </c:pt>
                <c:pt idx="91">
                  <c:v>1.1605980297155412</c:v>
                </c:pt>
                <c:pt idx="92">
                  <c:v>1.1678445073882286</c:v>
                </c:pt>
                <c:pt idx="93">
                  <c:v>1.1717334955392287</c:v>
                </c:pt>
                <c:pt idx="94">
                  <c:v>1.178878459051284</c:v>
                </c:pt>
                <c:pt idx="95">
                  <c:v>1.1840165656954353</c:v>
                </c:pt>
                <c:pt idx="96">
                  <c:v>1.1892118412176325</c:v>
                </c:pt>
                <c:pt idx="97">
                  <c:v>1.2093360026903199</c:v>
                </c:pt>
                <c:pt idx="98">
                  <c:v>1.2229033666769209</c:v>
                </c:pt>
                <c:pt idx="99">
                  <c:v>1.2272205482916494</c:v>
                </c:pt>
                <c:pt idx="100">
                  <c:v>1.2446332715486421</c:v>
                </c:pt>
                <c:pt idx="101">
                  <c:v>1.2505617844978514</c:v>
                </c:pt>
                <c:pt idx="102">
                  <c:v>1.2529773486956133</c:v>
                </c:pt>
                <c:pt idx="103">
                  <c:v>1.273094489428892</c:v>
                </c:pt>
                <c:pt idx="104">
                  <c:v>1.2803311523944452</c:v>
                </c:pt>
                <c:pt idx="105">
                  <c:v>1.2898465467794906</c:v>
                </c:pt>
                <c:pt idx="106">
                  <c:v>1.3052890213097841</c:v>
                </c:pt>
                <c:pt idx="107">
                  <c:v>1.3142029245920221</c:v>
                </c:pt>
                <c:pt idx="108">
                  <c:v>1.3286010283151806</c:v>
                </c:pt>
                <c:pt idx="109">
                  <c:v>1.340264339118082</c:v>
                </c:pt>
                <c:pt idx="110">
                  <c:v>1.3549181983482697</c:v>
                </c:pt>
                <c:pt idx="111">
                  <c:v>1.3616542396098683</c:v>
                </c:pt>
                <c:pt idx="112">
                  <c:v>1.3724727691973946</c:v>
                </c:pt>
                <c:pt idx="113">
                  <c:v>1.3869618559720747</c:v>
                </c:pt>
                <c:pt idx="114">
                  <c:v>1.3913046847777049</c:v>
                </c:pt>
                <c:pt idx="115">
                  <c:v>1.4039670897825725</c:v>
                </c:pt>
                <c:pt idx="116">
                  <c:v>1.4146767262690652</c:v>
                </c:pt>
                <c:pt idx="117">
                  <c:v>1.418371497843159</c:v>
                </c:pt>
                <c:pt idx="118">
                  <c:v>1.4351089405933561</c:v>
                </c:pt>
                <c:pt idx="119">
                  <c:v>1.4371889421034643</c:v>
                </c:pt>
                <c:pt idx="120">
                  <c:v>1.450466736409558</c:v>
                </c:pt>
                <c:pt idx="121">
                  <c:v>1.465357724695284</c:v>
                </c:pt>
                <c:pt idx="122">
                  <c:v>1.4732649399145603</c:v>
                </c:pt>
                <c:pt idx="123">
                  <c:v>1.479821880681041</c:v>
                </c:pt>
                <c:pt idx="124">
                  <c:v>1.4918766335260725</c:v>
                </c:pt>
                <c:pt idx="125">
                  <c:v>1.5049877927315101</c:v>
                </c:pt>
                <c:pt idx="126">
                  <c:v>1.5163049380974452</c:v>
                </c:pt>
                <c:pt idx="127">
                  <c:v>1.5221732732802937</c:v>
                </c:pt>
                <c:pt idx="128">
                  <c:v>1.531788677381813</c:v>
                </c:pt>
                <c:pt idx="129">
                  <c:v>1.534626345626469</c:v>
                </c:pt>
                <c:pt idx="130">
                  <c:v>1.5479726279618968</c:v>
                </c:pt>
                <c:pt idx="131">
                  <c:v>1.5487950574354787</c:v>
                </c:pt>
                <c:pt idx="132">
                  <c:v>1.5573123605813297</c:v>
                </c:pt>
                <c:pt idx="133">
                  <c:v>1.5631624991538753</c:v>
                </c:pt>
                <c:pt idx="134">
                  <c:v>1.5681882023272913</c:v>
                </c:pt>
                <c:pt idx="135">
                  <c:v>1.5766037763919138</c:v>
                </c:pt>
                <c:pt idx="136">
                  <c:v>1.5796397447047648</c:v>
                </c:pt>
                <c:pt idx="137">
                  <c:v>1.588926750138433</c:v>
                </c:pt>
                <c:pt idx="138">
                  <c:v>1.5937607441418753</c:v>
                </c:pt>
                <c:pt idx="139">
                  <c:v>1.6096046903420269</c:v>
                </c:pt>
                <c:pt idx="140">
                  <c:v>1.6215353623640389</c:v>
                </c:pt>
                <c:pt idx="141">
                  <c:v>1.6253572236494691</c:v>
                </c:pt>
                <c:pt idx="142">
                  <c:v>1.6327132391849715</c:v>
                </c:pt>
                <c:pt idx="143">
                  <c:v>1.6417477845607216</c:v>
                </c:pt>
                <c:pt idx="144">
                  <c:v>1.6517822838208176</c:v>
                </c:pt>
                <c:pt idx="145">
                  <c:v>1.668836662807176</c:v>
                </c:pt>
                <c:pt idx="146">
                  <c:v>1.6716685998359859</c:v>
                </c:pt>
                <c:pt idx="147">
                  <c:v>1.6799980623825557</c:v>
                </c:pt>
                <c:pt idx="148">
                  <c:v>1.6885438783272264</c:v>
                </c:pt>
                <c:pt idx="149">
                  <c:v>1.6965307574467334</c:v>
                </c:pt>
                <c:pt idx="150">
                  <c:v>1.7065823070739643</c:v>
                </c:pt>
                <c:pt idx="151">
                  <c:v>1.7106074832414524</c:v>
                </c:pt>
                <c:pt idx="152">
                  <c:v>1.7192111844661471</c:v>
                </c:pt>
                <c:pt idx="153">
                  <c:v>1.7327805543782937</c:v>
                </c:pt>
                <c:pt idx="154">
                  <c:v>1.7389711271719595</c:v>
                </c:pt>
                <c:pt idx="155">
                  <c:v>1.7518057552129354</c:v>
                </c:pt>
                <c:pt idx="156">
                  <c:v>1.7505182375736277</c:v>
                </c:pt>
                <c:pt idx="157">
                  <c:v>1.7622736776712167</c:v>
                </c:pt>
                <c:pt idx="158">
                  <c:v>1.7734580021099715</c:v>
                </c:pt>
                <c:pt idx="159">
                  <c:v>1.7831009160475413</c:v>
                </c:pt>
                <c:pt idx="160">
                  <c:v>1.7853273501224547</c:v>
                </c:pt>
                <c:pt idx="161">
                  <c:v>1.7968849199930388</c:v>
                </c:pt>
                <c:pt idx="162">
                  <c:v>1.8037189650455654</c:v>
                </c:pt>
                <c:pt idx="163">
                  <c:v>1.8100020969751109</c:v>
                </c:pt>
                <c:pt idx="164">
                  <c:v>1.8214387381913875</c:v>
                </c:pt>
                <c:pt idx="165">
                  <c:v>1.8245731401363563</c:v>
                </c:pt>
                <c:pt idx="166">
                  <c:v>1.8305583921224187</c:v>
                </c:pt>
                <c:pt idx="167">
                  <c:v>1.8401464296682841</c:v>
                </c:pt>
                <c:pt idx="168">
                  <c:v>1.8437376095160003</c:v>
                </c:pt>
                <c:pt idx="169">
                  <c:v>1.8555436275934116</c:v>
                </c:pt>
                <c:pt idx="170">
                  <c:v>1.8605868109751518</c:v>
                </c:pt>
                <c:pt idx="171">
                  <c:v>1.8624954491315293</c:v>
                </c:pt>
                <c:pt idx="172">
                  <c:v>1.8665799433830002</c:v>
                </c:pt>
                <c:pt idx="173">
                  <c:v>1.8725365392898443</c:v>
                </c:pt>
                <c:pt idx="174">
                  <c:v>1.8749413574578992</c:v>
                </c:pt>
                <c:pt idx="175">
                  <c:v>1.8715572177825388</c:v>
                </c:pt>
                <c:pt idx="176">
                  <c:v>1.8730401698821182</c:v>
                </c:pt>
                <c:pt idx="177">
                  <c:v>1.8808466589829405</c:v>
                </c:pt>
                <c:pt idx="178">
                  <c:v>1.8797858109302552</c:v>
                </c:pt>
                <c:pt idx="179">
                  <c:v>1.8794022493099114</c:v>
                </c:pt>
                <c:pt idx="180">
                  <c:v>1.8840296329821855</c:v>
                </c:pt>
                <c:pt idx="181">
                  <c:v>1.8803208199292745</c:v>
                </c:pt>
                <c:pt idx="182">
                  <c:v>1.8732015036081204</c:v>
                </c:pt>
                <c:pt idx="183">
                  <c:v>1.8540244255536182</c:v>
                </c:pt>
                <c:pt idx="184">
                  <c:v>1.7767199236074642</c:v>
                </c:pt>
                <c:pt idx="185">
                  <c:v>1.7466900719507694</c:v>
                </c:pt>
                <c:pt idx="186">
                  <c:v>1.7394521194616495</c:v>
                </c:pt>
                <c:pt idx="187">
                  <c:v>1.7219234823642191</c:v>
                </c:pt>
                <c:pt idx="188">
                  <c:v>1.6895918311442624</c:v>
                </c:pt>
                <c:pt idx="189">
                  <c:v>1.6740787193786952</c:v>
                </c:pt>
                <c:pt idx="190">
                  <c:v>1.6598433821855003</c:v>
                </c:pt>
                <c:pt idx="191">
                  <c:v>1.6376774750684642</c:v>
                </c:pt>
                <c:pt idx="192">
                  <c:v>1.6112700383858345</c:v>
                </c:pt>
                <c:pt idx="193">
                  <c:v>1.5734071907550411</c:v>
                </c:pt>
                <c:pt idx="194">
                  <c:v>1.5522277691651156</c:v>
                </c:pt>
                <c:pt idx="195">
                  <c:v>1.5307633628673585</c:v>
                </c:pt>
                <c:pt idx="196">
                  <c:v>1.4947263373240003</c:v>
                </c:pt>
                <c:pt idx="197">
                  <c:v>1.4725968234275699</c:v>
                </c:pt>
                <c:pt idx="198">
                  <c:v>1.4469666828937575</c:v>
                </c:pt>
                <c:pt idx="199">
                  <c:v>1.4193929437869186</c:v>
                </c:pt>
                <c:pt idx="200">
                  <c:v>1.3770309484383561</c:v>
                </c:pt>
                <c:pt idx="201">
                  <c:v>1.3300844102559499</c:v>
                </c:pt>
                <c:pt idx="202">
                  <c:v>1.2988593135350341</c:v>
                </c:pt>
                <c:pt idx="203">
                  <c:v>1.24326723625227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F1A-4FCD-8C7C-DF2E7516E6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8199520"/>
        <c:axId val="518182048"/>
      </c:scatterChart>
      <c:valAx>
        <c:axId val="518199520"/>
        <c:scaling>
          <c:orientation val="minMax"/>
          <c:max val="1.1600000000000001"/>
          <c:min val="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8182048"/>
        <c:crosses val="autoZero"/>
        <c:crossBetween val="midCat"/>
        <c:majorUnit val="4.0000000000000008E-2"/>
      </c:valAx>
      <c:valAx>
        <c:axId val="518182048"/>
        <c:scaling>
          <c:orientation val="minMax"/>
          <c:max val="3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819952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5.0925925925925923E-2"/>
          <c:w val="0.88829418197725285"/>
          <c:h val="0.8416746864975212"/>
        </c:manualLayout>
      </c:layout>
      <c:scatterChart>
        <c:scatterStyle val="lineMarker"/>
        <c:varyColors val="0"/>
        <c:ser>
          <c:idx val="0"/>
          <c:order val="0"/>
          <c:tx>
            <c:v>PLa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d0 s'!$A$7:$A$297</c:f>
              <c:numCache>
                <c:formatCode>General</c:formatCode>
                <c:ptCount val="291"/>
                <c:pt idx="0">
                  <c:v>1</c:v>
                </c:pt>
                <c:pt idx="1">
                  <c:v>1.0028732615919795</c:v>
                </c:pt>
                <c:pt idx="2">
                  <c:v>0.9999817258437026</c:v>
                </c:pt>
                <c:pt idx="3">
                  <c:v>1.0060169821738547</c:v>
                </c:pt>
                <c:pt idx="4">
                  <c:v>1.0064141276254952</c:v>
                </c:pt>
                <c:pt idx="5">
                  <c:v>1.0001325528724554</c:v>
                </c:pt>
                <c:pt idx="6">
                  <c:v>1.002921120231574</c:v>
                </c:pt>
                <c:pt idx="7">
                  <c:v>0.99993181647114604</c:v>
                </c:pt>
                <c:pt idx="8">
                  <c:v>1.0029393575695393</c:v>
                </c:pt>
                <c:pt idx="9">
                  <c:v>0.99991095150800047</c:v>
                </c:pt>
                <c:pt idx="10">
                  <c:v>1.0029617560513444</c:v>
                </c:pt>
                <c:pt idx="11">
                  <c:v>1.0030926288544542</c:v>
                </c:pt>
                <c:pt idx="12">
                  <c:v>1.0063027782908027</c:v>
                </c:pt>
                <c:pt idx="13">
                  <c:v>1.0032012434956274</c:v>
                </c:pt>
                <c:pt idx="14">
                  <c:v>1.0030926288544542</c:v>
                </c:pt>
                <c:pt idx="15">
                  <c:v>1.0063332566630219</c:v>
                </c:pt>
                <c:pt idx="16">
                  <c:v>1.003163283826072</c:v>
                </c:pt>
                <c:pt idx="17">
                  <c:v>1.0063540397845074</c:v>
                </c:pt>
                <c:pt idx="18">
                  <c:v>1.0064141276254952</c:v>
                </c:pt>
                <c:pt idx="19">
                  <c:v>1.0064141276254952</c:v>
                </c:pt>
                <c:pt idx="20">
                  <c:v>1.0097015122135711</c:v>
                </c:pt>
                <c:pt idx="21">
                  <c:v>1.0097356263965365</c:v>
                </c:pt>
                <c:pt idx="22">
                  <c:v>1.0163485945671629</c:v>
                </c:pt>
                <c:pt idx="23">
                  <c:v>1.0097422291428209</c:v>
                </c:pt>
                <c:pt idx="24">
                  <c:v>1.0130315325910726</c:v>
                </c:pt>
                <c:pt idx="25">
                  <c:v>1.0097356263965365</c:v>
                </c:pt>
                <c:pt idx="26">
                  <c:v>1.0097633663714214</c:v>
                </c:pt>
                <c:pt idx="27">
                  <c:v>1.0130571251675777</c:v>
                </c:pt>
                <c:pt idx="28">
                  <c:v>1.0131037015319344</c:v>
                </c:pt>
                <c:pt idx="29">
                  <c:v>1.0163446437638459</c:v>
                </c:pt>
                <c:pt idx="30">
                  <c:v>1.0131146791158838</c:v>
                </c:pt>
                <c:pt idx="31">
                  <c:v>1.016378623938619</c:v>
                </c:pt>
                <c:pt idx="32">
                  <c:v>1.0164605708644012</c:v>
                </c:pt>
                <c:pt idx="33">
                  <c:v>1.01970012270966</c:v>
                </c:pt>
                <c:pt idx="34">
                  <c:v>1.0195963180879135</c:v>
                </c:pt>
                <c:pt idx="35">
                  <c:v>1.016486258251754</c:v>
                </c:pt>
                <c:pt idx="36">
                  <c:v>1.0195762713151346</c:v>
                </c:pt>
                <c:pt idx="37">
                  <c:v>1.0166477686470381</c:v>
                </c:pt>
                <c:pt idx="38">
                  <c:v>1.022877134602904</c:v>
                </c:pt>
                <c:pt idx="39">
                  <c:v>1.0198481240938067</c:v>
                </c:pt>
                <c:pt idx="40">
                  <c:v>1.0230216214807015</c:v>
                </c:pt>
                <c:pt idx="41">
                  <c:v>1.0230216214807015</c:v>
                </c:pt>
                <c:pt idx="42">
                  <c:v>1.0232065261699979</c:v>
                </c:pt>
                <c:pt idx="43">
                  <c:v>1.0263431202517426</c:v>
                </c:pt>
                <c:pt idx="44">
                  <c:v>1.0263431202517426</c:v>
                </c:pt>
                <c:pt idx="45">
                  <c:v>1.0261270868627477</c:v>
                </c:pt>
                <c:pt idx="46">
                  <c:v>1.0232388050790118</c:v>
                </c:pt>
                <c:pt idx="47">
                  <c:v>1.0263431202517426</c:v>
                </c:pt>
                <c:pt idx="48">
                  <c:v>1.0261045268349365</c:v>
                </c:pt>
                <c:pt idx="49">
                  <c:v>1.0234525024156835</c:v>
                </c:pt>
                <c:pt idx="50">
                  <c:v>1.0293996509575023</c:v>
                </c:pt>
                <c:pt idx="51">
                  <c:v>1.0263431202517426</c:v>
                </c:pt>
                <c:pt idx="52">
                  <c:v>1.0266172011194146</c:v>
                </c:pt>
                <c:pt idx="53">
                  <c:v>1.0296646190227838</c:v>
                </c:pt>
                <c:pt idx="54">
                  <c:v>1.0296646190227838</c:v>
                </c:pt>
                <c:pt idx="55">
                  <c:v>1.0299785895140146</c:v>
                </c:pt>
                <c:pt idx="56">
                  <c:v>1.0329861177938251</c:v>
                </c:pt>
                <c:pt idx="57">
                  <c:v>1.0329861177938251</c:v>
                </c:pt>
                <c:pt idx="58">
                  <c:v>1.0329861177938251</c:v>
                </c:pt>
                <c:pt idx="59">
                  <c:v>1.0333244341660972</c:v>
                </c:pt>
                <c:pt idx="60">
                  <c:v>1.0359466669254336</c:v>
                </c:pt>
                <c:pt idx="61">
                  <c:v>1.0329861177938251</c:v>
                </c:pt>
                <c:pt idx="62">
                  <c:v>1.0329861177938251</c:v>
                </c:pt>
                <c:pt idx="63">
                  <c:v>1.0333741682240054</c:v>
                </c:pt>
                <c:pt idx="64">
                  <c:v>1.0363076165648664</c:v>
                </c:pt>
                <c:pt idx="65">
                  <c:v>1.0358989639777401</c:v>
                </c:pt>
                <c:pt idx="66">
                  <c:v>1.0334048638146183</c:v>
                </c:pt>
                <c:pt idx="67">
                  <c:v>1.0363076165648664</c:v>
                </c:pt>
                <c:pt idx="68">
                  <c:v>1.0367486143268247</c:v>
                </c:pt>
                <c:pt idx="69">
                  <c:v>1.0396291153359076</c:v>
                </c:pt>
                <c:pt idx="70">
                  <c:v>1.0396291153359076</c:v>
                </c:pt>
                <c:pt idx="71">
                  <c:v>1.0405696959368842</c:v>
                </c:pt>
                <c:pt idx="72">
                  <c:v>1.0453183360310603</c:v>
                </c:pt>
                <c:pt idx="73">
                  <c:v>1.0396291153359076</c:v>
                </c:pt>
                <c:pt idx="74">
                  <c:v>1.0396291153359076</c:v>
                </c:pt>
                <c:pt idx="75">
                  <c:v>1.0401383147727505</c:v>
                </c:pt>
                <c:pt idx="76">
                  <c:v>1.0429506141069489</c:v>
                </c:pt>
                <c:pt idx="77">
                  <c:v>1.0434795818540394</c:v>
                </c:pt>
                <c:pt idx="78">
                  <c:v>1.0457341641111566</c:v>
                </c:pt>
                <c:pt idx="79">
                  <c:v>1.0434987207879627</c:v>
                </c:pt>
                <c:pt idx="80">
                  <c:v>1.0462721128779899</c:v>
                </c:pt>
                <c:pt idx="81">
                  <c:v>1.0468369932849406</c:v>
                </c:pt>
                <c:pt idx="82">
                  <c:v>1.0495936116490314</c:v>
                </c:pt>
                <c:pt idx="83">
                  <c:v>1.0490059399887308</c:v>
                </c:pt>
                <c:pt idx="84">
                  <c:v>1.0462721128779899</c:v>
                </c:pt>
                <c:pt idx="85">
                  <c:v>1.0462721128779899</c:v>
                </c:pt>
                <c:pt idx="86">
                  <c:v>1.0468787719168282</c:v>
                </c:pt>
                <c:pt idx="87">
                  <c:v>1.0495936116490314</c:v>
                </c:pt>
                <c:pt idx="88">
                  <c:v>1.0495936116490314</c:v>
                </c:pt>
                <c:pt idx="89">
                  <c:v>1.0508880091637465</c:v>
                </c:pt>
                <c:pt idx="90">
                  <c:v>1.0555794381233434</c:v>
                </c:pt>
                <c:pt idx="91">
                  <c:v>1.0542494651550416</c:v>
                </c:pt>
                <c:pt idx="92">
                  <c:v>1.0595581079621552</c:v>
                </c:pt>
                <c:pt idx="93">
                  <c:v>1.0595581079621552</c:v>
                </c:pt>
                <c:pt idx="94">
                  <c:v>1.0602522038138815</c:v>
                </c:pt>
                <c:pt idx="95">
                  <c:v>1.0628796067331963</c:v>
                </c:pt>
                <c:pt idx="96">
                  <c:v>1.0635971543736571</c:v>
                </c:pt>
                <c:pt idx="97">
                  <c:v>1.0662011055042375</c:v>
                </c:pt>
                <c:pt idx="98">
                  <c:v>1.0662011055042375</c:v>
                </c:pt>
                <c:pt idx="99">
                  <c:v>1.0669443863294792</c:v>
                </c:pt>
                <c:pt idx="100">
                  <c:v>1.0695226042752788</c:v>
                </c:pt>
                <c:pt idx="101">
                  <c:v>1.0695226042752788</c:v>
                </c:pt>
                <c:pt idx="102">
                  <c:v>1.0695226042752788</c:v>
                </c:pt>
                <c:pt idx="103">
                  <c:v>1.071066350973531</c:v>
                </c:pt>
                <c:pt idx="104">
                  <c:v>1.0761656018173611</c:v>
                </c:pt>
                <c:pt idx="105">
                  <c:v>1.0777680638438443</c:v>
                </c:pt>
                <c:pt idx="106">
                  <c:v>1.0811789023502081</c:v>
                </c:pt>
                <c:pt idx="107">
                  <c:v>1.0769861990375746</c:v>
                </c:pt>
                <c:pt idx="108">
                  <c:v>1.0803190676396603</c:v>
                </c:pt>
                <c:pt idx="109">
                  <c:v>1.0819684221525576</c:v>
                </c:pt>
                <c:pt idx="110">
                  <c:v>1.0803399851562874</c:v>
                </c:pt>
                <c:pt idx="111">
                  <c:v>1.0828085993594436</c:v>
                </c:pt>
                <c:pt idx="112">
                  <c:v>1.083678551544319</c:v>
                </c:pt>
                <c:pt idx="113">
                  <c:v>1.0852475471961951</c:v>
                </c:pt>
                <c:pt idx="114">
                  <c:v>1.0828085993594436</c:v>
                </c:pt>
                <c:pt idx="115">
                  <c:v>1.0837104898124759</c:v>
                </c:pt>
                <c:pt idx="116">
                  <c:v>1.0861300981304849</c:v>
                </c:pt>
                <c:pt idx="117">
                  <c:v>1.0861300981304849</c:v>
                </c:pt>
                <c:pt idx="118">
                  <c:v>1.0870627595190572</c:v>
                </c:pt>
                <c:pt idx="119">
                  <c:v>1.0885128298622249</c:v>
                </c:pt>
                <c:pt idx="120">
                  <c:v>1.0861300981304849</c:v>
                </c:pt>
                <c:pt idx="121">
                  <c:v>1.0870903879785332</c:v>
                </c:pt>
                <c:pt idx="122">
                  <c:v>1.0894515969015262</c:v>
                </c:pt>
                <c:pt idx="123">
                  <c:v>1.0904333307228207</c:v>
                </c:pt>
                <c:pt idx="124">
                  <c:v>1.0927730956725674</c:v>
                </c:pt>
                <c:pt idx="125">
                  <c:v>1.0927730956725674</c:v>
                </c:pt>
                <c:pt idx="126">
                  <c:v>1.0927730956725674</c:v>
                </c:pt>
                <c:pt idx="127">
                  <c:v>1.0927730956725674</c:v>
                </c:pt>
                <c:pt idx="128">
                  <c:v>1.0938024793573127</c:v>
                </c:pt>
                <c:pt idx="129">
                  <c:v>1.0960945944436087</c:v>
                </c:pt>
                <c:pt idx="130">
                  <c:v>1.0971298432989369</c:v>
                </c:pt>
                <c:pt idx="131">
                  <c:v>1.0972957560625658</c:v>
                </c:pt>
                <c:pt idx="132">
                  <c:v>1.0938416058097264</c:v>
                </c:pt>
                <c:pt idx="133">
                  <c:v>1.0982485896874692</c:v>
                </c:pt>
                <c:pt idx="134">
                  <c:v>1.102737591985691</c:v>
                </c:pt>
                <c:pt idx="135">
                  <c:v>1.101666071080486</c:v>
                </c:pt>
                <c:pt idx="136">
                  <c:v>1.1016290531942212</c:v>
                </c:pt>
                <c:pt idx="137">
                  <c:v>1.1060590907567325</c:v>
                </c:pt>
                <c:pt idx="138">
                  <c:v>1.1049300265097193</c:v>
                </c:pt>
                <c:pt idx="139">
                  <c:v>1.102737591985691</c:v>
                </c:pt>
                <c:pt idx="140">
                  <c:v>1.1049966906562345</c:v>
                </c:pt>
                <c:pt idx="141">
                  <c:v>1.1093805895277737</c:v>
                </c:pt>
                <c:pt idx="142">
                  <c:v>1.1093805895277737</c:v>
                </c:pt>
                <c:pt idx="143">
                  <c:v>1.1093805895277737</c:v>
                </c:pt>
                <c:pt idx="144">
                  <c:v>1.1093805895277737</c:v>
                </c:pt>
                <c:pt idx="145">
                  <c:v>1.1105757336559874</c:v>
                </c:pt>
                <c:pt idx="146">
                  <c:v>1.1127020882988148</c:v>
                </c:pt>
                <c:pt idx="147">
                  <c:v>1.1139179245688788</c:v>
                </c:pt>
                <c:pt idx="148">
                  <c:v>1.1160235870698563</c:v>
                </c:pt>
                <c:pt idx="149">
                  <c:v>1.1147912765204497</c:v>
                </c:pt>
                <c:pt idx="150">
                  <c:v>1.1139454664291903</c:v>
                </c:pt>
                <c:pt idx="151">
                  <c:v>1.1147673196323851</c:v>
                </c:pt>
                <c:pt idx="152">
                  <c:v>1.1127020882988148</c:v>
                </c:pt>
                <c:pt idx="153">
                  <c:v>1.1139752217779093</c:v>
                </c:pt>
                <c:pt idx="154">
                  <c:v>1.1147457809282451</c:v>
                </c:pt>
                <c:pt idx="155">
                  <c:v>1.113991609850103</c:v>
                </c:pt>
                <c:pt idx="156">
                  <c:v>1.1147199370122018</c:v>
                </c:pt>
                <c:pt idx="157">
                  <c:v>1.1140170431306946</c:v>
                </c:pt>
                <c:pt idx="158">
                  <c:v>1.1173490026422022</c:v>
                </c:pt>
                <c:pt idx="159">
                  <c:v>1.1193450858408973</c:v>
                </c:pt>
                <c:pt idx="160">
                  <c:v>1.1193450858408973</c:v>
                </c:pt>
                <c:pt idx="161">
                  <c:v>1.1193450858408973</c:v>
                </c:pt>
                <c:pt idx="162">
                  <c:v>1.1207085513859656</c:v>
                </c:pt>
                <c:pt idx="163">
                  <c:v>1.1226665846119386</c:v>
                </c:pt>
                <c:pt idx="164">
                  <c:v>1.1240462715448973</c:v>
                </c:pt>
                <c:pt idx="165">
                  <c:v>1.1259880833829798</c:v>
                </c:pt>
                <c:pt idx="166">
                  <c:v>1.1245865527475583</c:v>
                </c:pt>
                <c:pt idx="167">
                  <c:v>1.1226665846119386</c:v>
                </c:pt>
                <c:pt idx="168">
                  <c:v>1.1212458114098318</c:v>
                </c:pt>
                <c:pt idx="169">
                  <c:v>1.1236420517967129</c:v>
                </c:pt>
                <c:pt idx="170">
                  <c:v>1.1293095821540211</c:v>
                </c:pt>
                <c:pt idx="171">
                  <c:v>1.1278621639683704</c:v>
                </c:pt>
                <c:pt idx="172">
                  <c:v>1.1274490254168776</c:v>
                </c:pt>
                <c:pt idx="173">
                  <c:v>1.1307802654888182</c:v>
                </c:pt>
                <c:pt idx="174">
                  <c:v>1.129667899292119</c:v>
                </c:pt>
                <c:pt idx="175">
                  <c:v>1.127475249199889</c:v>
                </c:pt>
                <c:pt idx="176">
                  <c:v>1.1293095821540211</c:v>
                </c:pt>
                <c:pt idx="177">
                  <c:v>1.1308213193441279</c:v>
                </c:pt>
                <c:pt idx="178">
                  <c:v>1.1311092167904506</c:v>
                </c:pt>
                <c:pt idx="179">
                  <c:v>1.1308408481586734</c:v>
                </c:pt>
                <c:pt idx="180">
                  <c:v>1.1341721489085161</c:v>
                </c:pt>
                <c:pt idx="181">
                  <c:v>1.1344027616202459</c:v>
                </c:pt>
                <c:pt idx="182">
                  <c:v>1.1326310809250622</c:v>
                </c:pt>
                <c:pt idx="183">
                  <c:v>1.1342016053067918</c:v>
                </c:pt>
                <c:pt idx="184">
                  <c:v>1.1343723499641252</c:v>
                </c:pt>
                <c:pt idx="185">
                  <c:v>1.1358106023825065</c:v>
                </c:pt>
                <c:pt idx="186">
                  <c:v>1.1392740784671447</c:v>
                </c:pt>
                <c:pt idx="187">
                  <c:v>1.1376676569092095</c:v>
                </c:pt>
                <c:pt idx="188">
                  <c:v>1.1359525796961036</c:v>
                </c:pt>
                <c:pt idx="189">
                  <c:v>1.1359525796961036</c:v>
                </c:pt>
                <c:pt idx="190">
                  <c:v>1.1359525796961036</c:v>
                </c:pt>
                <c:pt idx="191">
                  <c:v>1.1376014334219517</c:v>
                </c:pt>
                <c:pt idx="192">
                  <c:v>1.1392740784671447</c:v>
                </c:pt>
                <c:pt idx="193">
                  <c:v>1.1392740784671447</c:v>
                </c:pt>
                <c:pt idx="194">
                  <c:v>1.1392740784671447</c:v>
                </c:pt>
                <c:pt idx="195">
                  <c:v>1.1409639643087008</c:v>
                </c:pt>
                <c:pt idx="196">
                  <c:v>1.1425955772381859</c:v>
                </c:pt>
                <c:pt idx="197">
                  <c:v>1.1425955772381859</c:v>
                </c:pt>
                <c:pt idx="198">
                  <c:v>1.1425955772381859</c:v>
                </c:pt>
                <c:pt idx="199">
                  <c:v>1.1443246063500003</c:v>
                </c:pt>
                <c:pt idx="200">
                  <c:v>1.1441801056088501</c:v>
                </c:pt>
                <c:pt idx="201">
                  <c:v>1.1425955772381859</c:v>
                </c:pt>
                <c:pt idx="202">
                  <c:v>1.1443445797935166</c:v>
                </c:pt>
                <c:pt idx="203">
                  <c:v>1.1459170760092272</c:v>
                </c:pt>
                <c:pt idx="204">
                  <c:v>1.1476619987812988</c:v>
                </c:pt>
                <c:pt idx="205">
                  <c:v>1.1474837433659011</c:v>
                </c:pt>
                <c:pt idx="206">
                  <c:v>1.1476876528187077</c:v>
                </c:pt>
                <c:pt idx="207">
                  <c:v>1.1474577691859591</c:v>
                </c:pt>
                <c:pt idx="208">
                  <c:v>1.1495009887108176</c:v>
                </c:pt>
                <c:pt idx="209">
                  <c:v>1.1507627972658709</c:v>
                </c:pt>
                <c:pt idx="210">
                  <c:v>1.1510427403605783</c:v>
                </c:pt>
                <c:pt idx="211">
                  <c:v>1.1525600735513095</c:v>
                </c:pt>
                <c:pt idx="212">
                  <c:v>1.1525600735513095</c:v>
                </c:pt>
                <c:pt idx="213">
                  <c:v>1.1506940522844695</c:v>
                </c:pt>
                <c:pt idx="214">
                  <c:v>1.1511133963706914</c:v>
                </c:pt>
                <c:pt idx="215">
                  <c:v>1.1544408006929305</c:v>
                </c:pt>
                <c:pt idx="216">
                  <c:v>1.1539889363315377</c:v>
                </c:pt>
                <c:pt idx="217">
                  <c:v>1.1525600735513095</c:v>
                </c:pt>
                <c:pt idx="218">
                  <c:v>1.1544733694475224</c:v>
                </c:pt>
                <c:pt idx="219">
                  <c:v>1.155881572322351</c:v>
                </c:pt>
                <c:pt idx="220">
                  <c:v>1.1578031868143543</c:v>
                </c:pt>
                <c:pt idx="221">
                  <c:v>1.159203071093392</c:v>
                </c:pt>
                <c:pt idx="222">
                  <c:v>1.1572504233783745</c:v>
                </c:pt>
                <c:pt idx="223">
                  <c:v>1.155881572322351</c:v>
                </c:pt>
                <c:pt idx="224">
                  <c:v>1.155881572322351</c:v>
                </c:pt>
                <c:pt idx="225">
                  <c:v>1.1578448944752955</c:v>
                </c:pt>
                <c:pt idx="226">
                  <c:v>1.1572294242753711</c:v>
                </c:pt>
                <c:pt idx="227">
                  <c:v>1.1578821420960757</c:v>
                </c:pt>
                <c:pt idx="228">
                  <c:v>1.159203071093392</c:v>
                </c:pt>
                <c:pt idx="229">
                  <c:v>1.1571799203104125</c:v>
                </c:pt>
              </c:numCache>
            </c:numRef>
          </c:xVal>
          <c:yVal>
            <c:numRef>
              <c:f>'d0 s'!$B$7:$B$297</c:f>
              <c:numCache>
                <c:formatCode>General</c:formatCode>
                <c:ptCount val="291"/>
                <c:pt idx="0">
                  <c:v>0</c:v>
                </c:pt>
                <c:pt idx="1">
                  <c:v>5.5025101834629379E-3</c:v>
                </c:pt>
                <c:pt idx="2">
                  <c:v>1.363203423722157E-2</c:v>
                </c:pt>
                <c:pt idx="3">
                  <c:v>2.5332060386127758E-2</c:v>
                </c:pt>
                <c:pt idx="4">
                  <c:v>3.4859934064444167E-2</c:v>
                </c:pt>
                <c:pt idx="5">
                  <c:v>5.1848591702555714E-2</c:v>
                </c:pt>
                <c:pt idx="6">
                  <c:v>6.6286111024664141E-2</c:v>
                </c:pt>
                <c:pt idx="7">
                  <c:v>7.9684672922363725E-2</c:v>
                </c:pt>
                <c:pt idx="8">
                  <c:v>0.10042477229054747</c:v>
                </c:pt>
                <c:pt idx="9">
                  <c:v>0.1154376496793369</c:v>
                </c:pt>
                <c:pt idx="10">
                  <c:v>0.13950435357027499</c:v>
                </c:pt>
                <c:pt idx="11">
                  <c:v>0.15633083619549354</c:v>
                </c:pt>
                <c:pt idx="12">
                  <c:v>0.17878488795605957</c:v>
                </c:pt>
                <c:pt idx="13">
                  <c:v>0.19907931293681078</c:v>
                </c:pt>
                <c:pt idx="14">
                  <c:v>0.2175121768756362</c:v>
                </c:pt>
                <c:pt idx="15">
                  <c:v>0.24300683077196256</c:v>
                </c:pt>
                <c:pt idx="16">
                  <c:v>0.26251119661135602</c:v>
                </c:pt>
                <c:pt idx="17">
                  <c:v>0.28041831102121278</c:v>
                </c:pt>
                <c:pt idx="18">
                  <c:v>0.30110798877120426</c:v>
                </c:pt>
                <c:pt idx="19">
                  <c:v>0.31866406498426275</c:v>
                </c:pt>
                <c:pt idx="20">
                  <c:v>0.34656977352716717</c:v>
                </c:pt>
                <c:pt idx="21">
                  <c:v>0.36929023934371497</c:v>
                </c:pt>
                <c:pt idx="22">
                  <c:v>0.39220831028787756</c:v>
                </c:pt>
                <c:pt idx="23">
                  <c:v>0.41675075660120997</c:v>
                </c:pt>
                <c:pt idx="24">
                  <c:v>0.43784982302942105</c:v>
                </c:pt>
                <c:pt idx="25">
                  <c:v>0.45761599015449955</c:v>
                </c:pt>
                <c:pt idx="26">
                  <c:v>0.47647163468531267</c:v>
                </c:pt>
                <c:pt idx="27">
                  <c:v>0.49769658510295611</c:v>
                </c:pt>
                <c:pt idx="28">
                  <c:v>0.52502114835929836</c:v>
                </c:pt>
                <c:pt idx="29">
                  <c:v>0.55634266645056518</c:v>
                </c:pt>
                <c:pt idx="30">
                  <c:v>0.58670613128218851</c:v>
                </c:pt>
                <c:pt idx="31">
                  <c:v>0.60842475440677346</c:v>
                </c:pt>
                <c:pt idx="32">
                  <c:v>0.63328529055763216</c:v>
                </c:pt>
                <c:pt idx="33">
                  <c:v>0.65312730268005159</c:v>
                </c:pt>
                <c:pt idx="34">
                  <c:v>0.68036012069857654</c:v>
                </c:pt>
                <c:pt idx="35">
                  <c:v>0.7025994554417121</c:v>
                </c:pt>
                <c:pt idx="36">
                  <c:v>0.7239056926502313</c:v>
                </c:pt>
                <c:pt idx="37">
                  <c:v>0.7498244450729189</c:v>
                </c:pt>
                <c:pt idx="38">
                  <c:v>0.77537077475078764</c:v>
                </c:pt>
                <c:pt idx="39">
                  <c:v>0.79131965125550952</c:v>
                </c:pt>
                <c:pt idx="40">
                  <c:v>0.83239337352347542</c:v>
                </c:pt>
                <c:pt idx="41">
                  <c:v>0.85325516925091049</c:v>
                </c:pt>
                <c:pt idx="42">
                  <c:v>0.88969979584004588</c:v>
                </c:pt>
                <c:pt idx="43">
                  <c:v>0.91162486700673351</c:v>
                </c:pt>
                <c:pt idx="44">
                  <c:v>0.93022202634479911</c:v>
                </c:pt>
                <c:pt idx="45">
                  <c:v>0.94768627229201163</c:v>
                </c:pt>
                <c:pt idx="46">
                  <c:v>0.95980327587027425</c:v>
                </c:pt>
                <c:pt idx="47">
                  <c:v>0.97390593889138977</c:v>
                </c:pt>
                <c:pt idx="48">
                  <c:v>1.0003663198265138</c:v>
                </c:pt>
                <c:pt idx="49">
                  <c:v>1.0203788556509277</c:v>
                </c:pt>
                <c:pt idx="50">
                  <c:v>1.0449374998028191</c:v>
                </c:pt>
                <c:pt idx="51">
                  <c:v>1.0688607295318777</c:v>
                </c:pt>
                <c:pt idx="52">
                  <c:v>1.0980835859364855</c:v>
                </c:pt>
                <c:pt idx="53">
                  <c:v>1.1143593101651956</c:v>
                </c:pt>
                <c:pt idx="54">
                  <c:v>1.1311844854845481</c:v>
                </c:pt>
                <c:pt idx="55">
                  <c:v>1.1433731676869818</c:v>
                </c:pt>
                <c:pt idx="56">
                  <c:v>1.1571381844250701</c:v>
                </c:pt>
                <c:pt idx="57">
                  <c:v>1.1760972230329847</c:v>
                </c:pt>
                <c:pt idx="58">
                  <c:v>1.1946826485037465</c:v>
                </c:pt>
                <c:pt idx="59">
                  <c:v>1.2160056362329816</c:v>
                </c:pt>
                <c:pt idx="60">
                  <c:v>1.2336270989964426</c:v>
                </c:pt>
                <c:pt idx="61">
                  <c:v>1.24814061742919</c:v>
                </c:pt>
                <c:pt idx="62">
                  <c:v>1.2618697523411786</c:v>
                </c:pt>
                <c:pt idx="63">
                  <c:v>1.2748696869199347</c:v>
                </c:pt>
                <c:pt idx="64">
                  <c:v>1.2882715489678149</c:v>
                </c:pt>
                <c:pt idx="65">
                  <c:v>1.3018069050132641</c:v>
                </c:pt>
                <c:pt idx="66">
                  <c:v>1.3165667496313385</c:v>
                </c:pt>
                <c:pt idx="67">
                  <c:v>1.3330809774671757</c:v>
                </c:pt>
                <c:pt idx="68">
                  <c:v>1.3460300652876209</c:v>
                </c:pt>
                <c:pt idx="69">
                  <c:v>1.3623946438013412</c:v>
                </c:pt>
                <c:pt idx="70">
                  <c:v>1.3786298946906592</c:v>
                </c:pt>
                <c:pt idx="71">
                  <c:v>1.386348228534942</c:v>
                </c:pt>
                <c:pt idx="72">
                  <c:v>1.4108674196837292</c:v>
                </c:pt>
                <c:pt idx="73">
                  <c:v>1.4245304027930987</c:v>
                </c:pt>
                <c:pt idx="74">
                  <c:v>1.4379350707657665</c:v>
                </c:pt>
                <c:pt idx="75">
                  <c:v>1.4630853399081687</c:v>
                </c:pt>
                <c:pt idx="76">
                  <c:v>1.4760203130766423</c:v>
                </c:pt>
                <c:pt idx="77">
                  <c:v>1.4887488382030158</c:v>
                </c:pt>
                <c:pt idx="78">
                  <c:v>1.4968304117655267</c:v>
                </c:pt>
                <c:pt idx="79">
                  <c:v>1.5032746856992327</c:v>
                </c:pt>
                <c:pt idx="80">
                  <c:v>1.5093492577848877</c:v>
                </c:pt>
                <c:pt idx="81">
                  <c:v>1.5162217328471044</c:v>
                </c:pt>
                <c:pt idx="82">
                  <c:v>1.5266051850734697</c:v>
                </c:pt>
                <c:pt idx="83">
                  <c:v>1.5367537898977379</c:v>
                </c:pt>
                <c:pt idx="84">
                  <c:v>1.5545559372120517</c:v>
                </c:pt>
                <c:pt idx="85">
                  <c:v>1.5618970867421773</c:v>
                </c:pt>
                <c:pt idx="86">
                  <c:v>1.5708440755322544</c:v>
                </c:pt>
                <c:pt idx="87">
                  <c:v>1.5786901214684796</c:v>
                </c:pt>
                <c:pt idx="88">
                  <c:v>1.5846084120461517</c:v>
                </c:pt>
                <c:pt idx="89">
                  <c:v>1.5883299185975466</c:v>
                </c:pt>
                <c:pt idx="90">
                  <c:v>1.595799630499855</c:v>
                </c:pt>
                <c:pt idx="91">
                  <c:v>1.5993390070239919</c:v>
                </c:pt>
                <c:pt idx="92">
                  <c:v>1.6106507952156324</c:v>
                </c:pt>
                <c:pt idx="93">
                  <c:v>1.6130591289654439</c:v>
                </c:pt>
                <c:pt idx="94">
                  <c:v>1.6186119690962599</c:v>
                </c:pt>
                <c:pt idx="95">
                  <c:v>1.6244705700011302</c:v>
                </c:pt>
                <c:pt idx="96">
                  <c:v>1.6273060845431699</c:v>
                </c:pt>
                <c:pt idx="97">
                  <c:v>1.6302844461654125</c:v>
                </c:pt>
                <c:pt idx="98">
                  <c:v>1.6334780987442485</c:v>
                </c:pt>
                <c:pt idx="99">
                  <c:v>1.6357901807709703</c:v>
                </c:pt>
                <c:pt idx="100">
                  <c:v>1.6416220828763257</c:v>
                </c:pt>
                <c:pt idx="101">
                  <c:v>1.6442171381666908</c:v>
                </c:pt>
                <c:pt idx="102">
                  <c:v>1.6490474101501431</c:v>
                </c:pt>
                <c:pt idx="103">
                  <c:v>1.6512458947368935</c:v>
                </c:pt>
                <c:pt idx="104">
                  <c:v>1.653184193570417</c:v>
                </c:pt>
                <c:pt idx="105">
                  <c:v>1.6601913530225425</c:v>
                </c:pt>
                <c:pt idx="106">
                  <c:v>1.6613671205374554</c:v>
                </c:pt>
                <c:pt idx="107">
                  <c:v>1.6713660760396039</c:v>
                </c:pt>
                <c:pt idx="108">
                  <c:v>1.6730946957661144</c:v>
                </c:pt>
                <c:pt idx="109">
                  <c:v>1.677496426508956</c:v>
                </c:pt>
                <c:pt idx="110">
                  <c:v>1.6779254779177122</c:v>
                </c:pt>
                <c:pt idx="111">
                  <c:v>1.681459752760414</c:v>
                </c:pt>
                <c:pt idx="112">
                  <c:v>1.6858045147272216</c:v>
                </c:pt>
                <c:pt idx="113">
                  <c:v>1.6838966559262658</c:v>
                </c:pt>
                <c:pt idx="114">
                  <c:v>1.6863165534873326</c:v>
                </c:pt>
                <c:pt idx="115">
                  <c:v>1.6878411059564082</c:v>
                </c:pt>
                <c:pt idx="116">
                  <c:v>1.6905373445952501</c:v>
                </c:pt>
                <c:pt idx="117">
                  <c:v>1.6925031925085281</c:v>
                </c:pt>
                <c:pt idx="118">
                  <c:v>1.6925086343020574</c:v>
                </c:pt>
                <c:pt idx="119">
                  <c:v>1.6925732556002457</c:v>
                </c:pt>
                <c:pt idx="120">
                  <c:v>1.6937151819616352</c:v>
                </c:pt>
                <c:pt idx="121">
                  <c:v>1.6915049635075809</c:v>
                </c:pt>
                <c:pt idx="122">
                  <c:v>1.6933335761902344</c:v>
                </c:pt>
                <c:pt idx="123">
                  <c:v>1.6918161660751672</c:v>
                </c:pt>
                <c:pt idx="124">
                  <c:v>1.6917209346883655</c:v>
                </c:pt>
                <c:pt idx="125">
                  <c:v>1.6914216360441285</c:v>
                </c:pt>
                <c:pt idx="126">
                  <c:v>1.6903007966326737</c:v>
                </c:pt>
                <c:pt idx="127">
                  <c:v>1.6947385792576635</c:v>
                </c:pt>
                <c:pt idx="128">
                  <c:v>1.6921011800113841</c:v>
                </c:pt>
                <c:pt idx="129">
                  <c:v>1.6954682897590361</c:v>
                </c:pt>
                <c:pt idx="130">
                  <c:v>1.6953747589327137</c:v>
                </c:pt>
                <c:pt idx="131">
                  <c:v>1.6961252162719263</c:v>
                </c:pt>
                <c:pt idx="132">
                  <c:v>1.6988740022295552</c:v>
                </c:pt>
                <c:pt idx="133">
                  <c:v>1.6974689991621257</c:v>
                </c:pt>
                <c:pt idx="134">
                  <c:v>1.6995086514001743</c:v>
                </c:pt>
                <c:pt idx="135">
                  <c:v>1.6995069508396952</c:v>
                </c:pt>
                <c:pt idx="136">
                  <c:v>1.7013609018734781</c:v>
                </c:pt>
                <c:pt idx="137">
                  <c:v>1.6995486145714211</c:v>
                </c:pt>
                <c:pt idx="138">
                  <c:v>1.7035248650825137</c:v>
                </c:pt>
                <c:pt idx="139">
                  <c:v>1.7013830091597009</c:v>
                </c:pt>
                <c:pt idx="140">
                  <c:v>1.7002273082584369</c:v>
                </c:pt>
                <c:pt idx="141">
                  <c:v>1.7008723308479745</c:v>
                </c:pt>
                <c:pt idx="142">
                  <c:v>1.7000455183432728</c:v>
                </c:pt>
                <c:pt idx="143">
                  <c:v>1.69734859948024</c:v>
                </c:pt>
                <c:pt idx="144">
                  <c:v>1.7022485944433154</c:v>
                </c:pt>
                <c:pt idx="145">
                  <c:v>1.6969703948297947</c:v>
                </c:pt>
                <c:pt idx="146">
                  <c:v>1.6958832265158177</c:v>
                </c:pt>
                <c:pt idx="147">
                  <c:v>1.6967914958674468</c:v>
                </c:pt>
                <c:pt idx="148">
                  <c:v>1.6953444889561944</c:v>
                </c:pt>
                <c:pt idx="149">
                  <c:v>1.6952259598908335</c:v>
                </c:pt>
                <c:pt idx="150">
                  <c:v>1.6944943787729363</c:v>
                </c:pt>
                <c:pt idx="151">
                  <c:v>1.6956966750313154</c:v>
                </c:pt>
                <c:pt idx="152">
                  <c:v>1.6949836300226306</c:v>
                </c:pt>
                <c:pt idx="153">
                  <c:v>1.6936497103832073</c:v>
                </c:pt>
                <c:pt idx="154">
                  <c:v>1.6945380831772356</c:v>
                </c:pt>
                <c:pt idx="155">
                  <c:v>1.6904771447543085</c:v>
                </c:pt>
                <c:pt idx="156">
                  <c:v>1.693274056573481</c:v>
                </c:pt>
                <c:pt idx="157">
                  <c:v>1.6900987700478147</c:v>
                </c:pt>
                <c:pt idx="158">
                  <c:v>1.6890746925275952</c:v>
                </c:pt>
                <c:pt idx="159">
                  <c:v>1.6851368746833184</c:v>
                </c:pt>
                <c:pt idx="160">
                  <c:v>1.6823836672684425</c:v>
                </c:pt>
                <c:pt idx="161">
                  <c:v>1.6804832909335923</c:v>
                </c:pt>
                <c:pt idx="162">
                  <c:v>1.6793384736193899</c:v>
                </c:pt>
                <c:pt idx="163">
                  <c:v>1.6757637254372983</c:v>
                </c:pt>
                <c:pt idx="164">
                  <c:v>1.675708287165695</c:v>
                </c:pt>
                <c:pt idx="165">
                  <c:v>1.6690546742370733</c:v>
                </c:pt>
                <c:pt idx="166">
                  <c:v>1.6679974357875209</c:v>
                </c:pt>
                <c:pt idx="167">
                  <c:v>1.6657748032419717</c:v>
                </c:pt>
                <c:pt idx="168">
                  <c:v>1.6641363132208276</c:v>
                </c:pt>
                <c:pt idx="169">
                  <c:v>1.6598398471716123</c:v>
                </c:pt>
                <c:pt idx="170">
                  <c:v>1.6569505949184482</c:v>
                </c:pt>
                <c:pt idx="171">
                  <c:v>1.6550733462061087</c:v>
                </c:pt>
                <c:pt idx="172">
                  <c:v>1.6513168081088507</c:v>
                </c:pt>
                <c:pt idx="173">
                  <c:v>1.6423371685575838</c:v>
                </c:pt>
                <c:pt idx="174">
                  <c:v>1.6421363323650588</c:v>
                </c:pt>
                <c:pt idx="175">
                  <c:v>1.6342884158123054</c:v>
                </c:pt>
                <c:pt idx="176">
                  <c:v>1.6341209106051644</c:v>
                </c:pt>
                <c:pt idx="177">
                  <c:v>1.623095496798123</c:v>
                </c:pt>
                <c:pt idx="178">
                  <c:v>1.6193132802376407</c:v>
                </c:pt>
                <c:pt idx="179">
                  <c:v>1.60534504652236</c:v>
                </c:pt>
                <c:pt idx="180">
                  <c:v>1.5922692669462544</c:v>
                </c:pt>
                <c:pt idx="181">
                  <c:v>1.5695946737486195</c:v>
                </c:pt>
                <c:pt idx="182">
                  <c:v>1.5437803357393185</c:v>
                </c:pt>
                <c:pt idx="183">
                  <c:v>1.5130716146165224</c:v>
                </c:pt>
                <c:pt idx="184">
                  <c:v>1.447939468061447</c:v>
                </c:pt>
                <c:pt idx="185">
                  <c:v>1.3087699349209676</c:v>
                </c:pt>
                <c:pt idx="186">
                  <c:v>1.2151359696042172</c:v>
                </c:pt>
                <c:pt idx="187">
                  <c:v>1.1770911156047079</c:v>
                </c:pt>
                <c:pt idx="188">
                  <c:v>1.1435861628869304</c:v>
                </c:pt>
                <c:pt idx="189">
                  <c:v>1.1204679784884453</c:v>
                </c:pt>
                <c:pt idx="190">
                  <c:v>1.0965588634113612</c:v>
                </c:pt>
                <c:pt idx="191">
                  <c:v>1.0813909693064425</c:v>
                </c:pt>
                <c:pt idx="192">
                  <c:v>1.0458401573048677</c:v>
                </c:pt>
                <c:pt idx="193">
                  <c:v>0.98626306160922994</c:v>
                </c:pt>
                <c:pt idx="194">
                  <c:v>0.88853873817327278</c:v>
                </c:pt>
                <c:pt idx="195">
                  <c:v>0.73206693747116725</c:v>
                </c:pt>
                <c:pt idx="196">
                  <c:v>0.67486841571696743</c:v>
                </c:pt>
                <c:pt idx="197">
                  <c:v>0.65474538597545251</c:v>
                </c:pt>
                <c:pt idx="198">
                  <c:v>0.64175539967549522</c:v>
                </c:pt>
                <c:pt idx="199">
                  <c:v>0.63437135350729845</c:v>
                </c:pt>
                <c:pt idx="200">
                  <c:v>0.62500190298031699</c:v>
                </c:pt>
                <c:pt idx="201">
                  <c:v>0.61062192105915292</c:v>
                </c:pt>
                <c:pt idx="202">
                  <c:v>0.59878261900704732</c:v>
                </c:pt>
                <c:pt idx="203">
                  <c:v>0.58890538112115576</c:v>
                </c:pt>
                <c:pt idx="204">
                  <c:v>0.56634544821378907</c:v>
                </c:pt>
                <c:pt idx="205">
                  <c:v>0.54576501021754087</c:v>
                </c:pt>
                <c:pt idx="206">
                  <c:v>0.54009989058112717</c:v>
                </c:pt>
                <c:pt idx="207">
                  <c:v>0.53614664015050517</c:v>
                </c:pt>
                <c:pt idx="208">
                  <c:v>0.52415896419664221</c:v>
                </c:pt>
                <c:pt idx="209">
                  <c:v>0.52047589031206298</c:v>
                </c:pt>
                <c:pt idx="210">
                  <c:v>0.51300175695251093</c:v>
                </c:pt>
                <c:pt idx="211">
                  <c:v>0.51018256779106441</c:v>
                </c:pt>
                <c:pt idx="212">
                  <c:v>0.49508044286265651</c:v>
                </c:pt>
                <c:pt idx="213">
                  <c:v>0.49073984726902165</c:v>
                </c:pt>
                <c:pt idx="214">
                  <c:v>0.48526655085459369</c:v>
                </c:pt>
                <c:pt idx="215">
                  <c:v>0.48121156439333834</c:v>
                </c:pt>
                <c:pt idx="216">
                  <c:v>0.48196495519937832</c:v>
                </c:pt>
                <c:pt idx="217">
                  <c:v>0.47587167694845955</c:v>
                </c:pt>
                <c:pt idx="218">
                  <c:v>0.46477955865664505</c:v>
                </c:pt>
                <c:pt idx="219">
                  <c:v>0.46578016844225989</c:v>
                </c:pt>
                <c:pt idx="220">
                  <c:v>0.45902686015558086</c:v>
                </c:pt>
                <c:pt idx="221">
                  <c:v>0.46258149921001163</c:v>
                </c:pt>
                <c:pt idx="222">
                  <c:v>0.46225588439237114</c:v>
                </c:pt>
                <c:pt idx="223">
                  <c:v>0.45814048552011438</c:v>
                </c:pt>
                <c:pt idx="224">
                  <c:v>0.46089173729043958</c:v>
                </c:pt>
                <c:pt idx="225">
                  <c:v>0.45263878974569216</c:v>
                </c:pt>
                <c:pt idx="226">
                  <c:v>0.44842917982292174</c:v>
                </c:pt>
                <c:pt idx="227">
                  <c:v>0.44235214192457367</c:v>
                </c:pt>
                <c:pt idx="228">
                  <c:v>0.43914356692753803</c:v>
                </c:pt>
                <c:pt idx="229">
                  <c:v>0.433600972673606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AA5-44B0-8F9A-AB1F1C383170}"/>
            </c:ext>
          </c:extLst>
        </c:ser>
        <c:ser>
          <c:idx val="1"/>
          <c:order val="1"/>
          <c:tx>
            <c:v>TD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d0 s'!$C$7:$C$276</c:f>
              <c:numCache>
                <c:formatCode>General</c:formatCode>
                <c:ptCount val="270"/>
                <c:pt idx="0">
                  <c:v>1</c:v>
                </c:pt>
                <c:pt idx="1">
                  <c:v>0.99684941773222435</c:v>
                </c:pt>
                <c:pt idx="2">
                  <c:v>1.0002371147655635</c:v>
                </c:pt>
                <c:pt idx="3">
                  <c:v>1.0002371147655635</c:v>
                </c:pt>
                <c:pt idx="4">
                  <c:v>1.0002371147655635</c:v>
                </c:pt>
                <c:pt idx="5">
                  <c:v>1.0005321633267443</c:v>
                </c:pt>
                <c:pt idx="6">
                  <c:v>1.0038743406374382</c:v>
                </c:pt>
                <c:pt idx="7">
                  <c:v>1.0038743406374382</c:v>
                </c:pt>
                <c:pt idx="8">
                  <c:v>1.0038743406374382</c:v>
                </c:pt>
                <c:pt idx="9">
                  <c:v>1.0038743406374382</c:v>
                </c:pt>
                <c:pt idx="10">
                  <c:v>1.0038743406374382</c:v>
                </c:pt>
                <c:pt idx="11">
                  <c:v>1.0042337745790531</c:v>
                </c:pt>
                <c:pt idx="12">
                  <c:v>1.0075115665093133</c:v>
                </c:pt>
                <c:pt idx="13">
                  <c:v>1.0075115665093133</c:v>
                </c:pt>
                <c:pt idx="14">
                  <c:v>1.0075115665093133</c:v>
                </c:pt>
                <c:pt idx="15">
                  <c:v>1.0075115665093133</c:v>
                </c:pt>
                <c:pt idx="16">
                  <c:v>1.0075115665093133</c:v>
                </c:pt>
                <c:pt idx="17">
                  <c:v>1.0079377001724688</c:v>
                </c:pt>
                <c:pt idx="18">
                  <c:v>1.0111487923811879</c:v>
                </c:pt>
                <c:pt idx="19">
                  <c:v>1.0111487923811879</c:v>
                </c:pt>
                <c:pt idx="20">
                  <c:v>1.0111487923811879</c:v>
                </c:pt>
                <c:pt idx="21">
                  <c:v>1.0116131958368124</c:v>
                </c:pt>
                <c:pt idx="22">
                  <c:v>1.0147860182530626</c:v>
                </c:pt>
                <c:pt idx="23">
                  <c:v>1.0147860182530626</c:v>
                </c:pt>
                <c:pt idx="24">
                  <c:v>1.0147860182530626</c:v>
                </c:pt>
                <c:pt idx="25">
                  <c:v>1.0152917276130293</c:v>
                </c:pt>
                <c:pt idx="26">
                  <c:v>1.0179028952184836</c:v>
                </c:pt>
                <c:pt idx="27">
                  <c:v>1.0147860182530626</c:v>
                </c:pt>
                <c:pt idx="28">
                  <c:v>1.0153284161728535</c:v>
                </c:pt>
                <c:pt idx="29">
                  <c:v>1.0184232441249375</c:v>
                </c:pt>
                <c:pt idx="30">
                  <c:v>1.0184232441249375</c:v>
                </c:pt>
                <c:pt idx="31">
                  <c:v>1.0184232441249375</c:v>
                </c:pt>
                <c:pt idx="32">
                  <c:v>1.0184232441249375</c:v>
                </c:pt>
                <c:pt idx="33">
                  <c:v>1.0190195008562608</c:v>
                </c:pt>
                <c:pt idx="34">
                  <c:v>1.0220604699968121</c:v>
                </c:pt>
                <c:pt idx="35">
                  <c:v>1.0220604699968121</c:v>
                </c:pt>
                <c:pt idx="36">
                  <c:v>1.0220604699968121</c:v>
                </c:pt>
                <c:pt idx="37">
                  <c:v>1.0220604699968121</c:v>
                </c:pt>
                <c:pt idx="38">
                  <c:v>1.0227099160735591</c:v>
                </c:pt>
                <c:pt idx="39">
                  <c:v>1.025697695868687</c:v>
                </c:pt>
                <c:pt idx="40">
                  <c:v>1.025697695868687</c:v>
                </c:pt>
                <c:pt idx="41">
                  <c:v>1.025697695868687</c:v>
                </c:pt>
                <c:pt idx="42">
                  <c:v>1.025697695868687</c:v>
                </c:pt>
                <c:pt idx="43">
                  <c:v>1.0264009207191938</c:v>
                </c:pt>
                <c:pt idx="44">
                  <c:v>1.0293349217405616</c:v>
                </c:pt>
                <c:pt idx="45">
                  <c:v>1.0286404745548035</c:v>
                </c:pt>
                <c:pt idx="46">
                  <c:v>1.0264268584392444</c:v>
                </c:pt>
                <c:pt idx="47">
                  <c:v>1.0293349217405616</c:v>
                </c:pt>
                <c:pt idx="48">
                  <c:v>1.0300940855836904</c:v>
                </c:pt>
                <c:pt idx="49">
                  <c:v>1.0322078791434393</c:v>
                </c:pt>
                <c:pt idx="50">
                  <c:v>1.0300944603545119</c:v>
                </c:pt>
                <c:pt idx="51">
                  <c:v>1.0329721476124365</c:v>
                </c:pt>
                <c:pt idx="52">
                  <c:v>1.0329721476124365</c:v>
                </c:pt>
                <c:pt idx="53">
                  <c:v>1.0329721476124365</c:v>
                </c:pt>
                <c:pt idx="54">
                  <c:v>1.0329721476124365</c:v>
                </c:pt>
                <c:pt idx="55">
                  <c:v>1.0329721476124365</c:v>
                </c:pt>
                <c:pt idx="56">
                  <c:v>1.0338142984599008</c:v>
                </c:pt>
                <c:pt idx="57">
                  <c:v>1.0366093734843111</c:v>
                </c:pt>
                <c:pt idx="58">
                  <c:v>1.0366093734843111</c:v>
                </c:pt>
                <c:pt idx="59">
                  <c:v>1.0374841299869801</c:v>
                </c:pt>
                <c:pt idx="60">
                  <c:v>1.0402465993561862</c:v>
                </c:pt>
                <c:pt idx="61">
                  <c:v>1.0402465993561862</c:v>
                </c:pt>
                <c:pt idx="62">
                  <c:v>1.0402465993561862</c:v>
                </c:pt>
                <c:pt idx="63">
                  <c:v>1.0402465993561862</c:v>
                </c:pt>
                <c:pt idx="64">
                  <c:v>1.041176451843066</c:v>
                </c:pt>
                <c:pt idx="65">
                  <c:v>1.0448235045831269</c:v>
                </c:pt>
                <c:pt idx="66">
                  <c:v>1.0465691244505555</c:v>
                </c:pt>
                <c:pt idx="67">
                  <c:v>1.0438838252280609</c:v>
                </c:pt>
                <c:pt idx="68">
                  <c:v>1.0448581520951701</c:v>
                </c:pt>
                <c:pt idx="69">
                  <c:v>1.046537204316224</c:v>
                </c:pt>
                <c:pt idx="70">
                  <c:v>1.0438838252280609</c:v>
                </c:pt>
                <c:pt idx="71">
                  <c:v>1.0448882926025813</c:v>
                </c:pt>
                <c:pt idx="72">
                  <c:v>1.0485380032060019</c:v>
                </c:pt>
                <c:pt idx="73">
                  <c:v>1.0501299783391433</c:v>
                </c:pt>
                <c:pt idx="74">
                  <c:v>1.0485567994567744</c:v>
                </c:pt>
                <c:pt idx="75">
                  <c:v>1.0501110508937481</c:v>
                </c:pt>
                <c:pt idx="76">
                  <c:v>1.0485800987749809</c:v>
                </c:pt>
                <c:pt idx="77">
                  <c:v>1.0522278236235871</c:v>
                </c:pt>
                <c:pt idx="78">
                  <c:v>1.0537141064078177</c:v>
                </c:pt>
                <c:pt idx="79">
                  <c:v>1.0522442510013477</c:v>
                </c:pt>
                <c:pt idx="80">
                  <c:v>1.0547955028436851</c:v>
                </c:pt>
                <c:pt idx="81">
                  <c:v>1.0547955028436851</c:v>
                </c:pt>
                <c:pt idx="82">
                  <c:v>1.0547955028436851</c:v>
                </c:pt>
                <c:pt idx="83">
                  <c:v>1.0559302183048682</c:v>
                </c:pt>
                <c:pt idx="84">
                  <c:v>1.0584327287155599</c:v>
                </c:pt>
                <c:pt idx="85">
                  <c:v>1.0584327287155599</c:v>
                </c:pt>
                <c:pt idx="86">
                  <c:v>1.0596002158742386</c:v>
                </c:pt>
                <c:pt idx="87">
                  <c:v>1.0620699545874346</c:v>
                </c:pt>
                <c:pt idx="88">
                  <c:v>1.0620699545874346</c:v>
                </c:pt>
                <c:pt idx="89">
                  <c:v>1.0632698845215942</c:v>
                </c:pt>
                <c:pt idx="90">
                  <c:v>1.0657071804593095</c:v>
                </c:pt>
                <c:pt idx="91">
                  <c:v>1.0657071804593095</c:v>
                </c:pt>
                <c:pt idx="92">
                  <c:v>1.0644760509091293</c:v>
                </c:pt>
                <c:pt idx="93">
                  <c:v>1.0657955960176582</c:v>
                </c:pt>
                <c:pt idx="94">
                  <c:v>1.0717272121257302</c:v>
                </c:pt>
                <c:pt idx="95">
                  <c:v>1.0693444063311843</c:v>
                </c:pt>
                <c:pt idx="96">
                  <c:v>1.0693444063311843</c:v>
                </c:pt>
                <c:pt idx="97">
                  <c:v>1.070626593909773</c:v>
                </c:pt>
                <c:pt idx="98">
                  <c:v>1.0729816322030592</c:v>
                </c:pt>
                <c:pt idx="99">
                  <c:v>1.0742892696836908</c:v>
                </c:pt>
                <c:pt idx="100">
                  <c:v>1.0753026757624773</c:v>
                </c:pt>
                <c:pt idx="101">
                  <c:v>1.0743093801309405</c:v>
                </c:pt>
                <c:pt idx="102">
                  <c:v>1.0779601931223328</c:v>
                </c:pt>
                <c:pt idx="103">
                  <c:v>1.0802560839468087</c:v>
                </c:pt>
                <c:pt idx="104">
                  <c:v>1.0788953912823656</c:v>
                </c:pt>
                <c:pt idx="105">
                  <c:v>1.0779898077969114</c:v>
                </c:pt>
                <c:pt idx="106">
                  <c:v>1.0802560839468087</c:v>
                </c:pt>
                <c:pt idx="107">
                  <c:v>1.0802560839468087</c:v>
                </c:pt>
                <c:pt idx="108">
                  <c:v>1.0802560839468087</c:v>
                </c:pt>
                <c:pt idx="109">
                  <c:v>1.0816725391169761</c:v>
                </c:pt>
                <c:pt idx="110">
                  <c:v>1.0824680457456095</c:v>
                </c:pt>
                <c:pt idx="111">
                  <c:v>1.081692442296428</c:v>
                </c:pt>
                <c:pt idx="112">
                  <c:v>1.0838933098186834</c:v>
                </c:pt>
                <c:pt idx="113">
                  <c:v>1.085348017022991</c:v>
                </c:pt>
                <c:pt idx="114">
                  <c:v>1.087530535690558</c:v>
                </c:pt>
                <c:pt idx="115">
                  <c:v>1.087530535690558</c:v>
                </c:pt>
                <c:pt idx="116">
                  <c:v>1.0860522195063611</c:v>
                </c:pt>
                <c:pt idx="117">
                  <c:v>1.0853948188031122</c:v>
                </c:pt>
                <c:pt idx="118">
                  <c:v>1.0890424467906619</c:v>
                </c:pt>
                <c:pt idx="119">
                  <c:v>1.0911677615624329</c:v>
                </c:pt>
                <c:pt idx="120">
                  <c:v>1.0911677615624329</c:v>
                </c:pt>
                <c:pt idx="121">
                  <c:v>1.0911677615624329</c:v>
                </c:pt>
                <c:pt idx="122">
                  <c:v>1.0927122386884485</c:v>
                </c:pt>
                <c:pt idx="123">
                  <c:v>1.0948049874343075</c:v>
                </c:pt>
                <c:pt idx="124">
                  <c:v>1.0948049874343075</c:v>
                </c:pt>
                <c:pt idx="125">
                  <c:v>1.096357449597603</c:v>
                </c:pt>
                <c:pt idx="126">
                  <c:v>1.0984422133061824</c:v>
                </c:pt>
                <c:pt idx="127">
                  <c:v>1.0984422133061824</c:v>
                </c:pt>
                <c:pt idx="128">
                  <c:v>1.0984422133061824</c:v>
                </c:pt>
                <c:pt idx="129">
                  <c:v>1.1000454153428678</c:v>
                </c:pt>
                <c:pt idx="130">
                  <c:v>1.1020794391780573</c:v>
                </c:pt>
                <c:pt idx="131">
                  <c:v>1.1020794391780573</c:v>
                </c:pt>
                <c:pt idx="132">
                  <c:v>1.1037315028812045</c:v>
                </c:pt>
                <c:pt idx="133">
                  <c:v>1.1040453835181323</c:v>
                </c:pt>
                <c:pt idx="134">
                  <c:v>1.1054470755665675</c:v>
                </c:pt>
                <c:pt idx="135">
                  <c:v>1.1076854853403764</c:v>
                </c:pt>
                <c:pt idx="136">
                  <c:v>1.1057166650499322</c:v>
                </c:pt>
                <c:pt idx="137">
                  <c:v>1.1074321013352408</c:v>
                </c:pt>
                <c:pt idx="138">
                  <c:v>1.1093538909218068</c:v>
                </c:pt>
                <c:pt idx="139">
                  <c:v>1.1093538909218068</c:v>
                </c:pt>
                <c:pt idx="140">
                  <c:v>1.1093538909218068</c:v>
                </c:pt>
                <c:pt idx="141">
                  <c:v>1.1093538909218068</c:v>
                </c:pt>
                <c:pt idx="142">
                  <c:v>1.1111226975554385</c:v>
                </c:pt>
                <c:pt idx="143">
                  <c:v>1.1129911167936817</c:v>
                </c:pt>
                <c:pt idx="144">
                  <c:v>1.1129911167936817</c:v>
                </c:pt>
                <c:pt idx="145">
                  <c:v>1.1147909728629253</c:v>
                </c:pt>
                <c:pt idx="146">
                  <c:v>1.1166283426655563</c:v>
                </c:pt>
                <c:pt idx="147">
                  <c:v>1.1166283426655563</c:v>
                </c:pt>
                <c:pt idx="148">
                  <c:v>1.1166283426655563</c:v>
                </c:pt>
                <c:pt idx="149">
                  <c:v>1.1166283426655563</c:v>
                </c:pt>
                <c:pt idx="150">
                  <c:v>1.1184797827137096</c:v>
                </c:pt>
                <c:pt idx="151">
                  <c:v>1.1221276463499565</c:v>
                </c:pt>
                <c:pt idx="152">
                  <c:v>1.1239027944093058</c:v>
                </c:pt>
                <c:pt idx="153">
                  <c:v>1.1239027944093058</c:v>
                </c:pt>
                <c:pt idx="154">
                  <c:v>1.1239027944093058</c:v>
                </c:pt>
                <c:pt idx="155">
                  <c:v>1.1239027944093058</c:v>
                </c:pt>
                <c:pt idx="156">
                  <c:v>1.1258128984450833</c:v>
                </c:pt>
                <c:pt idx="157">
                  <c:v>1.1275400202811805</c:v>
                </c:pt>
                <c:pt idx="158">
                  <c:v>1.1236538013990751</c:v>
                </c:pt>
                <c:pt idx="159">
                  <c:v>1.1241705546593579</c:v>
                </c:pt>
                <c:pt idx="160">
                  <c:v>1.1275400202811805</c:v>
                </c:pt>
                <c:pt idx="161">
                  <c:v>1.1275400202811805</c:v>
                </c:pt>
                <c:pt idx="162">
                  <c:v>1.1295265982086042</c:v>
                </c:pt>
                <c:pt idx="163">
                  <c:v>1.1311772461530556</c:v>
                </c:pt>
                <c:pt idx="164">
                  <c:v>1.1311772461530556</c:v>
                </c:pt>
                <c:pt idx="165">
                  <c:v>1.1311772461530556</c:v>
                </c:pt>
                <c:pt idx="166">
                  <c:v>1.1311772461530556</c:v>
                </c:pt>
                <c:pt idx="167">
                  <c:v>1.1311772461530556</c:v>
                </c:pt>
                <c:pt idx="168">
                  <c:v>1.1332297038280597</c:v>
                </c:pt>
                <c:pt idx="169">
                  <c:v>1.1348144720249302</c:v>
                </c:pt>
                <c:pt idx="170">
                  <c:v>1.1348144720249302</c:v>
                </c:pt>
                <c:pt idx="171">
                  <c:v>1.1348144720249302</c:v>
                </c:pt>
                <c:pt idx="172">
                  <c:v>1.1348144720249302</c:v>
                </c:pt>
                <c:pt idx="173">
                  <c:v>1.1369202909326259</c:v>
                </c:pt>
                <c:pt idx="174">
                  <c:v>1.1384516978968051</c:v>
                </c:pt>
                <c:pt idx="175">
                  <c:v>1.1384516978968051</c:v>
                </c:pt>
                <c:pt idx="176">
                  <c:v>1.1384516978968051</c:v>
                </c:pt>
                <c:pt idx="177">
                  <c:v>1.1384516978968051</c:v>
                </c:pt>
                <c:pt idx="178">
                  <c:v>1.1406107196225179</c:v>
                </c:pt>
                <c:pt idx="179">
                  <c:v>1.1420889237686798</c:v>
                </c:pt>
                <c:pt idx="180">
                  <c:v>1.1420889237686798</c:v>
                </c:pt>
                <c:pt idx="181">
                  <c:v>1.1420889237686798</c:v>
                </c:pt>
                <c:pt idx="182">
                  <c:v>1.1442824570844485</c:v>
                </c:pt>
                <c:pt idx="183">
                  <c:v>1.1435142964375657</c:v>
                </c:pt>
                <c:pt idx="184">
                  <c:v>1.1443104053742768</c:v>
                </c:pt>
                <c:pt idx="185">
                  <c:v>1.1457261496405546</c:v>
                </c:pt>
                <c:pt idx="186">
                  <c:v>1.1457261496405546</c:v>
                </c:pt>
                <c:pt idx="187">
                  <c:v>1.1457261496405546</c:v>
                </c:pt>
                <c:pt idx="188">
                  <c:v>1.1479922513429901</c:v>
                </c:pt>
                <c:pt idx="189">
                  <c:v>1.1493633755124293</c:v>
                </c:pt>
                <c:pt idx="190">
                  <c:v>1.1493633755124293</c:v>
                </c:pt>
                <c:pt idx="191">
                  <c:v>1.1493633755124293</c:v>
                </c:pt>
                <c:pt idx="192">
                  <c:v>1.1493633755124293</c:v>
                </c:pt>
                <c:pt idx="193">
                  <c:v>1.1516829255546159</c:v>
                </c:pt>
                <c:pt idx="194">
                  <c:v>1.1530006013843042</c:v>
                </c:pt>
                <c:pt idx="195">
                  <c:v>1.1530006013843042</c:v>
                </c:pt>
                <c:pt idx="196">
                  <c:v>1.1530006013843042</c:v>
                </c:pt>
                <c:pt idx="197">
                  <c:v>1.1530006013843042</c:v>
                </c:pt>
                <c:pt idx="198">
                  <c:v>1.1553663524933662</c:v>
                </c:pt>
                <c:pt idx="199">
                  <c:v>1.1566378272561788</c:v>
                </c:pt>
                <c:pt idx="200">
                  <c:v>1.1566378272561788</c:v>
                </c:pt>
                <c:pt idx="201">
                  <c:v>1.1590397386672056</c:v>
                </c:pt>
                <c:pt idx="202">
                  <c:v>1.1578605297149498</c:v>
                </c:pt>
                <c:pt idx="203">
                  <c:v>1.1590558770741797</c:v>
                </c:pt>
                <c:pt idx="204">
                  <c:v>1.1602750531280537</c:v>
                </c:pt>
                <c:pt idx="205">
                  <c:v>1.1602750531280537</c:v>
                </c:pt>
                <c:pt idx="206">
                  <c:v>1.1627315792442356</c:v>
                </c:pt>
                <c:pt idx="207">
                  <c:v>1.1639122789999286</c:v>
                </c:pt>
                <c:pt idx="208">
                  <c:v>1.1639122789999286</c:v>
                </c:pt>
                <c:pt idx="209">
                  <c:v>1.1664042567890589</c:v>
                </c:pt>
                <c:pt idx="210">
                  <c:v>1.1625448347543295</c:v>
                </c:pt>
                <c:pt idx="211">
                  <c:v>1.1653010783487585</c:v>
                </c:pt>
                <c:pt idx="212">
                  <c:v>1.1675495048718032</c:v>
                </c:pt>
                <c:pt idx="213">
                  <c:v>1.1675495048718032</c:v>
                </c:pt>
                <c:pt idx="214">
                  <c:v>1.1700953717313185</c:v>
                </c:pt>
                <c:pt idx="215">
                  <c:v>1.1737434660056292</c:v>
                </c:pt>
                <c:pt idx="216">
                  <c:v>1.1722570569113573</c:v>
                </c:pt>
                <c:pt idx="217">
                  <c:v>1.1660394643056118</c:v>
                </c:pt>
                <c:pt idx="218">
                  <c:v>1.1690885243280065</c:v>
                </c:pt>
                <c:pt idx="219">
                  <c:v>1.1711867307436781</c:v>
                </c:pt>
                <c:pt idx="220">
                  <c:v>1.1711867307436781</c:v>
                </c:pt>
                <c:pt idx="221">
                  <c:v>1.1711867307436781</c:v>
                </c:pt>
                <c:pt idx="222">
                  <c:v>1.1685566596333723</c:v>
                </c:pt>
                <c:pt idx="223">
                  <c:v>1.1675495048718032</c:v>
                </c:pt>
                <c:pt idx="224">
                  <c:v>1.1728512744614925</c:v>
                </c:pt>
                <c:pt idx="225">
                  <c:v>1.1748239566155527</c:v>
                </c:pt>
                <c:pt idx="226">
                  <c:v>1.1774933803625436</c:v>
                </c:pt>
                <c:pt idx="227">
                  <c:v>1.1784611824874276</c:v>
                </c:pt>
                <c:pt idx="228">
                  <c:v>1.1757641099982394</c:v>
                </c:pt>
                <c:pt idx="229">
                  <c:v>1.1775315531725061</c:v>
                </c:pt>
                <c:pt idx="230">
                  <c:v>1.1757418306982148</c:v>
                </c:pt>
                <c:pt idx="231">
                  <c:v>1.1802784417470531</c:v>
                </c:pt>
                <c:pt idx="232">
                  <c:v>1.1793589413742604</c:v>
                </c:pt>
                <c:pt idx="233">
                  <c:v>1.1839628806423308</c:v>
                </c:pt>
                <c:pt idx="234">
                  <c:v>1.1829738874785827</c:v>
                </c:pt>
                <c:pt idx="235">
                  <c:v>1.1848713249473166</c:v>
                </c:pt>
                <c:pt idx="236">
                  <c:v>1.1857356342311771</c:v>
                </c:pt>
                <c:pt idx="237">
                  <c:v>1.1829508860261611</c:v>
                </c:pt>
                <c:pt idx="238">
                  <c:v>1.1820984083593022</c:v>
                </c:pt>
                <c:pt idx="239">
                  <c:v>1.1820984083593022</c:v>
                </c:pt>
                <c:pt idx="240">
                  <c:v>1.1820984083593022</c:v>
                </c:pt>
                <c:pt idx="241">
                  <c:v>1.1877153439704136</c:v>
                </c:pt>
                <c:pt idx="242">
                  <c:v>1.1836923642356039</c:v>
                </c:pt>
                <c:pt idx="243">
                  <c:v>1.1849515034380007</c:v>
                </c:pt>
                <c:pt idx="244">
                  <c:v>1.1886033477513755</c:v>
                </c:pt>
                <c:pt idx="245">
                  <c:v>1.1893728601030518</c:v>
                </c:pt>
                <c:pt idx="246">
                  <c:v>1.1893728601030518</c:v>
                </c:pt>
                <c:pt idx="247">
                  <c:v>1.1922664686407867</c:v>
                </c:pt>
                <c:pt idx="248">
                  <c:v>1.1871866188279068</c:v>
                </c:pt>
                <c:pt idx="249">
                  <c:v>1.1828134937519217</c:v>
                </c:pt>
                <c:pt idx="250">
                  <c:v>1.185032540840965</c:v>
                </c:pt>
                <c:pt idx="251">
                  <c:v>1.1828034111388941</c:v>
                </c:pt>
                <c:pt idx="252">
                  <c:v>1.1880048961577199</c:v>
                </c:pt>
                <c:pt idx="253">
                  <c:v>1.1864064270848489</c:v>
                </c:pt>
                <c:pt idx="254">
                  <c:v>1.1857356342311771</c:v>
                </c:pt>
                <c:pt idx="255">
                  <c:v>1.1857356342311771</c:v>
                </c:pt>
                <c:pt idx="256">
                  <c:v>1.1857356342311771</c:v>
                </c:pt>
                <c:pt idx="257">
                  <c:v>1.1857356342311771</c:v>
                </c:pt>
                <c:pt idx="258">
                  <c:v>1.188754733225821</c:v>
                </c:pt>
                <c:pt idx="259">
                  <c:v>1.1863425693077099</c:v>
                </c:pt>
                <c:pt idx="260">
                  <c:v>1.1857356342311771</c:v>
                </c:pt>
                <c:pt idx="261">
                  <c:v>1.1796431830866561</c:v>
                </c:pt>
                <c:pt idx="262">
                  <c:v>1.1876391127306505</c:v>
                </c:pt>
                <c:pt idx="263">
                  <c:v>1.186299659334062</c:v>
                </c:pt>
                <c:pt idx="264">
                  <c:v>1.1857356342311771</c:v>
                </c:pt>
                <c:pt idx="265">
                  <c:v>1.1857356342311771</c:v>
                </c:pt>
                <c:pt idx="266">
                  <c:v>1.1919425917644695</c:v>
                </c:pt>
                <c:pt idx="267">
                  <c:v>1.1898939788756169</c:v>
                </c:pt>
                <c:pt idx="268">
                  <c:v>1.1831175396213907</c:v>
                </c:pt>
                <c:pt idx="269">
                  <c:v>1.1852385409979451</c:v>
                </c:pt>
              </c:numCache>
            </c:numRef>
          </c:xVal>
          <c:yVal>
            <c:numRef>
              <c:f>'d0 s'!$D$7:$D$276</c:f>
              <c:numCache>
                <c:formatCode>General</c:formatCode>
                <c:ptCount val="270"/>
                <c:pt idx="0">
                  <c:v>0</c:v>
                </c:pt>
                <c:pt idx="1">
                  <c:v>1.2259161729587931E-2</c:v>
                </c:pt>
                <c:pt idx="2">
                  <c:v>1.9337669728630061E-2</c:v>
                </c:pt>
                <c:pt idx="3">
                  <c:v>2.5347185539824221E-2</c:v>
                </c:pt>
                <c:pt idx="4">
                  <c:v>4.1841235557709661E-2</c:v>
                </c:pt>
                <c:pt idx="5">
                  <c:v>4.8915531629432178E-2</c:v>
                </c:pt>
                <c:pt idx="6">
                  <c:v>5.9693377071190372E-2</c:v>
                </c:pt>
                <c:pt idx="7">
                  <c:v>6.9886174061868575E-2</c:v>
                </c:pt>
                <c:pt idx="8">
                  <c:v>8.0961542666013075E-2</c:v>
                </c:pt>
                <c:pt idx="9">
                  <c:v>0.10528502355776478</c:v>
                </c:pt>
                <c:pt idx="10">
                  <c:v>0.11684170638070533</c:v>
                </c:pt>
                <c:pt idx="11">
                  <c:v>0.13746848438188911</c:v>
                </c:pt>
                <c:pt idx="12">
                  <c:v>0.15206309781369953</c:v>
                </c:pt>
                <c:pt idx="13">
                  <c:v>0.16708952273286207</c:v>
                </c:pt>
                <c:pt idx="14">
                  <c:v>0.19186008544607286</c:v>
                </c:pt>
                <c:pt idx="15">
                  <c:v>0.21310614765179145</c:v>
                </c:pt>
                <c:pt idx="16">
                  <c:v>0.23544594166466859</c:v>
                </c:pt>
                <c:pt idx="17">
                  <c:v>0.26344084717083721</c:v>
                </c:pt>
                <c:pt idx="18">
                  <c:v>0.28019923002821995</c:v>
                </c:pt>
                <c:pt idx="19">
                  <c:v>0.30951435156722423</c:v>
                </c:pt>
                <c:pt idx="20">
                  <c:v>0.33491946210684082</c:v>
                </c:pt>
                <c:pt idx="21">
                  <c:v>0.36156732949002429</c:v>
                </c:pt>
                <c:pt idx="22">
                  <c:v>0.399251614378972</c:v>
                </c:pt>
                <c:pt idx="23">
                  <c:v>0.42626970178323864</c:v>
                </c:pt>
                <c:pt idx="24">
                  <c:v>0.47043741478528189</c:v>
                </c:pt>
                <c:pt idx="25">
                  <c:v>0.49771088929815399</c:v>
                </c:pt>
                <c:pt idx="26">
                  <c:v>0.53763955755228365</c:v>
                </c:pt>
                <c:pt idx="27">
                  <c:v>0.58650344533914855</c:v>
                </c:pt>
                <c:pt idx="28">
                  <c:v>0.61806555459043144</c:v>
                </c:pt>
                <c:pt idx="29">
                  <c:v>0.65802837469508002</c:v>
                </c:pt>
                <c:pt idx="30">
                  <c:v>0.68224971551030522</c:v>
                </c:pt>
                <c:pt idx="31">
                  <c:v>0.72034105716476649</c:v>
                </c:pt>
                <c:pt idx="32">
                  <c:v>0.7551074799004458</c:v>
                </c:pt>
                <c:pt idx="33">
                  <c:v>0.78242729568218272</c:v>
                </c:pt>
                <c:pt idx="34">
                  <c:v>0.82549444382206738</c:v>
                </c:pt>
                <c:pt idx="35">
                  <c:v>0.85286849446076651</c:v>
                </c:pt>
                <c:pt idx="36">
                  <c:v>0.89444117695313408</c:v>
                </c:pt>
                <c:pt idx="37">
                  <c:v>0.91833544399239175</c:v>
                </c:pt>
                <c:pt idx="38">
                  <c:v>0.93766098816067278</c:v>
                </c:pt>
                <c:pt idx="39">
                  <c:v>0.96375493508153043</c:v>
                </c:pt>
                <c:pt idx="40">
                  <c:v>0.99392208085355571</c:v>
                </c:pt>
                <c:pt idx="41">
                  <c:v>1.0294451603906116</c:v>
                </c:pt>
                <c:pt idx="42">
                  <c:v>1.0593362990688098</c:v>
                </c:pt>
                <c:pt idx="43">
                  <c:v>1.0876161792144603</c:v>
                </c:pt>
                <c:pt idx="44">
                  <c:v>1.1178370228646586</c:v>
                </c:pt>
                <c:pt idx="45">
                  <c:v>1.1442210457234225</c:v>
                </c:pt>
                <c:pt idx="46">
                  <c:v>1.1716777373966334</c:v>
                </c:pt>
                <c:pt idx="47">
                  <c:v>1.2078950231027521</c:v>
                </c:pt>
                <c:pt idx="48">
                  <c:v>1.2299630253052387</c:v>
                </c:pt>
                <c:pt idx="49">
                  <c:v>1.2571006441863268</c:v>
                </c:pt>
                <c:pt idx="50">
                  <c:v>1.2824747173523592</c:v>
                </c:pt>
                <c:pt idx="51">
                  <c:v>1.3053484025190008</c:v>
                </c:pt>
                <c:pt idx="52">
                  <c:v>1.3400611810743808</c:v>
                </c:pt>
                <c:pt idx="53">
                  <c:v>1.3565767152777142</c:v>
                </c:pt>
                <c:pt idx="54">
                  <c:v>1.3897354772386801</c:v>
                </c:pt>
                <c:pt idx="55">
                  <c:v>1.4057855582339811</c:v>
                </c:pt>
                <c:pt idx="56">
                  <c:v>1.4253466212959449</c:v>
                </c:pt>
                <c:pt idx="57">
                  <c:v>1.4531693177068026</c:v>
                </c:pt>
                <c:pt idx="58">
                  <c:v>1.4682526221034224</c:v>
                </c:pt>
                <c:pt idx="59">
                  <c:v>1.4983396506412099</c:v>
                </c:pt>
                <c:pt idx="60">
                  <c:v>1.5195540713722115</c:v>
                </c:pt>
                <c:pt idx="61">
                  <c:v>1.5496032966037612</c:v>
                </c:pt>
                <c:pt idx="62">
                  <c:v>1.5820589385478909</c:v>
                </c:pt>
                <c:pt idx="63">
                  <c:v>1.6012434720880819</c:v>
                </c:pt>
                <c:pt idx="64">
                  <c:v>1.6279971511402116</c:v>
                </c:pt>
                <c:pt idx="65">
                  <c:v>1.6380919226542801</c:v>
                </c:pt>
                <c:pt idx="66">
                  <c:v>1.6612422592892855</c:v>
                </c:pt>
                <c:pt idx="67">
                  <c:v>1.6809595831767414</c:v>
                </c:pt>
                <c:pt idx="68">
                  <c:v>1.696430908441062</c:v>
                </c:pt>
                <c:pt idx="69">
                  <c:v>1.7141715060371017</c:v>
                </c:pt>
                <c:pt idx="70">
                  <c:v>1.7241689769959125</c:v>
                </c:pt>
                <c:pt idx="71">
                  <c:v>1.739841991490662</c:v>
                </c:pt>
                <c:pt idx="72">
                  <c:v>1.7495113684138224</c:v>
                </c:pt>
                <c:pt idx="73">
                  <c:v>1.7590085899395449</c:v>
                </c:pt>
                <c:pt idx="74">
                  <c:v>1.7794588898641033</c:v>
                </c:pt>
                <c:pt idx="75">
                  <c:v>1.7836200458397216</c:v>
                </c:pt>
                <c:pt idx="76">
                  <c:v>1.8010936575854692</c:v>
                </c:pt>
                <c:pt idx="77">
                  <c:v>1.8126659799154297</c:v>
                </c:pt>
                <c:pt idx="78">
                  <c:v>1.8181532586904821</c:v>
                </c:pt>
                <c:pt idx="79">
                  <c:v>1.8320925834904387</c:v>
                </c:pt>
                <c:pt idx="80">
                  <c:v>1.8383743760709828</c:v>
                </c:pt>
                <c:pt idx="81">
                  <c:v>1.853286062048954</c:v>
                </c:pt>
                <c:pt idx="82">
                  <c:v>1.8541523162196889</c:v>
                </c:pt>
                <c:pt idx="83">
                  <c:v>1.8617396116144493</c:v>
                </c:pt>
                <c:pt idx="84">
                  <c:v>1.8681219266229396</c:v>
                </c:pt>
                <c:pt idx="85">
                  <c:v>1.8764541189837574</c:v>
                </c:pt>
                <c:pt idx="86">
                  <c:v>1.8920342361492637</c:v>
                </c:pt>
                <c:pt idx="87">
                  <c:v>1.8992499422270439</c:v>
                </c:pt>
                <c:pt idx="88">
                  <c:v>1.9098035084122476</c:v>
                </c:pt>
                <c:pt idx="89">
                  <c:v>1.9183455520809791</c:v>
                </c:pt>
                <c:pt idx="90">
                  <c:v>1.9303392953588638</c:v>
                </c:pt>
                <c:pt idx="91">
                  <c:v>1.9404604862289934</c:v>
                </c:pt>
                <c:pt idx="92">
                  <c:v>1.9536753192566008</c:v>
                </c:pt>
                <c:pt idx="93">
                  <c:v>1.9614969521917214</c:v>
                </c:pt>
                <c:pt idx="94">
                  <c:v>1.9645600939543955</c:v>
                </c:pt>
                <c:pt idx="95">
                  <c:v>1.9672278045421792</c:v>
                </c:pt>
                <c:pt idx="96">
                  <c:v>1.9684488942919016</c:v>
                </c:pt>
                <c:pt idx="97">
                  <c:v>1.9733253060048244</c:v>
                </c:pt>
                <c:pt idx="98">
                  <c:v>1.9746338159002186</c:v>
                </c:pt>
                <c:pt idx="99">
                  <c:v>1.9790093338055124</c:v>
                </c:pt>
                <c:pt idx="100">
                  <c:v>1.9794217335099051</c:v>
                </c:pt>
                <c:pt idx="101">
                  <c:v>1.9845717896100095</c:v>
                </c:pt>
                <c:pt idx="102">
                  <c:v>1.9845075669477106</c:v>
                </c:pt>
                <c:pt idx="103">
                  <c:v>1.9896793169906006</c:v>
                </c:pt>
                <c:pt idx="104">
                  <c:v>1.9983792324211702</c:v>
                </c:pt>
                <c:pt idx="105">
                  <c:v>2.0032010870898618</c:v>
                </c:pt>
                <c:pt idx="106">
                  <c:v>2.0095846908474293</c:v>
                </c:pt>
                <c:pt idx="107">
                  <c:v>2.0063656104465317</c:v>
                </c:pt>
                <c:pt idx="108">
                  <c:v>2.0037773727184494</c:v>
                </c:pt>
                <c:pt idx="109">
                  <c:v>2.0064132941623516</c:v>
                </c:pt>
                <c:pt idx="110">
                  <c:v>2.0041365041276888</c:v>
                </c:pt>
                <c:pt idx="111">
                  <c:v>2.0107746358278114</c:v>
                </c:pt>
                <c:pt idx="112">
                  <c:v>2.0071354232280636</c:v>
                </c:pt>
                <c:pt idx="113">
                  <c:v>2.0076464122367881</c:v>
                </c:pt>
                <c:pt idx="114">
                  <c:v>2.0103244328171841</c:v>
                </c:pt>
                <c:pt idx="115">
                  <c:v>2.0072591431393825</c:v>
                </c:pt>
                <c:pt idx="116">
                  <c:v>2.0110207869013679</c:v>
                </c:pt>
                <c:pt idx="117">
                  <c:v>2.0054140840452526</c:v>
                </c:pt>
                <c:pt idx="118">
                  <c:v>2.0050111351674222</c:v>
                </c:pt>
                <c:pt idx="119">
                  <c:v>2.0112781071335881</c:v>
                </c:pt>
                <c:pt idx="120">
                  <c:v>1.9988047344078368</c:v>
                </c:pt>
                <c:pt idx="121">
                  <c:v>2.0154921018213319</c:v>
                </c:pt>
                <c:pt idx="122">
                  <c:v>2.0042449738416059</c:v>
                </c:pt>
                <c:pt idx="123">
                  <c:v>2.0112727373457715</c:v>
                </c:pt>
                <c:pt idx="124">
                  <c:v>2.005625653685267</c:v>
                </c:pt>
                <c:pt idx="125">
                  <c:v>2.0051181013407482</c:v>
                </c:pt>
                <c:pt idx="126">
                  <c:v>2.0003971986830256</c:v>
                </c:pt>
                <c:pt idx="127">
                  <c:v>1.9962201481354658</c:v>
                </c:pt>
                <c:pt idx="128">
                  <c:v>1.9918461337707594</c:v>
                </c:pt>
                <c:pt idx="129">
                  <c:v>1.9912200165112275</c:v>
                </c:pt>
                <c:pt idx="130">
                  <c:v>1.9831346195985071</c:v>
                </c:pt>
                <c:pt idx="131">
                  <c:v>1.9800441993137217</c:v>
                </c:pt>
                <c:pt idx="132">
                  <c:v>1.9851332546242189</c:v>
                </c:pt>
                <c:pt idx="133">
                  <c:v>1.9770661149900783</c:v>
                </c:pt>
                <c:pt idx="134">
                  <c:v>1.9844654678112206</c:v>
                </c:pt>
                <c:pt idx="135">
                  <c:v>1.9737849598420099</c:v>
                </c:pt>
                <c:pt idx="136">
                  <c:v>1.9848808745967916</c:v>
                </c:pt>
                <c:pt idx="137">
                  <c:v>1.9759502730815808</c:v>
                </c:pt>
                <c:pt idx="138">
                  <c:v>1.9827619563239662</c:v>
                </c:pt>
                <c:pt idx="139">
                  <c:v>1.9820557218301935</c:v>
                </c:pt>
                <c:pt idx="140">
                  <c:v>1.979301235471278</c:v>
                </c:pt>
                <c:pt idx="141">
                  <c:v>1.9843395999847773</c:v>
                </c:pt>
                <c:pt idx="142">
                  <c:v>1.9802368673006152</c:v>
                </c:pt>
                <c:pt idx="143">
                  <c:v>1.9885048369991341</c:v>
                </c:pt>
                <c:pt idx="144">
                  <c:v>1.9819092340185323</c:v>
                </c:pt>
                <c:pt idx="145">
                  <c:v>1.979244745303437</c:v>
                </c:pt>
                <c:pt idx="146">
                  <c:v>1.9874216434005685</c:v>
                </c:pt>
                <c:pt idx="147">
                  <c:v>1.9749358127670802</c:v>
                </c:pt>
                <c:pt idx="148">
                  <c:v>1.985479498542698</c:v>
                </c:pt>
                <c:pt idx="149">
                  <c:v>1.9712078912725863</c:v>
                </c:pt>
                <c:pt idx="150">
                  <c:v>1.9777820151019194</c:v>
                </c:pt>
                <c:pt idx="151">
                  <c:v>1.9739344547348527</c:v>
                </c:pt>
                <c:pt idx="152">
                  <c:v>1.9682300217404567</c:v>
                </c:pt>
                <c:pt idx="153">
                  <c:v>1.9692472743446225</c:v>
                </c:pt>
                <c:pt idx="154">
                  <c:v>1.9591956759246079</c:v>
                </c:pt>
                <c:pt idx="155">
                  <c:v>1.9574504948838873</c:v>
                </c:pt>
                <c:pt idx="156">
                  <c:v>1.9575516616863702</c:v>
                </c:pt>
                <c:pt idx="157">
                  <c:v>1.9559392218005036</c:v>
                </c:pt>
                <c:pt idx="158">
                  <c:v>1.9536716678008856</c:v>
                </c:pt>
                <c:pt idx="159">
                  <c:v>1.9525938439901358</c:v>
                </c:pt>
                <c:pt idx="160">
                  <c:v>1.9409624539941825</c:v>
                </c:pt>
                <c:pt idx="161">
                  <c:v>1.9439527814340496</c:v>
                </c:pt>
                <c:pt idx="162">
                  <c:v>1.9337542656193469</c:v>
                </c:pt>
                <c:pt idx="163">
                  <c:v>1.9294951647139338</c:v>
                </c:pt>
                <c:pt idx="164">
                  <c:v>1.9245609740840963</c:v>
                </c:pt>
                <c:pt idx="165">
                  <c:v>1.9182102334279738</c:v>
                </c:pt>
                <c:pt idx="166">
                  <c:v>1.9095588608792782</c:v>
                </c:pt>
                <c:pt idx="167">
                  <c:v>1.8937491315866908</c:v>
                </c:pt>
                <c:pt idx="168">
                  <c:v>1.8860250139983412</c:v>
                </c:pt>
                <c:pt idx="169">
                  <c:v>1.8699360557392386</c:v>
                </c:pt>
                <c:pt idx="170">
                  <c:v>1.857682199939469</c:v>
                </c:pt>
                <c:pt idx="171">
                  <c:v>1.8490761483999523</c:v>
                </c:pt>
                <c:pt idx="172">
                  <c:v>1.8270063204696061</c:v>
                </c:pt>
                <c:pt idx="173">
                  <c:v>1.8194295498589683</c:v>
                </c:pt>
                <c:pt idx="174">
                  <c:v>1.8053643572325646</c:v>
                </c:pt>
                <c:pt idx="175">
                  <c:v>1.8039061376528172</c:v>
                </c:pt>
                <c:pt idx="176">
                  <c:v>1.7918171343390477</c:v>
                </c:pt>
                <c:pt idx="177">
                  <c:v>1.7907385587580025</c:v>
                </c:pt>
                <c:pt idx="178">
                  <c:v>1.7871093339635991</c:v>
                </c:pt>
                <c:pt idx="179">
                  <c:v>1.7856452076172531</c:v>
                </c:pt>
                <c:pt idx="180">
                  <c:v>1.780765896218907</c:v>
                </c:pt>
                <c:pt idx="181">
                  <c:v>1.7819090166495197</c:v>
                </c:pt>
                <c:pt idx="182">
                  <c:v>1.7692503862440603</c:v>
                </c:pt>
                <c:pt idx="183">
                  <c:v>1.7773176332739558</c:v>
                </c:pt>
                <c:pt idx="184">
                  <c:v>1.7667351776302944</c:v>
                </c:pt>
                <c:pt idx="185">
                  <c:v>1.7708258819897431</c:v>
                </c:pt>
                <c:pt idx="186">
                  <c:v>1.7697963862693538</c:v>
                </c:pt>
                <c:pt idx="187">
                  <c:v>1.7626015149683052</c:v>
                </c:pt>
                <c:pt idx="188">
                  <c:v>1.7639952970942403</c:v>
                </c:pt>
                <c:pt idx="189">
                  <c:v>1.7549058572553828</c:v>
                </c:pt>
                <c:pt idx="190">
                  <c:v>1.7388614682351702</c:v>
                </c:pt>
                <c:pt idx="191">
                  <c:v>1.7110966581369864</c:v>
                </c:pt>
                <c:pt idx="192">
                  <c:v>1.6791733769570945</c:v>
                </c:pt>
                <c:pt idx="193">
                  <c:v>1.6403204919943413</c:v>
                </c:pt>
                <c:pt idx="194">
                  <c:v>1.597483009679415</c:v>
                </c:pt>
                <c:pt idx="195">
                  <c:v>1.5480577642740962</c:v>
                </c:pt>
                <c:pt idx="196">
                  <c:v>1.5119479817200889</c:v>
                </c:pt>
                <c:pt idx="197">
                  <c:v>1.4854660139315305</c:v>
                </c:pt>
                <c:pt idx="198">
                  <c:v>1.4695480297165431</c:v>
                </c:pt>
                <c:pt idx="199">
                  <c:v>1.4478321781991306</c:v>
                </c:pt>
                <c:pt idx="200">
                  <c:v>1.4302902627523413</c:v>
                </c:pt>
                <c:pt idx="201">
                  <c:v>1.4187267468744025</c:v>
                </c:pt>
                <c:pt idx="202">
                  <c:v>1.4044965943662442</c:v>
                </c:pt>
                <c:pt idx="203">
                  <c:v>1.396592374094489</c:v>
                </c:pt>
                <c:pt idx="204">
                  <c:v>1.3677732598561971</c:v>
                </c:pt>
                <c:pt idx="205">
                  <c:v>1.3448705778353396</c:v>
                </c:pt>
                <c:pt idx="206">
                  <c:v>1.3335303377348566</c:v>
                </c:pt>
                <c:pt idx="207">
                  <c:v>1.3107929377830259</c:v>
                </c:pt>
                <c:pt idx="208">
                  <c:v>1.3079951709342981</c:v>
                </c:pt>
                <c:pt idx="209">
                  <c:v>1.2853831018301287</c:v>
                </c:pt>
                <c:pt idx="210">
                  <c:v>1.2754604857134944</c:v>
                </c:pt>
                <c:pt idx="211">
                  <c:v>1.2600901124601431</c:v>
                </c:pt>
                <c:pt idx="212">
                  <c:v>1.2520310275077287</c:v>
                </c:pt>
                <c:pt idx="213">
                  <c:v>1.2440131825257539</c:v>
                </c:pt>
                <c:pt idx="214">
                  <c:v>1.2153747079496457</c:v>
                </c:pt>
                <c:pt idx="215">
                  <c:v>1.1991097280458836</c:v>
                </c:pt>
                <c:pt idx="216">
                  <c:v>1.1880607452366261</c:v>
                </c:pt>
                <c:pt idx="217">
                  <c:v>1.1696903789253394</c:v>
                </c:pt>
                <c:pt idx="218">
                  <c:v>1.1699580091501685</c:v>
                </c:pt>
                <c:pt idx="219">
                  <c:v>1.1483448279758297</c:v>
                </c:pt>
                <c:pt idx="220">
                  <c:v>1.1439841306849108</c:v>
                </c:pt>
                <c:pt idx="221">
                  <c:v>1.1245247714042153</c:v>
                </c:pt>
                <c:pt idx="222">
                  <c:v>1.1106779143504748</c:v>
                </c:pt>
                <c:pt idx="223">
                  <c:v>1.1053713826333611</c:v>
                </c:pt>
                <c:pt idx="224">
                  <c:v>1.0639214534905035</c:v>
                </c:pt>
                <c:pt idx="225">
                  <c:v>1.0443563093898007</c:v>
                </c:pt>
                <c:pt idx="226">
                  <c:v>1.0287575053626909</c:v>
                </c:pt>
                <c:pt idx="227">
                  <c:v>1.006973779727264</c:v>
                </c:pt>
                <c:pt idx="228">
                  <c:v>0.98523107927076647</c:v>
                </c:pt>
                <c:pt idx="229">
                  <c:v>0.93484958205088886</c:v>
                </c:pt>
                <c:pt idx="230">
                  <c:v>0.92103795080523121</c:v>
                </c:pt>
                <c:pt idx="231">
                  <c:v>0.88914312950077368</c:v>
                </c:pt>
                <c:pt idx="232">
                  <c:v>0.87989818060671965</c:v>
                </c:pt>
                <c:pt idx="233">
                  <c:v>0.87842369056988356</c:v>
                </c:pt>
                <c:pt idx="234">
                  <c:v>0.86377904414008544</c:v>
                </c:pt>
                <c:pt idx="235">
                  <c:v>0.86812980732354128</c:v>
                </c:pt>
                <c:pt idx="236">
                  <c:v>0.85965735610492511</c:v>
                </c:pt>
                <c:pt idx="237">
                  <c:v>0.84716438365363855</c:v>
                </c:pt>
                <c:pt idx="238">
                  <c:v>0.79776120807625117</c:v>
                </c:pt>
                <c:pt idx="239">
                  <c:v>0.75017167833426202</c:v>
                </c:pt>
                <c:pt idx="240">
                  <c:v>0.73276873299619349</c:v>
                </c:pt>
                <c:pt idx="241">
                  <c:v>0.71192343147977188</c:v>
                </c:pt>
                <c:pt idx="242">
                  <c:v>0.70822037210287458</c:v>
                </c:pt>
                <c:pt idx="243">
                  <c:v>0.70289542201354849</c:v>
                </c:pt>
                <c:pt idx="244">
                  <c:v>0.68921395442458999</c:v>
                </c:pt>
                <c:pt idx="245">
                  <c:v>0.68935190427362414</c:v>
                </c:pt>
                <c:pt idx="246">
                  <c:v>0.67774102686713411</c:v>
                </c:pt>
                <c:pt idx="247">
                  <c:v>0.66536017558548</c:v>
                </c:pt>
                <c:pt idx="248">
                  <c:v>0.66607113549252861</c:v>
                </c:pt>
                <c:pt idx="249">
                  <c:v>0.6527287163063773</c:v>
                </c:pt>
                <c:pt idx="250">
                  <c:v>0.65603049143966374</c:v>
                </c:pt>
                <c:pt idx="251">
                  <c:v>0.64803992497980067</c:v>
                </c:pt>
                <c:pt idx="252">
                  <c:v>0.64867237858895743</c:v>
                </c:pt>
                <c:pt idx="253">
                  <c:v>0.6382958006102224</c:v>
                </c:pt>
                <c:pt idx="254">
                  <c:v>0.62444577538167101</c:v>
                </c:pt>
                <c:pt idx="255">
                  <c:v>0.61129613157816831</c:v>
                </c:pt>
                <c:pt idx="256">
                  <c:v>0.60126074991736467</c:v>
                </c:pt>
                <c:pt idx="257">
                  <c:v>0.58713273077349437</c:v>
                </c:pt>
                <c:pt idx="258">
                  <c:v>0.58702533501714127</c:v>
                </c:pt>
                <c:pt idx="259">
                  <c:v>0.57941704375201697</c:v>
                </c:pt>
                <c:pt idx="260">
                  <c:v>0.58084148736639174</c:v>
                </c:pt>
                <c:pt idx="261">
                  <c:v>0.57317896124430534</c:v>
                </c:pt>
                <c:pt idx="262">
                  <c:v>0.57329698918053951</c:v>
                </c:pt>
                <c:pt idx="263">
                  <c:v>0.57199202334510524</c:v>
                </c:pt>
                <c:pt idx="264">
                  <c:v>0.56946016838910529</c:v>
                </c:pt>
                <c:pt idx="265">
                  <c:v>0.56899938689647456</c:v>
                </c:pt>
                <c:pt idx="266">
                  <c:v>0.56222212399400262</c:v>
                </c:pt>
                <c:pt idx="267">
                  <c:v>0.56403308493548721</c:v>
                </c:pt>
                <c:pt idx="268">
                  <c:v>0.55922315119574673</c:v>
                </c:pt>
                <c:pt idx="269">
                  <c:v>0.556068830435930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AA5-44B0-8F9A-AB1F1C383170}"/>
            </c:ext>
          </c:extLst>
        </c:ser>
        <c:ser>
          <c:idx val="2"/>
          <c:order val="2"/>
          <c:tx>
            <c:v>EDC-TD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d0 s'!$E$7:$E$166</c:f>
              <c:numCache>
                <c:formatCode>General</c:formatCode>
                <c:ptCount val="16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99897824834170634</c:v>
                </c:pt>
                <c:pt idx="4">
                  <c:v>0.99747620718313423</c:v>
                </c:pt>
                <c:pt idx="5">
                  <c:v>1.0010441840992335</c:v>
                </c:pt>
                <c:pt idx="6">
                  <c:v>1.0025041035372684</c:v>
                </c:pt>
                <c:pt idx="7">
                  <c:v>1</c:v>
                </c:pt>
                <c:pt idx="8">
                  <c:v>1</c:v>
                </c:pt>
                <c:pt idx="9">
                  <c:v>1.001087685390065</c:v>
                </c:pt>
                <c:pt idx="10">
                  <c:v>1.0035587188612098</c:v>
                </c:pt>
                <c:pt idx="11">
                  <c:v>1.0035587188612098</c:v>
                </c:pt>
                <c:pt idx="12">
                  <c:v>1.0035587188612098</c:v>
                </c:pt>
                <c:pt idx="13">
                  <c:v>1.0046893720659644</c:v>
                </c:pt>
                <c:pt idx="14">
                  <c:v>1.0059770718177381</c:v>
                </c:pt>
                <c:pt idx="15">
                  <c:v>1.0047077809205882</c:v>
                </c:pt>
                <c:pt idx="16">
                  <c:v>1.0071174377224199</c:v>
                </c:pt>
                <c:pt idx="17">
                  <c:v>1.0071174377224199</c:v>
                </c:pt>
                <c:pt idx="18">
                  <c:v>1.0071174377224199</c:v>
                </c:pt>
                <c:pt idx="19">
                  <c:v>1.0083099079202642</c:v>
                </c:pt>
                <c:pt idx="20">
                  <c:v>1.0094739883654928</c:v>
                </c:pt>
                <c:pt idx="21">
                  <c:v>1.0083318612104988</c:v>
                </c:pt>
                <c:pt idx="22">
                  <c:v>1.0106761565836297</c:v>
                </c:pt>
                <c:pt idx="23">
                  <c:v>1.0106761565836297</c:v>
                </c:pt>
                <c:pt idx="24">
                  <c:v>1.0094308163868404</c:v>
                </c:pt>
                <c:pt idx="25">
                  <c:v>1.0083726189219071</c:v>
                </c:pt>
                <c:pt idx="26">
                  <c:v>1.0106761565836297</c:v>
                </c:pt>
                <c:pt idx="27">
                  <c:v>1.0106761565836297</c:v>
                </c:pt>
                <c:pt idx="28">
                  <c:v>1.0106761565836297</c:v>
                </c:pt>
                <c:pt idx="29">
                  <c:v>1.0093775469375978</c:v>
                </c:pt>
                <c:pt idx="30">
                  <c:v>1.0097368419173247</c:v>
                </c:pt>
                <c:pt idx="31">
                  <c:v>1.0142348754448398</c:v>
                </c:pt>
                <c:pt idx="32">
                  <c:v>1.0142348754448398</c:v>
                </c:pt>
                <c:pt idx="33">
                  <c:v>1.0128976171773059</c:v>
                </c:pt>
                <c:pt idx="34">
                  <c:v>1.0120263420427649</c:v>
                </c:pt>
                <c:pt idx="35">
                  <c:v>1.0142348754448398</c:v>
                </c:pt>
                <c:pt idx="36">
                  <c:v>1.0156078350806139</c:v>
                </c:pt>
                <c:pt idx="37">
                  <c:v>1.0177935943060497</c:v>
                </c:pt>
                <c:pt idx="38">
                  <c:v>1.0177935943060497</c:v>
                </c:pt>
                <c:pt idx="39">
                  <c:v>1.0177935943060497</c:v>
                </c:pt>
                <c:pt idx="40">
                  <c:v>1.0177935943060497</c:v>
                </c:pt>
                <c:pt idx="41">
                  <c:v>1.0177935943060497</c:v>
                </c:pt>
                <c:pt idx="42">
                  <c:v>1.0163593412409244</c:v>
                </c:pt>
                <c:pt idx="43">
                  <c:v>1.0156737037137882</c:v>
                </c:pt>
                <c:pt idx="44">
                  <c:v>1.019243431553545</c:v>
                </c:pt>
                <c:pt idx="45">
                  <c:v>1.0198875451338087</c:v>
                </c:pt>
                <c:pt idx="46">
                  <c:v>1.0177935943060497</c:v>
                </c:pt>
                <c:pt idx="47">
                  <c:v>1.0177935943060497</c:v>
                </c:pt>
                <c:pt idx="48">
                  <c:v>1.0207853084003107</c:v>
                </c:pt>
                <c:pt idx="49">
                  <c:v>1.0234056364552324</c:v>
                </c:pt>
                <c:pt idx="50">
                  <c:v>1.0228688532640047</c:v>
                </c:pt>
                <c:pt idx="51">
                  <c:v>1.0249110320284698</c:v>
                </c:pt>
                <c:pt idx="52">
                  <c:v>1.0249110320284698</c:v>
                </c:pt>
                <c:pt idx="53">
                  <c:v>1.0249110320284698</c:v>
                </c:pt>
                <c:pt idx="54">
                  <c:v>1.0264634864048394</c:v>
                </c:pt>
                <c:pt idx="55">
                  <c:v>1.0253392295105408</c:v>
                </c:pt>
                <c:pt idx="56">
                  <c:v>1.0245160472189945</c:v>
                </c:pt>
                <c:pt idx="57">
                  <c:v>1.0268777484445972</c:v>
                </c:pt>
                <c:pt idx="58">
                  <c:v>1.0265041974655453</c:v>
                </c:pt>
                <c:pt idx="59">
                  <c:v>1.0284697508896796</c:v>
                </c:pt>
                <c:pt idx="60">
                  <c:v>1.0284697508896796</c:v>
                </c:pt>
                <c:pt idx="61">
                  <c:v>1.0284697508896796</c:v>
                </c:pt>
                <c:pt idx="62">
                  <c:v>1.0284697508896796</c:v>
                </c:pt>
                <c:pt idx="63">
                  <c:v>1.0301137124928275</c:v>
                </c:pt>
                <c:pt idx="64">
                  <c:v>1.0303768949276</c:v>
                </c:pt>
                <c:pt idx="65">
                  <c:v>1.0301454871609634</c:v>
                </c:pt>
                <c:pt idx="66">
                  <c:v>1.0320284697508897</c:v>
                </c:pt>
                <c:pt idx="67">
                  <c:v>1.0320284697508897</c:v>
                </c:pt>
                <c:pt idx="68">
                  <c:v>1.0320284697508897</c:v>
                </c:pt>
                <c:pt idx="69">
                  <c:v>1.0337469789726683</c:v>
                </c:pt>
                <c:pt idx="70">
                  <c:v>1.0355871886120995</c:v>
                </c:pt>
                <c:pt idx="71">
                  <c:v>1.0355871886120995</c:v>
                </c:pt>
                <c:pt idx="72">
                  <c:v>1.0373306283931829</c:v>
                </c:pt>
                <c:pt idx="73">
                  <c:v>1.0426513364936836</c:v>
                </c:pt>
                <c:pt idx="74">
                  <c:v>1.0462633451957293</c:v>
                </c:pt>
                <c:pt idx="75">
                  <c:v>1.0462633451957293</c:v>
                </c:pt>
                <c:pt idx="76">
                  <c:v>1.0462633451957293</c:v>
                </c:pt>
                <c:pt idx="77">
                  <c:v>1.0462633451957293</c:v>
                </c:pt>
                <c:pt idx="78">
                  <c:v>1.0462633451957293</c:v>
                </c:pt>
                <c:pt idx="79">
                  <c:v>1.0480744267576703</c:v>
                </c:pt>
                <c:pt idx="80">
                  <c:v>1.0498220640569396</c:v>
                </c:pt>
                <c:pt idx="81">
                  <c:v>1.0498220640569396</c:v>
                </c:pt>
                <c:pt idx="82">
                  <c:v>1.047967470593083</c:v>
                </c:pt>
                <c:pt idx="83">
                  <c:v>1.0481139456553574</c:v>
                </c:pt>
                <c:pt idx="84">
                  <c:v>1.0498220640569396</c:v>
                </c:pt>
                <c:pt idx="85">
                  <c:v>1.0498220640569396</c:v>
                </c:pt>
                <c:pt idx="86">
                  <c:v>1.0536198080024999</c:v>
                </c:pt>
                <c:pt idx="87">
                  <c:v>1.0569395017793595</c:v>
                </c:pt>
                <c:pt idx="88">
                  <c:v>1.0569395017793595</c:v>
                </c:pt>
                <c:pt idx="89">
                  <c:v>1.0569395017793595</c:v>
                </c:pt>
                <c:pt idx="90">
                  <c:v>1.0588806231851671</c:v>
                </c:pt>
                <c:pt idx="91">
                  <c:v>1.0604982206405693</c:v>
                </c:pt>
                <c:pt idx="92">
                  <c:v>1.0604982206405693</c:v>
                </c:pt>
                <c:pt idx="93">
                  <c:v>1.0604982206405693</c:v>
                </c:pt>
                <c:pt idx="94">
                  <c:v>1.0604982206405693</c:v>
                </c:pt>
                <c:pt idx="95">
                  <c:v>1.0604982206405693</c:v>
                </c:pt>
                <c:pt idx="96">
                  <c:v>1.0625035671015508</c:v>
                </c:pt>
                <c:pt idx="97">
                  <c:v>1.0620418476849081</c:v>
                </c:pt>
                <c:pt idx="98">
                  <c:v>1.0625189965615784</c:v>
                </c:pt>
                <c:pt idx="99">
                  <c:v>1.0640569395017792</c:v>
                </c:pt>
                <c:pt idx="100">
                  <c:v>1.0640569395017792</c:v>
                </c:pt>
                <c:pt idx="101">
                  <c:v>1.0661112795919092</c:v>
                </c:pt>
                <c:pt idx="102">
                  <c:v>1.0655491314532426</c:v>
                </c:pt>
                <c:pt idx="103">
                  <c:v>1.0661353913618614</c:v>
                </c:pt>
                <c:pt idx="104">
                  <c:v>1.0676156583629892</c:v>
                </c:pt>
                <c:pt idx="105">
                  <c:v>1.0676156583629892</c:v>
                </c:pt>
                <c:pt idx="106">
                  <c:v>1.0676156583629892</c:v>
                </c:pt>
                <c:pt idx="107">
                  <c:v>1.0676156583629892</c:v>
                </c:pt>
                <c:pt idx="108">
                  <c:v>1.0697464553266021</c:v>
                </c:pt>
                <c:pt idx="109">
                  <c:v>1.0711743772241991</c:v>
                </c:pt>
                <c:pt idx="110">
                  <c:v>1.0711743772241991</c:v>
                </c:pt>
                <c:pt idx="111">
                  <c:v>1.0711743772241991</c:v>
                </c:pt>
                <c:pt idx="112">
                  <c:v>1.0733464174178799</c:v>
                </c:pt>
                <c:pt idx="113">
                  <c:v>1.0725487604170674</c:v>
                </c:pt>
                <c:pt idx="114">
                  <c:v>1.0733671328546839</c:v>
                </c:pt>
                <c:pt idx="115">
                  <c:v>1.0747330960854093</c:v>
                </c:pt>
                <c:pt idx="116">
                  <c:v>1.0769469287677218</c:v>
                </c:pt>
                <c:pt idx="117">
                  <c:v>1.0760677104047489</c:v>
                </c:pt>
                <c:pt idx="118">
                  <c:v>1.0747330960854093</c:v>
                </c:pt>
                <c:pt idx="119">
                  <c:v>1.0769787934797386</c:v>
                </c:pt>
                <c:pt idx="120">
                  <c:v>1.0782918149466192</c:v>
                </c:pt>
                <c:pt idx="121">
                  <c:v>1.0805557456104382</c:v>
                </c:pt>
                <c:pt idx="122">
                  <c:v>1.081850533807829</c:v>
                </c:pt>
                <c:pt idx="123">
                  <c:v>1.0841341447215929</c:v>
                </c:pt>
                <c:pt idx="124">
                  <c:v>1.0831104048336704</c:v>
                </c:pt>
                <c:pt idx="125">
                  <c:v>1.081850533807829</c:v>
                </c:pt>
                <c:pt idx="126">
                  <c:v>1.0841689444441081</c:v>
                </c:pt>
                <c:pt idx="127">
                  <c:v>1.0854092526690391</c:v>
                </c:pt>
                <c:pt idx="128">
                  <c:v>1.0854092526690391</c:v>
                </c:pt>
                <c:pt idx="129">
                  <c:v>1.0830588627734321</c:v>
                </c:pt>
                <c:pt idx="130">
                  <c:v>1.0842135475797974</c:v>
                </c:pt>
                <c:pt idx="131">
                  <c:v>1.0877824130636866</c:v>
                </c:pt>
                <c:pt idx="132">
                  <c:v>1.0865890216353156</c:v>
                </c:pt>
                <c:pt idx="133">
                  <c:v>1.0854092526690391</c:v>
                </c:pt>
                <c:pt idx="134">
                  <c:v>1.0878128135263396</c:v>
                </c:pt>
                <c:pt idx="135">
                  <c:v>1.0889679715302489</c:v>
                </c:pt>
                <c:pt idx="136">
                  <c:v>1.0913938349705627</c:v>
                </c:pt>
                <c:pt idx="137">
                  <c:v>1.092526690391459</c:v>
                </c:pt>
                <c:pt idx="138">
                  <c:v>1.0949694813059541</c:v>
                </c:pt>
                <c:pt idx="139">
                  <c:v>1.0936349312079607</c:v>
                </c:pt>
                <c:pt idx="140">
                  <c:v>1.092526690391459</c:v>
                </c:pt>
                <c:pt idx="141">
                  <c:v>1.092526690391459</c:v>
                </c:pt>
                <c:pt idx="142">
                  <c:v>1.092526690391459</c:v>
                </c:pt>
                <c:pt idx="143">
                  <c:v>1.0950249938871532</c:v>
                </c:pt>
                <c:pt idx="144">
                  <c:v>1.0960854092526688</c:v>
                </c:pt>
                <c:pt idx="145">
                  <c:v>1.0960854092526688</c:v>
                </c:pt>
                <c:pt idx="146">
                  <c:v>1.0960854092526688</c:v>
                </c:pt>
                <c:pt idx="147">
                  <c:v>1.0960854092526688</c:v>
                </c:pt>
                <c:pt idx="148">
                  <c:v>1.0960854092526688</c:v>
                </c:pt>
                <c:pt idx="149">
                  <c:v>1.0986465163658439</c:v>
                </c:pt>
                <c:pt idx="150">
                  <c:v>1.0996441281138789</c:v>
                </c:pt>
                <c:pt idx="151">
                  <c:v>1.0970596386277889</c:v>
                </c:pt>
                <c:pt idx="152">
                  <c:v>1.0960854092526688</c:v>
                </c:pt>
                <c:pt idx="153">
                  <c:v>1.0960854092526688</c:v>
                </c:pt>
                <c:pt idx="154">
                  <c:v>1.0986892389446574</c:v>
                </c:pt>
                <c:pt idx="155">
                  <c:v>1.0970227791579925</c:v>
                </c:pt>
                <c:pt idx="156">
                  <c:v>1.0987174080812654</c:v>
                </c:pt>
                <c:pt idx="157">
                  <c:v>1.0996441281138789</c:v>
                </c:pt>
                <c:pt idx="158">
                  <c:v>1.0996441281138789</c:v>
                </c:pt>
                <c:pt idx="159">
                  <c:v>1.0996441281138789</c:v>
                </c:pt>
              </c:numCache>
            </c:numRef>
          </c:xVal>
          <c:yVal>
            <c:numRef>
              <c:f>'d0 s'!$F$7:$F$166</c:f>
              <c:numCache>
                <c:formatCode>General</c:formatCode>
                <c:ptCount val="160"/>
                <c:pt idx="0">
                  <c:v>0</c:v>
                </c:pt>
                <c:pt idx="1">
                  <c:v>-6.2099077704689011E-3</c:v>
                </c:pt>
                <c:pt idx="2">
                  <c:v>2.9215897981201035E-3</c:v>
                </c:pt>
                <c:pt idx="3">
                  <c:v>1.2663622138075811E-2</c:v>
                </c:pt>
                <c:pt idx="4">
                  <c:v>2.3113607541116618E-2</c:v>
                </c:pt>
                <c:pt idx="5">
                  <c:v>2.5852596351509639E-2</c:v>
                </c:pt>
                <c:pt idx="6">
                  <c:v>3.9015044937687302E-2</c:v>
                </c:pt>
                <c:pt idx="7">
                  <c:v>5.1281340160190966E-2</c:v>
                </c:pt>
                <c:pt idx="8">
                  <c:v>6.8908802722865314E-2</c:v>
                </c:pt>
                <c:pt idx="9">
                  <c:v>8.4812801662852044E-2</c:v>
                </c:pt>
                <c:pt idx="10">
                  <c:v>0.10275088712234977</c:v>
                </c:pt>
                <c:pt idx="11">
                  <c:v>0.11724662230745032</c:v>
                </c:pt>
                <c:pt idx="12">
                  <c:v>0.14500886390398504</c:v>
                </c:pt>
                <c:pt idx="13">
                  <c:v>0.16800464532398224</c:v>
                </c:pt>
                <c:pt idx="14">
                  <c:v>0.18607126305084576</c:v>
                </c:pt>
                <c:pt idx="15">
                  <c:v>0.21645773436230514</c:v>
                </c:pt>
                <c:pt idx="16">
                  <c:v>0.23919901279098715</c:v>
                </c:pt>
                <c:pt idx="17">
                  <c:v>0.27154662514700323</c:v>
                </c:pt>
                <c:pt idx="18">
                  <c:v>0.28849572079812053</c:v>
                </c:pt>
                <c:pt idx="19">
                  <c:v>0.32847067324955015</c:v>
                </c:pt>
                <c:pt idx="20">
                  <c:v>0.34820774235286467</c:v>
                </c:pt>
                <c:pt idx="21">
                  <c:v>0.37984946095766747</c:v>
                </c:pt>
                <c:pt idx="22">
                  <c:v>0.40655944132316135</c:v>
                </c:pt>
                <c:pt idx="23">
                  <c:v>0.42949297853841439</c:v>
                </c:pt>
                <c:pt idx="24">
                  <c:v>0.45545116541533232</c:v>
                </c:pt>
                <c:pt idx="25">
                  <c:v>0.482327971171856</c:v>
                </c:pt>
                <c:pt idx="26">
                  <c:v>0.51622356192239693</c:v>
                </c:pt>
                <c:pt idx="27">
                  <c:v>0.54863600603208973</c:v>
                </c:pt>
                <c:pt idx="28">
                  <c:v>0.57373887145758362</c:v>
                </c:pt>
                <c:pt idx="29">
                  <c:v>0.59737268523240039</c:v>
                </c:pt>
                <c:pt idx="30">
                  <c:v>0.63275204675619801</c:v>
                </c:pt>
                <c:pt idx="31">
                  <c:v>0.66366033176737071</c:v>
                </c:pt>
                <c:pt idx="32">
                  <c:v>0.69477614080354522</c:v>
                </c:pt>
                <c:pt idx="33">
                  <c:v>0.72020137061675293</c:v>
                </c:pt>
                <c:pt idx="34">
                  <c:v>0.7527520080433463</c:v>
                </c:pt>
                <c:pt idx="35">
                  <c:v>0.77628382818080877</c:v>
                </c:pt>
                <c:pt idx="36">
                  <c:v>0.81175197253936726</c:v>
                </c:pt>
                <c:pt idx="37">
                  <c:v>0.84576333985122765</c:v>
                </c:pt>
                <c:pt idx="38">
                  <c:v>0.86735598060317187</c:v>
                </c:pt>
                <c:pt idx="39">
                  <c:v>0.90165101609356968</c:v>
                </c:pt>
                <c:pt idx="40">
                  <c:v>0.93673152221695188</c:v>
                </c:pt>
                <c:pt idx="41">
                  <c:v>0.95568413490244242</c:v>
                </c:pt>
                <c:pt idx="42">
                  <c:v>0.99606612570466924</c:v>
                </c:pt>
                <c:pt idx="43">
                  <c:v>1.0177296574957302</c:v>
                </c:pt>
                <c:pt idx="44">
                  <c:v>1.0514171000888612</c:v>
                </c:pt>
                <c:pt idx="45">
                  <c:v>1.0773365907566097</c:v>
                </c:pt>
                <c:pt idx="46">
                  <c:v>1.1130867909516535</c:v>
                </c:pt>
                <c:pt idx="47">
                  <c:v>1.1397085345982467</c:v>
                </c:pt>
                <c:pt idx="48">
                  <c:v>1.1687055181380339</c:v>
                </c:pt>
                <c:pt idx="49">
                  <c:v>1.1914101027823447</c:v>
                </c:pt>
                <c:pt idx="50">
                  <c:v>1.2249660614819431</c:v>
                </c:pt>
                <c:pt idx="51">
                  <c:v>1.2490681826054126</c:v>
                </c:pt>
                <c:pt idx="52">
                  <c:v>1.2899795417100131</c:v>
                </c:pt>
                <c:pt idx="53">
                  <c:v>1.3159209810340375</c:v>
                </c:pt>
                <c:pt idx="54">
                  <c:v>1.3361186338474824</c:v>
                </c:pt>
                <c:pt idx="55">
                  <c:v>1.3705476497610427</c:v>
                </c:pt>
                <c:pt idx="56">
                  <c:v>1.401651808325636</c:v>
                </c:pt>
                <c:pt idx="57">
                  <c:v>1.4341315547131126</c:v>
                </c:pt>
                <c:pt idx="58">
                  <c:v>1.4552896432773603</c:v>
                </c:pt>
                <c:pt idx="59">
                  <c:v>1.4780471751541178</c:v>
                </c:pt>
                <c:pt idx="60">
                  <c:v>1.5214425812346972</c:v>
                </c:pt>
                <c:pt idx="61">
                  <c:v>1.5406027179451929</c:v>
                </c:pt>
                <c:pt idx="62">
                  <c:v>1.5710566345647774</c:v>
                </c:pt>
                <c:pt idx="63">
                  <c:v>1.5948812248117024</c:v>
                </c:pt>
                <c:pt idx="64">
                  <c:v>1.6209363602556885</c:v>
                </c:pt>
                <c:pt idx="65">
                  <c:v>1.6373681021532451</c:v>
                </c:pt>
                <c:pt idx="66">
                  <c:v>1.6759466623682644</c:v>
                </c:pt>
                <c:pt idx="67">
                  <c:v>1.6973371362316885</c:v>
                </c:pt>
                <c:pt idx="68">
                  <c:v>1.7281909136793987</c:v>
                </c:pt>
                <c:pt idx="69">
                  <c:v>1.7591501695037302</c:v>
                </c:pt>
                <c:pt idx="70">
                  <c:v>1.7756728266884321</c:v>
                </c:pt>
                <c:pt idx="71">
                  <c:v>1.7972093475348647</c:v>
                </c:pt>
                <c:pt idx="72">
                  <c:v>1.8184924706244565</c:v>
                </c:pt>
                <c:pt idx="73">
                  <c:v>1.8465260017734757</c:v>
                </c:pt>
                <c:pt idx="74">
                  <c:v>1.8699261819843027</c:v>
                </c:pt>
                <c:pt idx="75">
                  <c:v>1.8875034148910497</c:v>
                </c:pt>
                <c:pt idx="76">
                  <c:v>1.9069511726186554</c:v>
                </c:pt>
                <c:pt idx="77">
                  <c:v>1.9330367865284701</c:v>
                </c:pt>
                <c:pt idx="78">
                  <c:v>1.9424524480057652</c:v>
                </c:pt>
                <c:pt idx="79">
                  <c:v>1.9627142824349588</c:v>
                </c:pt>
                <c:pt idx="80">
                  <c:v>1.9926611954967184</c:v>
                </c:pt>
                <c:pt idx="81">
                  <c:v>2.00749432625831</c:v>
                </c:pt>
                <c:pt idx="82">
                  <c:v>2.0166158133282295</c:v>
                </c:pt>
                <c:pt idx="83">
                  <c:v>2.0435123832776081</c:v>
                </c:pt>
                <c:pt idx="84">
                  <c:v>2.0512886569684072</c:v>
                </c:pt>
                <c:pt idx="85">
                  <c:v>2.0792947262915629</c:v>
                </c:pt>
                <c:pt idx="86">
                  <c:v>2.0866626093446903</c:v>
                </c:pt>
                <c:pt idx="87">
                  <c:v>2.1019759059706487</c:v>
                </c:pt>
                <c:pt idx="88">
                  <c:v>2.1107799176900377</c:v>
                </c:pt>
                <c:pt idx="89">
                  <c:v>2.1314503508010461</c:v>
                </c:pt>
                <c:pt idx="90">
                  <c:v>2.1436737759289102</c:v>
                </c:pt>
                <c:pt idx="91">
                  <c:v>2.1559348570452732</c:v>
                </c:pt>
                <c:pt idx="92">
                  <c:v>2.1707465592609241</c:v>
                </c:pt>
                <c:pt idx="93">
                  <c:v>2.1809729687336428</c:v>
                </c:pt>
                <c:pt idx="94">
                  <c:v>2.1851013965553641</c:v>
                </c:pt>
                <c:pt idx="95">
                  <c:v>2.1987428505097162</c:v>
                </c:pt>
                <c:pt idx="96">
                  <c:v>2.2038944393890496</c:v>
                </c:pt>
                <c:pt idx="97">
                  <c:v>2.2008103931267424</c:v>
                </c:pt>
                <c:pt idx="98">
                  <c:v>2.2171759769892625</c:v>
                </c:pt>
                <c:pt idx="99">
                  <c:v>2.2221184815125747</c:v>
                </c:pt>
                <c:pt idx="100">
                  <c:v>2.2275950353313081</c:v>
                </c:pt>
                <c:pt idx="101">
                  <c:v>2.2292308863675001</c:v>
                </c:pt>
                <c:pt idx="102">
                  <c:v>2.2205614792036745</c:v>
                </c:pt>
                <c:pt idx="103">
                  <c:v>2.2077792475282818</c:v>
                </c:pt>
                <c:pt idx="104">
                  <c:v>2.1966902870704352</c:v>
                </c:pt>
                <c:pt idx="105">
                  <c:v>2.1876031272828471</c:v>
                </c:pt>
                <c:pt idx="106">
                  <c:v>2.1818477943227568</c:v>
                </c:pt>
                <c:pt idx="107">
                  <c:v>2.1657524597920483</c:v>
                </c:pt>
                <c:pt idx="108">
                  <c:v>2.148401994992823</c:v>
                </c:pt>
                <c:pt idx="109">
                  <c:v>2.1392413956254583</c:v>
                </c:pt>
                <c:pt idx="110">
                  <c:v>2.1312206700756291</c:v>
                </c:pt>
                <c:pt idx="111">
                  <c:v>2.1260576387688541</c:v>
                </c:pt>
                <c:pt idx="112">
                  <c:v>2.1131690965403025</c:v>
                </c:pt>
                <c:pt idx="113">
                  <c:v>2.0980447039892347</c:v>
                </c:pt>
                <c:pt idx="114">
                  <c:v>1.9988627831271195</c:v>
                </c:pt>
                <c:pt idx="115">
                  <c:v>1.9606827314533497</c:v>
                </c:pt>
                <c:pt idx="116">
                  <c:v>1.9410263054579957</c:v>
                </c:pt>
                <c:pt idx="117">
                  <c:v>1.915132924329235</c:v>
                </c:pt>
                <c:pt idx="118">
                  <c:v>1.8937249747584424</c:v>
                </c:pt>
                <c:pt idx="119">
                  <c:v>1.878302871049699</c:v>
                </c:pt>
                <c:pt idx="120">
                  <c:v>1.8632119736044181</c:v>
                </c:pt>
                <c:pt idx="121">
                  <c:v>1.8517581037331823</c:v>
                </c:pt>
                <c:pt idx="122">
                  <c:v>1.8326550751378385</c:v>
                </c:pt>
                <c:pt idx="123">
                  <c:v>1.8225457945133183</c:v>
                </c:pt>
                <c:pt idx="124">
                  <c:v>1.8047684231483725</c:v>
                </c:pt>
                <c:pt idx="125">
                  <c:v>1.7850666435315139</c:v>
                </c:pt>
                <c:pt idx="126">
                  <c:v>1.7106542493790429</c:v>
                </c:pt>
                <c:pt idx="127">
                  <c:v>1.6038071503944005</c:v>
                </c:pt>
                <c:pt idx="128">
                  <c:v>1.5333325116136116</c:v>
                </c:pt>
                <c:pt idx="129">
                  <c:v>1.1344350318556045</c:v>
                </c:pt>
                <c:pt idx="130">
                  <c:v>0.99044425305739869</c:v>
                </c:pt>
                <c:pt idx="131">
                  <c:v>0.94911046033598512</c:v>
                </c:pt>
                <c:pt idx="132">
                  <c:v>0.89680494002698685</c:v>
                </c:pt>
                <c:pt idx="133">
                  <c:v>0.87474768470979303</c:v>
                </c:pt>
                <c:pt idx="134">
                  <c:v>0.86838985593375118</c:v>
                </c:pt>
                <c:pt idx="135">
                  <c:v>0.86253799049486124</c:v>
                </c:pt>
                <c:pt idx="136">
                  <c:v>0.85602672916900424</c:v>
                </c:pt>
                <c:pt idx="137">
                  <c:v>0.86027238986099031</c:v>
                </c:pt>
                <c:pt idx="138">
                  <c:v>0.8576440642771509</c:v>
                </c:pt>
                <c:pt idx="139">
                  <c:v>0.85153006322773028</c:v>
                </c:pt>
                <c:pt idx="140">
                  <c:v>0.82428959632263077</c:v>
                </c:pt>
                <c:pt idx="141">
                  <c:v>0.82261764962895889</c:v>
                </c:pt>
                <c:pt idx="142">
                  <c:v>0.80253884202782799</c:v>
                </c:pt>
                <c:pt idx="143">
                  <c:v>0.80344523831447723</c:v>
                </c:pt>
                <c:pt idx="144">
                  <c:v>0.79604073949353127</c:v>
                </c:pt>
                <c:pt idx="145">
                  <c:v>0.79800087932568842</c:v>
                </c:pt>
                <c:pt idx="146">
                  <c:v>0.80144681836141962</c:v>
                </c:pt>
                <c:pt idx="147">
                  <c:v>0.78170769482226776</c:v>
                </c:pt>
                <c:pt idx="148">
                  <c:v>0.79015522291575124</c:v>
                </c:pt>
                <c:pt idx="149">
                  <c:v>0.77151940943734976</c:v>
                </c:pt>
                <c:pt idx="150">
                  <c:v>0.78785129014994315</c:v>
                </c:pt>
                <c:pt idx="151">
                  <c:v>0.75594335306845284</c:v>
                </c:pt>
                <c:pt idx="152">
                  <c:v>0.72745025242446326</c:v>
                </c:pt>
                <c:pt idx="153">
                  <c:v>0.70057141823762548</c:v>
                </c:pt>
                <c:pt idx="154">
                  <c:v>0.68574156417116472</c:v>
                </c:pt>
                <c:pt idx="155">
                  <c:v>0.68646025263670407</c:v>
                </c:pt>
                <c:pt idx="156">
                  <c:v>0.68392882360889951</c:v>
                </c:pt>
                <c:pt idx="157">
                  <c:v>0.66340630987811766</c:v>
                </c:pt>
                <c:pt idx="158">
                  <c:v>0.66053623700901121</c:v>
                </c:pt>
                <c:pt idx="159">
                  <c:v>0.659058135438442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AA5-44B0-8F9A-AB1F1C3831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1201280"/>
        <c:axId val="811191712"/>
      </c:scatterChart>
      <c:valAx>
        <c:axId val="811201280"/>
        <c:scaling>
          <c:orientation val="minMax"/>
          <c:max val="1.1600000000000001"/>
          <c:min val="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1191712"/>
        <c:crosses val="autoZero"/>
        <c:crossBetween val="midCat"/>
        <c:majorUnit val="4.0000000000000008E-2"/>
      </c:valAx>
      <c:valAx>
        <c:axId val="811191712"/>
        <c:scaling>
          <c:orientation val="minMax"/>
          <c:max val="3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12012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842629046369205"/>
          <c:y val="5.430592009332167E-2"/>
          <c:w val="0.73895231846019249"/>
          <c:h val="0.75401137357830272"/>
        </c:manualLayout>
      </c:layout>
      <c:scatterChart>
        <c:scatterStyle val="lineMarker"/>
        <c:varyColors val="0"/>
        <c:ser>
          <c:idx val="0"/>
          <c:order val="0"/>
          <c:tx>
            <c:v>PLA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d0 u'!$A$7:$A$274</c:f>
              <c:numCache>
                <c:formatCode>General</c:formatCode>
                <c:ptCount val="268"/>
                <c:pt idx="0">
                  <c:v>1</c:v>
                </c:pt>
                <c:pt idx="1">
                  <c:v>1.0032573676486496</c:v>
                </c:pt>
                <c:pt idx="2">
                  <c:v>0.99983422688079893</c:v>
                </c:pt>
                <c:pt idx="3">
                  <c:v>0.996514861406256</c:v>
                </c:pt>
                <c:pt idx="4">
                  <c:v>0.996514861406256</c:v>
                </c:pt>
                <c:pt idx="5">
                  <c:v>0.996514861406256</c:v>
                </c:pt>
                <c:pt idx="6">
                  <c:v>0.99678284814701457</c:v>
                </c:pt>
                <c:pt idx="7">
                  <c:v>1.0033403056624635</c:v>
                </c:pt>
                <c:pt idx="8">
                  <c:v>1.0033403056624635</c:v>
                </c:pt>
                <c:pt idx="9">
                  <c:v>1.0033403056624635</c:v>
                </c:pt>
                <c:pt idx="10">
                  <c:v>1.0035074412665603</c:v>
                </c:pt>
                <c:pt idx="11">
                  <c:v>1.006753027790567</c:v>
                </c:pt>
                <c:pt idx="12">
                  <c:v>1.006753027790567</c:v>
                </c:pt>
                <c:pt idx="13">
                  <c:v>1.0065524214060642</c:v>
                </c:pt>
                <c:pt idx="14">
                  <c:v>1.0033403056624635</c:v>
                </c:pt>
                <c:pt idx="15">
                  <c:v>1.0033403056624635</c:v>
                </c:pt>
                <c:pt idx="16">
                  <c:v>1.0033403056624635</c:v>
                </c:pt>
                <c:pt idx="17">
                  <c:v>1.0035818522668551</c:v>
                </c:pt>
                <c:pt idx="18">
                  <c:v>1.006753027790567</c:v>
                </c:pt>
                <c:pt idx="19">
                  <c:v>1.006753027790567</c:v>
                </c:pt>
                <c:pt idx="20">
                  <c:v>1.0070251309355713</c:v>
                </c:pt>
                <c:pt idx="21">
                  <c:v>1.0101657499186705</c:v>
                </c:pt>
                <c:pt idx="22">
                  <c:v>1.0098708481572078</c:v>
                </c:pt>
                <c:pt idx="23">
                  <c:v>1.006753027790567</c:v>
                </c:pt>
                <c:pt idx="24">
                  <c:v>1.0070677805543737</c:v>
                </c:pt>
                <c:pt idx="25">
                  <c:v>1.0101657499186705</c:v>
                </c:pt>
                <c:pt idx="26">
                  <c:v>1.0101657499186705</c:v>
                </c:pt>
                <c:pt idx="27">
                  <c:v>1.0101657499186705</c:v>
                </c:pt>
                <c:pt idx="28">
                  <c:v>1.0101657499186705</c:v>
                </c:pt>
                <c:pt idx="29">
                  <c:v>1.0105294519089274</c:v>
                </c:pt>
                <c:pt idx="30">
                  <c:v>1.013578472046774</c:v>
                </c:pt>
                <c:pt idx="31">
                  <c:v>1.013578472046774</c:v>
                </c:pt>
                <c:pt idx="32">
                  <c:v>1.0139733754290485</c:v>
                </c:pt>
                <c:pt idx="33">
                  <c:v>1.0165937583175004</c:v>
                </c:pt>
                <c:pt idx="34">
                  <c:v>1.0139948160432137</c:v>
                </c:pt>
                <c:pt idx="35">
                  <c:v>1.0165703728405135</c:v>
                </c:pt>
                <c:pt idx="36">
                  <c:v>1.014016505803232</c:v>
                </c:pt>
                <c:pt idx="37">
                  <c:v>1.0169911941748777</c:v>
                </c:pt>
                <c:pt idx="38">
                  <c:v>1.0177412644824293</c:v>
                </c:pt>
                <c:pt idx="39">
                  <c:v>1.0233486340724884</c:v>
                </c:pt>
                <c:pt idx="40">
                  <c:v>1.0199259489229535</c:v>
                </c:pt>
                <c:pt idx="41">
                  <c:v>1.0174782364147059</c:v>
                </c:pt>
                <c:pt idx="42">
                  <c:v>1.0204039163029814</c:v>
                </c:pt>
                <c:pt idx="43">
                  <c:v>1.0208876413100367</c:v>
                </c:pt>
                <c:pt idx="44">
                  <c:v>1.0232993683614056</c:v>
                </c:pt>
                <c:pt idx="45">
                  <c:v>1.0204039163029814</c:v>
                </c:pt>
                <c:pt idx="46">
                  <c:v>1.0198658852014602</c:v>
                </c:pt>
                <c:pt idx="47">
                  <c:v>1.0180817432761722</c:v>
                </c:pt>
                <c:pt idx="48">
                  <c:v>1.0243722495797989</c:v>
                </c:pt>
                <c:pt idx="49">
                  <c:v>1.0266617924383461</c:v>
                </c:pt>
                <c:pt idx="50">
                  <c:v>1.0238166384310849</c:v>
                </c:pt>
                <c:pt idx="51">
                  <c:v>1.0238166384310849</c:v>
                </c:pt>
                <c:pt idx="52">
                  <c:v>1.0244122119157082</c:v>
                </c:pt>
                <c:pt idx="53">
                  <c:v>1.0272293605591887</c:v>
                </c:pt>
                <c:pt idx="54">
                  <c:v>1.0272293605591887</c:v>
                </c:pt>
                <c:pt idx="55">
                  <c:v>1.0284856468725516</c:v>
                </c:pt>
                <c:pt idx="56">
                  <c:v>1.0327775751517445</c:v>
                </c:pt>
                <c:pt idx="57">
                  <c:v>1.0265840291681019</c:v>
                </c:pt>
                <c:pt idx="58">
                  <c:v>1.0251204512279555</c:v>
                </c:pt>
                <c:pt idx="59">
                  <c:v>1.0306420826872922</c:v>
                </c:pt>
                <c:pt idx="60">
                  <c:v>1.0306420826872922</c:v>
                </c:pt>
                <c:pt idx="61">
                  <c:v>1.031331315434288</c:v>
                </c:pt>
                <c:pt idx="62">
                  <c:v>1.0340548048153959</c:v>
                </c:pt>
                <c:pt idx="63">
                  <c:v>1.0333538639790414</c:v>
                </c:pt>
                <c:pt idx="64">
                  <c:v>1.0306420826872922</c:v>
                </c:pt>
                <c:pt idx="65">
                  <c:v>1.0313709443059165</c:v>
                </c:pt>
                <c:pt idx="66">
                  <c:v>1.0340548048153959</c:v>
                </c:pt>
                <c:pt idx="67">
                  <c:v>1.0340548048153959</c:v>
                </c:pt>
                <c:pt idx="68">
                  <c:v>1.0348081031974783</c:v>
                </c:pt>
                <c:pt idx="69">
                  <c:v>1.0359335118565389</c:v>
                </c:pt>
                <c:pt idx="70">
                  <c:v>1.0314215045652</c:v>
                </c:pt>
                <c:pt idx="71">
                  <c:v>1.0340548048153959</c:v>
                </c:pt>
                <c:pt idx="72">
                  <c:v>1.0340548048153959</c:v>
                </c:pt>
                <c:pt idx="73">
                  <c:v>1.0340548048153959</c:v>
                </c:pt>
                <c:pt idx="74">
                  <c:v>1.0356970608432312</c:v>
                </c:pt>
                <c:pt idx="75">
                  <c:v>1.0408802490716031</c:v>
                </c:pt>
                <c:pt idx="76">
                  <c:v>1.0392113186892216</c:v>
                </c:pt>
                <c:pt idx="77">
                  <c:v>1.0365842071147702</c:v>
                </c:pt>
                <c:pt idx="78">
                  <c:v>1.0425715824268453</c:v>
                </c:pt>
                <c:pt idx="79">
                  <c:v>1.0383391733140672</c:v>
                </c:pt>
                <c:pt idx="80">
                  <c:v>1.0408802490716031</c:v>
                </c:pt>
                <c:pt idx="81">
                  <c:v>1.0399888342751828</c:v>
                </c:pt>
                <c:pt idx="82">
                  <c:v>1.0383695885001483</c:v>
                </c:pt>
                <c:pt idx="83">
                  <c:v>1.0417911166548093</c:v>
                </c:pt>
                <c:pt idx="84">
                  <c:v>1.0452143010333212</c:v>
                </c:pt>
                <c:pt idx="85">
                  <c:v>1.0458428958824484</c:v>
                </c:pt>
                <c:pt idx="86">
                  <c:v>1.0427640551022743</c:v>
                </c:pt>
                <c:pt idx="87">
                  <c:v>1.0458013961759582</c:v>
                </c:pt>
                <c:pt idx="88">
                  <c:v>1.0428058895008496</c:v>
                </c:pt>
                <c:pt idx="89">
                  <c:v>1.0467335225765424</c:v>
                </c:pt>
                <c:pt idx="90">
                  <c:v>1.046255085362972</c:v>
                </c:pt>
                <c:pt idx="91">
                  <c:v>1.0501257776508808</c:v>
                </c:pt>
                <c:pt idx="92">
                  <c:v>1.0487078286501694</c:v>
                </c:pt>
                <c:pt idx="93">
                  <c:v>1.050107166091685</c:v>
                </c:pt>
                <c:pt idx="94">
                  <c:v>1.0477056933278102</c:v>
                </c:pt>
                <c:pt idx="95">
                  <c:v>1.0487392972530543</c:v>
                </c:pt>
                <c:pt idx="96">
                  <c:v>1.0500749215527687</c:v>
                </c:pt>
                <c:pt idx="97">
                  <c:v>1.0487606705597368</c:v>
                </c:pt>
                <c:pt idx="98">
                  <c:v>1.0511184154559141</c:v>
                </c:pt>
                <c:pt idx="99">
                  <c:v>1.0500417048279287</c:v>
                </c:pt>
                <c:pt idx="100">
                  <c:v>1.0477056933278102</c:v>
                </c:pt>
                <c:pt idx="101">
                  <c:v>1.048800198983137</c:v>
                </c:pt>
                <c:pt idx="102">
                  <c:v>1.0522233427931407</c:v>
                </c:pt>
                <c:pt idx="103">
                  <c:v>1.0545311375840176</c:v>
                </c:pt>
                <c:pt idx="104">
                  <c:v>1.0545311375840176</c:v>
                </c:pt>
                <c:pt idx="105">
                  <c:v>1.0545311375840176</c:v>
                </c:pt>
                <c:pt idx="106">
                  <c:v>1.0533881748149594</c:v>
                </c:pt>
                <c:pt idx="107">
                  <c:v>1.0545842904748244</c:v>
                </c:pt>
                <c:pt idx="108">
                  <c:v>1.0613565818402246</c:v>
                </c:pt>
                <c:pt idx="109">
                  <c:v>1.0590072154964321</c:v>
                </c:pt>
                <c:pt idx="110">
                  <c:v>1.0568935602067562</c:v>
                </c:pt>
                <c:pt idx="111">
                  <c:v>1.0589791771383774</c:v>
                </c:pt>
                <c:pt idx="112">
                  <c:v>1.0545311375840176</c:v>
                </c:pt>
                <c:pt idx="113">
                  <c:v>1.0557453717582197</c:v>
                </c:pt>
                <c:pt idx="114">
                  <c:v>1.0579438597121211</c:v>
                </c:pt>
                <c:pt idx="115">
                  <c:v>1.0604155034942315</c:v>
                </c:pt>
                <c:pt idx="116">
                  <c:v>1.0635231944763501</c:v>
                </c:pt>
                <c:pt idx="117">
                  <c:v>1.0626114867083096</c:v>
                </c:pt>
                <c:pt idx="118">
                  <c:v>1.0647693039683284</c:v>
                </c:pt>
                <c:pt idx="119">
                  <c:v>1.0660457585509149</c:v>
                </c:pt>
                <c:pt idx="120">
                  <c:v>1.0668964414617186</c:v>
                </c:pt>
                <c:pt idx="121">
                  <c:v>1.0634737819971731</c:v>
                </c:pt>
                <c:pt idx="122">
                  <c:v>1.0626618014111482</c:v>
                </c:pt>
                <c:pt idx="123">
                  <c:v>1.0647693039683284</c:v>
                </c:pt>
                <c:pt idx="124">
                  <c:v>1.0660954377076521</c:v>
                </c:pt>
                <c:pt idx="125">
                  <c:v>1.0668484663888991</c:v>
                </c:pt>
                <c:pt idx="126">
                  <c:v>1.0647693039683284</c:v>
                </c:pt>
                <c:pt idx="127">
                  <c:v>1.0647693039683284</c:v>
                </c:pt>
                <c:pt idx="128">
                  <c:v>1.0674996527774603</c:v>
                </c:pt>
                <c:pt idx="129">
                  <c:v>1.0715947482245356</c:v>
                </c:pt>
                <c:pt idx="130">
                  <c:v>1.0715947482245356</c:v>
                </c:pt>
                <c:pt idx="131">
                  <c:v>1.072991436552335</c:v>
                </c:pt>
                <c:pt idx="132">
                  <c:v>1.0736018730803516</c:v>
                </c:pt>
                <c:pt idx="133">
                  <c:v>1.0730128248307798</c:v>
                </c:pt>
                <c:pt idx="134">
                  <c:v>1.0735793719089948</c:v>
                </c:pt>
                <c:pt idx="135">
                  <c:v>1.0715947482245356</c:v>
                </c:pt>
                <c:pt idx="136">
                  <c:v>1.0744920667578428</c:v>
                </c:pt>
                <c:pt idx="137">
                  <c:v>1.0769618973541488</c:v>
                </c:pt>
                <c:pt idx="138">
                  <c:v>1.0750074703526393</c:v>
                </c:pt>
                <c:pt idx="139">
                  <c:v>1.0794340319452982</c:v>
                </c:pt>
                <c:pt idx="140">
                  <c:v>1.0837662396221266</c:v>
                </c:pt>
                <c:pt idx="141">
                  <c:v>1.0818329146088466</c:v>
                </c:pt>
                <c:pt idx="142">
                  <c:v>1.0803517037475343</c:v>
                </c:pt>
                <c:pt idx="143">
                  <c:v>1.0784201924807428</c:v>
                </c:pt>
                <c:pt idx="144">
                  <c:v>1.0799150551216932</c:v>
                </c:pt>
                <c:pt idx="145">
                  <c:v>1.0818329146088466</c:v>
                </c:pt>
                <c:pt idx="146">
                  <c:v>1.0818329146088466</c:v>
                </c:pt>
                <c:pt idx="147">
                  <c:v>1.0818329146088466</c:v>
                </c:pt>
                <c:pt idx="148">
                  <c:v>1.0818329146088466</c:v>
                </c:pt>
                <c:pt idx="149">
                  <c:v>1.0818329146088466</c:v>
                </c:pt>
                <c:pt idx="150">
                  <c:v>1.0833910625169221</c:v>
                </c:pt>
                <c:pt idx="151">
                  <c:v>1.0852456367369501</c:v>
                </c:pt>
                <c:pt idx="152">
                  <c:v>1.0884554814163088</c:v>
                </c:pt>
                <c:pt idx="153">
                  <c:v>1.0904716582180594</c:v>
                </c:pt>
                <c:pt idx="154">
                  <c:v>1.0886583588650538</c:v>
                </c:pt>
                <c:pt idx="155">
                  <c:v>1.0886583588650538</c:v>
                </c:pt>
                <c:pt idx="156">
                  <c:v>1.0886583588650538</c:v>
                </c:pt>
                <c:pt idx="157">
                  <c:v>1.0886583588650538</c:v>
                </c:pt>
                <c:pt idx="158">
                  <c:v>1.0886583588650538</c:v>
                </c:pt>
                <c:pt idx="159">
                  <c:v>1.0903260864574398</c:v>
                </c:pt>
                <c:pt idx="160">
                  <c:v>1.0937601259556291</c:v>
                </c:pt>
                <c:pt idx="161">
                  <c:v>1.0937893979905862</c:v>
                </c:pt>
                <c:pt idx="162">
                  <c:v>1.0920710809931573</c:v>
                </c:pt>
                <c:pt idx="163">
                  <c:v>1.0937840134160193</c:v>
                </c:pt>
                <c:pt idx="164">
                  <c:v>1.0937606814677254</c:v>
                </c:pt>
                <c:pt idx="165">
                  <c:v>1.0938114096197253</c:v>
                </c:pt>
                <c:pt idx="166">
                  <c:v>1.0954838031212608</c:v>
                </c:pt>
                <c:pt idx="167">
                  <c:v>1.0989893934777184</c:v>
                </c:pt>
                <c:pt idx="168">
                  <c:v>1.0987774609465579</c:v>
                </c:pt>
                <c:pt idx="169">
                  <c:v>1.0972600925354108</c:v>
                </c:pt>
                <c:pt idx="170">
                  <c:v>1.0988965252493645</c:v>
                </c:pt>
                <c:pt idx="171">
                  <c:v>1.0988965252493645</c:v>
                </c:pt>
                <c:pt idx="172">
                  <c:v>1.1007068998811071</c:v>
                </c:pt>
                <c:pt idx="173">
                  <c:v>1.1023092473774683</c:v>
                </c:pt>
                <c:pt idx="174">
                  <c:v>1.1023092473774683</c:v>
                </c:pt>
                <c:pt idx="175">
                  <c:v>1.1004657916568166</c:v>
                </c:pt>
                <c:pt idx="176">
                  <c:v>1.1007498300882554</c:v>
                </c:pt>
                <c:pt idx="177">
                  <c:v>1.1060316224458764</c:v>
                </c:pt>
                <c:pt idx="178">
                  <c:v>1.1054136814929898</c:v>
                </c:pt>
                <c:pt idx="179">
                  <c:v>1.1023092473774683</c:v>
                </c:pt>
                <c:pt idx="180">
                  <c:v>1.1023092473774683</c:v>
                </c:pt>
                <c:pt idx="181">
                  <c:v>1.1042113980221857</c:v>
                </c:pt>
                <c:pt idx="182">
                  <c:v>1.1057219695055718</c:v>
                </c:pt>
                <c:pt idx="183">
                  <c:v>1.109564429261845</c:v>
                </c:pt>
                <c:pt idx="184">
                  <c:v>1.1106164616940861</c:v>
                </c:pt>
                <c:pt idx="185">
                  <c:v>1.1091346916336753</c:v>
                </c:pt>
                <c:pt idx="186">
                  <c:v>1.1091346916336753</c:v>
                </c:pt>
                <c:pt idx="187">
                  <c:v>1.1091346916336753</c:v>
                </c:pt>
                <c:pt idx="188">
                  <c:v>1.1111078960676728</c:v>
                </c:pt>
                <c:pt idx="189">
                  <c:v>1.1145309858367027</c:v>
                </c:pt>
                <c:pt idx="190">
                  <c:v>1.1139680537373187</c:v>
                </c:pt>
                <c:pt idx="191">
                  <c:v>1.110544987675663</c:v>
                </c:pt>
                <c:pt idx="192">
                  <c:v>1.1151725386177416</c:v>
                </c:pt>
                <c:pt idx="193">
                  <c:v>1.1173491743249986</c:v>
                </c:pt>
                <c:pt idx="194">
                  <c:v>1.1159601358898827</c:v>
                </c:pt>
                <c:pt idx="195">
                  <c:v>1.1159601358898827</c:v>
                </c:pt>
                <c:pt idx="196">
                  <c:v>1.1159601358898827</c:v>
                </c:pt>
                <c:pt idx="197">
                  <c:v>1.1180244441328424</c:v>
                </c:pt>
                <c:pt idx="198">
                  <c:v>1.1193728580179862</c:v>
                </c:pt>
                <c:pt idx="199">
                  <c:v>1.1193728580179862</c:v>
                </c:pt>
                <c:pt idx="200">
                  <c:v>1.1193728580179862</c:v>
                </c:pt>
                <c:pt idx="201">
                  <c:v>1.1193728580179862</c:v>
                </c:pt>
                <c:pt idx="202">
                  <c:v>1.1214875162165936</c:v>
                </c:pt>
                <c:pt idx="203">
                  <c:v>1.1227855801460898</c:v>
                </c:pt>
                <c:pt idx="204">
                  <c:v>1.1227855801460898</c:v>
                </c:pt>
                <c:pt idx="205">
                  <c:v>1.1227855801460898</c:v>
                </c:pt>
                <c:pt idx="206">
                  <c:v>1.1227855801460898</c:v>
                </c:pt>
                <c:pt idx="207">
                  <c:v>1.1227855801460898</c:v>
                </c:pt>
                <c:pt idx="208">
                  <c:v>1.1227855801460898</c:v>
                </c:pt>
                <c:pt idx="209">
                  <c:v>1.1249686648563126</c:v>
                </c:pt>
                <c:pt idx="210">
                  <c:v>1.1261983022741935</c:v>
                </c:pt>
                <c:pt idx="211">
                  <c:v>1.1261983022741935</c:v>
                </c:pt>
                <c:pt idx="212">
                  <c:v>1.1261983022741935</c:v>
                </c:pt>
                <c:pt idx="213">
                  <c:v>1.1261983022741935</c:v>
                </c:pt>
                <c:pt idx="214">
                  <c:v>1.1261983022741935</c:v>
                </c:pt>
                <c:pt idx="215">
                  <c:v>1.1261983022741935</c:v>
                </c:pt>
                <c:pt idx="216">
                  <c:v>1.1261983022741935</c:v>
                </c:pt>
                <c:pt idx="217">
                  <c:v>1.1261983022741935</c:v>
                </c:pt>
                <c:pt idx="218">
                  <c:v>1.1261983022741935</c:v>
                </c:pt>
                <c:pt idx="219">
                  <c:v>1.1261983022741935</c:v>
                </c:pt>
                <c:pt idx="220">
                  <c:v>1.1284925239630275</c:v>
                </c:pt>
                <c:pt idx="221">
                  <c:v>1.1273033186271808</c:v>
                </c:pt>
                <c:pt idx="222">
                  <c:v>1.1261983022741935</c:v>
                </c:pt>
                <c:pt idx="223">
                  <c:v>1.1285252926302249</c:v>
                </c:pt>
                <c:pt idx="224">
                  <c:v>1.1319292487002066</c:v>
                </c:pt>
                <c:pt idx="225">
                  <c:v>1.1306849380901236</c:v>
                </c:pt>
                <c:pt idx="226">
                  <c:v>1.129611024402297</c:v>
                </c:pt>
                <c:pt idx="227">
                  <c:v>1.127243587519817</c:v>
                </c:pt>
                <c:pt idx="228">
                  <c:v>1.1285756785281178</c:v>
                </c:pt>
                <c:pt idx="229">
                  <c:v>1.129611024402297</c:v>
                </c:pt>
                <c:pt idx="230">
                  <c:v>1.129611024402297</c:v>
                </c:pt>
                <c:pt idx="231">
                  <c:v>1.127204280013667</c:v>
                </c:pt>
                <c:pt idx="232">
                  <c:v>1.128614045078483</c:v>
                </c:pt>
                <c:pt idx="233">
                  <c:v>1.1271818797781188</c:v>
                </c:pt>
                <c:pt idx="234">
                  <c:v>1.1309560543460102</c:v>
                </c:pt>
                <c:pt idx="235">
                  <c:v>1.1305996884675227</c:v>
                </c:pt>
                <c:pt idx="236">
                  <c:v>1.1320687985698399</c:v>
                </c:pt>
                <c:pt idx="237">
                  <c:v>1.1305555980451154</c:v>
                </c:pt>
                <c:pt idx="238">
                  <c:v>1.1271314965420265</c:v>
                </c:pt>
                <c:pt idx="239">
                  <c:v>1.1261983022741935</c:v>
                </c:pt>
                <c:pt idx="240">
                  <c:v>1.1286856636548408</c:v>
                </c:pt>
                <c:pt idx="241">
                  <c:v>1.129611024402297</c:v>
                </c:pt>
                <c:pt idx="242">
                  <c:v>1.129611024402297</c:v>
                </c:pt>
                <c:pt idx="243">
                  <c:v>1.129611024402297</c:v>
                </c:pt>
                <c:pt idx="244">
                  <c:v>1.1270880616371315</c:v>
                </c:pt>
                <c:pt idx="245">
                  <c:v>1.1287420376575654</c:v>
                </c:pt>
                <c:pt idx="246">
                  <c:v>1.1270529886450815</c:v>
                </c:pt>
                <c:pt idx="247">
                  <c:v>1.1287672897975898</c:v>
                </c:pt>
                <c:pt idx="248">
                  <c:v>1.1270318232838668</c:v>
                </c:pt>
                <c:pt idx="249">
                  <c:v>1.1287874269360356</c:v>
                </c:pt>
                <c:pt idx="250">
                  <c:v>1.129611024402297</c:v>
                </c:pt>
                <c:pt idx="251">
                  <c:v>1.129611024402297</c:v>
                </c:pt>
                <c:pt idx="252">
                  <c:v>1.1322278176615503</c:v>
                </c:pt>
                <c:pt idx="253">
                  <c:v>1.1330237465304007</c:v>
                </c:pt>
                <c:pt idx="254">
                  <c:v>1.1303873836657652</c:v>
                </c:pt>
                <c:pt idx="255">
                  <c:v>1.129611024402297</c:v>
                </c:pt>
                <c:pt idx="256">
                  <c:v>1.132272064840431</c:v>
                </c:pt>
                <c:pt idx="257">
                  <c:v>1.1330237465304007</c:v>
                </c:pt>
                <c:pt idx="258">
                  <c:v>1.1303423601563647</c:v>
                </c:pt>
                <c:pt idx="259">
                  <c:v>1.129611024402297</c:v>
                </c:pt>
                <c:pt idx="260">
                  <c:v>1.129611024402297</c:v>
                </c:pt>
                <c:pt idx="261">
                  <c:v>1.1323226929434984</c:v>
                </c:pt>
                <c:pt idx="262">
                  <c:v>1.1330237465304007</c:v>
                </c:pt>
                <c:pt idx="263">
                  <c:v>1.1330237465304007</c:v>
                </c:pt>
                <c:pt idx="264">
                  <c:v>1.1275589784898639</c:v>
                </c:pt>
                <c:pt idx="265">
                  <c:v>1.1289447743367169</c:v>
                </c:pt>
                <c:pt idx="266">
                  <c:v>1.129611024402297</c:v>
                </c:pt>
                <c:pt idx="267">
                  <c:v>1.129611024402297</c:v>
                </c:pt>
              </c:numCache>
            </c:numRef>
          </c:xVal>
          <c:yVal>
            <c:numRef>
              <c:f>'d0 u'!$B$7:$B$274</c:f>
              <c:numCache>
                <c:formatCode>General</c:formatCode>
                <c:ptCount val="268"/>
                <c:pt idx="0">
                  <c:v>0</c:v>
                </c:pt>
                <c:pt idx="1">
                  <c:v>1.8946526031340324E-2</c:v>
                </c:pt>
                <c:pt idx="2">
                  <c:v>4.2397162366298063E-2</c:v>
                </c:pt>
                <c:pt idx="3">
                  <c:v>5.4946938349354837E-2</c:v>
                </c:pt>
                <c:pt idx="4">
                  <c:v>8.1699185313717101E-2</c:v>
                </c:pt>
                <c:pt idx="5">
                  <c:v>0.11508812106424775</c:v>
                </c:pt>
                <c:pt idx="6">
                  <c:v>0.12781182604451352</c:v>
                </c:pt>
                <c:pt idx="7">
                  <c:v>0.15665138921430033</c:v>
                </c:pt>
                <c:pt idx="8">
                  <c:v>0.18055928089926326</c:v>
                </c:pt>
                <c:pt idx="9">
                  <c:v>0.20213520094271648</c:v>
                </c:pt>
                <c:pt idx="10">
                  <c:v>0.23211174674572488</c:v>
                </c:pt>
                <c:pt idx="11">
                  <c:v>0.25258697569370292</c:v>
                </c:pt>
                <c:pt idx="12">
                  <c:v>0.28170605580652969</c:v>
                </c:pt>
                <c:pt idx="13">
                  <c:v>0.31086664286352</c:v>
                </c:pt>
                <c:pt idx="14">
                  <c:v>0.33142625564529099</c:v>
                </c:pt>
                <c:pt idx="15">
                  <c:v>0.35742003350488777</c:v>
                </c:pt>
                <c:pt idx="16">
                  <c:v>0.38841521788028127</c:v>
                </c:pt>
                <c:pt idx="17">
                  <c:v>0.40824520251443291</c:v>
                </c:pt>
                <c:pt idx="18">
                  <c:v>0.44329571387460065</c:v>
                </c:pt>
                <c:pt idx="19">
                  <c:v>0.45323214463649425</c:v>
                </c:pt>
                <c:pt idx="20">
                  <c:v>0.4859196202408877</c:v>
                </c:pt>
                <c:pt idx="21">
                  <c:v>0.50910957638294574</c:v>
                </c:pt>
                <c:pt idx="22">
                  <c:v>0.53736698483267153</c:v>
                </c:pt>
                <c:pt idx="23">
                  <c:v>0.56414888991463608</c:v>
                </c:pt>
                <c:pt idx="24">
                  <c:v>0.58927585280710704</c:v>
                </c:pt>
                <c:pt idx="25">
                  <c:v>0.60794893051347476</c:v>
                </c:pt>
                <c:pt idx="26">
                  <c:v>0.63966869586898445</c:v>
                </c:pt>
                <c:pt idx="27">
                  <c:v>0.66342667466209737</c:v>
                </c:pt>
                <c:pt idx="28">
                  <c:v>0.68986498780788774</c:v>
                </c:pt>
                <c:pt idx="29">
                  <c:v>0.7072563733785393</c:v>
                </c:pt>
                <c:pt idx="30">
                  <c:v>0.73177988731091992</c:v>
                </c:pt>
                <c:pt idx="31">
                  <c:v>0.76429157728149089</c:v>
                </c:pt>
                <c:pt idx="32">
                  <c:v>0.78649632632732314</c:v>
                </c:pt>
                <c:pt idx="33">
                  <c:v>0.81102219560453925</c:v>
                </c:pt>
                <c:pt idx="34">
                  <c:v>0.83158983578604906</c:v>
                </c:pt>
                <c:pt idx="35">
                  <c:v>0.85953047438975227</c:v>
                </c:pt>
                <c:pt idx="36">
                  <c:v>0.88643158876126837</c:v>
                </c:pt>
                <c:pt idx="37">
                  <c:v>0.91667498552030058</c:v>
                </c:pt>
                <c:pt idx="38">
                  <c:v>0.93845500340384902</c:v>
                </c:pt>
                <c:pt idx="39">
                  <c:v>0.95184345639521029</c:v>
                </c:pt>
                <c:pt idx="40">
                  <c:v>0.98309032618999426</c:v>
                </c:pt>
                <c:pt idx="41">
                  <c:v>1.0003290469608006</c:v>
                </c:pt>
                <c:pt idx="42">
                  <c:v>1.032524399699704</c:v>
                </c:pt>
                <c:pt idx="43">
                  <c:v>1.0463583493425008</c:v>
                </c:pt>
                <c:pt idx="44">
                  <c:v>1.0696217537887653</c:v>
                </c:pt>
                <c:pt idx="45">
                  <c:v>1.0936705936347297</c:v>
                </c:pt>
                <c:pt idx="46">
                  <c:v>1.1107518427794973</c:v>
                </c:pt>
                <c:pt idx="47">
                  <c:v>1.1414552528050652</c:v>
                </c:pt>
                <c:pt idx="48">
                  <c:v>1.1567154839154201</c:v>
                </c:pt>
                <c:pt idx="49">
                  <c:v>1.176271960139275</c:v>
                </c:pt>
                <c:pt idx="50">
                  <c:v>1.2023015969222588</c:v>
                </c:pt>
                <c:pt idx="51">
                  <c:v>1.2178710992297814</c:v>
                </c:pt>
                <c:pt idx="52">
                  <c:v>1.2488178307971654</c:v>
                </c:pt>
                <c:pt idx="53">
                  <c:v>1.2546432234587201</c:v>
                </c:pt>
                <c:pt idx="54">
                  <c:v>1.2813666775341974</c:v>
                </c:pt>
                <c:pt idx="55">
                  <c:v>1.293610048390204</c:v>
                </c:pt>
                <c:pt idx="56">
                  <c:v>1.3058053509842975</c:v>
                </c:pt>
                <c:pt idx="57">
                  <c:v>1.3289910771193039</c:v>
                </c:pt>
                <c:pt idx="58">
                  <c:v>1.346667699756162</c:v>
                </c:pt>
                <c:pt idx="59">
                  <c:v>1.3671887137236136</c:v>
                </c:pt>
                <c:pt idx="60">
                  <c:v>1.3800240932933749</c:v>
                </c:pt>
                <c:pt idx="61">
                  <c:v>1.4012676693739425</c:v>
                </c:pt>
                <c:pt idx="62">
                  <c:v>1.4190602326585393</c:v>
                </c:pt>
                <c:pt idx="63">
                  <c:v>1.4267867250788588</c:v>
                </c:pt>
                <c:pt idx="64">
                  <c:v>1.4434461271570587</c:v>
                </c:pt>
                <c:pt idx="65">
                  <c:v>1.4524114348234685</c:v>
                </c:pt>
                <c:pt idx="66">
                  <c:v>1.4734730244644232</c:v>
                </c:pt>
                <c:pt idx="67">
                  <c:v>1.4905345656218072</c:v>
                </c:pt>
                <c:pt idx="68">
                  <c:v>1.5000358344085749</c:v>
                </c:pt>
                <c:pt idx="69">
                  <c:v>1.511363793284662</c:v>
                </c:pt>
                <c:pt idx="70">
                  <c:v>1.5217565360569201</c:v>
                </c:pt>
                <c:pt idx="71">
                  <c:v>1.5394222952665815</c:v>
                </c:pt>
                <c:pt idx="72">
                  <c:v>1.5503942605949235</c:v>
                </c:pt>
                <c:pt idx="73">
                  <c:v>1.5614059303076038</c:v>
                </c:pt>
                <c:pt idx="74">
                  <c:v>1.5712018575399169</c:v>
                </c:pt>
                <c:pt idx="75">
                  <c:v>1.5841197222471233</c:v>
                </c:pt>
                <c:pt idx="76">
                  <c:v>1.5988526445242683</c:v>
                </c:pt>
                <c:pt idx="77">
                  <c:v>1.6088550730097684</c:v>
                </c:pt>
                <c:pt idx="78">
                  <c:v>1.6090586901672428</c:v>
                </c:pt>
                <c:pt idx="79">
                  <c:v>1.6239440849711813</c:v>
                </c:pt>
                <c:pt idx="80">
                  <c:v>1.626887593057849</c:v>
                </c:pt>
                <c:pt idx="81">
                  <c:v>1.6404516874782493</c:v>
                </c:pt>
                <c:pt idx="82">
                  <c:v>1.6501037944709103</c:v>
                </c:pt>
                <c:pt idx="83">
                  <c:v>1.6586166836561682</c:v>
                </c:pt>
                <c:pt idx="84">
                  <c:v>1.6591248613211427</c:v>
                </c:pt>
                <c:pt idx="85">
                  <c:v>1.6680438311830652</c:v>
                </c:pt>
                <c:pt idx="86">
                  <c:v>1.6756201583531587</c:v>
                </c:pt>
                <c:pt idx="87">
                  <c:v>1.6809407381280781</c:v>
                </c:pt>
                <c:pt idx="88">
                  <c:v>1.6867373859690074</c:v>
                </c:pt>
                <c:pt idx="89">
                  <c:v>1.6954727350704137</c:v>
                </c:pt>
                <c:pt idx="90">
                  <c:v>1.7033878473504911</c:v>
                </c:pt>
                <c:pt idx="91">
                  <c:v>1.7036681814539811</c:v>
                </c:pt>
                <c:pt idx="92">
                  <c:v>1.7149984476066393</c:v>
                </c:pt>
                <c:pt idx="93">
                  <c:v>1.7201971262693394</c:v>
                </c:pt>
                <c:pt idx="94">
                  <c:v>1.7264719571798073</c:v>
                </c:pt>
                <c:pt idx="95">
                  <c:v>1.7323503210659941</c:v>
                </c:pt>
                <c:pt idx="96">
                  <c:v>1.7421670137874554</c:v>
                </c:pt>
                <c:pt idx="97">
                  <c:v>1.747226486763646</c:v>
                </c:pt>
                <c:pt idx="98">
                  <c:v>1.7469125048768137</c:v>
                </c:pt>
                <c:pt idx="99">
                  <c:v>1.7510015757814521</c:v>
                </c:pt>
                <c:pt idx="100">
                  <c:v>1.7569087806247912</c:v>
                </c:pt>
                <c:pt idx="101">
                  <c:v>1.7635454694109587</c:v>
                </c:pt>
                <c:pt idx="102">
                  <c:v>1.7592627795473235</c:v>
                </c:pt>
                <c:pt idx="103">
                  <c:v>1.7669921560633555</c:v>
                </c:pt>
                <c:pt idx="104">
                  <c:v>1.7724361751348752</c:v>
                </c:pt>
                <c:pt idx="105">
                  <c:v>1.7740295418808525</c:v>
                </c:pt>
                <c:pt idx="106">
                  <c:v>1.7757067396756137</c:v>
                </c:pt>
                <c:pt idx="107">
                  <c:v>1.7821336585667813</c:v>
                </c:pt>
                <c:pt idx="108">
                  <c:v>1.7802428454160686</c:v>
                </c:pt>
                <c:pt idx="109">
                  <c:v>1.7828812161760945</c:v>
                </c:pt>
                <c:pt idx="110">
                  <c:v>1.783543981371388</c:v>
                </c:pt>
                <c:pt idx="111">
                  <c:v>1.7851990677656653</c:v>
                </c:pt>
                <c:pt idx="112">
                  <c:v>1.7876318986377424</c:v>
                </c:pt>
                <c:pt idx="113">
                  <c:v>1.783632042427217</c:v>
                </c:pt>
                <c:pt idx="114">
                  <c:v>1.7926131164835362</c:v>
                </c:pt>
                <c:pt idx="115">
                  <c:v>1.7883436934601877</c:v>
                </c:pt>
                <c:pt idx="116">
                  <c:v>1.7944170222167042</c:v>
                </c:pt>
                <c:pt idx="117">
                  <c:v>1.7972119032375267</c:v>
                </c:pt>
                <c:pt idx="118">
                  <c:v>1.7957533198979587</c:v>
                </c:pt>
                <c:pt idx="119">
                  <c:v>1.7956992911715652</c:v>
                </c:pt>
                <c:pt idx="120">
                  <c:v>1.7951443911560137</c:v>
                </c:pt>
                <c:pt idx="121">
                  <c:v>1.8000200510986395</c:v>
                </c:pt>
                <c:pt idx="122">
                  <c:v>1.8002815424434588</c:v>
                </c:pt>
                <c:pt idx="123">
                  <c:v>1.7979609990312202</c:v>
                </c:pt>
                <c:pt idx="124">
                  <c:v>1.8008245215300589</c:v>
                </c:pt>
                <c:pt idx="125">
                  <c:v>1.8076177205770234</c:v>
                </c:pt>
                <c:pt idx="126">
                  <c:v>1.8097004222293069</c:v>
                </c:pt>
                <c:pt idx="127">
                  <c:v>1.8119627069081039</c:v>
                </c:pt>
                <c:pt idx="128">
                  <c:v>1.8170473676535392</c:v>
                </c:pt>
                <c:pt idx="129">
                  <c:v>1.8219001471034943</c:v>
                </c:pt>
                <c:pt idx="130">
                  <c:v>1.8143638127273134</c:v>
                </c:pt>
                <c:pt idx="131">
                  <c:v>1.8201271973309974</c:v>
                </c:pt>
                <c:pt idx="132">
                  <c:v>1.8224231297931361</c:v>
                </c:pt>
                <c:pt idx="133">
                  <c:v>1.8194313611715074</c:v>
                </c:pt>
                <c:pt idx="134">
                  <c:v>1.8239274741180491</c:v>
                </c:pt>
                <c:pt idx="135">
                  <c:v>1.8290944277278844</c:v>
                </c:pt>
                <c:pt idx="136">
                  <c:v>1.8304543749940005</c:v>
                </c:pt>
                <c:pt idx="137">
                  <c:v>1.8312117385287427</c:v>
                </c:pt>
                <c:pt idx="138">
                  <c:v>1.8342552286001943</c:v>
                </c:pt>
                <c:pt idx="139">
                  <c:v>1.8333178974928392</c:v>
                </c:pt>
                <c:pt idx="140">
                  <c:v>1.8377824776595653</c:v>
                </c:pt>
                <c:pt idx="141">
                  <c:v>1.8384354369294265</c:v>
                </c:pt>
                <c:pt idx="142">
                  <c:v>1.8376651911004911</c:v>
                </c:pt>
                <c:pt idx="143">
                  <c:v>1.841711000569404</c:v>
                </c:pt>
                <c:pt idx="144">
                  <c:v>1.8444758869947941</c:v>
                </c:pt>
                <c:pt idx="145">
                  <c:v>1.8382520084419556</c:v>
                </c:pt>
                <c:pt idx="146">
                  <c:v>1.8438652277954168</c:v>
                </c:pt>
                <c:pt idx="147">
                  <c:v>1.8410445821862074</c:v>
                </c:pt>
                <c:pt idx="148">
                  <c:v>1.8457045117693553</c:v>
                </c:pt>
                <c:pt idx="149">
                  <c:v>1.8442545807169328</c:v>
                </c:pt>
                <c:pt idx="150">
                  <c:v>1.8425685383619814</c:v>
                </c:pt>
                <c:pt idx="151">
                  <c:v>1.8435489386320105</c:v>
                </c:pt>
                <c:pt idx="152">
                  <c:v>1.843873880082562</c:v>
                </c:pt>
                <c:pt idx="153">
                  <c:v>1.8473644049898266</c:v>
                </c:pt>
                <c:pt idx="154">
                  <c:v>1.8577932950950427</c:v>
                </c:pt>
                <c:pt idx="155">
                  <c:v>1.8460271459433328</c:v>
                </c:pt>
                <c:pt idx="156">
                  <c:v>1.8534834947316881</c:v>
                </c:pt>
                <c:pt idx="157">
                  <c:v>1.8498491495847718</c:v>
                </c:pt>
                <c:pt idx="158">
                  <c:v>1.8566002408342976</c:v>
                </c:pt>
                <c:pt idx="159">
                  <c:v>1.8549372712450651</c:v>
                </c:pt>
                <c:pt idx="160">
                  <c:v>1.8536701918609686</c:v>
                </c:pt>
                <c:pt idx="161">
                  <c:v>1.8564273873644492</c:v>
                </c:pt>
                <c:pt idx="162">
                  <c:v>1.857403557627433</c:v>
                </c:pt>
                <c:pt idx="163">
                  <c:v>1.8542372050785265</c:v>
                </c:pt>
                <c:pt idx="164">
                  <c:v>1.8506065131195135</c:v>
                </c:pt>
                <c:pt idx="165">
                  <c:v>1.8553779610703072</c:v>
                </c:pt>
                <c:pt idx="166">
                  <c:v>1.8539039958869266</c:v>
                </c:pt>
                <c:pt idx="167">
                  <c:v>1.8546719344392908</c:v>
                </c:pt>
                <c:pt idx="168">
                  <c:v>1.8514598209050397</c:v>
                </c:pt>
                <c:pt idx="169">
                  <c:v>1.8591124804750556</c:v>
                </c:pt>
                <c:pt idx="170">
                  <c:v>1.8539536023332233</c:v>
                </c:pt>
                <c:pt idx="171">
                  <c:v>1.8585229713109235</c:v>
                </c:pt>
                <c:pt idx="172">
                  <c:v>1.8536655773078232</c:v>
                </c:pt>
                <c:pt idx="173">
                  <c:v>1.8530526108318748</c:v>
                </c:pt>
                <c:pt idx="174">
                  <c:v>1.8548586315685716</c:v>
                </c:pt>
                <c:pt idx="175">
                  <c:v>1.8548372892602814</c:v>
                </c:pt>
                <c:pt idx="176">
                  <c:v>1.8636262825419814</c:v>
                </c:pt>
                <c:pt idx="177">
                  <c:v>1.858095163779875</c:v>
                </c:pt>
                <c:pt idx="178">
                  <c:v>1.8556746383828489</c:v>
                </c:pt>
                <c:pt idx="179">
                  <c:v>1.8625680116876493</c:v>
                </c:pt>
                <c:pt idx="180">
                  <c:v>1.8550203332016555</c:v>
                </c:pt>
                <c:pt idx="181">
                  <c:v>1.8589577006716878</c:v>
                </c:pt>
                <c:pt idx="182">
                  <c:v>1.8572480087318717</c:v>
                </c:pt>
                <c:pt idx="183">
                  <c:v>1.857356835276849</c:v>
                </c:pt>
                <c:pt idx="184">
                  <c:v>1.8578452088179136</c:v>
                </c:pt>
                <c:pt idx="185">
                  <c:v>1.8559780452520618</c:v>
                </c:pt>
                <c:pt idx="186">
                  <c:v>1.8616502924311555</c:v>
                </c:pt>
                <c:pt idx="187">
                  <c:v>1.8523446614703811</c:v>
                </c:pt>
                <c:pt idx="188">
                  <c:v>1.8553370069111557</c:v>
                </c:pt>
                <c:pt idx="189">
                  <c:v>1.8577279222588394</c:v>
                </c:pt>
                <c:pt idx="190">
                  <c:v>1.8544875445865814</c:v>
                </c:pt>
                <c:pt idx="191">
                  <c:v>1.8571395667329911</c:v>
                </c:pt>
                <c:pt idx="192">
                  <c:v>1.84526670603983</c:v>
                </c:pt>
                <c:pt idx="193">
                  <c:v>1.8419180786417393</c:v>
                </c:pt>
                <c:pt idx="194">
                  <c:v>1.8313315246374393</c:v>
                </c:pt>
                <c:pt idx="195">
                  <c:v>1.8323346131270941</c:v>
                </c:pt>
                <c:pt idx="196">
                  <c:v>1.8304011153597974</c:v>
                </c:pt>
                <c:pt idx="197">
                  <c:v>1.825430664804675</c:v>
                </c:pt>
                <c:pt idx="198">
                  <c:v>1.8233085471776234</c:v>
                </c:pt>
                <c:pt idx="199">
                  <c:v>1.8162198244564007</c:v>
                </c:pt>
                <c:pt idx="200">
                  <c:v>1.8114497224169395</c:v>
                </c:pt>
                <c:pt idx="201">
                  <c:v>1.8086784909809781</c:v>
                </c:pt>
                <c:pt idx="202">
                  <c:v>1.8039241553314265</c:v>
                </c:pt>
                <c:pt idx="203">
                  <c:v>1.7932660757533976</c:v>
                </c:pt>
                <c:pt idx="204">
                  <c:v>1.7899091806142555</c:v>
                </c:pt>
                <c:pt idx="205">
                  <c:v>1.7759980333428236</c:v>
                </c:pt>
                <c:pt idx="206">
                  <c:v>1.7615665952044137</c:v>
                </c:pt>
                <c:pt idx="207">
                  <c:v>1.7491123008151199</c:v>
                </c:pt>
                <c:pt idx="208">
                  <c:v>1.734903322592859</c:v>
                </c:pt>
                <c:pt idx="209">
                  <c:v>1.7264315798397976</c:v>
                </c:pt>
                <c:pt idx="210">
                  <c:v>1.7158482944773104</c:v>
                </c:pt>
                <c:pt idx="211">
                  <c:v>1.7060214112843233</c:v>
                </c:pt>
                <c:pt idx="212">
                  <c:v>1.7111226075118586</c:v>
                </c:pt>
                <c:pt idx="213">
                  <c:v>1.6933160082947816</c:v>
                </c:pt>
                <c:pt idx="214">
                  <c:v>1.6903382756056331</c:v>
                </c:pt>
                <c:pt idx="215">
                  <c:v>1.66810093627822</c:v>
                </c:pt>
                <c:pt idx="216">
                  <c:v>1.6596974504570814</c:v>
                </c:pt>
                <c:pt idx="217">
                  <c:v>1.639969082128617</c:v>
                </c:pt>
                <c:pt idx="218">
                  <c:v>1.6293915649575588</c:v>
                </c:pt>
                <c:pt idx="219">
                  <c:v>1.6191259146698072</c:v>
                </c:pt>
                <c:pt idx="220">
                  <c:v>1.5818353261678459</c:v>
                </c:pt>
                <c:pt idx="221">
                  <c:v>1.5755876057570974</c:v>
                </c:pt>
                <c:pt idx="222">
                  <c:v>1.5665402936358621</c:v>
                </c:pt>
                <c:pt idx="223">
                  <c:v>1.5584451176466492</c:v>
                </c:pt>
                <c:pt idx="224">
                  <c:v>1.549490673407433</c:v>
                </c:pt>
                <c:pt idx="225">
                  <c:v>1.542121039763575</c:v>
                </c:pt>
                <c:pt idx="226">
                  <c:v>1.5340465331269846</c:v>
                </c:pt>
                <c:pt idx="227">
                  <c:v>1.5229778544556718</c:v>
                </c:pt>
                <c:pt idx="228">
                  <c:v>1.5232116584816298</c:v>
                </c:pt>
                <c:pt idx="229">
                  <c:v>1.4922338748170492</c:v>
                </c:pt>
                <c:pt idx="230">
                  <c:v>1.4799132101958814</c:v>
                </c:pt>
                <c:pt idx="231">
                  <c:v>1.4656414548235555</c:v>
                </c:pt>
                <c:pt idx="232">
                  <c:v>1.4585546548328103</c:v>
                </c:pt>
                <c:pt idx="233">
                  <c:v>1.4492715198186137</c:v>
                </c:pt>
                <c:pt idx="234">
                  <c:v>1.4251883592336427</c:v>
                </c:pt>
                <c:pt idx="235">
                  <c:v>1.3977681076334363</c:v>
                </c:pt>
                <c:pt idx="236">
                  <c:v>1.3723126943072974</c:v>
                </c:pt>
                <c:pt idx="237">
                  <c:v>1.3586324669661072</c:v>
                </c:pt>
                <c:pt idx="238">
                  <c:v>1.3620382955958781</c:v>
                </c:pt>
                <c:pt idx="239">
                  <c:v>1.3546346296225815</c:v>
                </c:pt>
                <c:pt idx="240">
                  <c:v>1.3545672379193783</c:v>
                </c:pt>
                <c:pt idx="241">
                  <c:v>1.3501531294276652</c:v>
                </c:pt>
                <c:pt idx="242">
                  <c:v>1.3513731019150814</c:v>
                </c:pt>
                <c:pt idx="243">
                  <c:v>1.3476759796181039</c:v>
                </c:pt>
                <c:pt idx="244">
                  <c:v>1.3454717613997007</c:v>
                </c:pt>
                <c:pt idx="245">
                  <c:v>1.3412659807551297</c:v>
                </c:pt>
                <c:pt idx="246">
                  <c:v>1.3505151795764136</c:v>
                </c:pt>
                <c:pt idx="247">
                  <c:v>1.3503468445231845</c:v>
                </c:pt>
                <c:pt idx="248">
                  <c:v>1.3490883212897071</c:v>
                </c:pt>
                <c:pt idx="249">
                  <c:v>1.3522668831771427</c:v>
                </c:pt>
                <c:pt idx="250">
                  <c:v>1.3446953628332394</c:v>
                </c:pt>
                <c:pt idx="251">
                  <c:v>1.3387082685385974</c:v>
                </c:pt>
                <c:pt idx="252">
                  <c:v>1.333228390543691</c:v>
                </c:pt>
                <c:pt idx="253">
                  <c:v>1.3297434415548071</c:v>
                </c:pt>
                <c:pt idx="254">
                  <c:v>1.3292621821165072</c:v>
                </c:pt>
                <c:pt idx="255">
                  <c:v>1.322321413505462</c:v>
                </c:pt>
                <c:pt idx="256">
                  <c:v>1.307228940629191</c:v>
                </c:pt>
                <c:pt idx="257">
                  <c:v>1.2878435874177554</c:v>
                </c:pt>
                <c:pt idx="258">
                  <c:v>1.2704889259992105</c:v>
                </c:pt>
                <c:pt idx="259">
                  <c:v>1.2559305876493461</c:v>
                </c:pt>
                <c:pt idx="260">
                  <c:v>1.2122870092430427</c:v>
                </c:pt>
                <c:pt idx="261">
                  <c:v>1.2045515761260071</c:v>
                </c:pt>
                <c:pt idx="262">
                  <c:v>1.1848706992403168</c:v>
                </c:pt>
                <c:pt idx="263">
                  <c:v>1.1862295890046717</c:v>
                </c:pt>
                <c:pt idx="264">
                  <c:v>1.1800803123943266</c:v>
                </c:pt>
                <c:pt idx="265">
                  <c:v>1.1713549614914007</c:v>
                </c:pt>
                <c:pt idx="266">
                  <c:v>1.1655088033406975</c:v>
                </c:pt>
                <c:pt idx="267">
                  <c:v>1.15733594904022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DC2-49E8-B058-2B285C669968}"/>
            </c:ext>
          </c:extLst>
        </c:ser>
        <c:ser>
          <c:idx val="1"/>
          <c:order val="1"/>
          <c:tx>
            <c:v>TD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d0 u'!$C$7:$C$208</c:f>
              <c:numCache>
                <c:formatCode>General</c:formatCode>
                <c:ptCount val="202"/>
                <c:pt idx="0">
                  <c:v>1</c:v>
                </c:pt>
                <c:pt idx="2">
                  <c:v>1.0030427762647174</c:v>
                </c:pt>
                <c:pt idx="6">
                  <c:v>1.0061801509066166</c:v>
                </c:pt>
                <c:pt idx="7">
                  <c:v>1.0039692774752289</c:v>
                </c:pt>
                <c:pt idx="8">
                  <c:v>1.0036888429084219</c:v>
                </c:pt>
                <c:pt idx="9">
                  <c:v>1.009858585936142</c:v>
                </c:pt>
                <c:pt idx="10">
                  <c:v>1.0041844122818633</c:v>
                </c:pt>
                <c:pt idx="11">
                  <c:v>1.0036888429084219</c:v>
                </c:pt>
                <c:pt idx="12">
                  <c:v>1.0036888429084219</c:v>
                </c:pt>
                <c:pt idx="13">
                  <c:v>1.0068198073161438</c:v>
                </c:pt>
                <c:pt idx="14">
                  <c:v>1.0007620917736428</c:v>
                </c:pt>
                <c:pt idx="15">
                  <c:v>1.0066427905968098</c:v>
                </c:pt>
                <c:pt idx="16">
                  <c:v>1.0101946430161444</c:v>
                </c:pt>
                <c:pt idx="17">
                  <c:v>1.0103801018611447</c:v>
                </c:pt>
                <c:pt idx="18">
                  <c:v>1.0103801018611447</c:v>
                </c:pt>
                <c:pt idx="19">
                  <c:v>1.0071932037840232</c:v>
                </c:pt>
                <c:pt idx="20">
                  <c:v>1.0070344723847833</c:v>
                </c:pt>
                <c:pt idx="21">
                  <c:v>1.0070344723847833</c:v>
                </c:pt>
                <c:pt idx="22">
                  <c:v>1.0070344723847833</c:v>
                </c:pt>
                <c:pt idx="23">
                  <c:v>1.0102624578768968</c:v>
                </c:pt>
                <c:pt idx="24">
                  <c:v>1.0071489107149152</c:v>
                </c:pt>
                <c:pt idx="25">
                  <c:v>1.0102828932350378</c:v>
                </c:pt>
                <c:pt idx="26">
                  <c:v>1.0103801018611447</c:v>
                </c:pt>
                <c:pt idx="27">
                  <c:v>1.0071105859378489</c:v>
                </c:pt>
                <c:pt idx="28">
                  <c:v>1.0070344723847833</c:v>
                </c:pt>
                <c:pt idx="29">
                  <c:v>1.0136052503436366</c:v>
                </c:pt>
                <c:pt idx="30">
                  <c:v>1.0104525174867152</c:v>
                </c:pt>
                <c:pt idx="31">
                  <c:v>1.0136856584072604</c:v>
                </c:pt>
                <c:pt idx="32">
                  <c:v>1.0104045948346152</c:v>
                </c:pt>
                <c:pt idx="33">
                  <c:v>1.0103801018611447</c:v>
                </c:pt>
                <c:pt idx="34">
                  <c:v>1.0103801018611447</c:v>
                </c:pt>
                <c:pt idx="35">
                  <c:v>1.017045255643414</c:v>
                </c:pt>
                <c:pt idx="36">
                  <c:v>1.0103892070459917</c:v>
                </c:pt>
                <c:pt idx="37">
                  <c:v>1.0136768976348436</c:v>
                </c:pt>
                <c:pt idx="38">
                  <c:v>1.0071312222108215</c:v>
                </c:pt>
                <c:pt idx="39">
                  <c:v>1.0169833049834827</c:v>
                </c:pt>
                <c:pt idx="40">
                  <c:v>1.010432027023582</c:v>
                </c:pt>
                <c:pt idx="41">
                  <c:v>1.0136698128413775</c:v>
                </c:pt>
                <c:pt idx="42">
                  <c:v>1.0103801018611447</c:v>
                </c:pt>
                <c:pt idx="43">
                  <c:v>1.0105457744561268</c:v>
                </c:pt>
                <c:pt idx="44">
                  <c:v>1.0170713608138675</c:v>
                </c:pt>
                <c:pt idx="45">
                  <c:v>1.0170713608138675</c:v>
                </c:pt>
                <c:pt idx="46">
                  <c:v>1.0170713608138675</c:v>
                </c:pt>
                <c:pt idx="47">
                  <c:v>1.0171901596226822</c:v>
                </c:pt>
                <c:pt idx="48">
                  <c:v>1.0202850753272525</c:v>
                </c:pt>
                <c:pt idx="49">
                  <c:v>1.0170713608138675</c:v>
                </c:pt>
                <c:pt idx="50">
                  <c:v>1.0170713608138675</c:v>
                </c:pt>
                <c:pt idx="51">
                  <c:v>1.0172344166291136</c:v>
                </c:pt>
                <c:pt idx="52">
                  <c:v>1.0202484195595274</c:v>
                </c:pt>
                <c:pt idx="53">
                  <c:v>1.0172529524265406</c:v>
                </c:pt>
                <c:pt idx="54">
                  <c:v>1.0204169902902289</c:v>
                </c:pt>
                <c:pt idx="55">
                  <c:v>1.0205926689044156</c:v>
                </c:pt>
                <c:pt idx="56">
                  <c:v>1.0235504618446429</c:v>
                </c:pt>
                <c:pt idx="57">
                  <c:v>1.0204169902902289</c:v>
                </c:pt>
                <c:pt idx="58">
                  <c:v>1.0204169902902289</c:v>
                </c:pt>
                <c:pt idx="59">
                  <c:v>1.0204169902902289</c:v>
                </c:pt>
                <c:pt idx="60">
                  <c:v>1.0206523746628624</c:v>
                </c:pt>
                <c:pt idx="61">
                  <c:v>1.0240240834621697</c:v>
                </c:pt>
                <c:pt idx="62">
                  <c:v>1.0268387588346037</c:v>
                </c:pt>
                <c:pt idx="63">
                  <c:v>1.0237626197665903</c:v>
                </c:pt>
                <c:pt idx="64">
                  <c:v>1.0237626197665903</c:v>
                </c:pt>
                <c:pt idx="65">
                  <c:v>1.0243407807919889</c:v>
                </c:pt>
                <c:pt idx="66">
                  <c:v>1.0301457682186299</c:v>
                </c:pt>
                <c:pt idx="67">
                  <c:v>1.0274279160669095</c:v>
                </c:pt>
                <c:pt idx="68">
                  <c:v>1.0304538787193132</c:v>
                </c:pt>
                <c:pt idx="69">
                  <c:v>1.0301159096611341</c:v>
                </c:pt>
                <c:pt idx="70">
                  <c:v>1.0274502348283949</c:v>
                </c:pt>
                <c:pt idx="71">
                  <c:v>1.0308117115801334</c:v>
                </c:pt>
                <c:pt idx="72">
                  <c:v>1.0337995081956746</c:v>
                </c:pt>
                <c:pt idx="73">
                  <c:v>1.0337995081956746</c:v>
                </c:pt>
                <c:pt idx="74">
                  <c:v>1.0337995081956746</c:v>
                </c:pt>
                <c:pt idx="75">
                  <c:v>1.0337995081956746</c:v>
                </c:pt>
                <c:pt idx="76">
                  <c:v>1.0342093301055617</c:v>
                </c:pt>
                <c:pt idx="77">
                  <c:v>1.0375645387845536</c:v>
                </c:pt>
                <c:pt idx="78">
                  <c:v>1.0400603484949205</c:v>
                </c:pt>
                <c:pt idx="79">
                  <c:v>1.0375819291725583</c:v>
                </c:pt>
                <c:pt idx="80">
                  <c:v>1.040927856043085</c:v>
                </c:pt>
                <c:pt idx="81">
                  <c:v>1.0438363966247588</c:v>
                </c:pt>
                <c:pt idx="82">
                  <c:v>1.0438363966247588</c:v>
                </c:pt>
                <c:pt idx="83">
                  <c:v>1.0447961377707575</c:v>
                </c:pt>
                <c:pt idx="84">
                  <c:v>1.0505276555774816</c:v>
                </c:pt>
                <c:pt idx="85">
                  <c:v>1.0510264347714986</c:v>
                </c:pt>
                <c:pt idx="86">
                  <c:v>1.0533646601530224</c:v>
                </c:pt>
                <c:pt idx="87">
                  <c:v>1.0510436231029054</c:v>
                </c:pt>
                <c:pt idx="88">
                  <c:v>1.0544012632819786</c:v>
                </c:pt>
                <c:pt idx="89">
                  <c:v>1.0572189145302042</c:v>
                </c:pt>
                <c:pt idx="90">
                  <c:v>1.0572189145302042</c:v>
                </c:pt>
                <c:pt idx="91">
                  <c:v>1.0566628530330882</c:v>
                </c:pt>
                <c:pt idx="92">
                  <c:v>1.0544381856190825</c:v>
                </c:pt>
                <c:pt idx="93">
                  <c:v>1.0577963826514472</c:v>
                </c:pt>
                <c:pt idx="94">
                  <c:v>1.0605645440065659</c:v>
                </c:pt>
                <c:pt idx="95">
                  <c:v>1.0587733162396931</c:v>
                </c:pt>
                <c:pt idx="96">
                  <c:v>1.0523387087072937</c:v>
                </c:pt>
                <c:pt idx="97">
                  <c:v>1.0599588474929964</c:v>
                </c:pt>
                <c:pt idx="98">
                  <c:v>1.0578446264365839</c:v>
                </c:pt>
                <c:pt idx="99">
                  <c:v>1.0605645440065659</c:v>
                </c:pt>
                <c:pt idx="100">
                  <c:v>1.0605645440065659</c:v>
                </c:pt>
                <c:pt idx="101">
                  <c:v>1.0612215110247072</c:v>
                </c:pt>
                <c:pt idx="102">
                  <c:v>1.063910173482927</c:v>
                </c:pt>
                <c:pt idx="103">
                  <c:v>1.063910173482927</c:v>
                </c:pt>
                <c:pt idx="104">
                  <c:v>1.0645966284772546</c:v>
                </c:pt>
                <c:pt idx="105">
                  <c:v>1.0672558029592887</c:v>
                </c:pt>
                <c:pt idx="106">
                  <c:v>1.0665520871680072</c:v>
                </c:pt>
                <c:pt idx="107">
                  <c:v>1.0653438555725883</c:v>
                </c:pt>
                <c:pt idx="108">
                  <c:v>1.0706014324356501</c:v>
                </c:pt>
                <c:pt idx="109">
                  <c:v>1.0698676125778095</c:v>
                </c:pt>
                <c:pt idx="110">
                  <c:v>1.0680011350802172</c:v>
                </c:pt>
                <c:pt idx="111">
                  <c:v>1.0713556150256209</c:v>
                </c:pt>
                <c:pt idx="112">
                  <c:v>1.0739470619120113</c:v>
                </c:pt>
                <c:pt idx="113">
                  <c:v>1.0739470619120113</c:v>
                </c:pt>
                <c:pt idx="114">
                  <c:v>1.0739470619120113</c:v>
                </c:pt>
                <c:pt idx="115">
                  <c:v>1.0747362193030336</c:v>
                </c:pt>
                <c:pt idx="116">
                  <c:v>1.0772926913883729</c:v>
                </c:pt>
                <c:pt idx="117">
                  <c:v>1.0764768889644545</c:v>
                </c:pt>
                <c:pt idx="118">
                  <c:v>1.0747722395047676</c:v>
                </c:pt>
                <c:pt idx="119">
                  <c:v>1.0772926913883729</c:v>
                </c:pt>
                <c:pt idx="120">
                  <c:v>1.0764526613825154</c:v>
                </c:pt>
                <c:pt idx="121">
                  <c:v>1.075650990559313</c:v>
                </c:pt>
                <c:pt idx="122">
                  <c:v>1.0806383208647341</c:v>
                </c:pt>
                <c:pt idx="123">
                  <c:v>1.0806383208647341</c:v>
                </c:pt>
                <c:pt idx="124">
                  <c:v>1.0806383208647341</c:v>
                </c:pt>
                <c:pt idx="125">
                  <c:v>1.0806383208647341</c:v>
                </c:pt>
                <c:pt idx="126">
                  <c:v>1.0824359832449995</c:v>
                </c:pt>
                <c:pt idx="127">
                  <c:v>1.0864171757028076</c:v>
                </c:pt>
                <c:pt idx="128">
                  <c:v>1.0839839503410955</c:v>
                </c:pt>
                <c:pt idx="129">
                  <c:v>1.0839839503410955</c:v>
                </c:pt>
                <c:pt idx="130">
                  <c:v>1.0839839503410955</c:v>
                </c:pt>
                <c:pt idx="131">
                  <c:v>1.0848833359073986</c:v>
                </c:pt>
                <c:pt idx="132">
                  <c:v>1.0873295798174571</c:v>
                </c:pt>
                <c:pt idx="133">
                  <c:v>1.0883018363407002</c:v>
                </c:pt>
                <c:pt idx="134">
                  <c:v>1.0906752092938183</c:v>
                </c:pt>
                <c:pt idx="135">
                  <c:v>1.0916597754359896</c:v>
                </c:pt>
                <c:pt idx="136">
                  <c:v>1.0930395264260058</c:v>
                </c:pt>
                <c:pt idx="137">
                  <c:v>1.0916886676404438</c:v>
                </c:pt>
                <c:pt idx="138">
                  <c:v>1.0919736120499366</c:v>
                </c:pt>
                <c:pt idx="139">
                  <c:v>1.0893983138055066</c:v>
                </c:pt>
                <c:pt idx="140">
                  <c:v>1.0929806969653453</c:v>
                </c:pt>
                <c:pt idx="141">
                  <c:v>1.09276558120489</c:v>
                </c:pt>
                <c:pt idx="142">
                  <c:v>1.0973664682465414</c:v>
                </c:pt>
                <c:pt idx="143">
                  <c:v>1.0973664682465414</c:v>
                </c:pt>
                <c:pt idx="144">
                  <c:v>1.0962847254331152</c:v>
                </c:pt>
                <c:pt idx="145">
                  <c:v>1.0940208387701797</c:v>
                </c:pt>
                <c:pt idx="146">
                  <c:v>1.0962237558703916</c:v>
                </c:pt>
                <c:pt idx="147">
                  <c:v>1.1007120977229026</c:v>
                </c:pt>
                <c:pt idx="148">
                  <c:v>1.0995925676764868</c:v>
                </c:pt>
                <c:pt idx="149">
                  <c:v>1.0973664682465414</c:v>
                </c:pt>
                <c:pt idx="150">
                  <c:v>1.0985025849494114</c:v>
                </c:pt>
                <c:pt idx="151">
                  <c:v>1.1018552892589084</c:v>
                </c:pt>
                <c:pt idx="152">
                  <c:v>1.104057727199264</c:v>
                </c:pt>
                <c:pt idx="153">
                  <c:v>1.1028844210200692</c:v>
                </c:pt>
                <c:pt idx="154">
                  <c:v>1.1018933776677711</c:v>
                </c:pt>
                <c:pt idx="155">
                  <c:v>1.104057727199264</c:v>
                </c:pt>
                <c:pt idx="156">
                  <c:v>1.104057727199264</c:v>
                </c:pt>
                <c:pt idx="157">
                  <c:v>1.1052709127625291</c:v>
                </c:pt>
                <c:pt idx="158">
                  <c:v>1.1074033566756254</c:v>
                </c:pt>
                <c:pt idx="159">
                  <c:v>1.1061725545325769</c:v>
                </c:pt>
                <c:pt idx="160">
                  <c:v>1.104057727199264</c:v>
                </c:pt>
                <c:pt idx="161">
                  <c:v>1.1053052466308206</c:v>
                </c:pt>
                <c:pt idx="162">
                  <c:v>1.108665798561794</c:v>
                </c:pt>
                <c:pt idx="163">
                  <c:v>1.1082031594515112</c:v>
                </c:pt>
                <c:pt idx="164">
                  <c:v>1.1066135807845374</c:v>
                </c:pt>
                <c:pt idx="165">
                  <c:v>1.1107489861519868</c:v>
                </c:pt>
                <c:pt idx="166">
                  <c:v>1.1107489861519868</c:v>
                </c:pt>
                <c:pt idx="167">
                  <c:v>1.1107489861519868</c:v>
                </c:pt>
                <c:pt idx="168">
                  <c:v>1.1120693508105113</c:v>
                </c:pt>
                <c:pt idx="169">
                  <c:v>1.1140946156283482</c:v>
                </c:pt>
                <c:pt idx="170">
                  <c:v>1.1140946156283482</c:v>
                </c:pt>
                <c:pt idx="171">
                  <c:v>1.115440302116141</c:v>
                </c:pt>
                <c:pt idx="172">
                  <c:v>1.1160807338389929</c:v>
                </c:pt>
                <c:pt idx="173">
                  <c:v>1.1154655258071811</c:v>
                </c:pt>
                <c:pt idx="174">
                  <c:v>1.1174402451047096</c:v>
                </c:pt>
                <c:pt idx="175">
                  <c:v>1.1174402451047096</c:v>
                </c:pt>
                <c:pt idx="176">
                  <c:v>1.1160404151221446</c:v>
                </c:pt>
                <c:pt idx="177">
                  <c:v>1.1169176844224338</c:v>
                </c:pt>
                <c:pt idx="178">
                  <c:v>1.120785874581071</c:v>
                </c:pt>
                <c:pt idx="179">
                  <c:v>1.120785874581071</c:v>
                </c:pt>
                <c:pt idx="180">
                  <c:v>1.1193461657766066</c:v>
                </c:pt>
                <c:pt idx="181">
                  <c:v>1.1174402451047096</c:v>
                </c:pt>
                <c:pt idx="182">
                  <c:v>1.1203528820466722</c:v>
                </c:pt>
                <c:pt idx="183">
                  <c:v>1.1241315040574325</c:v>
                </c:pt>
                <c:pt idx="184">
                  <c:v>1.1241315040574325</c:v>
                </c:pt>
                <c:pt idx="185">
                  <c:v>1.1256214594755671</c:v>
                </c:pt>
                <c:pt idx="186">
                  <c:v>1.1274771335337939</c:v>
                </c:pt>
                <c:pt idx="187">
                  <c:v>1.1274771335337939</c:v>
                </c:pt>
                <c:pt idx="188">
                  <c:v>1.1274771335337939</c:v>
                </c:pt>
                <c:pt idx="189">
                  <c:v>1.1274771335337939</c:v>
                </c:pt>
                <c:pt idx="190">
                  <c:v>1.1274771335337939</c:v>
                </c:pt>
                <c:pt idx="191">
                  <c:v>1.1274771335337939</c:v>
                </c:pt>
                <c:pt idx="192">
                  <c:v>1.1274771335337939</c:v>
                </c:pt>
                <c:pt idx="193">
                  <c:v>1.1290433232191508</c:v>
                </c:pt>
                <c:pt idx="194">
                  <c:v>1.1276699385326254</c:v>
                </c:pt>
                <c:pt idx="195">
                  <c:v>1.1273022547419622</c:v>
                </c:pt>
                <c:pt idx="196">
                  <c:v>1.132420552175071</c:v>
                </c:pt>
                <c:pt idx="197">
                  <c:v>1.1325597949286101</c:v>
                </c:pt>
                <c:pt idx="198">
                  <c:v>1.1308227630101553</c:v>
                </c:pt>
                <c:pt idx="199">
                  <c:v>1.1308227630101553</c:v>
                </c:pt>
                <c:pt idx="200">
                  <c:v>1.1308227630101553</c:v>
                </c:pt>
                <c:pt idx="201">
                  <c:v>1.129174946504095</c:v>
                </c:pt>
              </c:numCache>
            </c:numRef>
          </c:xVal>
          <c:yVal>
            <c:numRef>
              <c:f>'d0 u'!$D$7:$D$208</c:f>
              <c:numCache>
                <c:formatCode>General</c:formatCode>
                <c:ptCount val="202"/>
                <c:pt idx="0">
                  <c:v>0</c:v>
                </c:pt>
                <c:pt idx="2">
                  <c:v>3.6818155795580306E-3</c:v>
                </c:pt>
                <c:pt idx="6">
                  <c:v>1.7141655686942987E-2</c:v>
                </c:pt>
                <c:pt idx="7">
                  <c:v>2.3676015204200984E-2</c:v>
                </c:pt>
                <c:pt idx="8">
                  <c:v>2.7631857541002922E-2</c:v>
                </c:pt>
                <c:pt idx="9">
                  <c:v>2.9981460526267618E-2</c:v>
                </c:pt>
                <c:pt idx="10">
                  <c:v>3.9354927091567127E-2</c:v>
                </c:pt>
                <c:pt idx="11">
                  <c:v>4.2811666167232483E-2</c:v>
                </c:pt>
                <c:pt idx="12">
                  <c:v>4.6320238161361216E-2</c:v>
                </c:pt>
                <c:pt idx="13">
                  <c:v>5.3796167860086015E-2</c:v>
                </c:pt>
                <c:pt idx="14">
                  <c:v>5.8405159411367792E-2</c:v>
                </c:pt>
                <c:pt idx="15">
                  <c:v>6.6443534540425245E-2</c:v>
                </c:pt>
                <c:pt idx="16">
                  <c:v>6.7702321754691916E-2</c:v>
                </c:pt>
                <c:pt idx="17">
                  <c:v>7.2082871653763508E-2</c:v>
                </c:pt>
                <c:pt idx="18">
                  <c:v>8.3779549143584528E-2</c:v>
                </c:pt>
                <c:pt idx="19">
                  <c:v>8.6498197492315895E-2</c:v>
                </c:pt>
                <c:pt idx="20">
                  <c:v>9.8647433524257103E-2</c:v>
                </c:pt>
                <c:pt idx="21">
                  <c:v>0.10218526036379175</c:v>
                </c:pt>
                <c:pt idx="22">
                  <c:v>0.11466323338412311</c:v>
                </c:pt>
                <c:pt idx="23">
                  <c:v>0.12553015598424758</c:v>
                </c:pt>
                <c:pt idx="24">
                  <c:v>0.12746224201273659</c:v>
                </c:pt>
                <c:pt idx="25">
                  <c:v>0.14184061468430539</c:v>
                </c:pt>
                <c:pt idx="26">
                  <c:v>0.15235384880321967</c:v>
                </c:pt>
                <c:pt idx="27">
                  <c:v>0.1618415331360939</c:v>
                </c:pt>
                <c:pt idx="28">
                  <c:v>0.17535320386804398</c:v>
                </c:pt>
                <c:pt idx="29">
                  <c:v>0.18493589839618191</c:v>
                </c:pt>
                <c:pt idx="30">
                  <c:v>0.19181866890006072</c:v>
                </c:pt>
                <c:pt idx="31">
                  <c:v>0.21104837273827126</c:v>
                </c:pt>
                <c:pt idx="32">
                  <c:v>0.22778550869431982</c:v>
                </c:pt>
                <c:pt idx="33">
                  <c:v>0.2420880542746906</c:v>
                </c:pt>
                <c:pt idx="34">
                  <c:v>0.25410817749492443</c:v>
                </c:pt>
                <c:pt idx="35">
                  <c:v>0.27581322357082988</c:v>
                </c:pt>
                <c:pt idx="36">
                  <c:v>0.28813090511828604</c:v>
                </c:pt>
                <c:pt idx="37">
                  <c:v>0.30473456679795957</c:v>
                </c:pt>
                <c:pt idx="38">
                  <c:v>0.3263570814835412</c:v>
                </c:pt>
                <c:pt idx="39">
                  <c:v>0.34500756079242462</c:v>
                </c:pt>
                <c:pt idx="40">
                  <c:v>0.36980654304152805</c:v>
                </c:pt>
                <c:pt idx="41">
                  <c:v>0.38583194668755105</c:v>
                </c:pt>
                <c:pt idx="42">
                  <c:v>0.41195402481579407</c:v>
                </c:pt>
                <c:pt idx="43">
                  <c:v>0.43532623923177111</c:v>
                </c:pt>
                <c:pt idx="44">
                  <c:v>0.45773293670077275</c:v>
                </c:pt>
                <c:pt idx="45">
                  <c:v>0.48615759902301903</c:v>
                </c:pt>
                <c:pt idx="46">
                  <c:v>0.50974625953410602</c:v>
                </c:pt>
                <c:pt idx="47">
                  <c:v>0.52717107551536391</c:v>
                </c:pt>
                <c:pt idx="48">
                  <c:v>0.5557401494194919</c:v>
                </c:pt>
                <c:pt idx="49">
                  <c:v>0.58663150445483192</c:v>
                </c:pt>
                <c:pt idx="50">
                  <c:v>0.60757255404942956</c:v>
                </c:pt>
                <c:pt idx="51">
                  <c:v>0.64249700990510117</c:v>
                </c:pt>
                <c:pt idx="52">
                  <c:v>0.67924992877176449</c:v>
                </c:pt>
                <c:pt idx="53">
                  <c:v>0.69610316655025051</c:v>
                </c:pt>
                <c:pt idx="54">
                  <c:v>0.71928154352948537</c:v>
                </c:pt>
                <c:pt idx="55">
                  <c:v>0.7465673558573015</c:v>
                </c:pt>
                <c:pt idx="56">
                  <c:v>0.78412072889029649</c:v>
                </c:pt>
                <c:pt idx="57">
                  <c:v>0.81264708123868734</c:v>
                </c:pt>
                <c:pt idx="58">
                  <c:v>0.84331249649986628</c:v>
                </c:pt>
                <c:pt idx="59">
                  <c:v>0.87073082884250674</c:v>
                </c:pt>
                <c:pt idx="60">
                  <c:v>0.9026467182317186</c:v>
                </c:pt>
                <c:pt idx="61">
                  <c:v>0.935353029806822</c:v>
                </c:pt>
                <c:pt idx="62">
                  <c:v>0.955614106873377</c:v>
                </c:pt>
                <c:pt idx="63">
                  <c:v>0.99356004842885803</c:v>
                </c:pt>
                <c:pt idx="64">
                  <c:v>1.0253871670252785</c:v>
                </c:pt>
                <c:pt idx="65">
                  <c:v>1.0531866167517514</c:v>
                </c:pt>
                <c:pt idx="66">
                  <c:v>1.0847483038266117</c:v>
                </c:pt>
                <c:pt idx="67">
                  <c:v>1.1167069637080536</c:v>
                </c:pt>
                <c:pt idx="68">
                  <c:v>1.1448149090672555</c:v>
                </c:pt>
                <c:pt idx="69">
                  <c:v>1.1765441546837481</c:v>
                </c:pt>
                <c:pt idx="70">
                  <c:v>1.2152161180043262</c:v>
                </c:pt>
                <c:pt idx="71">
                  <c:v>1.243038078516185</c:v>
                </c:pt>
                <c:pt idx="72">
                  <c:v>1.2708273494527464</c:v>
                </c:pt>
                <c:pt idx="73">
                  <c:v>1.2990624318128745</c:v>
                </c:pt>
                <c:pt idx="74">
                  <c:v>1.3289143758013935</c:v>
                </c:pt>
                <c:pt idx="75">
                  <c:v>1.3664965234904838</c:v>
                </c:pt>
                <c:pt idx="76">
                  <c:v>1.3949359646327006</c:v>
                </c:pt>
                <c:pt idx="77">
                  <c:v>1.430813165011469</c:v>
                </c:pt>
                <c:pt idx="78">
                  <c:v>1.451141774434175</c:v>
                </c:pt>
                <c:pt idx="79">
                  <c:v>1.4822984631180962</c:v>
                </c:pt>
                <c:pt idx="80">
                  <c:v>1.5140887814740633</c:v>
                </c:pt>
                <c:pt idx="81">
                  <c:v>1.5540358339771274</c:v>
                </c:pt>
                <c:pt idx="82">
                  <c:v>1.5848129712448911</c:v>
                </c:pt>
                <c:pt idx="83">
                  <c:v>1.6089233926119682</c:v>
                </c:pt>
                <c:pt idx="84">
                  <c:v>1.6328334679891341</c:v>
                </c:pt>
                <c:pt idx="85">
                  <c:v>1.6640348846248814</c:v>
                </c:pt>
                <c:pt idx="86">
                  <c:v>1.6990370026901256</c:v>
                </c:pt>
                <c:pt idx="87">
                  <c:v>1.7341765344191864</c:v>
                </c:pt>
                <c:pt idx="88">
                  <c:v>1.7582476108483294</c:v>
                </c:pt>
                <c:pt idx="89">
                  <c:v>1.7913233929226544</c:v>
                </c:pt>
                <c:pt idx="90">
                  <c:v>1.8106120040606577</c:v>
                </c:pt>
                <c:pt idx="91">
                  <c:v>1.8473607633256759</c:v>
                </c:pt>
                <c:pt idx="92">
                  <c:v>1.8876979375267267</c:v>
                </c:pt>
                <c:pt idx="93">
                  <c:v>1.8993029325026021</c:v>
                </c:pt>
                <c:pt idx="94">
                  <c:v>1.9282075639184082</c:v>
                </c:pt>
                <c:pt idx="95">
                  <c:v>1.9594411807645526</c:v>
                </c:pt>
                <c:pt idx="96">
                  <c:v>1.9911843243441947</c:v>
                </c:pt>
                <c:pt idx="97">
                  <c:v>2.0223177192588944</c:v>
                </c:pt>
                <c:pt idx="98">
                  <c:v>2.0406814307365893</c:v>
                </c:pt>
                <c:pt idx="99">
                  <c:v>2.0709490412708584</c:v>
                </c:pt>
                <c:pt idx="100">
                  <c:v>2.0955752532421457</c:v>
                </c:pt>
                <c:pt idx="101">
                  <c:v>2.1228246568214333</c:v>
                </c:pt>
                <c:pt idx="102">
                  <c:v>2.1432646456952953</c:v>
                </c:pt>
                <c:pt idx="103">
                  <c:v>2.1750438065315514</c:v>
                </c:pt>
                <c:pt idx="104">
                  <c:v>2.201472643047131</c:v>
                </c:pt>
                <c:pt idx="105">
                  <c:v>2.222911132062205</c:v>
                </c:pt>
                <c:pt idx="106">
                  <c:v>2.2518396444851145</c:v>
                </c:pt>
                <c:pt idx="107">
                  <c:v>2.273751642977075</c:v>
                </c:pt>
                <c:pt idx="108">
                  <c:v>2.2900737240934985</c:v>
                </c:pt>
                <c:pt idx="109">
                  <c:v>2.3132122667699027</c:v>
                </c:pt>
                <c:pt idx="110">
                  <c:v>2.3373187732177811</c:v>
                </c:pt>
                <c:pt idx="111">
                  <c:v>2.3633146196701653</c:v>
                </c:pt>
                <c:pt idx="112">
                  <c:v>2.3811327871577483</c:v>
                </c:pt>
                <c:pt idx="113">
                  <c:v>2.3953208458198501</c:v>
                </c:pt>
                <c:pt idx="114">
                  <c:v>2.4106324862915116</c:v>
                </c:pt>
                <c:pt idx="115">
                  <c:v>2.4375645856698762</c:v>
                </c:pt>
                <c:pt idx="116">
                  <c:v>2.4493138454181622</c:v>
                </c:pt>
                <c:pt idx="117">
                  <c:v>2.468097431979742</c:v>
                </c:pt>
                <c:pt idx="118">
                  <c:v>2.4786160368784316</c:v>
                </c:pt>
                <c:pt idx="119">
                  <c:v>2.502713343266195</c:v>
                </c:pt>
                <c:pt idx="120">
                  <c:v>2.5235988499446842</c:v>
                </c:pt>
                <c:pt idx="121">
                  <c:v>2.5277858560259521</c:v>
                </c:pt>
                <c:pt idx="122">
                  <c:v>2.5457839140506415</c:v>
                </c:pt>
                <c:pt idx="123">
                  <c:v>2.5532966439898175</c:v>
                </c:pt>
                <c:pt idx="124">
                  <c:v>2.5698841566278041</c:v>
                </c:pt>
                <c:pt idx="125">
                  <c:v>2.5790722762373677</c:v>
                </c:pt>
                <c:pt idx="126">
                  <c:v>2.5983653895324479</c:v>
                </c:pt>
                <c:pt idx="127">
                  <c:v>2.607576411419315</c:v>
                </c:pt>
                <c:pt idx="128">
                  <c:v>2.6174202799943855</c:v>
                </c:pt>
                <c:pt idx="129">
                  <c:v>2.6251438283323263</c:v>
                </c:pt>
                <c:pt idx="130">
                  <c:v>2.6253468168926943</c:v>
                </c:pt>
                <c:pt idx="131">
                  <c:v>2.6366102351686251</c:v>
                </c:pt>
                <c:pt idx="132">
                  <c:v>2.6418016137698994</c:v>
                </c:pt>
                <c:pt idx="133">
                  <c:v>2.6492088366367175</c:v>
                </c:pt>
                <c:pt idx="134">
                  <c:v>2.651874896609919</c:v>
                </c:pt>
                <c:pt idx="135">
                  <c:v>2.6544147004390193</c:v>
                </c:pt>
                <c:pt idx="136">
                  <c:v>2.6510883893432293</c:v>
                </c:pt>
                <c:pt idx="137">
                  <c:v>2.6484587381185563</c:v>
                </c:pt>
                <c:pt idx="138">
                  <c:v>2.6617712251022345</c:v>
                </c:pt>
                <c:pt idx="139">
                  <c:v>2.6557821817145562</c:v>
                </c:pt>
                <c:pt idx="140">
                  <c:v>2.6406437764173676</c:v>
                </c:pt>
                <c:pt idx="141">
                  <c:v>2.6441053479714167</c:v>
                </c:pt>
                <c:pt idx="142">
                  <c:v>2.6443400473772787</c:v>
                </c:pt>
                <c:pt idx="143">
                  <c:v>2.6421381010748881</c:v>
                </c:pt>
                <c:pt idx="144">
                  <c:v>2.6387376022603131</c:v>
                </c:pt>
                <c:pt idx="145">
                  <c:v>2.6337407951431309</c:v>
                </c:pt>
                <c:pt idx="146">
                  <c:v>2.63303610968766</c:v>
                </c:pt>
                <c:pt idx="147">
                  <c:v>2.6191150485147991</c:v>
                </c:pt>
                <c:pt idx="148">
                  <c:v>2.6054510017872263</c:v>
                </c:pt>
                <c:pt idx="149">
                  <c:v>2.5939517096296729</c:v>
                </c:pt>
                <c:pt idx="150">
                  <c:v>2.5808696156407436</c:v>
                </c:pt>
                <c:pt idx="151">
                  <c:v>2.5763018836675613</c:v>
                </c:pt>
                <c:pt idx="152">
                  <c:v>2.5641472340364184</c:v>
                </c:pt>
                <c:pt idx="153">
                  <c:v>2.5461556356284021</c:v>
                </c:pt>
                <c:pt idx="154">
                  <c:v>2.4848360604987367</c:v>
                </c:pt>
                <c:pt idx="155">
                  <c:v>2.4164306773683331</c:v>
                </c:pt>
                <c:pt idx="156">
                  <c:v>2.3626868623769139</c:v>
                </c:pt>
                <c:pt idx="157">
                  <c:v>2.2952600132998175</c:v>
                </c:pt>
                <c:pt idx="158">
                  <c:v>2.2444377067592165</c:v>
                </c:pt>
                <c:pt idx="159">
                  <c:v>2.1648853741989931</c:v>
                </c:pt>
                <c:pt idx="160">
                  <c:v>2.0395633298139058</c:v>
                </c:pt>
                <c:pt idx="161">
                  <c:v>1.7650856044638927</c:v>
                </c:pt>
                <c:pt idx="162">
                  <c:v>1.6556970854649204</c:v>
                </c:pt>
                <c:pt idx="163">
                  <c:v>1.5513641952440667</c:v>
                </c:pt>
                <c:pt idx="164">
                  <c:v>1.4725363184812621</c:v>
                </c:pt>
                <c:pt idx="165">
                  <c:v>1.4496805308438665</c:v>
                </c:pt>
                <c:pt idx="166">
                  <c:v>1.4255163772108121</c:v>
                </c:pt>
                <c:pt idx="167">
                  <c:v>1.3991299196955411</c:v>
                </c:pt>
                <c:pt idx="168">
                  <c:v>1.3826049478917284</c:v>
                </c:pt>
                <c:pt idx="169">
                  <c:v>1.3556482823954032</c:v>
                </c:pt>
                <c:pt idx="170">
                  <c:v>1.3377397781473475</c:v>
                </c:pt>
                <c:pt idx="171">
                  <c:v>1.3257599296583522</c:v>
                </c:pt>
                <c:pt idx="172">
                  <c:v>1.3025585525288383</c:v>
                </c:pt>
                <c:pt idx="173">
                  <c:v>1.2877487068252622</c:v>
                </c:pt>
                <c:pt idx="174">
                  <c:v>1.2648122718524082</c:v>
                </c:pt>
                <c:pt idx="175">
                  <c:v>1.2525795195832816</c:v>
                </c:pt>
                <c:pt idx="176">
                  <c:v>1.2456209464564509</c:v>
                </c:pt>
                <c:pt idx="177">
                  <c:v>1.2237987953600635</c:v>
                </c:pt>
                <c:pt idx="178">
                  <c:v>1.2186661405467432</c:v>
                </c:pt>
                <c:pt idx="179">
                  <c:v>1.2288775221614427</c:v>
                </c:pt>
                <c:pt idx="180">
                  <c:v>1.2180658855608515</c:v>
                </c:pt>
                <c:pt idx="181">
                  <c:v>1.2068778294794655</c:v>
                </c:pt>
                <c:pt idx="182">
                  <c:v>1.1965081872562275</c:v>
                </c:pt>
                <c:pt idx="183">
                  <c:v>1.181496723214001</c:v>
                </c:pt>
                <c:pt idx="184">
                  <c:v>1.1689396198894</c:v>
                </c:pt>
                <c:pt idx="185">
                  <c:v>1.1519400620059221</c:v>
                </c:pt>
                <c:pt idx="186">
                  <c:v>1.144922373599216</c:v>
                </c:pt>
                <c:pt idx="187">
                  <c:v>1.1319693740708088</c:v>
                </c:pt>
                <c:pt idx="188">
                  <c:v>1.1128053552362538</c:v>
                </c:pt>
                <c:pt idx="189">
                  <c:v>1.0835408448732555</c:v>
                </c:pt>
                <c:pt idx="190">
                  <c:v>1.0442703882804247</c:v>
                </c:pt>
                <c:pt idx="191">
                  <c:v>1.017592660776891</c:v>
                </c:pt>
                <c:pt idx="192">
                  <c:v>1.004815636866395</c:v>
                </c:pt>
                <c:pt idx="193">
                  <c:v>1.005231792777042</c:v>
                </c:pt>
                <c:pt idx="194">
                  <c:v>1.0002714922813738</c:v>
                </c:pt>
                <c:pt idx="195">
                  <c:v>0.99485911649142622</c:v>
                </c:pt>
                <c:pt idx="196">
                  <c:v>0.99019732858453624</c:v>
                </c:pt>
                <c:pt idx="197">
                  <c:v>0.98466163283987951</c:v>
                </c:pt>
                <c:pt idx="198">
                  <c:v>0.9400757925802079</c:v>
                </c:pt>
                <c:pt idx="199">
                  <c:v>0.91095045759466431</c:v>
                </c:pt>
                <c:pt idx="200">
                  <c:v>0.88683191277025708</c:v>
                </c:pt>
                <c:pt idx="201">
                  <c:v>0.867134779814037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DC2-49E8-B058-2B285C669968}"/>
            </c:ext>
          </c:extLst>
        </c:ser>
        <c:ser>
          <c:idx val="2"/>
          <c:order val="2"/>
          <c:tx>
            <c:v>EDC-TD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d0 u'!$E$7:$E$195</c:f>
              <c:numCache>
                <c:formatCode>General</c:formatCode>
                <c:ptCount val="189"/>
                <c:pt idx="0">
                  <c:v>1</c:v>
                </c:pt>
                <c:pt idx="1">
                  <c:v>1</c:v>
                </c:pt>
                <c:pt idx="2">
                  <c:v>1.0026785325655505</c:v>
                </c:pt>
                <c:pt idx="3">
                  <c:v>1.0033783783783783</c:v>
                </c:pt>
                <c:pt idx="4">
                  <c:v>1.0033783783783783</c:v>
                </c:pt>
                <c:pt idx="5">
                  <c:v>1.0033783783783783</c:v>
                </c:pt>
                <c:pt idx="8">
                  <c:v>1.0046504603685995</c:v>
                </c:pt>
                <c:pt idx="9">
                  <c:v>1.0061313649726984</c:v>
                </c:pt>
                <c:pt idx="10">
                  <c:v>1.0095194982127409</c:v>
                </c:pt>
                <c:pt idx="11">
                  <c:v>1.0101351351351351</c:v>
                </c:pt>
                <c:pt idx="12">
                  <c:v>1.0101351351351351</c:v>
                </c:pt>
                <c:pt idx="13">
                  <c:v>1.007349301566546</c:v>
                </c:pt>
                <c:pt idx="14">
                  <c:v>1.0151569891527354</c:v>
                </c:pt>
                <c:pt idx="15">
                  <c:v>1.0140793151586738</c:v>
                </c:pt>
                <c:pt idx="16">
                  <c:v>1.0135135135135136</c:v>
                </c:pt>
                <c:pt idx="17">
                  <c:v>1.0191733088574533</c:v>
                </c:pt>
                <c:pt idx="18">
                  <c:v>1.017429882331558</c:v>
                </c:pt>
                <c:pt idx="19">
                  <c:v>1.0197422320525555</c:v>
                </c:pt>
                <c:pt idx="20">
                  <c:v>1.0174071815275669</c:v>
                </c:pt>
                <c:pt idx="21">
                  <c:v>1.0168918918918919</c:v>
                </c:pt>
                <c:pt idx="22">
                  <c:v>1.0168918918918919</c:v>
                </c:pt>
                <c:pt idx="23">
                  <c:v>1.0168918918918919</c:v>
                </c:pt>
                <c:pt idx="24">
                  <c:v>1.0197936531778304</c:v>
                </c:pt>
                <c:pt idx="25">
                  <c:v>1.0202702702702702</c:v>
                </c:pt>
                <c:pt idx="26">
                  <c:v>1.0202702702702702</c:v>
                </c:pt>
                <c:pt idx="27">
                  <c:v>1.0261259694458715</c:v>
                </c:pt>
                <c:pt idx="29">
                  <c:v>1.0296951996039689</c:v>
                </c:pt>
                <c:pt idx="30">
                  <c:v>1.0240666990090659</c:v>
                </c:pt>
                <c:pt idx="31">
                  <c:v>1.026624265532172</c:v>
                </c:pt>
                <c:pt idx="32">
                  <c:v>1.027027027027027</c:v>
                </c:pt>
                <c:pt idx="33">
                  <c:v>1.0479665840221757</c:v>
                </c:pt>
                <c:pt idx="34">
                  <c:v>1.0506756756756757</c:v>
                </c:pt>
                <c:pt idx="35">
                  <c:v>1.0295923857997076</c:v>
                </c:pt>
                <c:pt idx="36">
                  <c:v>1.0300516742429735</c:v>
                </c:pt>
                <c:pt idx="37">
                  <c:v>1.0544998449715024</c:v>
                </c:pt>
                <c:pt idx="38">
                  <c:v>1.0331143156057059</c:v>
                </c:pt>
                <c:pt idx="39">
                  <c:v>1.0334577062242802</c:v>
                </c:pt>
                <c:pt idx="40">
                  <c:v>1.0337837837837835</c:v>
                </c:pt>
                <c:pt idx="41">
                  <c:v>1.0337837837837835</c:v>
                </c:pt>
                <c:pt idx="42">
                  <c:v>1.0307231339731611</c:v>
                </c:pt>
                <c:pt idx="43">
                  <c:v>1.0334965889043983</c:v>
                </c:pt>
                <c:pt idx="44">
                  <c:v>1.0368854491673394</c:v>
                </c:pt>
                <c:pt idx="45">
                  <c:v>1.0340502613554341</c:v>
                </c:pt>
                <c:pt idx="46">
                  <c:v>1.0306622493377957</c:v>
                </c:pt>
                <c:pt idx="47">
                  <c:v>1.0335300892735297</c:v>
                </c:pt>
                <c:pt idx="48">
                  <c:v>1.0337837837837835</c:v>
                </c:pt>
                <c:pt idx="49">
                  <c:v>1.0432411571390139</c:v>
                </c:pt>
                <c:pt idx="50">
                  <c:v>1.0439189189189189</c:v>
                </c:pt>
                <c:pt idx="51">
                  <c:v>1.0344025340248792</c:v>
                </c:pt>
                <c:pt idx="52">
                  <c:v>1.0369293439024214</c:v>
                </c:pt>
                <c:pt idx="53">
                  <c:v>1.0371621621621623</c:v>
                </c:pt>
                <c:pt idx="54">
                  <c:v>1.0403620135282297</c:v>
                </c:pt>
                <c:pt idx="55">
                  <c:v>1.0469678912130307</c:v>
                </c:pt>
                <c:pt idx="56">
                  <c:v>1.044074962211053</c:v>
                </c:pt>
                <c:pt idx="57">
                  <c:v>1.0407253060599764</c:v>
                </c:pt>
                <c:pt idx="58">
                  <c:v>1.0437816096466788</c:v>
                </c:pt>
                <c:pt idx="59">
                  <c:v>1.0439189189189189</c:v>
                </c:pt>
                <c:pt idx="60">
                  <c:v>1.0439189189189189</c:v>
                </c:pt>
                <c:pt idx="62">
                  <c:v>1.0447044303921675</c:v>
                </c:pt>
                <c:pt idx="63">
                  <c:v>1.0439189189189189</c:v>
                </c:pt>
                <c:pt idx="64">
                  <c:v>1.0472212807161465</c:v>
                </c:pt>
                <c:pt idx="65">
                  <c:v>1.0472972972972974</c:v>
                </c:pt>
                <c:pt idx="66">
                  <c:v>1.0506175078365052</c:v>
                </c:pt>
                <c:pt idx="67">
                  <c:v>1.0506756756756757</c:v>
                </c:pt>
                <c:pt idx="68">
                  <c:v>1.047333084979275</c:v>
                </c:pt>
                <c:pt idx="69">
                  <c:v>1.0472972972972974</c:v>
                </c:pt>
                <c:pt idx="70">
                  <c:v>1.050660445099193</c:v>
                </c:pt>
                <c:pt idx="71">
                  <c:v>1.0506756756756757</c:v>
                </c:pt>
                <c:pt idx="72">
                  <c:v>1.0540522144214528</c:v>
                </c:pt>
                <c:pt idx="73">
                  <c:v>1.0506647440798476</c:v>
                </c:pt>
                <c:pt idx="74">
                  <c:v>1.0473154624159644</c:v>
                </c:pt>
                <c:pt idx="75">
                  <c:v>1.0506756756756757</c:v>
                </c:pt>
                <c:pt idx="76">
                  <c:v>1.0506756756756757</c:v>
                </c:pt>
                <c:pt idx="77">
                  <c:v>1.0507284126197283</c:v>
                </c:pt>
                <c:pt idx="78">
                  <c:v>1.0539321947232732</c:v>
                </c:pt>
                <c:pt idx="79">
                  <c:v>1.047374198899776</c:v>
                </c:pt>
                <c:pt idx="80">
                  <c:v>1.0507449365767687</c:v>
                </c:pt>
                <c:pt idx="81">
                  <c:v>1.0539597631079998</c:v>
                </c:pt>
                <c:pt idx="82">
                  <c:v>1.0508866181347976</c:v>
                </c:pt>
                <c:pt idx="83">
                  <c:v>1.0573182750663983</c:v>
                </c:pt>
                <c:pt idx="84">
                  <c:v>1.0540540540540539</c:v>
                </c:pt>
                <c:pt idx="85">
                  <c:v>1.0541869837224509</c:v>
                </c:pt>
                <c:pt idx="86">
                  <c:v>1.0574324324324322</c:v>
                </c:pt>
                <c:pt idx="87">
                  <c:v>1.0586827495518081</c:v>
                </c:pt>
                <c:pt idx="89">
                  <c:v>1.0574324324324322</c:v>
                </c:pt>
                <c:pt idx="90">
                  <c:v>1.0576157784676767</c:v>
                </c:pt>
                <c:pt idx="91">
                  <c:v>1.0610030679640381</c:v>
                </c:pt>
                <c:pt idx="92">
                  <c:v>1.0656187872879113</c:v>
                </c:pt>
                <c:pt idx="94">
                  <c:v>1.0675675675675675</c:v>
                </c:pt>
                <c:pt idx="95">
                  <c:v>1.0673335161743276</c:v>
                </c:pt>
                <c:pt idx="96">
                  <c:v>1.0644345054416735</c:v>
                </c:pt>
                <c:pt idx="97">
                  <c:v>1.0678239302577179</c:v>
                </c:pt>
                <c:pt idx="98">
                  <c:v>1.0709459459459458</c:v>
                </c:pt>
                <c:pt idx="99">
                  <c:v>1.0709459459459458</c:v>
                </c:pt>
                <c:pt idx="100">
                  <c:v>1.070379840928759</c:v>
                </c:pt>
                <c:pt idx="101">
                  <c:v>1.0644831885103965</c:v>
                </c:pt>
                <c:pt idx="102">
                  <c:v>1.0678741010402586</c:v>
                </c:pt>
                <c:pt idx="103">
                  <c:v>1.0709459459459458</c:v>
                </c:pt>
                <c:pt idx="104">
                  <c:v>1.0709459459459458</c:v>
                </c:pt>
                <c:pt idx="105">
                  <c:v>1.0712799677360805</c:v>
                </c:pt>
                <c:pt idx="106">
                  <c:v>1.0739816962216182</c:v>
                </c:pt>
                <c:pt idx="107">
                  <c:v>1.0716563896676821</c:v>
                </c:pt>
                <c:pt idx="108">
                  <c:v>1.0769827159975995</c:v>
                </c:pt>
                <c:pt idx="109">
                  <c:v>1.07169372087634</c:v>
                </c:pt>
                <c:pt idx="110">
                  <c:v>1.0769338267691664</c:v>
                </c:pt>
                <c:pt idx="111">
                  <c:v>1.0713416910310023</c:v>
                </c:pt>
                <c:pt idx="112">
                  <c:v>1.0743243243243243</c:v>
                </c:pt>
                <c:pt idx="113">
                  <c:v>1.0747354321184597</c:v>
                </c:pt>
                <c:pt idx="114">
                  <c:v>1.0772813499230924</c:v>
                </c:pt>
                <c:pt idx="115">
                  <c:v>1.0743243243243243</c:v>
                </c:pt>
                <c:pt idx="116">
                  <c:v>1.0743243243243243</c:v>
                </c:pt>
                <c:pt idx="117">
                  <c:v>1.0747780683372712</c:v>
                </c:pt>
                <c:pt idx="118">
                  <c:v>1.0781632600419919</c:v>
                </c:pt>
                <c:pt idx="119">
                  <c:v>1.0810810810810809</c:v>
                </c:pt>
                <c:pt idx="120">
                  <c:v>1.0805989332709693</c:v>
                </c:pt>
                <c:pt idx="121">
                  <c:v>1.0777027027027026</c:v>
                </c:pt>
                <c:pt idx="122">
                  <c:v>1.0777027027027026</c:v>
                </c:pt>
                <c:pt idx="123">
                  <c:v>1.0782165955017515</c:v>
                </c:pt>
                <c:pt idx="124">
                  <c:v>1.0816018405886803</c:v>
                </c:pt>
                <c:pt idx="125">
                  <c:v>1.0839297153515772</c:v>
                </c:pt>
                <c:pt idx="126">
                  <c:v>1.0810810810810809</c:v>
                </c:pt>
                <c:pt idx="127">
                  <c:v>1.0810810810810809</c:v>
                </c:pt>
                <c:pt idx="128">
                  <c:v>1.0810810810810809</c:v>
                </c:pt>
                <c:pt idx="129">
                  <c:v>1.0822175393947973</c:v>
                </c:pt>
                <c:pt idx="130">
                  <c:v>1.0872741346559673</c:v>
                </c:pt>
                <c:pt idx="131">
                  <c:v>1.0844594594594592</c:v>
                </c:pt>
                <c:pt idx="132">
                  <c:v>1.0844594594594592</c:v>
                </c:pt>
                <c:pt idx="133">
                  <c:v>1.0844594594594592</c:v>
                </c:pt>
                <c:pt idx="134">
                  <c:v>1.0844594594594592</c:v>
                </c:pt>
                <c:pt idx="135">
                  <c:v>1.0901585932878763</c:v>
                </c:pt>
                <c:pt idx="137">
                  <c:v>1.0851143816920705</c:v>
                </c:pt>
                <c:pt idx="138">
                  <c:v>1.0871725780471491</c:v>
                </c:pt>
                <c:pt idx="139">
                  <c:v>1.0851319315625783</c:v>
                </c:pt>
                <c:pt idx="140">
                  <c:v>1.0892093429913314</c:v>
                </c:pt>
                <c:pt idx="141">
                  <c:v>1.0945945945945945</c:v>
                </c:pt>
                <c:pt idx="142">
                  <c:v>1.0945945945945945</c:v>
                </c:pt>
                <c:pt idx="143">
                  <c:v>1.0945945945945945</c:v>
                </c:pt>
                <c:pt idx="144">
                  <c:v>1.093146402708193</c:v>
                </c:pt>
                <c:pt idx="145">
                  <c:v>1.0885735716142897</c:v>
                </c:pt>
                <c:pt idx="146">
                  <c:v>1.0919573501951447</c:v>
                </c:pt>
                <c:pt idx="147">
                  <c:v>1.0945945945945945</c:v>
                </c:pt>
                <c:pt idx="148">
                  <c:v>1.0953492782149887</c:v>
                </c:pt>
                <c:pt idx="149">
                  <c:v>1.097972972972973</c:v>
                </c:pt>
                <c:pt idx="150">
                  <c:v>1.0971879550307331</c:v>
                </c:pt>
                <c:pt idx="151">
                  <c:v>1.0961846651009859</c:v>
                </c:pt>
                <c:pt idx="152">
                  <c:v>1.1013513513513513</c:v>
                </c:pt>
                <c:pt idx="153">
                  <c:v>1.1021596208074378</c:v>
                </c:pt>
                <c:pt idx="154">
                  <c:v>1.1039058688900629</c:v>
                </c:pt>
                <c:pt idx="155">
                  <c:v>1.1013513513513513</c:v>
                </c:pt>
                <c:pt idx="156">
                  <c:v>1.1013513513513513</c:v>
                </c:pt>
                <c:pt idx="157">
                  <c:v>1.1022030201886104</c:v>
                </c:pt>
                <c:pt idx="158">
                  <c:v>1.1038799141648108</c:v>
                </c:pt>
                <c:pt idx="159">
                  <c:v>1.1030831466587732</c:v>
                </c:pt>
                <c:pt idx="160">
                  <c:v>1.1081081081081079</c:v>
                </c:pt>
                <c:pt idx="161">
                  <c:v>1.1063180595746838</c:v>
                </c:pt>
                <c:pt idx="162">
                  <c:v>1.1022486306750634</c:v>
                </c:pt>
                <c:pt idx="163">
                  <c:v>1.1047297297297296</c:v>
                </c:pt>
                <c:pt idx="164">
                  <c:v>1.1056527044600692</c:v>
                </c:pt>
                <c:pt idx="165">
                  <c:v>1.1071732120279409</c:v>
                </c:pt>
                <c:pt idx="166">
                  <c:v>1.1047297297297296</c:v>
                </c:pt>
                <c:pt idx="167">
                  <c:v>1.1028278252098536</c:v>
                </c:pt>
                <c:pt idx="168">
                  <c:v>1.1008451341648626</c:v>
                </c:pt>
                <c:pt idx="169">
                  <c:v>1.107133685485306</c:v>
                </c:pt>
                <c:pt idx="170">
                  <c:v>1.1037457726874138</c:v>
                </c:pt>
                <c:pt idx="171">
                  <c:v>1.1023469035806142</c:v>
                </c:pt>
                <c:pt idx="172">
                  <c:v>1.1047297297297296</c:v>
                </c:pt>
                <c:pt idx="173">
                  <c:v>1.1037204255236386</c:v>
                </c:pt>
                <c:pt idx="174">
                  <c:v>1.1033977839446594</c:v>
                </c:pt>
                <c:pt idx="175">
                  <c:v>1.1070761175048558</c:v>
                </c:pt>
                <c:pt idx="176">
                  <c:v>1.1036905462809152</c:v>
                </c:pt>
                <c:pt idx="177">
                  <c:v>1.1013513513513513</c:v>
                </c:pt>
                <c:pt idx="178">
                  <c:v>1.1024108942323203</c:v>
                </c:pt>
                <c:pt idx="179">
                  <c:v>1.1047297297297296</c:v>
                </c:pt>
                <c:pt idx="180">
                  <c:v>1.105805100380755</c:v>
                </c:pt>
                <c:pt idx="181">
                  <c:v>1.1081081081081079</c:v>
                </c:pt>
                <c:pt idx="182">
                  <c:v>1.1058983257316015</c:v>
                </c:pt>
                <c:pt idx="183">
                  <c:v>1.1035802853749421</c:v>
                </c:pt>
                <c:pt idx="184">
                  <c:v>1.1069844748707498</c:v>
                </c:pt>
                <c:pt idx="185">
                  <c:v>1.1035951720819692</c:v>
                </c:pt>
                <c:pt idx="186">
                  <c:v>1.1013513513513513</c:v>
                </c:pt>
                <c:pt idx="187">
                  <c:v>1.1025049907381514</c:v>
                </c:pt>
                <c:pt idx="188">
                  <c:v>1.1047297297297296</c:v>
                </c:pt>
              </c:numCache>
            </c:numRef>
          </c:xVal>
          <c:yVal>
            <c:numRef>
              <c:f>'d0 u'!$F$7:$F$195</c:f>
              <c:numCache>
                <c:formatCode>General</c:formatCode>
                <c:ptCount val="189"/>
                <c:pt idx="0">
                  <c:v>0</c:v>
                </c:pt>
                <c:pt idx="1">
                  <c:v>3.7100640756468711E-2</c:v>
                </c:pt>
                <c:pt idx="2">
                  <c:v>6.4636340304728701E-2</c:v>
                </c:pt>
                <c:pt idx="3">
                  <c:v>9.3273199614017421E-2</c:v>
                </c:pt>
                <c:pt idx="4">
                  <c:v>0.13000569156100678</c:v>
                </c:pt>
                <c:pt idx="5">
                  <c:v>0.16040505781289063</c:v>
                </c:pt>
                <c:pt idx="8">
                  <c:v>0.24691052855022486</c:v>
                </c:pt>
                <c:pt idx="9">
                  <c:v>0.27700303903510448</c:v>
                </c:pt>
                <c:pt idx="10">
                  <c:v>0.30341823134691415</c:v>
                </c:pt>
                <c:pt idx="11">
                  <c:v>0.33963266760110777</c:v>
                </c:pt>
                <c:pt idx="12">
                  <c:v>0.37054964491436582</c:v>
                </c:pt>
                <c:pt idx="13">
                  <c:v>0.39562421340134968</c:v>
                </c:pt>
                <c:pt idx="14">
                  <c:v>0.41591935460605933</c:v>
                </c:pt>
                <c:pt idx="15">
                  <c:v>0.45042645426527217</c:v>
                </c:pt>
                <c:pt idx="16">
                  <c:v>0.4795686552120787</c:v>
                </c:pt>
                <c:pt idx="17">
                  <c:v>0.50617804330202709</c:v>
                </c:pt>
                <c:pt idx="18">
                  <c:v>0.52997091965329157</c:v>
                </c:pt>
                <c:pt idx="19">
                  <c:v>0.57162610633719479</c:v>
                </c:pt>
                <c:pt idx="20">
                  <c:v>0.58835616876040775</c:v>
                </c:pt>
                <c:pt idx="21">
                  <c:v>0.62952865395815294</c:v>
                </c:pt>
                <c:pt idx="22">
                  <c:v>0.64732828327724956</c:v>
                </c:pt>
                <c:pt idx="23">
                  <c:v>0.68125173810028194</c:v>
                </c:pt>
                <c:pt idx="24">
                  <c:v>0.70291254669427872</c:v>
                </c:pt>
                <c:pt idx="25">
                  <c:v>0.72824971209610778</c:v>
                </c:pt>
                <c:pt idx="26">
                  <c:v>0.7622227252971755</c:v>
                </c:pt>
                <c:pt idx="27">
                  <c:v>0.79190314657265293</c:v>
                </c:pt>
                <c:pt idx="29">
                  <c:v>0.84338252462686891</c:v>
                </c:pt>
                <c:pt idx="30">
                  <c:v>0.86752990440976252</c:v>
                </c:pt>
                <c:pt idx="31">
                  <c:v>0.90255080572059154</c:v>
                </c:pt>
                <c:pt idx="32">
                  <c:v>0.91926817812265926</c:v>
                </c:pt>
                <c:pt idx="33">
                  <c:v>0.95675911514028522</c:v>
                </c:pt>
                <c:pt idx="34">
                  <c:v>0.97780897612533346</c:v>
                </c:pt>
                <c:pt idx="35">
                  <c:v>1.0022532254938143</c:v>
                </c:pt>
                <c:pt idx="36">
                  <c:v>1.0277436325146303</c:v>
                </c:pt>
                <c:pt idx="37">
                  <c:v>1.0489730765261946</c:v>
                </c:pt>
                <c:pt idx="38">
                  <c:v>1.0730609478008366</c:v>
                </c:pt>
                <c:pt idx="39">
                  <c:v>1.1014999581440819</c:v>
                </c:pt>
                <c:pt idx="40">
                  <c:v>1.1240044608712205</c:v>
                </c:pt>
                <c:pt idx="41">
                  <c:v>1.1467918933879948</c:v>
                </c:pt>
                <c:pt idx="42">
                  <c:v>1.1744411421879659</c:v>
                </c:pt>
                <c:pt idx="43">
                  <c:v>1.194674515676114</c:v>
                </c:pt>
                <c:pt idx="44">
                  <c:v>1.2124577537178982</c:v>
                </c:pt>
                <c:pt idx="45">
                  <c:v>1.2354717800213433</c:v>
                </c:pt>
                <c:pt idx="46">
                  <c:v>1.2587641215612819</c:v>
                </c:pt>
                <c:pt idx="47">
                  <c:v>1.283465824540585</c:v>
                </c:pt>
                <c:pt idx="48">
                  <c:v>1.2935563140819142</c:v>
                </c:pt>
                <c:pt idx="49">
                  <c:v>1.320404745638369</c:v>
                </c:pt>
                <c:pt idx="50">
                  <c:v>1.3424718271820788</c:v>
                </c:pt>
                <c:pt idx="51">
                  <c:v>1.3530790505390011</c:v>
                </c:pt>
                <c:pt idx="52">
                  <c:v>1.3687013317981078</c:v>
                </c:pt>
                <c:pt idx="53">
                  <c:v>1.3852126836296044</c:v>
                </c:pt>
                <c:pt idx="54">
                  <c:v>1.3935671398235916</c:v>
                </c:pt>
                <c:pt idx="55">
                  <c:v>1.4012327778243239</c:v>
                </c:pt>
                <c:pt idx="56">
                  <c:v>1.4072816879037884</c:v>
                </c:pt>
                <c:pt idx="57">
                  <c:v>1.4113564344663787</c:v>
                </c:pt>
                <c:pt idx="58">
                  <c:v>1.4109429512773788</c:v>
                </c:pt>
                <c:pt idx="59">
                  <c:v>1.4164666675271529</c:v>
                </c:pt>
                <c:pt idx="60">
                  <c:v>1.4141385293295303</c:v>
                </c:pt>
                <c:pt idx="62">
                  <c:v>1.4166043350292787</c:v>
                </c:pt>
                <c:pt idx="63">
                  <c:v>1.4125810215069401</c:v>
                </c:pt>
                <c:pt idx="64">
                  <c:v>1.4130316133941367</c:v>
                </c:pt>
                <c:pt idx="65">
                  <c:v>1.40933401041454</c:v>
                </c:pt>
                <c:pt idx="66">
                  <c:v>1.3967721392550787</c:v>
                </c:pt>
                <c:pt idx="67">
                  <c:v>1.3826063263320141</c:v>
                </c:pt>
                <c:pt idx="68">
                  <c:v>1.3583775189134366</c:v>
                </c:pt>
                <c:pt idx="69">
                  <c:v>1.3519878048569915</c:v>
                </c:pt>
                <c:pt idx="70">
                  <c:v>1.3374916668380465</c:v>
                </c:pt>
                <c:pt idx="71">
                  <c:v>1.3147009656794626</c:v>
                </c:pt>
                <c:pt idx="72">
                  <c:v>1.2962714979244818</c:v>
                </c:pt>
                <c:pt idx="73">
                  <c:v>1.2760885961113433</c:v>
                </c:pt>
                <c:pt idx="74">
                  <c:v>1.2412063236678785</c:v>
                </c:pt>
                <c:pt idx="75">
                  <c:v>1.2206645442112787</c:v>
                </c:pt>
                <c:pt idx="76">
                  <c:v>1.1924967350017626</c:v>
                </c:pt>
                <c:pt idx="77">
                  <c:v>1.163031659539669</c:v>
                </c:pt>
                <c:pt idx="78">
                  <c:v>1.1279702847523079</c:v>
                </c:pt>
                <c:pt idx="79">
                  <c:v>1.1053101369930851</c:v>
                </c:pt>
                <c:pt idx="80">
                  <c:v>1.0528077701887786</c:v>
                </c:pt>
                <c:pt idx="81">
                  <c:v>1.0238664465085143</c:v>
                </c:pt>
                <c:pt idx="82">
                  <c:v>0.99236875652305612</c:v>
                </c:pt>
                <c:pt idx="83">
                  <c:v>0.96360691973278523</c:v>
                </c:pt>
                <c:pt idx="84">
                  <c:v>0.94452564634623037</c:v>
                </c:pt>
                <c:pt idx="85">
                  <c:v>0.93934686794396249</c:v>
                </c:pt>
                <c:pt idx="86">
                  <c:v>0.92974898195074307</c:v>
                </c:pt>
                <c:pt idx="87">
                  <c:v>0.93361107452261738</c:v>
                </c:pt>
                <c:pt idx="89">
                  <c:v>0.88833279066508841</c:v>
                </c:pt>
                <c:pt idx="90">
                  <c:v>0.8637268396635206</c:v>
                </c:pt>
                <c:pt idx="91">
                  <c:v>0.8455061804383045</c:v>
                </c:pt>
                <c:pt idx="92">
                  <c:v>0.80905611356419793</c:v>
                </c:pt>
                <c:pt idx="94">
                  <c:v>0.76100409872108843</c:v>
                </c:pt>
                <c:pt idx="95">
                  <c:v>0.75497037821239155</c:v>
                </c:pt>
                <c:pt idx="96">
                  <c:v>0.74262798673683672</c:v>
                </c:pt>
                <c:pt idx="97">
                  <c:v>0.73934098285052074</c:v>
                </c:pt>
                <c:pt idx="98">
                  <c:v>0.73782409270924965</c:v>
                </c:pt>
                <c:pt idx="99">
                  <c:v>0.72173982738487219</c:v>
                </c:pt>
                <c:pt idx="100">
                  <c:v>0.67978008019347225</c:v>
                </c:pt>
                <c:pt idx="101">
                  <c:v>0.65995869977820454</c:v>
                </c:pt>
                <c:pt idx="102">
                  <c:v>0.62868298902626907</c:v>
                </c:pt>
                <c:pt idx="103">
                  <c:v>0.60010741675092383</c:v>
                </c:pt>
                <c:pt idx="104">
                  <c:v>0.56536084101084649</c:v>
                </c:pt>
                <c:pt idx="105">
                  <c:v>0.53594715052073993</c:v>
                </c:pt>
                <c:pt idx="106">
                  <c:v>0.52150806952868833</c:v>
                </c:pt>
                <c:pt idx="107">
                  <c:v>0.49098991458454322</c:v>
                </c:pt>
                <c:pt idx="108">
                  <c:v>0.46095864306534651</c:v>
                </c:pt>
                <c:pt idx="109">
                  <c:v>0.4525203077543174</c:v>
                </c:pt>
                <c:pt idx="110">
                  <c:v>0.44091989796969155</c:v>
                </c:pt>
                <c:pt idx="111">
                  <c:v>0.42677499474056257</c:v>
                </c:pt>
                <c:pt idx="112">
                  <c:v>0.42835744999108838</c:v>
                </c:pt>
                <c:pt idx="113">
                  <c:v>0.42829236556445294</c:v>
                </c:pt>
                <c:pt idx="114">
                  <c:v>0.43158311877519806</c:v>
                </c:pt>
                <c:pt idx="115">
                  <c:v>0.43242407301741415</c:v>
                </c:pt>
                <c:pt idx="116">
                  <c:v>0.43551736180820766</c:v>
                </c:pt>
                <c:pt idx="117">
                  <c:v>0.43341591353377862</c:v>
                </c:pt>
                <c:pt idx="118">
                  <c:v>0.43454580609836901</c:v>
                </c:pt>
                <c:pt idx="119">
                  <c:v>0.44248966319907224</c:v>
                </c:pt>
                <c:pt idx="120">
                  <c:v>0.44706403127601091</c:v>
                </c:pt>
                <c:pt idx="121">
                  <c:v>0.43932379133278199</c:v>
                </c:pt>
                <c:pt idx="122">
                  <c:v>0.43670854140673998</c:v>
                </c:pt>
                <c:pt idx="123">
                  <c:v>0.436990413694611</c:v>
                </c:pt>
                <c:pt idx="124">
                  <c:v>0.42915547927541098</c:v>
                </c:pt>
                <c:pt idx="125">
                  <c:v>0.42543292886787865</c:v>
                </c:pt>
                <c:pt idx="126">
                  <c:v>0.42048809869635617</c:v>
                </c:pt>
                <c:pt idx="127">
                  <c:v>0.40697149571872393</c:v>
                </c:pt>
                <c:pt idx="128">
                  <c:v>0.37184830514653999</c:v>
                </c:pt>
                <c:pt idx="129">
                  <c:v>0.36774721717642067</c:v>
                </c:pt>
                <c:pt idx="130">
                  <c:v>0.35458655967827868</c:v>
                </c:pt>
                <c:pt idx="131">
                  <c:v>0.34104448052183356</c:v>
                </c:pt>
                <c:pt idx="132">
                  <c:v>0.33433991934983998</c:v>
                </c:pt>
                <c:pt idx="133">
                  <c:v>0.30922716062876587</c:v>
                </c:pt>
                <c:pt idx="134">
                  <c:v>0.30856437139934001</c:v>
                </c:pt>
                <c:pt idx="135">
                  <c:v>0.30648743793849154</c:v>
                </c:pt>
                <c:pt idx="137">
                  <c:v>0.30987673108616254</c:v>
                </c:pt>
                <c:pt idx="138">
                  <c:v>0.31017559550462381</c:v>
                </c:pt>
                <c:pt idx="139">
                  <c:v>0.30942702846181092</c:v>
                </c:pt>
                <c:pt idx="140">
                  <c:v>0.30080437540046578</c:v>
                </c:pt>
                <c:pt idx="141">
                  <c:v>0.29667221129902066</c:v>
                </c:pt>
                <c:pt idx="142">
                  <c:v>0.28928693143590778</c:v>
                </c:pt>
                <c:pt idx="143">
                  <c:v>0.28455184712525294</c:v>
                </c:pt>
                <c:pt idx="144">
                  <c:v>0.28530466820924649</c:v>
                </c:pt>
                <c:pt idx="145">
                  <c:v>0.26870566390214323</c:v>
                </c:pt>
                <c:pt idx="146">
                  <c:v>0.26462389937331743</c:v>
                </c:pt>
                <c:pt idx="147">
                  <c:v>0.25307912860185866</c:v>
                </c:pt>
                <c:pt idx="148">
                  <c:v>0.23558401172199547</c:v>
                </c:pt>
                <c:pt idx="149">
                  <c:v>0.21856027625260807</c:v>
                </c:pt>
                <c:pt idx="150">
                  <c:v>0.21077199208159611</c:v>
                </c:pt>
                <c:pt idx="151">
                  <c:v>0.19875771456187771</c:v>
                </c:pt>
                <c:pt idx="152">
                  <c:v>0.19238547331863834</c:v>
                </c:pt>
                <c:pt idx="153">
                  <c:v>0.18672738224267968</c:v>
                </c:pt>
                <c:pt idx="154">
                  <c:v>0.18554374936126902</c:v>
                </c:pt>
                <c:pt idx="155">
                  <c:v>0.18745568851309449</c:v>
                </c:pt>
                <c:pt idx="156">
                  <c:v>0.16889617207550225</c:v>
                </c:pt>
                <c:pt idx="157">
                  <c:v>0.15247254482200062</c:v>
                </c:pt>
                <c:pt idx="158">
                  <c:v>0.15025748721053517</c:v>
                </c:pt>
                <c:pt idx="159">
                  <c:v>0.15036590517528611</c:v>
                </c:pt>
                <c:pt idx="160">
                  <c:v>0.13799854223766644</c:v>
                </c:pt>
                <c:pt idx="161">
                  <c:v>0.13670694803999323</c:v>
                </c:pt>
                <c:pt idx="162">
                  <c:v>0.12817245217100257</c:v>
                </c:pt>
                <c:pt idx="163">
                  <c:v>0.12521872957867966</c:v>
                </c:pt>
                <c:pt idx="164">
                  <c:v>0.12452956289052969</c:v>
                </c:pt>
                <c:pt idx="165">
                  <c:v>0.12628171112268194</c:v>
                </c:pt>
                <c:pt idx="166">
                  <c:v>0.12628124245712838</c:v>
                </c:pt>
                <c:pt idx="167">
                  <c:v>0.13186153505117676</c:v>
                </c:pt>
                <c:pt idx="168">
                  <c:v>0.12984022858642774</c:v>
                </c:pt>
                <c:pt idx="169">
                  <c:v>0.12967477762891419</c:v>
                </c:pt>
                <c:pt idx="170">
                  <c:v>0.11705427520698128</c:v>
                </c:pt>
                <c:pt idx="171">
                  <c:v>0.12583342651205676</c:v>
                </c:pt>
                <c:pt idx="172">
                  <c:v>0.1149009853120774</c:v>
                </c:pt>
                <c:pt idx="173">
                  <c:v>0.10555428002149839</c:v>
                </c:pt>
                <c:pt idx="174">
                  <c:v>0.11424952817540032</c:v>
                </c:pt>
                <c:pt idx="175">
                  <c:v>0.11312053689072224</c:v>
                </c:pt>
                <c:pt idx="176">
                  <c:v>0.11672289260933483</c:v>
                </c:pt>
                <c:pt idx="177">
                  <c:v>0.11412177475229385</c:v>
                </c:pt>
                <c:pt idx="178">
                  <c:v>0.11358486428376161</c:v>
                </c:pt>
                <c:pt idx="179">
                  <c:v>0.1148491196574703</c:v>
                </c:pt>
                <c:pt idx="180">
                  <c:v>0.11351980389125904</c:v>
                </c:pt>
                <c:pt idx="181">
                  <c:v>0.11694916193523711</c:v>
                </c:pt>
                <c:pt idx="182">
                  <c:v>0.11986799898647515</c:v>
                </c:pt>
                <c:pt idx="183">
                  <c:v>0.12134250493780258</c:v>
                </c:pt>
                <c:pt idx="184">
                  <c:v>0.12124115300755353</c:v>
                </c:pt>
                <c:pt idx="185">
                  <c:v>0.1151352580035887</c:v>
                </c:pt>
                <c:pt idx="186">
                  <c:v>0.11601393381434094</c:v>
                </c:pt>
                <c:pt idx="187">
                  <c:v>0.11422736870665709</c:v>
                </c:pt>
                <c:pt idx="188">
                  <c:v>0.115086709059053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DC2-49E8-B058-2B285C6699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5861360"/>
        <c:axId val="535843888"/>
      </c:scatterChart>
      <c:valAx>
        <c:axId val="535861360"/>
        <c:scaling>
          <c:orientation val="minMax"/>
          <c:max val="1.1600000000000001"/>
          <c:min val="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843888"/>
        <c:crosses val="autoZero"/>
        <c:crossBetween val="midCat"/>
        <c:majorUnit val="4.0000000000000008E-2"/>
      </c:valAx>
      <c:valAx>
        <c:axId val="53584388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8613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7599" y="336709"/>
            <a:ext cx="4725591" cy="716280"/>
          </a:xfrm>
        </p:spPr>
        <p:txBody>
          <a:bodyPr anchor="b"/>
          <a:lstStyle>
            <a:lvl1pPr algn="ctr">
              <a:defRPr sz="1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599" y="1080611"/>
            <a:ext cx="4725591" cy="496729"/>
          </a:xfrm>
        </p:spPr>
        <p:txBody>
          <a:bodyPr/>
          <a:lstStyle>
            <a:lvl1pPr marL="0" indent="0" algn="ctr">
              <a:buNone/>
              <a:defRPr sz="720"/>
            </a:lvl1pPr>
            <a:lvl2pPr marL="137160" indent="0" algn="ctr">
              <a:buNone/>
              <a:defRPr sz="600"/>
            </a:lvl2pPr>
            <a:lvl3pPr marL="274320" indent="0" algn="ctr">
              <a:buNone/>
              <a:defRPr sz="540"/>
            </a:lvl3pPr>
            <a:lvl4pPr marL="411480" indent="0" algn="ctr">
              <a:buNone/>
              <a:defRPr sz="480"/>
            </a:lvl4pPr>
            <a:lvl5pPr marL="548640" indent="0" algn="ctr">
              <a:buNone/>
              <a:defRPr sz="480"/>
            </a:lvl5pPr>
            <a:lvl6pPr marL="685800" indent="0" algn="ctr">
              <a:buNone/>
              <a:defRPr sz="480"/>
            </a:lvl6pPr>
            <a:lvl7pPr marL="822960" indent="0" algn="ctr">
              <a:buNone/>
              <a:defRPr sz="480"/>
            </a:lvl7pPr>
            <a:lvl8pPr marL="960120" indent="0" algn="ctr">
              <a:buNone/>
              <a:defRPr sz="480"/>
            </a:lvl8pPr>
            <a:lvl9pPr marL="1097280" indent="0" algn="ctr">
              <a:buNone/>
              <a:defRPr sz="4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177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617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09002" y="109538"/>
            <a:ext cx="1358607" cy="174355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179" y="109538"/>
            <a:ext cx="3997062" cy="174355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22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143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897" y="512922"/>
            <a:ext cx="5434430" cy="855821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9897" y="1376839"/>
            <a:ext cx="5434430" cy="450056"/>
          </a:xfrm>
        </p:spPr>
        <p:txBody>
          <a:bodyPr/>
          <a:lstStyle>
            <a:lvl1pPr marL="0" indent="0">
              <a:buNone/>
              <a:defRPr sz="720">
                <a:solidFill>
                  <a:schemeClr val="tx1">
                    <a:tint val="75000"/>
                  </a:schemeClr>
                </a:solidFill>
              </a:defRPr>
            </a:lvl1pPr>
            <a:lvl2pPr marL="137160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2pPr>
            <a:lvl3pPr marL="274320" indent="0">
              <a:buNone/>
              <a:defRPr sz="540">
                <a:solidFill>
                  <a:schemeClr val="tx1">
                    <a:tint val="75000"/>
                  </a:schemeClr>
                </a:solidFill>
              </a:defRPr>
            </a:lvl3pPr>
            <a:lvl4pPr marL="411480" indent="0">
              <a:buNone/>
              <a:defRPr sz="480">
                <a:solidFill>
                  <a:schemeClr val="tx1">
                    <a:tint val="75000"/>
                  </a:schemeClr>
                </a:solidFill>
              </a:defRPr>
            </a:lvl4pPr>
            <a:lvl5pPr marL="548640" indent="0">
              <a:buNone/>
              <a:defRPr sz="480">
                <a:solidFill>
                  <a:schemeClr val="tx1">
                    <a:tint val="75000"/>
                  </a:schemeClr>
                </a:solidFill>
              </a:defRPr>
            </a:lvl5pPr>
            <a:lvl6pPr marL="685800" indent="0">
              <a:buNone/>
              <a:defRPr sz="480">
                <a:solidFill>
                  <a:schemeClr val="tx1">
                    <a:tint val="75000"/>
                  </a:schemeClr>
                </a:solidFill>
              </a:defRPr>
            </a:lvl6pPr>
            <a:lvl7pPr marL="822960" indent="0">
              <a:buNone/>
              <a:defRPr sz="480">
                <a:solidFill>
                  <a:schemeClr val="tx1">
                    <a:tint val="75000"/>
                  </a:schemeClr>
                </a:solidFill>
              </a:defRPr>
            </a:lvl7pPr>
            <a:lvl8pPr marL="960120" indent="0">
              <a:buNone/>
              <a:defRPr sz="480">
                <a:solidFill>
                  <a:schemeClr val="tx1">
                    <a:tint val="75000"/>
                  </a:schemeClr>
                </a:solidFill>
              </a:defRPr>
            </a:lvl8pPr>
            <a:lvl9pPr marL="1097280" indent="0">
              <a:buNone/>
              <a:defRPr sz="4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029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179" y="547688"/>
            <a:ext cx="2677835" cy="13054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9774" y="547688"/>
            <a:ext cx="2677835" cy="13054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156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109538"/>
            <a:ext cx="5434430" cy="3976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000" y="504349"/>
            <a:ext cx="2665528" cy="247174"/>
          </a:xfrm>
        </p:spPr>
        <p:txBody>
          <a:bodyPr anchor="b"/>
          <a:lstStyle>
            <a:lvl1pPr marL="0" indent="0">
              <a:buNone/>
              <a:defRPr sz="720" b="1"/>
            </a:lvl1pPr>
            <a:lvl2pPr marL="137160" indent="0">
              <a:buNone/>
              <a:defRPr sz="600" b="1"/>
            </a:lvl2pPr>
            <a:lvl3pPr marL="274320" indent="0">
              <a:buNone/>
              <a:defRPr sz="540" b="1"/>
            </a:lvl3pPr>
            <a:lvl4pPr marL="411480" indent="0">
              <a:buNone/>
              <a:defRPr sz="480" b="1"/>
            </a:lvl4pPr>
            <a:lvl5pPr marL="548640" indent="0">
              <a:buNone/>
              <a:defRPr sz="480" b="1"/>
            </a:lvl5pPr>
            <a:lvl6pPr marL="685800" indent="0">
              <a:buNone/>
              <a:defRPr sz="480" b="1"/>
            </a:lvl6pPr>
            <a:lvl7pPr marL="822960" indent="0">
              <a:buNone/>
              <a:defRPr sz="480" b="1"/>
            </a:lvl7pPr>
            <a:lvl8pPr marL="960120" indent="0">
              <a:buNone/>
              <a:defRPr sz="480" b="1"/>
            </a:lvl8pPr>
            <a:lvl9pPr marL="1097280" indent="0">
              <a:buNone/>
              <a:defRPr sz="4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000" y="751523"/>
            <a:ext cx="2665528" cy="11053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9774" y="504349"/>
            <a:ext cx="2678656" cy="247174"/>
          </a:xfrm>
        </p:spPr>
        <p:txBody>
          <a:bodyPr anchor="b"/>
          <a:lstStyle>
            <a:lvl1pPr marL="0" indent="0">
              <a:buNone/>
              <a:defRPr sz="720" b="1"/>
            </a:lvl1pPr>
            <a:lvl2pPr marL="137160" indent="0">
              <a:buNone/>
              <a:defRPr sz="600" b="1"/>
            </a:lvl2pPr>
            <a:lvl3pPr marL="274320" indent="0">
              <a:buNone/>
              <a:defRPr sz="540" b="1"/>
            </a:lvl3pPr>
            <a:lvl4pPr marL="411480" indent="0">
              <a:buNone/>
              <a:defRPr sz="480" b="1"/>
            </a:lvl4pPr>
            <a:lvl5pPr marL="548640" indent="0">
              <a:buNone/>
              <a:defRPr sz="480" b="1"/>
            </a:lvl5pPr>
            <a:lvl6pPr marL="685800" indent="0">
              <a:buNone/>
              <a:defRPr sz="480" b="1"/>
            </a:lvl6pPr>
            <a:lvl7pPr marL="822960" indent="0">
              <a:buNone/>
              <a:defRPr sz="480" b="1"/>
            </a:lvl7pPr>
            <a:lvl8pPr marL="960120" indent="0">
              <a:buNone/>
              <a:defRPr sz="480" b="1"/>
            </a:lvl8pPr>
            <a:lvl9pPr marL="1097280" indent="0">
              <a:buNone/>
              <a:defRPr sz="4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9774" y="751523"/>
            <a:ext cx="2678656" cy="11053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051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779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865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137160"/>
            <a:ext cx="2032168" cy="480060"/>
          </a:xfrm>
        </p:spPr>
        <p:txBody>
          <a:bodyPr anchor="b"/>
          <a:lstStyle>
            <a:lvl1pPr>
              <a:defRPr sz="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8656" y="296227"/>
            <a:ext cx="3189774" cy="1462088"/>
          </a:xfrm>
        </p:spPr>
        <p:txBody>
          <a:bodyPr/>
          <a:lstStyle>
            <a:lvl1pPr>
              <a:defRPr sz="960"/>
            </a:lvl1pPr>
            <a:lvl2pPr>
              <a:defRPr sz="840"/>
            </a:lvl2pPr>
            <a:lvl3pPr>
              <a:defRPr sz="72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617220"/>
            <a:ext cx="2032168" cy="1143476"/>
          </a:xfrm>
        </p:spPr>
        <p:txBody>
          <a:bodyPr/>
          <a:lstStyle>
            <a:lvl1pPr marL="0" indent="0">
              <a:buNone/>
              <a:defRPr sz="480"/>
            </a:lvl1pPr>
            <a:lvl2pPr marL="137160" indent="0">
              <a:buNone/>
              <a:defRPr sz="420"/>
            </a:lvl2pPr>
            <a:lvl3pPr marL="274320" indent="0">
              <a:buNone/>
              <a:defRPr sz="360"/>
            </a:lvl3pPr>
            <a:lvl4pPr marL="411480" indent="0">
              <a:buNone/>
              <a:defRPr sz="300"/>
            </a:lvl4pPr>
            <a:lvl5pPr marL="548640" indent="0">
              <a:buNone/>
              <a:defRPr sz="300"/>
            </a:lvl5pPr>
            <a:lvl6pPr marL="685800" indent="0">
              <a:buNone/>
              <a:defRPr sz="300"/>
            </a:lvl6pPr>
            <a:lvl7pPr marL="822960" indent="0">
              <a:buNone/>
              <a:defRPr sz="300"/>
            </a:lvl7pPr>
            <a:lvl8pPr marL="960120" indent="0">
              <a:buNone/>
              <a:defRPr sz="300"/>
            </a:lvl8pPr>
            <a:lvl9pPr marL="1097280" indent="0">
              <a:buNone/>
              <a:defRPr sz="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529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137160"/>
            <a:ext cx="2032168" cy="480060"/>
          </a:xfrm>
        </p:spPr>
        <p:txBody>
          <a:bodyPr anchor="b"/>
          <a:lstStyle>
            <a:lvl1pPr>
              <a:defRPr sz="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78656" y="296227"/>
            <a:ext cx="3189774" cy="1462088"/>
          </a:xfrm>
        </p:spPr>
        <p:txBody>
          <a:bodyPr anchor="t"/>
          <a:lstStyle>
            <a:lvl1pPr marL="0" indent="0">
              <a:buNone/>
              <a:defRPr sz="960"/>
            </a:lvl1pPr>
            <a:lvl2pPr marL="137160" indent="0">
              <a:buNone/>
              <a:defRPr sz="840"/>
            </a:lvl2pPr>
            <a:lvl3pPr marL="274320" indent="0">
              <a:buNone/>
              <a:defRPr sz="720"/>
            </a:lvl3pPr>
            <a:lvl4pPr marL="411480" indent="0">
              <a:buNone/>
              <a:defRPr sz="600"/>
            </a:lvl4pPr>
            <a:lvl5pPr marL="548640" indent="0">
              <a:buNone/>
              <a:defRPr sz="600"/>
            </a:lvl5pPr>
            <a:lvl6pPr marL="685800" indent="0">
              <a:buNone/>
              <a:defRPr sz="600"/>
            </a:lvl6pPr>
            <a:lvl7pPr marL="822960" indent="0">
              <a:buNone/>
              <a:defRPr sz="600"/>
            </a:lvl7pPr>
            <a:lvl8pPr marL="960120" indent="0">
              <a:buNone/>
              <a:defRPr sz="600"/>
            </a:lvl8pPr>
            <a:lvl9pPr marL="1097280" indent="0">
              <a:buNone/>
              <a:defRPr sz="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617220"/>
            <a:ext cx="2032168" cy="1143476"/>
          </a:xfrm>
        </p:spPr>
        <p:txBody>
          <a:bodyPr/>
          <a:lstStyle>
            <a:lvl1pPr marL="0" indent="0">
              <a:buNone/>
              <a:defRPr sz="480"/>
            </a:lvl1pPr>
            <a:lvl2pPr marL="137160" indent="0">
              <a:buNone/>
              <a:defRPr sz="420"/>
            </a:lvl2pPr>
            <a:lvl3pPr marL="274320" indent="0">
              <a:buNone/>
              <a:defRPr sz="360"/>
            </a:lvl3pPr>
            <a:lvl4pPr marL="411480" indent="0">
              <a:buNone/>
              <a:defRPr sz="300"/>
            </a:lvl4pPr>
            <a:lvl5pPr marL="548640" indent="0">
              <a:buNone/>
              <a:defRPr sz="300"/>
            </a:lvl5pPr>
            <a:lvl6pPr marL="685800" indent="0">
              <a:buNone/>
              <a:defRPr sz="300"/>
            </a:lvl6pPr>
            <a:lvl7pPr marL="822960" indent="0">
              <a:buNone/>
              <a:defRPr sz="300"/>
            </a:lvl7pPr>
            <a:lvl8pPr marL="960120" indent="0">
              <a:buNone/>
              <a:defRPr sz="300"/>
            </a:lvl8pPr>
            <a:lvl9pPr marL="1097280" indent="0">
              <a:buNone/>
              <a:defRPr sz="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500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179" y="109538"/>
            <a:ext cx="5434430" cy="3976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179" y="547688"/>
            <a:ext cx="5434430" cy="13054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179" y="1906905"/>
            <a:ext cx="1417677" cy="1095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5E496F-8541-418E-A56C-DA5A3B9DBD65}" type="datetimeFigureOut">
              <a:rPr lang="en-US" smtClean="0"/>
              <a:t>12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7136" y="1906905"/>
            <a:ext cx="2126516" cy="1095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49932" y="1906905"/>
            <a:ext cx="1417677" cy="1095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F0093F-562B-4002-ABCA-35CADEBA95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049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274320" rtl="0" eaLnBrk="1" latinLnBrk="0" hangingPunct="1">
        <a:lnSpc>
          <a:spcPct val="90000"/>
        </a:lnSpc>
        <a:spcBef>
          <a:spcPct val="0"/>
        </a:spcBef>
        <a:buNone/>
        <a:defRPr sz="13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" indent="-68580" algn="l" defTabSz="27432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84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" indent="-68580" algn="l" defTabSz="274320" rtl="0" eaLnBrk="1" latinLnBrk="0" hangingPunct="1">
        <a:lnSpc>
          <a:spcPct val="90000"/>
        </a:lnSpc>
        <a:spcBef>
          <a:spcPts val="150"/>
        </a:spcBef>
        <a:buFont typeface="Arial" panose="020B0604020202020204" pitchFamily="34" charset="0"/>
        <a:buChar char="•"/>
        <a:defRPr sz="72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" indent="-68580" algn="l" defTabSz="274320" rtl="0" eaLnBrk="1" latinLnBrk="0" hangingPunct="1">
        <a:lnSpc>
          <a:spcPct val="90000"/>
        </a:lnSpc>
        <a:spcBef>
          <a:spcPts val="150"/>
        </a:spcBef>
        <a:buFont typeface="Arial" panose="020B0604020202020204" pitchFamily="34" charset="0"/>
        <a:buChar char="•"/>
        <a:defRPr sz="6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" indent="-68580" algn="l" defTabSz="274320" rtl="0" eaLnBrk="1" latinLnBrk="0" hangingPunct="1">
        <a:lnSpc>
          <a:spcPct val="90000"/>
        </a:lnSpc>
        <a:spcBef>
          <a:spcPts val="150"/>
        </a:spcBef>
        <a:buFont typeface="Arial" panose="020B0604020202020204" pitchFamily="34" charset="0"/>
        <a:buChar char="•"/>
        <a:defRPr sz="54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" indent="-68580" algn="l" defTabSz="274320" rtl="0" eaLnBrk="1" latinLnBrk="0" hangingPunct="1">
        <a:lnSpc>
          <a:spcPct val="90000"/>
        </a:lnSpc>
        <a:spcBef>
          <a:spcPts val="150"/>
        </a:spcBef>
        <a:buFont typeface="Arial" panose="020B0604020202020204" pitchFamily="34" charset="0"/>
        <a:buChar char="•"/>
        <a:defRPr sz="54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" indent="-68580" algn="l" defTabSz="274320" rtl="0" eaLnBrk="1" latinLnBrk="0" hangingPunct="1">
        <a:lnSpc>
          <a:spcPct val="90000"/>
        </a:lnSpc>
        <a:spcBef>
          <a:spcPts val="150"/>
        </a:spcBef>
        <a:buFont typeface="Arial" panose="020B0604020202020204" pitchFamily="34" charset="0"/>
        <a:buChar char="•"/>
        <a:defRPr sz="54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" indent="-68580" algn="l" defTabSz="274320" rtl="0" eaLnBrk="1" latinLnBrk="0" hangingPunct="1">
        <a:lnSpc>
          <a:spcPct val="90000"/>
        </a:lnSpc>
        <a:spcBef>
          <a:spcPts val="150"/>
        </a:spcBef>
        <a:buFont typeface="Arial" panose="020B0604020202020204" pitchFamily="34" charset="0"/>
        <a:buChar char="•"/>
        <a:defRPr sz="54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" indent="-68580" algn="l" defTabSz="274320" rtl="0" eaLnBrk="1" latinLnBrk="0" hangingPunct="1">
        <a:lnSpc>
          <a:spcPct val="90000"/>
        </a:lnSpc>
        <a:spcBef>
          <a:spcPts val="150"/>
        </a:spcBef>
        <a:buFont typeface="Arial" panose="020B0604020202020204" pitchFamily="34" charset="0"/>
        <a:buChar char="•"/>
        <a:defRPr sz="54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" indent="-68580" algn="l" defTabSz="274320" rtl="0" eaLnBrk="1" latinLnBrk="0" hangingPunct="1">
        <a:lnSpc>
          <a:spcPct val="90000"/>
        </a:lnSpc>
        <a:spcBef>
          <a:spcPts val="150"/>
        </a:spcBef>
        <a:buFont typeface="Arial" panose="020B0604020202020204" pitchFamily="34" charset="0"/>
        <a:buChar char="•"/>
        <a:defRPr sz="5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" rtl="0" eaLnBrk="1" latinLnBrk="0" hangingPunct="1">
        <a:defRPr sz="54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" algn="l" defTabSz="274320" rtl="0" eaLnBrk="1" latinLnBrk="0" hangingPunct="1">
        <a:defRPr sz="54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" algn="l" defTabSz="274320" rtl="0" eaLnBrk="1" latinLnBrk="0" hangingPunct="1">
        <a:defRPr sz="54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" algn="l" defTabSz="274320" rtl="0" eaLnBrk="1" latinLnBrk="0" hangingPunct="1">
        <a:defRPr sz="54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" algn="l" defTabSz="274320" rtl="0" eaLnBrk="1" latinLnBrk="0" hangingPunct="1">
        <a:defRPr sz="54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" algn="l" defTabSz="274320" rtl="0" eaLnBrk="1" latinLnBrk="0" hangingPunct="1">
        <a:defRPr sz="54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" algn="l" defTabSz="274320" rtl="0" eaLnBrk="1" latinLnBrk="0" hangingPunct="1">
        <a:defRPr sz="54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" algn="l" defTabSz="274320" rtl="0" eaLnBrk="1" latinLnBrk="0" hangingPunct="1">
        <a:defRPr sz="54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" algn="l" defTabSz="274320" rtl="0" eaLnBrk="1" latinLnBrk="0" hangingPunct="1">
        <a:defRPr sz="5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7" name="Group 186">
            <a:extLst>
              <a:ext uri="{FF2B5EF4-FFF2-40B4-BE49-F238E27FC236}">
                <a16:creationId xmlns:a16="http://schemas.microsoft.com/office/drawing/2014/main" id="{4FE6EACE-47ED-42D4-AD36-5FA1211F823E}"/>
              </a:ext>
            </a:extLst>
          </p:cNvPr>
          <p:cNvGrpSpPr/>
          <p:nvPr/>
        </p:nvGrpSpPr>
        <p:grpSpPr>
          <a:xfrm>
            <a:off x="93169" y="37058"/>
            <a:ext cx="6114450" cy="1983284"/>
            <a:chOff x="-27120" y="-18310"/>
            <a:chExt cx="6114450" cy="1983284"/>
          </a:xfrm>
        </p:grpSpPr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30510A66-61AF-4344-8E12-D2A12CF7AC7E}"/>
                </a:ext>
              </a:extLst>
            </p:cNvPr>
            <p:cNvSpPr txBox="1"/>
            <p:nvPr/>
          </p:nvSpPr>
          <p:spPr>
            <a:xfrm>
              <a:off x="-27120" y="-18310"/>
              <a:ext cx="30489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0A8A9EDB-238E-4358-911C-B764D64ECA2B}"/>
                </a:ext>
              </a:extLst>
            </p:cNvPr>
            <p:cNvSpPr txBox="1"/>
            <p:nvPr/>
          </p:nvSpPr>
          <p:spPr>
            <a:xfrm>
              <a:off x="4049180" y="-18310"/>
              <a:ext cx="30489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9EFC3561-8FD4-493E-AD69-A16BDF03F537}"/>
                </a:ext>
              </a:extLst>
            </p:cNvPr>
            <p:cNvSpPr txBox="1"/>
            <p:nvPr/>
          </p:nvSpPr>
          <p:spPr>
            <a:xfrm>
              <a:off x="2011030" y="-18310"/>
              <a:ext cx="30489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191" name="Group 190">
              <a:extLst>
                <a:ext uri="{FF2B5EF4-FFF2-40B4-BE49-F238E27FC236}">
                  <a16:creationId xmlns:a16="http://schemas.microsoft.com/office/drawing/2014/main" id="{66AA7E3E-22F3-4B9D-9572-43937574994E}"/>
                </a:ext>
              </a:extLst>
            </p:cNvPr>
            <p:cNvGrpSpPr/>
            <p:nvPr/>
          </p:nvGrpSpPr>
          <p:grpSpPr>
            <a:xfrm>
              <a:off x="2133944" y="1703364"/>
              <a:ext cx="2124586" cy="261610"/>
              <a:chOff x="319088" y="170282"/>
              <a:chExt cx="2124586" cy="261610"/>
            </a:xfrm>
          </p:grpSpPr>
          <p:grpSp>
            <p:nvGrpSpPr>
              <p:cNvPr id="204" name="Group 203">
                <a:extLst>
                  <a:ext uri="{FF2B5EF4-FFF2-40B4-BE49-F238E27FC236}">
                    <a16:creationId xmlns:a16="http://schemas.microsoft.com/office/drawing/2014/main" id="{B552DE7D-A8AE-4217-88CE-3673BE7FE311}"/>
                  </a:ext>
                </a:extLst>
              </p:cNvPr>
              <p:cNvGrpSpPr/>
              <p:nvPr/>
            </p:nvGrpSpPr>
            <p:grpSpPr>
              <a:xfrm>
                <a:off x="382381" y="170282"/>
                <a:ext cx="495690" cy="261610"/>
                <a:chOff x="537587" y="271932"/>
                <a:chExt cx="495690" cy="261610"/>
              </a:xfrm>
            </p:grpSpPr>
            <p:sp>
              <p:nvSpPr>
                <p:cNvPr id="227" name="Rectangle 226">
                  <a:extLst>
                    <a:ext uri="{FF2B5EF4-FFF2-40B4-BE49-F238E27FC236}">
                      <a16:creationId xmlns:a16="http://schemas.microsoft.com/office/drawing/2014/main" id="{B96128B6-C8A8-4265-A8E1-6FA1366240BC}"/>
                    </a:ext>
                  </a:extLst>
                </p:cNvPr>
                <p:cNvSpPr/>
                <p:nvPr/>
              </p:nvSpPr>
              <p:spPr>
                <a:xfrm>
                  <a:off x="537587" y="353493"/>
                  <a:ext cx="91440" cy="90251"/>
                </a:xfrm>
                <a:prstGeom prst="rect">
                  <a:avLst/>
                </a:prstGeom>
                <a:solidFill>
                  <a:schemeClr val="accent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F42D35E1-669A-43DF-A6BC-248D33FDD84E}"/>
                    </a:ext>
                  </a:extLst>
                </p:cNvPr>
                <p:cNvSpPr txBox="1"/>
                <p:nvPr/>
              </p:nvSpPr>
              <p:spPr>
                <a:xfrm>
                  <a:off x="580909" y="271932"/>
                  <a:ext cx="45236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PLA</a:t>
                  </a:r>
                </a:p>
              </p:txBody>
            </p:sp>
          </p:grpSp>
          <p:grpSp>
            <p:nvGrpSpPr>
              <p:cNvPr id="205" name="Group 204">
                <a:extLst>
                  <a:ext uri="{FF2B5EF4-FFF2-40B4-BE49-F238E27FC236}">
                    <a16:creationId xmlns:a16="http://schemas.microsoft.com/office/drawing/2014/main" id="{5F820643-300C-4F47-8213-5C0C6FF7E6A3}"/>
                  </a:ext>
                </a:extLst>
              </p:cNvPr>
              <p:cNvGrpSpPr/>
              <p:nvPr/>
            </p:nvGrpSpPr>
            <p:grpSpPr>
              <a:xfrm>
                <a:off x="948698" y="170282"/>
                <a:ext cx="536560" cy="261610"/>
                <a:chOff x="963683" y="263175"/>
                <a:chExt cx="536560" cy="261610"/>
              </a:xfrm>
            </p:grpSpPr>
            <p:sp>
              <p:nvSpPr>
                <p:cNvPr id="225" name="Rectangle 224">
                  <a:extLst>
                    <a:ext uri="{FF2B5EF4-FFF2-40B4-BE49-F238E27FC236}">
                      <a16:creationId xmlns:a16="http://schemas.microsoft.com/office/drawing/2014/main" id="{30B509D1-B4DF-41B0-A776-99778F30B980}"/>
                    </a:ext>
                  </a:extLst>
                </p:cNvPr>
                <p:cNvSpPr/>
                <p:nvPr/>
              </p:nvSpPr>
              <p:spPr>
                <a:xfrm>
                  <a:off x="963683" y="344555"/>
                  <a:ext cx="91440" cy="90251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6" name="TextBox 225">
                  <a:extLst>
                    <a:ext uri="{FF2B5EF4-FFF2-40B4-BE49-F238E27FC236}">
                      <a16:creationId xmlns:a16="http://schemas.microsoft.com/office/drawing/2014/main" id="{C4AC588B-9BCF-4B4F-9D97-13C6831D74F6}"/>
                    </a:ext>
                  </a:extLst>
                </p:cNvPr>
                <p:cNvSpPr txBox="1"/>
                <p:nvPr/>
              </p:nvSpPr>
              <p:spPr>
                <a:xfrm>
                  <a:off x="1009403" y="263175"/>
                  <a:ext cx="49084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TDM</a:t>
                  </a:r>
                </a:p>
              </p:txBody>
            </p:sp>
          </p:grpSp>
          <p:grpSp>
            <p:nvGrpSpPr>
              <p:cNvPr id="221" name="Group 220">
                <a:extLst>
                  <a:ext uri="{FF2B5EF4-FFF2-40B4-BE49-F238E27FC236}">
                    <a16:creationId xmlns:a16="http://schemas.microsoft.com/office/drawing/2014/main" id="{7AE9A579-B43F-4CE3-8093-E7B43BADC267}"/>
                  </a:ext>
                </a:extLst>
              </p:cNvPr>
              <p:cNvGrpSpPr/>
              <p:nvPr/>
            </p:nvGrpSpPr>
            <p:grpSpPr>
              <a:xfrm>
                <a:off x="1555884" y="170282"/>
                <a:ext cx="887790" cy="261610"/>
                <a:chOff x="1389779" y="255963"/>
                <a:chExt cx="887790" cy="261610"/>
              </a:xfrm>
            </p:grpSpPr>
            <p:sp>
              <p:nvSpPr>
                <p:cNvPr id="223" name="Rectangle 222">
                  <a:extLst>
                    <a:ext uri="{FF2B5EF4-FFF2-40B4-BE49-F238E27FC236}">
                      <a16:creationId xmlns:a16="http://schemas.microsoft.com/office/drawing/2014/main" id="{43487C8C-7B72-45AF-B259-457DB6D0FEF8}"/>
                    </a:ext>
                  </a:extLst>
                </p:cNvPr>
                <p:cNvSpPr/>
                <p:nvPr/>
              </p:nvSpPr>
              <p:spPr>
                <a:xfrm>
                  <a:off x="1389779" y="335617"/>
                  <a:ext cx="91440" cy="90251"/>
                </a:xfrm>
                <a:prstGeom prst="rect">
                  <a:avLst/>
                </a:prstGeom>
                <a:solidFill>
                  <a:srgbClr val="FFC11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53B0FBE3-C901-4333-804A-11BDCD963FA4}"/>
                    </a:ext>
                  </a:extLst>
                </p:cNvPr>
                <p:cNvSpPr txBox="1"/>
                <p:nvPr/>
              </p:nvSpPr>
              <p:spPr>
                <a:xfrm>
                  <a:off x="1440480" y="255963"/>
                  <a:ext cx="83708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EDC-TDM</a:t>
                  </a:r>
                </a:p>
              </p:txBody>
            </p:sp>
          </p:grpSp>
          <p:sp>
            <p:nvSpPr>
              <p:cNvPr id="222" name="Rectangle 221">
                <a:extLst>
                  <a:ext uri="{FF2B5EF4-FFF2-40B4-BE49-F238E27FC236}">
                    <a16:creationId xmlns:a16="http://schemas.microsoft.com/office/drawing/2014/main" id="{0E9DBAB7-1F4F-4661-9F2D-173F139FB34B}"/>
                  </a:ext>
                </a:extLst>
              </p:cNvPr>
              <p:cNvSpPr/>
              <p:nvPr/>
            </p:nvSpPr>
            <p:spPr>
              <a:xfrm>
                <a:off x="319088" y="170282"/>
                <a:ext cx="2090737" cy="2502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aphicFrame>
          <p:nvGraphicFramePr>
            <p:cNvPr id="192" name="Chart 191">
              <a:extLst>
                <a:ext uri="{FF2B5EF4-FFF2-40B4-BE49-F238E27FC236}">
                  <a16:creationId xmlns:a16="http://schemas.microsoft.com/office/drawing/2014/main" id="{B24268B3-E5AB-4A71-A20A-0A09CF83001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03339823"/>
                </p:ext>
              </p:extLst>
            </p:nvPr>
          </p:nvGraphicFramePr>
          <p:xfrm>
            <a:off x="4258530" y="120189"/>
            <a:ext cx="1828800" cy="13820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94" name="Chart 193">
              <a:extLst>
                <a:ext uri="{FF2B5EF4-FFF2-40B4-BE49-F238E27FC236}">
                  <a16:creationId xmlns:a16="http://schemas.microsoft.com/office/drawing/2014/main" id="{F247EFA3-0E44-410D-9DE7-07F59491804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56600503"/>
                </p:ext>
              </p:extLst>
            </p:nvPr>
          </p:nvGraphicFramePr>
          <p:xfrm>
            <a:off x="2268151" y="120189"/>
            <a:ext cx="18288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95" name="Chart 194">
              <a:extLst>
                <a:ext uri="{FF2B5EF4-FFF2-40B4-BE49-F238E27FC236}">
                  <a16:creationId xmlns:a16="http://schemas.microsoft.com/office/drawing/2014/main" id="{4563B8EE-2B99-4BD2-B899-7F1C5C81456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91756696"/>
                </p:ext>
              </p:extLst>
            </p:nvPr>
          </p:nvGraphicFramePr>
          <p:xfrm>
            <a:off x="277772" y="120189"/>
            <a:ext cx="18288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60EC5E02-0607-475D-8A3F-AB7FF64E5DDB}"/>
                </a:ext>
              </a:extLst>
            </p:cNvPr>
            <p:cNvSpPr txBox="1"/>
            <p:nvPr/>
          </p:nvSpPr>
          <p:spPr>
            <a:xfrm rot="16200000">
              <a:off x="-355734" y="630585"/>
              <a:ext cx="10054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/>
                <a:t>Stress (MPa)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AA551317-38FB-4FDC-BF03-CAF6B3089F8B}"/>
                </a:ext>
              </a:extLst>
            </p:cNvPr>
            <p:cNvSpPr txBox="1"/>
            <p:nvPr/>
          </p:nvSpPr>
          <p:spPr>
            <a:xfrm>
              <a:off x="552659" y="1437073"/>
              <a:ext cx="13515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Stretch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2C7B1419-54AA-42D3-B73C-CC64A2C10331}"/>
                </a:ext>
              </a:extLst>
            </p:cNvPr>
            <p:cNvSpPr txBox="1"/>
            <p:nvPr/>
          </p:nvSpPr>
          <p:spPr>
            <a:xfrm rot="16200000">
              <a:off x="1631243" y="630584"/>
              <a:ext cx="10054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/>
                <a:t>Stress (MPa)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0F78E579-DBB5-4A8E-8D22-A58961CE0525}"/>
                </a:ext>
              </a:extLst>
            </p:cNvPr>
            <p:cNvSpPr txBox="1"/>
            <p:nvPr/>
          </p:nvSpPr>
          <p:spPr>
            <a:xfrm rot="16200000">
              <a:off x="3618220" y="630583"/>
              <a:ext cx="10054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/>
                <a:t>Stress (MPa)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E9BB50E2-77A6-4CEF-B01E-68107483348F}"/>
                </a:ext>
              </a:extLst>
            </p:cNvPr>
            <p:cNvSpPr txBox="1"/>
            <p:nvPr/>
          </p:nvSpPr>
          <p:spPr>
            <a:xfrm>
              <a:off x="2489714" y="1437073"/>
              <a:ext cx="13515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Stretch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8246248B-07C8-42B9-A6AF-F26A70BF444B}"/>
                </a:ext>
              </a:extLst>
            </p:cNvPr>
            <p:cNvSpPr txBox="1"/>
            <p:nvPr/>
          </p:nvSpPr>
          <p:spPr>
            <a:xfrm>
              <a:off x="4497106" y="1437073"/>
              <a:ext cx="13515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Stretc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73051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purdue gpy">
      <a:dk1>
        <a:srgbClr val="000000"/>
      </a:dk1>
      <a:lt1>
        <a:srgbClr val="FFFFFF"/>
      </a:lt1>
      <a:dk2>
        <a:srgbClr val="000000"/>
      </a:dk2>
      <a:lt2>
        <a:srgbClr val="FFFFFF"/>
      </a:lt2>
      <a:accent1>
        <a:srgbClr val="118B7E"/>
      </a:accent1>
      <a:accent2>
        <a:srgbClr val="D81A60"/>
      </a:accent2>
      <a:accent3>
        <a:srgbClr val="DAAA00"/>
      </a:accent3>
      <a:accent4>
        <a:srgbClr val="849E2A"/>
      </a:accent4>
      <a:accent5>
        <a:srgbClr val="FFD100"/>
      </a:accent5>
      <a:accent6>
        <a:srgbClr val="CFB991"/>
      </a:accent6>
      <a:hlink>
        <a:srgbClr val="118B7E"/>
      </a:hlink>
      <a:folHlink>
        <a:srgbClr val="D81A60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</TotalTime>
  <Words>21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my Jenkins</dc:creator>
  <cp:lastModifiedBy>Jenkins, Tommy L.</cp:lastModifiedBy>
  <cp:revision>11</cp:revision>
  <dcterms:created xsi:type="dcterms:W3CDTF">2023-12-21T23:02:20Z</dcterms:created>
  <dcterms:modified xsi:type="dcterms:W3CDTF">2024-12-29T20:13:31Z</dcterms:modified>
</cp:coreProperties>
</file>